
<file path=[Content_Types].xml><?xml version="1.0" encoding="utf-8"?>
<Types xmlns="http://schemas.openxmlformats.org/package/2006/content-types">
  <Default Extension="emf" ContentType="image/x-emf"/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heme/theme2.xml" ContentType="application/vnd.openxmlformats-officedocument.theme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17" r:id="rId2"/>
    <p:sldId id="318" r:id="rId3"/>
    <p:sldId id="31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6F1CFDF-6D63-4785-9454-2C5CE44D1ADC}" v="20" dt="2021-10-11T04:14:29.0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14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72" y="10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李 昱熙" userId="069dfa28105d5f6a" providerId="LiveId" clId="{A6F1CFDF-6D63-4785-9454-2C5CE44D1ADC}"/>
    <pc:docChg chg="custSel modSld modMainMaster">
      <pc:chgData name="李 昱熙" userId="069dfa28105d5f6a" providerId="LiveId" clId="{A6F1CFDF-6D63-4785-9454-2C5CE44D1ADC}" dt="2021-10-11T04:14:29.008" v="23"/>
      <pc:docMkLst>
        <pc:docMk/>
      </pc:docMkLst>
      <pc:sldChg chg="modTransition">
        <pc:chgData name="李 昱熙" userId="069dfa28105d5f6a" providerId="LiveId" clId="{A6F1CFDF-6D63-4785-9454-2C5CE44D1ADC}" dt="2021-10-11T04:14:23.362" v="21"/>
        <pc:sldMkLst>
          <pc:docMk/>
          <pc:sldMk cId="3489149437" sldId="317"/>
        </pc:sldMkLst>
      </pc:sldChg>
      <pc:sldChg chg="modTransition">
        <pc:chgData name="李 昱熙" userId="069dfa28105d5f6a" providerId="LiveId" clId="{A6F1CFDF-6D63-4785-9454-2C5CE44D1ADC}" dt="2021-10-11T04:14:26.369" v="22"/>
        <pc:sldMkLst>
          <pc:docMk/>
          <pc:sldMk cId="4266705948" sldId="318"/>
        </pc:sldMkLst>
      </pc:sldChg>
      <pc:sldChg chg="modTransition">
        <pc:chgData name="李 昱熙" userId="069dfa28105d5f6a" providerId="LiveId" clId="{A6F1CFDF-6D63-4785-9454-2C5CE44D1ADC}" dt="2021-10-11T04:14:29.008" v="23"/>
        <pc:sldMkLst>
          <pc:docMk/>
          <pc:sldMk cId="666274762" sldId="319"/>
        </pc:sldMkLst>
      </pc:sldChg>
      <pc:sldMasterChg chg="delSp modSldLayout sldLayoutOrd">
        <pc:chgData name="李 昱熙" userId="069dfa28105d5f6a" providerId="LiveId" clId="{A6F1CFDF-6D63-4785-9454-2C5CE44D1ADC}" dt="2021-10-11T04:13:58.618" v="20" actId="478"/>
        <pc:sldMasterMkLst>
          <pc:docMk/>
          <pc:sldMasterMk cId="716909701" sldId="2147483660"/>
        </pc:sldMasterMkLst>
        <pc:picChg chg="del">
          <ac:chgData name="李 昱熙" userId="069dfa28105d5f6a" providerId="LiveId" clId="{A6F1CFDF-6D63-4785-9454-2C5CE44D1ADC}" dt="2021-10-11T04:13:15.259" v="3" actId="478"/>
          <ac:picMkLst>
            <pc:docMk/>
            <pc:sldMasterMk cId="716909701" sldId="2147483660"/>
            <ac:picMk id="2" creationId="{00000000-0000-0000-0000-000000000000}"/>
          </ac:picMkLst>
        </pc:picChg>
        <pc:sldLayoutChg chg="delSp">
          <pc:chgData name="李 昱熙" userId="069dfa28105d5f6a" providerId="LiveId" clId="{A6F1CFDF-6D63-4785-9454-2C5CE44D1ADC}" dt="2021-10-11T04:13:13.194" v="2" actId="478"/>
          <pc:sldLayoutMkLst>
            <pc:docMk/>
            <pc:sldMasterMk cId="716909701" sldId="2147483660"/>
            <pc:sldLayoutMk cId="2673421588" sldId="2147483661"/>
          </pc:sldLayoutMkLst>
          <pc:picChg chg="del">
            <ac:chgData name="李 昱熙" userId="069dfa28105d5f6a" providerId="LiveId" clId="{A6F1CFDF-6D63-4785-9454-2C5CE44D1ADC}" dt="2021-10-11T04:13:13.194" v="2" actId="478"/>
            <ac:picMkLst>
              <pc:docMk/>
              <pc:sldMasterMk cId="716909701" sldId="2147483660"/>
              <pc:sldLayoutMk cId="2673421588" sldId="2147483661"/>
              <ac:picMk id="8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49.833" v="16" actId="478"/>
          <pc:sldLayoutMkLst>
            <pc:docMk/>
            <pc:sldMasterMk cId="716909701" sldId="2147483660"/>
            <pc:sldLayoutMk cId="1096948356" sldId="2147483662"/>
          </pc:sldLayoutMkLst>
          <pc:picChg chg="del">
            <ac:chgData name="李 昱熙" userId="069dfa28105d5f6a" providerId="LiveId" clId="{A6F1CFDF-6D63-4785-9454-2C5CE44D1ADC}" dt="2021-10-11T04:13:49.833" v="16" actId="478"/>
            <ac:picMkLst>
              <pc:docMk/>
              <pc:sldMasterMk cId="716909701" sldId="2147483660"/>
              <pc:sldLayoutMk cId="1096948356" sldId="2147483662"/>
              <ac:picMk id="11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51.611" v="17" actId="478"/>
          <pc:sldLayoutMkLst>
            <pc:docMk/>
            <pc:sldMasterMk cId="716909701" sldId="2147483660"/>
            <pc:sldLayoutMk cId="2493038152" sldId="2147483663"/>
          </pc:sldLayoutMkLst>
          <pc:picChg chg="del">
            <ac:chgData name="李 昱熙" userId="069dfa28105d5f6a" providerId="LiveId" clId="{A6F1CFDF-6D63-4785-9454-2C5CE44D1ADC}" dt="2021-10-11T04:13:51.611" v="17" actId="478"/>
            <ac:picMkLst>
              <pc:docMk/>
              <pc:sldMasterMk cId="716909701" sldId="2147483660"/>
              <pc:sldLayoutMk cId="2493038152" sldId="2147483663"/>
              <ac:picMk id="11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53.433" v="18" actId="478"/>
          <pc:sldLayoutMkLst>
            <pc:docMk/>
            <pc:sldMasterMk cId="716909701" sldId="2147483660"/>
            <pc:sldLayoutMk cId="2052499962" sldId="2147483664"/>
          </pc:sldLayoutMkLst>
          <pc:picChg chg="del">
            <ac:chgData name="李 昱熙" userId="069dfa28105d5f6a" providerId="LiveId" clId="{A6F1CFDF-6D63-4785-9454-2C5CE44D1ADC}" dt="2021-10-11T04:13:53.433" v="18" actId="478"/>
            <ac:picMkLst>
              <pc:docMk/>
              <pc:sldMasterMk cId="716909701" sldId="2147483660"/>
              <pc:sldLayoutMk cId="2052499962" sldId="2147483664"/>
              <ac:picMk id="11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55.051" v="19" actId="478"/>
          <pc:sldLayoutMkLst>
            <pc:docMk/>
            <pc:sldMasterMk cId="716909701" sldId="2147483660"/>
            <pc:sldLayoutMk cId="3298969289" sldId="2147483665"/>
          </pc:sldLayoutMkLst>
          <pc:picChg chg="del">
            <ac:chgData name="李 昱熙" userId="069dfa28105d5f6a" providerId="LiveId" clId="{A6F1CFDF-6D63-4785-9454-2C5CE44D1ADC}" dt="2021-10-11T04:13:55.051" v="19" actId="478"/>
            <ac:picMkLst>
              <pc:docMk/>
              <pc:sldMasterMk cId="716909701" sldId="2147483660"/>
              <pc:sldLayoutMk cId="3298969289" sldId="2147483665"/>
              <ac:picMk id="11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58.618" v="20" actId="478"/>
          <pc:sldLayoutMkLst>
            <pc:docMk/>
            <pc:sldMasterMk cId="716909701" sldId="2147483660"/>
            <pc:sldLayoutMk cId="641160369" sldId="2147483666"/>
          </pc:sldLayoutMkLst>
          <pc:picChg chg="del">
            <ac:chgData name="李 昱熙" userId="069dfa28105d5f6a" providerId="LiveId" clId="{A6F1CFDF-6D63-4785-9454-2C5CE44D1ADC}" dt="2021-10-11T04:13:58.618" v="20" actId="478"/>
            <ac:picMkLst>
              <pc:docMk/>
              <pc:sldMasterMk cId="716909701" sldId="2147483660"/>
              <pc:sldLayoutMk cId="641160369" sldId="2147483666"/>
              <ac:picMk id="8" creationId="{00000000-0000-0000-0000-000000000000}"/>
            </ac:picMkLst>
          </pc:picChg>
        </pc:sldLayoutChg>
        <pc:sldLayoutChg chg="delSp mod">
          <pc:chgData name="李 昱熙" userId="069dfa28105d5f6a" providerId="LiveId" clId="{A6F1CFDF-6D63-4785-9454-2C5CE44D1ADC}" dt="2021-10-11T04:13:41.402" v="15" actId="478"/>
          <pc:sldLayoutMkLst>
            <pc:docMk/>
            <pc:sldMasterMk cId="716909701" sldId="2147483660"/>
            <pc:sldLayoutMk cId="3163926048" sldId="2147483667"/>
          </pc:sldLayoutMkLst>
          <pc:picChg chg="del">
            <ac:chgData name="李 昱熙" userId="069dfa28105d5f6a" providerId="LiveId" clId="{A6F1CFDF-6D63-4785-9454-2C5CE44D1ADC}" dt="2021-10-11T04:13:41.402" v="15" actId="478"/>
            <ac:picMkLst>
              <pc:docMk/>
              <pc:sldMasterMk cId="716909701" sldId="2147483660"/>
              <pc:sldLayoutMk cId="3163926048" sldId="2147483667"/>
              <ac:picMk id="4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38.059" v="13" actId="478"/>
          <pc:sldLayoutMkLst>
            <pc:docMk/>
            <pc:sldMasterMk cId="716909701" sldId="2147483660"/>
            <pc:sldLayoutMk cId="1757423769" sldId="2147483668"/>
          </pc:sldLayoutMkLst>
          <pc:picChg chg="del">
            <ac:chgData name="李 昱熙" userId="069dfa28105d5f6a" providerId="LiveId" clId="{A6F1CFDF-6D63-4785-9454-2C5CE44D1ADC}" dt="2021-10-11T04:13:38.059" v="13" actId="478"/>
            <ac:picMkLst>
              <pc:docMk/>
              <pc:sldMasterMk cId="716909701" sldId="2147483660"/>
              <pc:sldLayoutMk cId="1757423769" sldId="2147483668"/>
              <ac:picMk id="8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39.674" v="14" actId="478"/>
          <pc:sldLayoutMkLst>
            <pc:docMk/>
            <pc:sldMasterMk cId="716909701" sldId="2147483660"/>
            <pc:sldLayoutMk cId="3300641120" sldId="2147483669"/>
          </pc:sldLayoutMkLst>
          <pc:picChg chg="del">
            <ac:chgData name="李 昱熙" userId="069dfa28105d5f6a" providerId="LiveId" clId="{A6F1CFDF-6D63-4785-9454-2C5CE44D1ADC}" dt="2021-10-11T04:13:39.674" v="14" actId="478"/>
            <ac:picMkLst>
              <pc:docMk/>
              <pc:sldMasterMk cId="716909701" sldId="2147483660"/>
              <pc:sldLayoutMk cId="3300641120" sldId="2147483669"/>
              <ac:picMk id="3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34.635" v="11" actId="478"/>
          <pc:sldLayoutMkLst>
            <pc:docMk/>
            <pc:sldMasterMk cId="716909701" sldId="2147483660"/>
            <pc:sldLayoutMk cId="4164924076" sldId="2147483671"/>
          </pc:sldLayoutMkLst>
          <pc:picChg chg="del">
            <ac:chgData name="李 昱熙" userId="069dfa28105d5f6a" providerId="LiveId" clId="{A6F1CFDF-6D63-4785-9454-2C5CE44D1ADC}" dt="2021-10-11T04:13:34.635" v="11" actId="478"/>
            <ac:picMkLst>
              <pc:docMk/>
              <pc:sldMasterMk cId="716909701" sldId="2147483660"/>
              <pc:sldLayoutMk cId="4164924076" sldId="2147483671"/>
              <ac:picMk id="6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36.185" v="12" actId="478"/>
          <pc:sldLayoutMkLst>
            <pc:docMk/>
            <pc:sldMasterMk cId="716909701" sldId="2147483660"/>
            <pc:sldLayoutMk cId="819513292" sldId="2147483672"/>
          </pc:sldLayoutMkLst>
          <pc:picChg chg="del">
            <ac:chgData name="李 昱熙" userId="069dfa28105d5f6a" providerId="LiveId" clId="{A6F1CFDF-6D63-4785-9454-2C5CE44D1ADC}" dt="2021-10-11T04:13:36.185" v="12" actId="478"/>
            <ac:picMkLst>
              <pc:docMk/>
              <pc:sldMasterMk cId="716909701" sldId="2147483660"/>
              <pc:sldLayoutMk cId="819513292" sldId="2147483672"/>
              <ac:picMk id="6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30.627" v="10" actId="478"/>
          <pc:sldLayoutMkLst>
            <pc:docMk/>
            <pc:sldMasterMk cId="716909701" sldId="2147483660"/>
            <pc:sldLayoutMk cId="1604045192" sldId="2147483673"/>
          </pc:sldLayoutMkLst>
          <pc:picChg chg="del">
            <ac:chgData name="李 昱熙" userId="069dfa28105d5f6a" providerId="LiveId" clId="{A6F1CFDF-6D63-4785-9454-2C5CE44D1ADC}" dt="2021-10-11T04:13:30.627" v="10" actId="478"/>
            <ac:picMkLst>
              <pc:docMk/>
              <pc:sldMasterMk cId="716909701" sldId="2147483660"/>
              <pc:sldLayoutMk cId="1604045192" sldId="2147483673"/>
              <ac:picMk id="11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28.507" v="9" actId="478"/>
          <pc:sldLayoutMkLst>
            <pc:docMk/>
            <pc:sldMasterMk cId="716909701" sldId="2147483660"/>
            <pc:sldLayoutMk cId="3177657845" sldId="2147483674"/>
          </pc:sldLayoutMkLst>
          <pc:picChg chg="del">
            <ac:chgData name="李 昱熙" userId="069dfa28105d5f6a" providerId="LiveId" clId="{A6F1CFDF-6D63-4785-9454-2C5CE44D1ADC}" dt="2021-10-11T04:13:28.507" v="9" actId="478"/>
            <ac:picMkLst>
              <pc:docMk/>
              <pc:sldMasterMk cId="716909701" sldId="2147483660"/>
              <pc:sldLayoutMk cId="3177657845" sldId="2147483674"/>
              <ac:picMk id="11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26.795" v="8" actId="478"/>
          <pc:sldLayoutMkLst>
            <pc:docMk/>
            <pc:sldMasterMk cId="716909701" sldId="2147483660"/>
            <pc:sldLayoutMk cId="819012492" sldId="2147483675"/>
          </pc:sldLayoutMkLst>
          <pc:picChg chg="del">
            <ac:chgData name="李 昱熙" userId="069dfa28105d5f6a" providerId="LiveId" clId="{A6F1CFDF-6D63-4785-9454-2C5CE44D1ADC}" dt="2021-10-11T04:13:26.795" v="8" actId="478"/>
            <ac:picMkLst>
              <pc:docMk/>
              <pc:sldMasterMk cId="716909701" sldId="2147483660"/>
              <pc:sldLayoutMk cId="819012492" sldId="2147483675"/>
              <ac:picMk id="7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24.908" v="7" actId="478"/>
          <pc:sldLayoutMkLst>
            <pc:docMk/>
            <pc:sldMasterMk cId="716909701" sldId="2147483660"/>
            <pc:sldLayoutMk cId="1492691412" sldId="2147483676"/>
          </pc:sldLayoutMkLst>
          <pc:picChg chg="del">
            <ac:chgData name="李 昱熙" userId="069dfa28105d5f6a" providerId="LiveId" clId="{A6F1CFDF-6D63-4785-9454-2C5CE44D1ADC}" dt="2021-10-11T04:13:24.908" v="7" actId="478"/>
            <ac:picMkLst>
              <pc:docMk/>
              <pc:sldMasterMk cId="716909701" sldId="2147483660"/>
              <pc:sldLayoutMk cId="1492691412" sldId="2147483676"/>
              <ac:picMk id="6" creationId="{00000000-0000-0000-0000-000000000000}"/>
            </ac:picMkLst>
          </pc:picChg>
        </pc:sldLayoutChg>
        <pc:sldLayoutChg chg="delSp">
          <pc:chgData name="李 昱熙" userId="069dfa28105d5f6a" providerId="LiveId" clId="{A6F1CFDF-6D63-4785-9454-2C5CE44D1ADC}" dt="2021-10-11T04:13:23.145" v="6" actId="478"/>
          <pc:sldLayoutMkLst>
            <pc:docMk/>
            <pc:sldMasterMk cId="716909701" sldId="2147483660"/>
            <pc:sldLayoutMk cId="633083529" sldId="2147483677"/>
          </pc:sldLayoutMkLst>
          <pc:picChg chg="del">
            <ac:chgData name="李 昱熙" userId="069dfa28105d5f6a" providerId="LiveId" clId="{A6F1CFDF-6D63-4785-9454-2C5CE44D1ADC}" dt="2021-10-11T04:13:23.145" v="6" actId="478"/>
            <ac:picMkLst>
              <pc:docMk/>
              <pc:sldMasterMk cId="716909701" sldId="2147483660"/>
              <pc:sldLayoutMk cId="633083529" sldId="2147483677"/>
              <ac:picMk id="6" creationId="{00000000-0000-0000-0000-000000000000}"/>
            </ac:picMkLst>
          </pc:picChg>
        </pc:sldLayoutChg>
        <pc:sldLayoutChg chg="delSp mod ord setBg">
          <pc:chgData name="李 昱熙" userId="069dfa28105d5f6a" providerId="LiveId" clId="{A6F1CFDF-6D63-4785-9454-2C5CE44D1ADC}" dt="2021-10-11T04:13:21.657" v="5" actId="20578"/>
          <pc:sldLayoutMkLst>
            <pc:docMk/>
            <pc:sldMasterMk cId="716909701" sldId="2147483660"/>
            <pc:sldLayoutMk cId="2005689831" sldId="2147483678"/>
          </pc:sldLayoutMkLst>
          <pc:picChg chg="del">
            <ac:chgData name="李 昱熙" userId="069dfa28105d5f6a" providerId="LiveId" clId="{A6F1CFDF-6D63-4785-9454-2C5CE44D1ADC}" dt="2021-10-11T04:12:57.964" v="0" actId="478"/>
            <ac:picMkLst>
              <pc:docMk/>
              <pc:sldMasterMk cId="716909701" sldId="2147483660"/>
              <pc:sldLayoutMk cId="2005689831" sldId="2147483678"/>
              <ac:picMk id="7" creationId="{00000000-0000-0000-0000-000000000000}"/>
            </ac:picMkLst>
          </pc:picChg>
        </pc:sldLayoutChg>
        <pc:sldLayoutChg chg="delSp mod">
          <pc:chgData name="李 昱熙" userId="069dfa28105d5f6a" providerId="LiveId" clId="{A6F1CFDF-6D63-4785-9454-2C5CE44D1ADC}" dt="2021-10-11T04:13:19.979" v="4" actId="478"/>
          <pc:sldLayoutMkLst>
            <pc:docMk/>
            <pc:sldMasterMk cId="716909701" sldId="2147483660"/>
            <pc:sldLayoutMk cId="4075256383" sldId="2147483679"/>
          </pc:sldLayoutMkLst>
          <pc:spChg chg="del">
            <ac:chgData name="李 昱熙" userId="069dfa28105d5f6a" providerId="LiveId" clId="{A6F1CFDF-6D63-4785-9454-2C5CE44D1ADC}" dt="2021-10-11T04:13:19.979" v="4" actId="478"/>
            <ac:spMkLst>
              <pc:docMk/>
              <pc:sldMasterMk cId="716909701" sldId="2147483660"/>
              <pc:sldLayoutMk cId="4075256383" sldId="2147483679"/>
              <ac:spMk id="507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4E97DA-40DA-4E83-AEF7-1D06F3AE7888}" type="datetimeFigureOut">
              <a:rPr lang="en-US" smtClean="0"/>
              <a:t>10/1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D0CA37-DA13-497D-9AEC-2957D947D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7563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2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3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1.xml"/><Relationship Id="rId2" Type="http://schemas.openxmlformats.org/officeDocument/2006/relationships/tags" Target="../tags/tag5.xml"/><Relationship Id="rId1" Type="http://schemas.openxmlformats.org/officeDocument/2006/relationships/tags" Target="../tags/tag4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6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hteck 10"/>
          <p:cNvSpPr/>
          <p:nvPr userDrawn="1">
            <p:custDataLst>
              <p:tags r:id="rId1"/>
            </p:custDataLst>
          </p:nvPr>
        </p:nvSpPr>
        <p:spPr bwMode="auto">
          <a:xfrm>
            <a:off x="311574" y="152400"/>
            <a:ext cx="11579791" cy="5650992"/>
          </a:xfrm>
          <a:custGeom>
            <a:avLst/>
            <a:gdLst>
              <a:gd name="connsiteX0" fmla="*/ 0 w 8684821"/>
              <a:gd name="connsiteY0" fmla="*/ 0 h 5636316"/>
              <a:gd name="connsiteX1" fmla="*/ 8684821 w 8684821"/>
              <a:gd name="connsiteY1" fmla="*/ 0 h 5636316"/>
              <a:gd name="connsiteX2" fmla="*/ 8684821 w 8684821"/>
              <a:gd name="connsiteY2" fmla="*/ 5636316 h 5636316"/>
              <a:gd name="connsiteX3" fmla="*/ 0 w 8684821"/>
              <a:gd name="connsiteY3" fmla="*/ 5636316 h 5636316"/>
              <a:gd name="connsiteX4" fmla="*/ 0 w 8684821"/>
              <a:gd name="connsiteY4" fmla="*/ 0 h 5636316"/>
              <a:gd name="connsiteX0" fmla="*/ 8684821 w 8684821"/>
              <a:gd name="connsiteY0" fmla="*/ 0 h 5636316"/>
              <a:gd name="connsiteX1" fmla="*/ 8684821 w 8684821"/>
              <a:gd name="connsiteY1" fmla="*/ 5636316 h 5636316"/>
              <a:gd name="connsiteX2" fmla="*/ 0 w 8684821"/>
              <a:gd name="connsiteY2" fmla="*/ 5636316 h 5636316"/>
              <a:gd name="connsiteX3" fmla="*/ 0 w 8684821"/>
              <a:gd name="connsiteY3" fmla="*/ 0 h 5636316"/>
              <a:gd name="connsiteX0" fmla="*/ 8684821 w 8684821"/>
              <a:gd name="connsiteY0" fmla="*/ 5636316 h 5636316"/>
              <a:gd name="connsiteX1" fmla="*/ 0 w 8684821"/>
              <a:gd name="connsiteY1" fmla="*/ 5636316 h 5636316"/>
              <a:gd name="connsiteX2" fmla="*/ 0 w 8684821"/>
              <a:gd name="connsiteY2" fmla="*/ 0 h 5636316"/>
              <a:gd name="connsiteX0" fmla="*/ 0 w 0"/>
              <a:gd name="connsiteY0" fmla="*/ 5636316 h 5636316"/>
              <a:gd name="connsiteX1" fmla="*/ 0 w 0"/>
              <a:gd name="connsiteY1" fmla="*/ 0 h 5636316"/>
              <a:gd name="connsiteX0" fmla="*/ 0 w 8684821"/>
              <a:gd name="connsiteY0" fmla="*/ 5636316 h 5636316"/>
              <a:gd name="connsiteX1" fmla="*/ 0 w 8684821"/>
              <a:gd name="connsiteY1" fmla="*/ 0 h 5636316"/>
              <a:gd name="connsiteX2" fmla="*/ 8684821 w 8684821"/>
              <a:gd name="connsiteY2" fmla="*/ 0 h 5636316"/>
              <a:gd name="connsiteX0" fmla="*/ 0 w 8684821"/>
              <a:gd name="connsiteY0" fmla="*/ 5636316 h 5636316"/>
              <a:gd name="connsiteX1" fmla="*/ 0 w 8684821"/>
              <a:gd name="connsiteY1" fmla="*/ 0 h 5636316"/>
              <a:gd name="connsiteX2" fmla="*/ 8684821 w 8684821"/>
              <a:gd name="connsiteY2" fmla="*/ 0 h 5636316"/>
              <a:gd name="connsiteX3" fmla="*/ 8684821 w 8684821"/>
              <a:gd name="connsiteY3" fmla="*/ 4412595 h 5636316"/>
              <a:gd name="connsiteX0" fmla="*/ 0 w 8684843"/>
              <a:gd name="connsiteY0" fmla="*/ 5636316 h 5636316"/>
              <a:gd name="connsiteX1" fmla="*/ 0 w 8684843"/>
              <a:gd name="connsiteY1" fmla="*/ 0 h 5636316"/>
              <a:gd name="connsiteX2" fmla="*/ 8684821 w 8684843"/>
              <a:gd name="connsiteY2" fmla="*/ 0 h 5636316"/>
              <a:gd name="connsiteX3" fmla="*/ 8684821 w 8684843"/>
              <a:gd name="connsiteY3" fmla="*/ 4412595 h 5636316"/>
              <a:gd name="connsiteX4" fmla="*/ 7086785 w 8684843"/>
              <a:gd name="connsiteY4" fmla="*/ 5636316 h 5636316"/>
              <a:gd name="connsiteX0" fmla="*/ 0 w 8684843"/>
              <a:gd name="connsiteY0" fmla="*/ 5636316 h 5636316"/>
              <a:gd name="connsiteX1" fmla="*/ 0 w 8684843"/>
              <a:gd name="connsiteY1" fmla="*/ 0 h 5636316"/>
              <a:gd name="connsiteX2" fmla="*/ 8684821 w 8684843"/>
              <a:gd name="connsiteY2" fmla="*/ 0 h 5636316"/>
              <a:gd name="connsiteX3" fmla="*/ 8684821 w 8684843"/>
              <a:gd name="connsiteY3" fmla="*/ 4412595 h 5636316"/>
              <a:gd name="connsiteX4" fmla="*/ 7086785 w 8684843"/>
              <a:gd name="connsiteY4" fmla="*/ 5636316 h 5636316"/>
              <a:gd name="connsiteX5" fmla="*/ 0 w 8684843"/>
              <a:gd name="connsiteY5" fmla="*/ 5636316 h 5636316"/>
              <a:gd name="connsiteX0" fmla="*/ 0 w 8684843"/>
              <a:gd name="connsiteY0" fmla="*/ 5636316 h 5636316"/>
              <a:gd name="connsiteX1" fmla="*/ 0 w 8684843"/>
              <a:gd name="connsiteY1" fmla="*/ 0 h 5636316"/>
              <a:gd name="connsiteX2" fmla="*/ 8684821 w 8684843"/>
              <a:gd name="connsiteY2" fmla="*/ 0 h 5636316"/>
              <a:gd name="connsiteX3" fmla="*/ 8684821 w 8684843"/>
              <a:gd name="connsiteY3" fmla="*/ 4412595 h 5636316"/>
              <a:gd name="connsiteX4" fmla="*/ 7086785 w 8684843"/>
              <a:gd name="connsiteY4" fmla="*/ 5636316 h 5636316"/>
              <a:gd name="connsiteX5" fmla="*/ 0 w 8684843"/>
              <a:gd name="connsiteY5" fmla="*/ 5636316 h 5636316"/>
              <a:gd name="connsiteX6" fmla="*/ 0 w 8684843"/>
              <a:gd name="connsiteY6" fmla="*/ 0 h 56363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8684843" h="5636316">
                <a:moveTo>
                  <a:pt x="0" y="5636316"/>
                </a:moveTo>
                <a:lnTo>
                  <a:pt x="0" y="0"/>
                </a:lnTo>
                <a:lnTo>
                  <a:pt x="8684821" y="0"/>
                </a:lnTo>
                <a:lnTo>
                  <a:pt x="8684821" y="4412595"/>
                </a:lnTo>
                <a:cubicBezTo>
                  <a:pt x="8684821" y="4412595"/>
                  <a:pt x="8710016" y="5571530"/>
                  <a:pt x="7086785" y="5636316"/>
                </a:cubicBezTo>
                <a:lnTo>
                  <a:pt x="0" y="5636316"/>
                </a:lnTo>
                <a:lnTo>
                  <a:pt x="0" y="0"/>
                </a:lnTo>
                <a:close/>
              </a:path>
            </a:pathLst>
          </a:custGeom>
          <a:gradFill flip="none" rotWithShape="1">
            <a:gsLst>
              <a:gs pos="18000">
                <a:srgbClr val="0089C4"/>
              </a:gs>
              <a:gs pos="0">
                <a:srgbClr val="0089C4"/>
              </a:gs>
              <a:gs pos="100000">
                <a:srgbClr val="629FD5"/>
              </a:gs>
            </a:gsLst>
            <a:lin ang="2100000" scaled="1"/>
            <a:tileRect/>
          </a:gra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1240B29-F687-4F45-9708-019B960494DF}">
              <a14:hiddenLine xmlns:a14="http://schemas.microsoft.com/office/drawing/2010/main"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sz="200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17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1104899" y="2052000"/>
            <a:ext cx="9984000" cy="1620000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sz="4800">
                <a:solidFill>
                  <a:schemeClr val="bg1"/>
                </a:solidFill>
              </a:defRPr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pPr lvl="0"/>
            <a:r>
              <a:rPr lang="de-DE" dirty="0"/>
              <a:t>Click to </a:t>
            </a:r>
            <a:r>
              <a:rPr lang="de-DE" dirty="0" err="1"/>
              <a:t>add</a:t>
            </a:r>
            <a:r>
              <a:rPr lang="de-DE" dirty="0"/>
              <a:t> title</a:t>
            </a:r>
          </a:p>
        </p:txBody>
      </p:sp>
      <p:sp>
        <p:nvSpPr>
          <p:cNvPr id="2" name="Rectangle 1"/>
          <p:cNvSpPr/>
          <p:nvPr userDrawn="1"/>
        </p:nvSpPr>
        <p:spPr>
          <a:xfrm>
            <a:off x="143339" y="6237312"/>
            <a:ext cx="7680853" cy="5760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800">
              <a:solidFill>
                <a:srgbClr val="FFFFFF"/>
              </a:solidFill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1104000" y="4608000"/>
            <a:ext cx="5760000" cy="252000"/>
          </a:xfrm>
          <a:prstGeom prst="rect">
            <a:avLst/>
          </a:prstGeom>
        </p:spPr>
        <p:txBody>
          <a:bodyPr lIns="0" tIns="0" rIns="0" bIns="0"/>
          <a:lstStyle>
            <a:lvl1pPr marL="0" indent="0">
              <a:spcBef>
                <a:spcPts val="0"/>
              </a:spcBef>
              <a:buFontTx/>
              <a:buNone/>
              <a:defRPr sz="1800" b="1">
                <a:solidFill>
                  <a:schemeClr val="bg1"/>
                </a:solidFill>
              </a:defRPr>
            </a:lvl1pPr>
          </a:lstStyle>
          <a:p>
            <a:pPr lvl="0"/>
            <a:r>
              <a:rPr lang="de-DE" dirty="0"/>
              <a:t>_</a:t>
            </a:r>
            <a:r>
              <a:rPr lang="de-DE" dirty="0" err="1"/>
              <a:t>Author</a:t>
            </a:r>
            <a:endParaRPr lang="de-DE" dirty="0"/>
          </a:p>
        </p:txBody>
      </p:sp>
      <p:sp>
        <p:nvSpPr>
          <p:cNvPr id="16" name="Text Placeholder 3"/>
          <p:cNvSpPr>
            <a:spLocks noGrp="1"/>
          </p:cNvSpPr>
          <p:nvPr>
            <p:ph type="body" sz="quarter" idx="12" hasCustomPrompt="1"/>
          </p:nvPr>
        </p:nvSpPr>
        <p:spPr>
          <a:xfrm>
            <a:off x="1104000" y="4878000"/>
            <a:ext cx="5760000" cy="252000"/>
          </a:xfrm>
          <a:prstGeom prst="rect">
            <a:avLst/>
          </a:prstGeom>
        </p:spPr>
        <p:txBody>
          <a:bodyPr lIns="0" tIns="0" rIns="0" bIns="0"/>
          <a:lstStyle>
            <a:lvl1pPr marL="0" indent="0">
              <a:spcBef>
                <a:spcPts val="0"/>
              </a:spcBef>
              <a:buFontTx/>
              <a:buNone/>
              <a:defRPr sz="1600" b="0">
                <a:solidFill>
                  <a:schemeClr val="bg1"/>
                </a:solidFill>
              </a:defRPr>
            </a:lvl1pPr>
          </a:lstStyle>
          <a:p>
            <a:pPr lvl="0"/>
            <a:r>
              <a:rPr lang="de-DE" dirty="0"/>
              <a:t>_Sector</a:t>
            </a:r>
          </a:p>
        </p:txBody>
      </p:sp>
      <p:sp>
        <p:nvSpPr>
          <p:cNvPr id="18" name="Text Placeholder 3"/>
          <p:cNvSpPr>
            <a:spLocks noGrp="1"/>
          </p:cNvSpPr>
          <p:nvPr>
            <p:ph type="body" sz="quarter" idx="13" hasCustomPrompt="1"/>
          </p:nvPr>
        </p:nvSpPr>
        <p:spPr>
          <a:xfrm>
            <a:off x="1104000" y="5148000"/>
            <a:ext cx="5760000" cy="252000"/>
          </a:xfrm>
          <a:prstGeom prst="rect">
            <a:avLst/>
          </a:prstGeom>
        </p:spPr>
        <p:txBody>
          <a:bodyPr lIns="0" tIns="0" rIns="0" bIns="0"/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600" b="0">
                <a:solidFill>
                  <a:schemeClr val="bg1"/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dirty="0"/>
              <a:t>_</a:t>
            </a:r>
            <a:r>
              <a:rPr lang="en-US" sz="1600" dirty="0">
                <a:solidFill>
                  <a:srgbClr val="FFFFFF"/>
                </a:solidFill>
                <a:latin typeface="+mn-lt"/>
              </a:rPr>
              <a:t>November 01, 2013</a:t>
            </a:r>
          </a:p>
          <a:p>
            <a:pPr lvl="0"/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73421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Full bleed divider dark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ihandform 3"/>
          <p:cNvSpPr/>
          <p:nvPr userDrawn="1">
            <p:custDataLst>
              <p:tags r:id="rId1"/>
            </p:custDataLst>
          </p:nvPr>
        </p:nvSpPr>
        <p:spPr bwMode="auto">
          <a:xfrm>
            <a:off x="1" y="1"/>
            <a:ext cx="12192001" cy="6858001"/>
          </a:xfrm>
          <a:custGeom>
            <a:avLst/>
            <a:gdLst/>
            <a:ahLst/>
            <a:cxnLst/>
            <a:rect l="0" t="0" r="0" b="0"/>
            <a:pathLst>
              <a:path w="9144001" h="6858001">
                <a:moveTo>
                  <a:pt x="0" y="0"/>
                </a:moveTo>
                <a:lnTo>
                  <a:pt x="9144000" y="0"/>
                </a:lnTo>
                <a:lnTo>
                  <a:pt x="9144000" y="6858000"/>
                </a:lnTo>
                <a:lnTo>
                  <a:pt x="9144000" y="6858000"/>
                </a:lnTo>
                <a:lnTo>
                  <a:pt x="0" y="6858000"/>
                </a:lnTo>
                <a:close/>
              </a:path>
            </a:pathLst>
          </a:custGeom>
          <a:gradFill flip="none" rotWithShape="1">
            <a:gsLst>
              <a:gs pos="0">
                <a:srgbClr val="003478"/>
              </a:gs>
              <a:gs pos="100000">
                <a:srgbClr val="0089C4"/>
              </a:gs>
            </a:gsLst>
            <a:lin ang="2100000" scaled="1"/>
            <a:tileRect/>
          </a:gra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1240B29-F687-4F45-9708-019B960494DF}">
              <a14:hiddenLine xmlns:a14="http://schemas.microsoft.com/office/drawing/2010/main"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sz="200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5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1104899" y="2052000"/>
            <a:ext cx="9984000" cy="1620000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sz="4800">
                <a:solidFill>
                  <a:schemeClr val="bg1"/>
                </a:solidFill>
              </a:defRPr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pPr lvl="0"/>
            <a:r>
              <a:rPr lang="en-US" noProof="0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1884460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719403" y="450000"/>
            <a:ext cx="10753195" cy="1008000"/>
          </a:xfrm>
          <a:prstGeom prst="rect">
            <a:avLst/>
          </a:prstGeom>
        </p:spPr>
        <p:txBody>
          <a:bodyPr lIns="0" tIns="0" rIns="0" bIns="0">
            <a:noAutofit/>
          </a:bodyPr>
          <a:lstStyle>
            <a:lvl1pPr marL="0" indent="0" algn="l">
              <a:spcBef>
                <a:spcPts val="0"/>
              </a:spcBef>
              <a:buFontTx/>
              <a:buNone/>
              <a:defRPr sz="32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noProof="0" dirty="0"/>
              <a:t>Click to add title</a:t>
            </a:r>
          </a:p>
        </p:txBody>
      </p:sp>
      <p:sp>
        <p:nvSpPr>
          <p:cNvPr id="14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3292566" y="6493227"/>
            <a:ext cx="4287765" cy="144000"/>
          </a:xfrm>
          <a:prstGeom prst="rect">
            <a:avLst/>
          </a:prstGeom>
          <a:noFill/>
          <a:ln w="0">
            <a:noFill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txBody>
          <a:bodyPr vert="horz" wrap="square" lIns="0" tIns="0" rIns="0" bIns="0" rtlCol="0" anchor="t">
            <a:noAutofit/>
          </a:bodyPr>
          <a:lstStyle>
            <a:lvl1pPr>
              <a:defRPr lang="en-GB" sz="900">
                <a:solidFill>
                  <a:srgbClr val="000000"/>
                </a:solidFill>
                <a:latin typeface="Calibri"/>
              </a:defRPr>
            </a:lvl1pPr>
          </a:lstStyle>
          <a:p>
            <a:r>
              <a:rPr lang="en-US" dirty="0"/>
              <a:t> </a:t>
            </a:r>
          </a:p>
        </p:txBody>
      </p:sp>
      <p:sp>
        <p:nvSpPr>
          <p:cNvPr id="7" name="TextBox 6"/>
          <p:cNvSpPr txBox="1"/>
          <p:nvPr userDrawn="1"/>
        </p:nvSpPr>
        <p:spPr>
          <a:xfrm>
            <a:off x="313267" y="6472500"/>
            <a:ext cx="677333" cy="184150"/>
          </a:xfrm>
          <a:prstGeom prst="rect">
            <a:avLst/>
          </a:prstGeom>
        </p:spPr>
        <p:txBody>
          <a:bodyPr vert="horz" lIns="0" tIns="0" rIns="0" bIns="0" rtlCol="0" anchor="b"/>
          <a:lstStyle>
            <a:defPPr>
              <a:defRPr lang="de-DE"/>
            </a:defPPr>
            <a:lvl1pPr>
              <a:defRPr lang="en-US" sz="1200" smtClean="0"/>
            </a:lvl1pPr>
          </a:lstStyle>
          <a:p>
            <a:fld id="{C3A9D72B-53BE-4D95-9D29-99D7313A36B1}" type="slidenum">
              <a:rPr sz="1200">
                <a:solidFill>
                  <a:srgbClr val="000000"/>
                </a:solidFill>
              </a:rPr>
              <a:pPr/>
              <a:t>‹#›</a:t>
            </a:fld>
            <a:endParaRPr sz="1200" dirty="0">
              <a:solidFill>
                <a:srgbClr val="000000"/>
              </a:solidFill>
            </a:endParaRPr>
          </a:p>
        </p:txBody>
      </p:sp>
      <p:sp>
        <p:nvSpPr>
          <p:cNvPr id="8" name="TextBox 7"/>
          <p:cNvSpPr txBox="1"/>
          <p:nvPr userDrawn="1"/>
        </p:nvSpPr>
        <p:spPr>
          <a:xfrm>
            <a:off x="1104003" y="6508750"/>
            <a:ext cx="6048637" cy="139700"/>
          </a:xfrm>
          <a:prstGeom prst="rect">
            <a:avLst/>
          </a:prstGeom>
          <a:noFill/>
        </p:spPr>
        <p:txBody>
          <a:bodyPr wrap="square" lIns="0" tIns="0" rIns="0" bIns="0" rtlCol="0" anchor="b">
            <a:no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4164924076"/>
      </p:ext>
    </p:extLst>
  </p:cSld>
  <p:clrMapOvr>
    <a:masterClrMapping/>
  </p:clrMapOvr>
  <p:hf hd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719403" y="450000"/>
            <a:ext cx="10753195" cy="1008000"/>
          </a:xfrm>
          <a:prstGeom prst="rect">
            <a:avLst/>
          </a:prstGeom>
        </p:spPr>
        <p:txBody>
          <a:bodyPr lIns="0" tIns="0" rIns="0" bIns="0">
            <a:noAutofit/>
          </a:bodyPr>
          <a:lstStyle>
            <a:lvl1pPr marL="0" indent="0" algn="l">
              <a:spcBef>
                <a:spcPts val="0"/>
              </a:spcBef>
              <a:buFontTx/>
              <a:buNone/>
              <a:defRPr sz="32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noProof="0" dirty="0"/>
              <a:t>Click to add title</a:t>
            </a:r>
          </a:p>
        </p:txBody>
      </p:sp>
      <p:sp>
        <p:nvSpPr>
          <p:cNvPr id="7" name="TextBox 6"/>
          <p:cNvSpPr txBox="1"/>
          <p:nvPr userDrawn="1"/>
        </p:nvSpPr>
        <p:spPr>
          <a:xfrm>
            <a:off x="313267" y="6472500"/>
            <a:ext cx="677333" cy="184150"/>
          </a:xfrm>
          <a:prstGeom prst="rect">
            <a:avLst/>
          </a:prstGeom>
        </p:spPr>
        <p:txBody>
          <a:bodyPr vert="horz" lIns="0" tIns="0" rIns="0" bIns="0" rtlCol="0" anchor="b"/>
          <a:lstStyle>
            <a:defPPr>
              <a:defRPr lang="de-DE"/>
            </a:defPPr>
            <a:lvl1pPr>
              <a:defRPr lang="en-US" sz="1200" smtClean="0"/>
            </a:lvl1pPr>
          </a:lstStyle>
          <a:p>
            <a:fld id="{C3A9D72B-53BE-4D95-9D29-99D7313A36B1}" type="slidenum">
              <a:rPr sz="1200">
                <a:solidFill>
                  <a:srgbClr val="000000"/>
                </a:solidFill>
              </a:rPr>
              <a:pPr/>
              <a:t>‹#›</a:t>
            </a:fld>
            <a:endParaRPr sz="1200" dirty="0">
              <a:solidFill>
                <a:srgbClr val="000000"/>
              </a:solidFill>
            </a:endParaRPr>
          </a:p>
        </p:txBody>
      </p:sp>
      <p:sp>
        <p:nvSpPr>
          <p:cNvPr id="8" name="TextBox 7"/>
          <p:cNvSpPr txBox="1"/>
          <p:nvPr userDrawn="1"/>
        </p:nvSpPr>
        <p:spPr>
          <a:xfrm>
            <a:off x="1104003" y="6508750"/>
            <a:ext cx="6048637" cy="139700"/>
          </a:xfrm>
          <a:prstGeom prst="rect">
            <a:avLst/>
          </a:prstGeom>
          <a:noFill/>
        </p:spPr>
        <p:txBody>
          <a:bodyPr wrap="square" lIns="0" tIns="0" rIns="0" bIns="0" rtlCol="0" anchor="b">
            <a:no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819513292"/>
      </p:ext>
    </p:extLst>
  </p:cSld>
  <p:clrMapOvr>
    <a:masterClrMapping/>
  </p:clrMapOvr>
  <p:hf hdr="0" dt="0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Vertical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platzhalter 12"/>
          <p:cNvSpPr>
            <a:spLocks noGrp="1"/>
          </p:cNvSpPr>
          <p:nvPr>
            <p:ph type="body" sz="quarter" idx="11" hasCustomPrompt="1"/>
          </p:nvPr>
        </p:nvSpPr>
        <p:spPr>
          <a:xfrm>
            <a:off x="5328000" y="450000"/>
            <a:ext cx="6144597" cy="1034784"/>
          </a:xfrm>
          <a:prstGeom prst="rect">
            <a:avLst/>
          </a:prstGeom>
        </p:spPr>
        <p:txBody>
          <a:bodyPr lIns="0" tIns="0" rIns="0" bIns="0"/>
          <a:lstStyle>
            <a:lvl1pPr marL="0" indent="0">
              <a:spcBef>
                <a:spcPts val="0"/>
              </a:spcBef>
              <a:buFontTx/>
              <a:buNone/>
              <a:defRPr/>
            </a:lvl1pPr>
          </a:lstStyle>
          <a:p>
            <a:pPr lvl="0"/>
            <a:r>
              <a:rPr lang="en-US" noProof="0" dirty="0"/>
              <a:t>Click to add title</a:t>
            </a:r>
          </a:p>
        </p:txBody>
      </p:sp>
      <p:sp>
        <p:nvSpPr>
          <p:cNvPr id="9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5327915" y="1548000"/>
            <a:ext cx="6144683" cy="4617304"/>
          </a:xfrm>
          <a:prstGeom prst="rect">
            <a:avLst/>
          </a:prstGeom>
        </p:spPr>
        <p:txBody>
          <a:bodyPr lIns="0" tIns="0" rIns="0" bIns="0" spcCol="432000"/>
          <a:lstStyle>
            <a:lvl1pPr marL="216000" indent="-216000">
              <a:spcBef>
                <a:spcPts val="0"/>
              </a:spcBef>
              <a:defRPr sz="1800"/>
            </a:lvl1pPr>
            <a:lvl2pPr marL="432000" indent="-216000">
              <a:spcBef>
                <a:spcPts val="0"/>
              </a:spcBef>
              <a:defRPr sz="1800"/>
            </a:lvl2pPr>
            <a:lvl3pPr marL="648000" indent="-216000">
              <a:spcBef>
                <a:spcPts val="0"/>
              </a:spcBef>
              <a:buFont typeface="Wingdings" panose="05000000000000000000" pitchFamily="2" charset="2"/>
              <a:buChar char="§"/>
              <a:defRPr sz="1800"/>
            </a:lvl3pPr>
            <a:lvl4pPr marL="864000" indent="-216000">
              <a:spcBef>
                <a:spcPts val="0"/>
              </a:spcBef>
              <a:buFont typeface="Arial" panose="020B0604020202020204" pitchFamily="34" charset="0"/>
              <a:buChar char="•"/>
              <a:defRPr sz="1800"/>
            </a:lvl4pPr>
            <a:lvl5pPr marL="1080000" indent="-2286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5pPr>
            <a:lvl6pPr marL="1296000" indent="-2286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6pPr>
            <a:lvl7pPr marL="1512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7pPr>
            <a:lvl8pPr marL="1728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8pPr>
            <a:lvl9pPr marL="1944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9pPr>
          </a:lstStyle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  <a:endParaRPr lang="en-US" noProof="0" dirty="0"/>
          </a:p>
        </p:txBody>
      </p:sp>
      <p:sp>
        <p:nvSpPr>
          <p:cNvPr id="5" name="TextBox 4"/>
          <p:cNvSpPr txBox="1"/>
          <p:nvPr userDrawn="1"/>
        </p:nvSpPr>
        <p:spPr>
          <a:xfrm>
            <a:off x="1104003" y="6508750"/>
            <a:ext cx="6048637" cy="139700"/>
          </a:xfrm>
          <a:prstGeom prst="rect">
            <a:avLst/>
          </a:prstGeom>
          <a:noFill/>
        </p:spPr>
        <p:txBody>
          <a:bodyPr wrap="square" lIns="0" tIns="0" rIns="0" bIns="0" rtlCol="0" anchor="b">
            <a:no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Confidential</a:t>
            </a:r>
          </a:p>
        </p:txBody>
      </p:sp>
      <p:sp>
        <p:nvSpPr>
          <p:cNvPr id="6" name="TextBox 5"/>
          <p:cNvSpPr txBox="1"/>
          <p:nvPr userDrawn="1"/>
        </p:nvSpPr>
        <p:spPr>
          <a:xfrm>
            <a:off x="313267" y="6472500"/>
            <a:ext cx="677333" cy="184150"/>
          </a:xfrm>
          <a:prstGeom prst="rect">
            <a:avLst/>
          </a:prstGeom>
        </p:spPr>
        <p:txBody>
          <a:bodyPr vert="horz" lIns="0" tIns="0" rIns="0" bIns="0" rtlCol="0" anchor="b"/>
          <a:lstStyle>
            <a:defPPr>
              <a:defRPr lang="de-DE"/>
            </a:defPPr>
            <a:lvl1pPr>
              <a:defRPr lang="en-US" sz="1200" smtClean="0"/>
            </a:lvl1pPr>
          </a:lstStyle>
          <a:p>
            <a:fld id="{C3A9D72B-53BE-4D95-9D29-99D7313A36B1}" type="slidenum">
              <a:rPr sz="1200">
                <a:solidFill>
                  <a:srgbClr val="000000"/>
                </a:solidFill>
              </a:rPr>
              <a:pPr/>
              <a:t>‹#›</a:t>
            </a:fld>
            <a:endParaRPr sz="12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0404519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Standar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719403" y="450000"/>
            <a:ext cx="10753195" cy="1008000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noProof="0" dirty="0"/>
              <a:t>Click to add text</a:t>
            </a:r>
          </a:p>
          <a:p>
            <a:pPr lvl="0"/>
            <a:endParaRPr lang="en-US" noProof="0" dirty="0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719403" y="1548000"/>
            <a:ext cx="10753195" cy="4617304"/>
          </a:xfrm>
          <a:prstGeom prst="rect">
            <a:avLst/>
          </a:prstGeom>
        </p:spPr>
        <p:txBody>
          <a:bodyPr lIns="0" tIns="0" rIns="0" bIns="0" spcCol="432000"/>
          <a:lstStyle>
            <a:lvl1pPr marL="216000" indent="-216000">
              <a:spcBef>
                <a:spcPts val="0"/>
              </a:spcBef>
              <a:defRPr sz="1800"/>
            </a:lvl1pPr>
            <a:lvl2pPr marL="432000" indent="-216000">
              <a:spcBef>
                <a:spcPts val="0"/>
              </a:spcBef>
              <a:defRPr sz="1800"/>
            </a:lvl2pPr>
            <a:lvl3pPr marL="648000" indent="-216000">
              <a:spcBef>
                <a:spcPts val="0"/>
              </a:spcBef>
              <a:buFont typeface="Wingdings" panose="05000000000000000000" pitchFamily="2" charset="2"/>
              <a:buChar char="§"/>
              <a:defRPr sz="1800"/>
            </a:lvl3pPr>
            <a:lvl4pPr marL="864000" indent="-216000">
              <a:spcBef>
                <a:spcPts val="0"/>
              </a:spcBef>
              <a:buFont typeface="Arial" panose="020B0604020202020204" pitchFamily="34" charset="0"/>
              <a:buChar char="•"/>
              <a:defRPr sz="1800"/>
            </a:lvl4pPr>
            <a:lvl5pPr marL="1080000" indent="-2286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5pPr>
            <a:lvl6pPr marL="1296000" indent="-2286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6pPr>
            <a:lvl7pPr marL="1512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7pPr>
            <a:lvl8pPr marL="1728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8pPr>
            <a:lvl9pPr marL="1944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9pPr>
          </a:lstStyle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  <a:endParaRPr lang="en-US" noProof="0" dirty="0"/>
          </a:p>
        </p:txBody>
      </p:sp>
      <p:sp>
        <p:nvSpPr>
          <p:cNvPr id="6" name="TextBox 5"/>
          <p:cNvSpPr txBox="1"/>
          <p:nvPr userDrawn="1"/>
        </p:nvSpPr>
        <p:spPr>
          <a:xfrm>
            <a:off x="313267" y="6472500"/>
            <a:ext cx="677333" cy="184150"/>
          </a:xfrm>
          <a:prstGeom prst="rect">
            <a:avLst/>
          </a:prstGeom>
        </p:spPr>
        <p:txBody>
          <a:bodyPr vert="horz" lIns="0" tIns="0" rIns="0" bIns="0" rtlCol="0" anchor="b"/>
          <a:lstStyle>
            <a:defPPr>
              <a:defRPr lang="de-DE"/>
            </a:defPPr>
            <a:lvl1pPr>
              <a:defRPr lang="en-US" sz="1200" smtClean="0"/>
            </a:lvl1pPr>
          </a:lstStyle>
          <a:p>
            <a:fld id="{C3A9D72B-53BE-4D95-9D29-99D7313A36B1}" type="slidenum">
              <a:rPr sz="1200">
                <a:solidFill>
                  <a:srgbClr val="000000"/>
                </a:solidFill>
              </a:rPr>
              <a:pPr/>
              <a:t>‹#›</a:t>
            </a:fld>
            <a:endParaRPr sz="12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 userDrawn="1"/>
        </p:nvSpPr>
        <p:spPr>
          <a:xfrm>
            <a:off x="1104003" y="6508750"/>
            <a:ext cx="6048637" cy="139700"/>
          </a:xfrm>
          <a:prstGeom prst="rect">
            <a:avLst/>
          </a:prstGeom>
          <a:noFill/>
        </p:spPr>
        <p:txBody>
          <a:bodyPr wrap="square" lIns="0" tIns="0" rIns="0" bIns="0" rtlCol="0" anchor="b">
            <a:no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3177657845"/>
      </p:ext>
    </p:extLst>
  </p:cSld>
  <p:clrMapOvr>
    <a:masterClrMapping/>
  </p:clrMapOvr>
  <p:transition>
    <p:randomBar dir="vert"/>
  </p:transition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719403" y="450000"/>
            <a:ext cx="10753195" cy="1008000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noProof="0" dirty="0"/>
              <a:t>Click to add text</a:t>
            </a:r>
          </a:p>
          <a:p>
            <a:pPr lvl="0"/>
            <a:endParaRPr lang="en-US" noProof="0" dirty="0"/>
          </a:p>
        </p:txBody>
      </p:sp>
      <p:sp>
        <p:nvSpPr>
          <p:cNvPr id="4" name="Picture Placeholder 3"/>
          <p:cNvSpPr>
            <a:spLocks noGrp="1"/>
          </p:cNvSpPr>
          <p:nvPr>
            <p:ph type="pic" sz="quarter" idx="14"/>
          </p:nvPr>
        </p:nvSpPr>
        <p:spPr>
          <a:xfrm>
            <a:off x="719667" y="1557338"/>
            <a:ext cx="10752667" cy="460851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5" name="TextBox 4"/>
          <p:cNvSpPr txBox="1"/>
          <p:nvPr userDrawn="1"/>
        </p:nvSpPr>
        <p:spPr>
          <a:xfrm>
            <a:off x="313267" y="6472500"/>
            <a:ext cx="677333" cy="184150"/>
          </a:xfrm>
          <a:prstGeom prst="rect">
            <a:avLst/>
          </a:prstGeom>
        </p:spPr>
        <p:txBody>
          <a:bodyPr vert="horz" lIns="0" tIns="0" rIns="0" bIns="0" rtlCol="0" anchor="b"/>
          <a:lstStyle>
            <a:defPPr>
              <a:defRPr lang="de-DE"/>
            </a:defPPr>
            <a:lvl1pPr>
              <a:defRPr lang="en-US" sz="1200" smtClean="0"/>
            </a:lvl1pPr>
          </a:lstStyle>
          <a:p>
            <a:fld id="{C3A9D72B-53BE-4D95-9D29-99D7313A36B1}" type="slidenum">
              <a:rPr sz="1200">
                <a:solidFill>
                  <a:srgbClr val="000000"/>
                </a:solidFill>
              </a:rPr>
              <a:pPr/>
              <a:t>‹#›</a:t>
            </a:fld>
            <a:endParaRPr sz="1200" dirty="0">
              <a:solidFill>
                <a:srgbClr val="000000"/>
              </a:solidFill>
            </a:endParaRPr>
          </a:p>
        </p:txBody>
      </p:sp>
      <p:sp>
        <p:nvSpPr>
          <p:cNvPr id="6" name="TextBox 5"/>
          <p:cNvSpPr txBox="1"/>
          <p:nvPr userDrawn="1"/>
        </p:nvSpPr>
        <p:spPr>
          <a:xfrm>
            <a:off x="1104003" y="6508750"/>
            <a:ext cx="6048637" cy="139700"/>
          </a:xfrm>
          <a:prstGeom prst="rect">
            <a:avLst/>
          </a:prstGeom>
          <a:noFill/>
        </p:spPr>
        <p:txBody>
          <a:bodyPr wrap="square" lIns="0" tIns="0" rIns="0" bIns="0" rtlCol="0" anchor="b">
            <a:no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819012492"/>
      </p:ext>
    </p:extLst>
  </p:cSld>
  <p:clrMapOvr>
    <a:masterClrMapping/>
  </p:clrMapOvr>
  <p:transition>
    <p:randomBar dir="vert"/>
  </p:transition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Divider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1104899" y="2052000"/>
            <a:ext cx="9984000" cy="1620000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sz="4800">
                <a:solidFill>
                  <a:schemeClr val="tx1"/>
                </a:solidFill>
              </a:defRPr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pPr lvl="0"/>
            <a:r>
              <a:rPr lang="en-US" noProof="0" dirty="0"/>
              <a:t>Click to add title</a:t>
            </a:r>
          </a:p>
        </p:txBody>
      </p:sp>
      <p:sp>
        <p:nvSpPr>
          <p:cNvPr id="3" name="TextBox 2"/>
          <p:cNvSpPr txBox="1"/>
          <p:nvPr userDrawn="1"/>
        </p:nvSpPr>
        <p:spPr>
          <a:xfrm>
            <a:off x="313267" y="6472500"/>
            <a:ext cx="677333" cy="184150"/>
          </a:xfrm>
          <a:prstGeom prst="rect">
            <a:avLst/>
          </a:prstGeom>
        </p:spPr>
        <p:txBody>
          <a:bodyPr vert="horz" lIns="0" tIns="0" rIns="0" bIns="0" rtlCol="0" anchor="b"/>
          <a:lstStyle>
            <a:defPPr>
              <a:defRPr lang="de-DE"/>
            </a:defPPr>
            <a:lvl1pPr>
              <a:defRPr lang="en-US" sz="1200" smtClean="0"/>
            </a:lvl1pPr>
          </a:lstStyle>
          <a:p>
            <a:fld id="{C3A9D72B-53BE-4D95-9D29-99D7313A36B1}" type="slidenum">
              <a:rPr sz="1200">
                <a:solidFill>
                  <a:srgbClr val="000000"/>
                </a:solidFill>
              </a:rPr>
              <a:pPr/>
              <a:t>‹#›</a:t>
            </a:fld>
            <a:endParaRPr sz="1200" dirty="0">
              <a:solidFill>
                <a:srgbClr val="000000"/>
              </a:solidFill>
            </a:endParaRPr>
          </a:p>
        </p:txBody>
      </p:sp>
      <p:sp>
        <p:nvSpPr>
          <p:cNvPr id="5" name="TextBox 4"/>
          <p:cNvSpPr txBox="1"/>
          <p:nvPr userDrawn="1"/>
        </p:nvSpPr>
        <p:spPr>
          <a:xfrm>
            <a:off x="1104003" y="6508750"/>
            <a:ext cx="6048637" cy="139700"/>
          </a:xfrm>
          <a:prstGeom prst="rect">
            <a:avLst/>
          </a:prstGeom>
          <a:noFill/>
        </p:spPr>
        <p:txBody>
          <a:bodyPr wrap="square" lIns="0" tIns="0" rIns="0" bIns="0" rtlCol="0" anchor="b">
            <a:no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1492691412"/>
      </p:ext>
    </p:extLst>
  </p:cSld>
  <p:clrMapOvr>
    <a:masterClrMapping/>
  </p:clrMapOvr>
  <p:transition spd="slow">
    <p:fade/>
  </p:transition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5_Standar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719403" y="450000"/>
            <a:ext cx="10753195" cy="1008000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noProof="0" dirty="0"/>
              <a:t>Click to add text</a:t>
            </a:r>
          </a:p>
          <a:p>
            <a:pPr lvl="0"/>
            <a:endParaRPr lang="en-US" noProof="0" dirty="0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719403" y="1548000"/>
            <a:ext cx="10753195" cy="4617304"/>
          </a:xfrm>
          <a:prstGeom prst="rect">
            <a:avLst/>
          </a:prstGeom>
        </p:spPr>
        <p:txBody>
          <a:bodyPr lIns="0" tIns="0" rIns="0" bIns="0" spcCol="432000"/>
          <a:lstStyle>
            <a:lvl1pPr marL="215995" indent="-215995">
              <a:spcBef>
                <a:spcPts val="0"/>
              </a:spcBef>
              <a:defRPr sz="1800"/>
            </a:lvl1pPr>
            <a:lvl2pPr marL="431989" indent="-215995">
              <a:spcBef>
                <a:spcPts val="0"/>
              </a:spcBef>
              <a:defRPr sz="1800"/>
            </a:lvl2pPr>
            <a:lvl3pPr marL="647984" indent="-215995">
              <a:spcBef>
                <a:spcPts val="0"/>
              </a:spcBef>
              <a:buFont typeface="Wingdings" panose="05000000000000000000" pitchFamily="2" charset="2"/>
              <a:buChar char="§"/>
              <a:defRPr sz="1800"/>
            </a:lvl3pPr>
            <a:lvl4pPr marL="863978" indent="-215995">
              <a:spcBef>
                <a:spcPts val="0"/>
              </a:spcBef>
              <a:buFont typeface="Arial" panose="020B0604020202020204" pitchFamily="34" charset="0"/>
              <a:buChar char="•"/>
              <a:defRPr sz="1800"/>
            </a:lvl4pPr>
            <a:lvl5pPr marL="1079973" indent="-228594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5pPr>
            <a:lvl6pPr marL="1295968" indent="-228594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6pPr>
            <a:lvl7pPr marL="1511962" indent="-215995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7pPr>
            <a:lvl8pPr marL="1727957" indent="-215995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8pPr>
            <a:lvl9pPr marL="1943951" indent="-215995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9pPr>
          </a:lstStyle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  <a:endParaRPr lang="en-US" noProof="0" dirty="0"/>
          </a:p>
        </p:txBody>
      </p:sp>
    </p:spTree>
    <p:extLst>
      <p:ext uri="{BB962C8B-B14F-4D97-AF65-F5344CB8AC3E}">
        <p14:creationId xmlns:p14="http://schemas.microsoft.com/office/powerpoint/2010/main" val="63308352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light blue_emp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 userDrawn="1"/>
        </p:nvSpPr>
        <p:spPr>
          <a:xfrm>
            <a:off x="16436051" y="-1558724"/>
            <a:ext cx="1219200" cy="1219200"/>
          </a:xfrm>
          <a:prstGeom prst="rect">
            <a:avLst/>
          </a:prstGeom>
        </p:spPr>
        <p:txBody>
          <a:bodyPr vert="horz" wrap="square" lIns="0" tIns="0" rIns="0" bIns="0" spcCol="385658" rtlCol="0">
            <a:noAutofit/>
          </a:bodyPr>
          <a:lstStyle/>
          <a:p>
            <a:endParaRPr lang="en-US" sz="2400">
              <a:solidFill>
                <a:schemeClr val="bg1"/>
              </a:solidFill>
              <a:latin typeface="Calibri Light" charset="0"/>
              <a:ea typeface="Calibri Light" charset="0"/>
              <a:cs typeface="Calibri Light" charset="0"/>
            </a:endParaRPr>
          </a:p>
        </p:txBody>
      </p:sp>
      <p:sp>
        <p:nvSpPr>
          <p:cNvPr id="8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672680" y="516495"/>
            <a:ext cx="10084059" cy="1258291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lnSpc>
                <a:spcPct val="80000"/>
              </a:lnSpc>
              <a:spcBef>
                <a:spcPts val="0"/>
              </a:spcBef>
              <a:buFontTx/>
              <a:buNone/>
              <a:defRPr sz="3867" b="0" i="0">
                <a:solidFill>
                  <a:schemeClr val="bg1"/>
                </a:solidFill>
                <a:latin typeface="Calibri Light" charset="0"/>
                <a:ea typeface="Calibri Light" charset="0"/>
                <a:cs typeface="Calibri Light" charset="0"/>
              </a:defRPr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pPr lvl="0"/>
            <a:r>
              <a:rPr lang="en-US" noProof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20056898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End slide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8" name="Picture 5" descr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17471" y="2447783"/>
            <a:ext cx="1526004" cy="1943767"/>
          </a:xfrm>
          <a:prstGeom prst="rect">
            <a:avLst/>
          </a:prstGeom>
          <a:ln w="12700">
            <a:miter lim="400000"/>
          </a:ln>
        </p:spPr>
      </p:pic>
      <p:sp>
        <p:nvSpPr>
          <p:cNvPr id="509" name="幻灯片编号"/>
          <p:cNvSpPr txBox="1">
            <a:spLocks noGrp="1"/>
          </p:cNvSpPr>
          <p:nvPr>
            <p:ph type="sldNum" sz="quarter" idx="2"/>
          </p:nvPr>
        </p:nvSpPr>
        <p:spPr>
          <a:xfrm>
            <a:off x="8737600" y="6356350"/>
            <a:ext cx="2844800" cy="372535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075256383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ndar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1104000" y="828000"/>
            <a:ext cx="9984000" cy="512768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de-DE" dirty="0"/>
              <a:t>Click to add titl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quarter" idx="12" hasCustomPrompt="1"/>
          </p:nvPr>
        </p:nvSpPr>
        <p:spPr>
          <a:xfrm>
            <a:off x="1104000" y="1368000"/>
            <a:ext cx="9984000" cy="374400"/>
          </a:xfrm>
          <a:prstGeom prst="rect">
            <a:avLst/>
          </a:prstGeom>
        </p:spPr>
        <p:txBody>
          <a:bodyPr lIns="0" tIns="0" rIns="0" bIns="0"/>
          <a:lstStyle>
            <a:lvl1pPr marL="0" indent="0">
              <a:spcBef>
                <a:spcPts val="0"/>
              </a:spcBef>
              <a:buFontTx/>
              <a:buNone/>
              <a:defRPr sz="2200"/>
            </a:lvl1pPr>
          </a:lstStyle>
          <a:p>
            <a:pPr lvl="0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subtitle</a:t>
            </a:r>
            <a:endParaRPr lang="de-DE" dirty="0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1104897" y="2124000"/>
            <a:ext cx="9984000" cy="3960000"/>
          </a:xfrm>
          <a:prstGeom prst="rect">
            <a:avLst/>
          </a:prstGeom>
        </p:spPr>
        <p:txBody>
          <a:bodyPr lIns="0" tIns="0" rIns="0" bIns="0" spcCol="432000"/>
          <a:lstStyle>
            <a:lvl1pPr marL="216000" indent="-216000">
              <a:spcBef>
                <a:spcPts val="0"/>
              </a:spcBef>
              <a:defRPr sz="1800"/>
            </a:lvl1pPr>
            <a:lvl2pPr marL="432000" indent="-216000">
              <a:spcBef>
                <a:spcPts val="0"/>
              </a:spcBef>
              <a:defRPr sz="1800"/>
            </a:lvl2pPr>
            <a:lvl3pPr marL="648000" indent="-216000">
              <a:spcBef>
                <a:spcPts val="0"/>
              </a:spcBef>
              <a:buFont typeface="Wingdings" panose="05000000000000000000" pitchFamily="2" charset="2"/>
              <a:buChar char="§"/>
              <a:defRPr sz="1800"/>
            </a:lvl3pPr>
            <a:lvl4pPr marL="864000" indent="-216000">
              <a:spcBef>
                <a:spcPts val="0"/>
              </a:spcBef>
              <a:buFont typeface="Arial" panose="020B0604020202020204" pitchFamily="34" charset="0"/>
              <a:buChar char="•"/>
              <a:defRPr sz="1800"/>
            </a:lvl4pPr>
            <a:lvl5pPr marL="1080000" indent="-2286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5pPr>
            <a:lvl6pPr marL="1296000" indent="-2286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6pPr>
            <a:lvl7pPr marL="1512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7pPr>
            <a:lvl8pPr marL="1728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8pPr>
            <a:lvl9pPr marL="1944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6948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ertical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Inhaltsplatzhalter 6"/>
          <p:cNvSpPr>
            <a:spLocks noGrp="1"/>
          </p:cNvSpPr>
          <p:nvPr>
            <p:ph sz="half" idx="2" hasCustomPrompt="1"/>
            <p:custDataLst>
              <p:tags r:id="rId1"/>
            </p:custDataLst>
          </p:nvPr>
        </p:nvSpPr>
        <p:spPr>
          <a:xfrm>
            <a:off x="2" y="-1"/>
            <a:ext cx="4649724" cy="6858000"/>
          </a:xfrm>
          <a:prstGeom prst="rect">
            <a:avLst/>
          </a:prstGeom>
          <a:ln w="0">
            <a:noFill/>
          </a:ln>
          <a:effectLst/>
          <a:extLst>
            <a:ext uri="{91240B29-F687-4F45-9708-019B960494DF}">
              <a14:hiddenLine xmlns:a14="http://schemas.microsoft.com/office/drawing/2010/main" w="0">
                <a:solidFill>
                  <a:schemeClr val="tx1"/>
                </a:solidFill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 marL="0" indent="0">
              <a:buFontTx/>
              <a:buNone/>
              <a:defRPr sz="2200">
                <a:solidFill>
                  <a:schemeClr val="tx1"/>
                </a:solidFill>
              </a:defRPr>
            </a:lvl1pPr>
          </a:lstStyle>
          <a:p>
            <a:r>
              <a:rPr lang="de-DE" dirty="0" err="1">
                <a:solidFill>
                  <a:srgbClr val="FFFFFF"/>
                </a:solidFill>
              </a:rPr>
              <a:t>Choose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icon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to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add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image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13" name="Textplatzhalter 12"/>
          <p:cNvSpPr>
            <a:spLocks noGrp="1"/>
          </p:cNvSpPr>
          <p:nvPr>
            <p:ph type="body" sz="quarter" idx="11" hasCustomPrompt="1"/>
          </p:nvPr>
        </p:nvSpPr>
        <p:spPr>
          <a:xfrm>
            <a:off x="5328000" y="828000"/>
            <a:ext cx="5760000" cy="540006"/>
          </a:xfrm>
          <a:prstGeom prst="rect">
            <a:avLst/>
          </a:prstGeom>
        </p:spPr>
        <p:txBody>
          <a:bodyPr lIns="0" tIns="0" rIns="0" bIns="0"/>
          <a:lstStyle>
            <a:lvl1pPr marL="0" indent="0">
              <a:spcBef>
                <a:spcPts val="0"/>
              </a:spcBef>
              <a:buFontTx/>
              <a:buNone/>
              <a:defRPr/>
            </a:lvl1pPr>
          </a:lstStyle>
          <a:p>
            <a:pPr lvl="0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title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sz="quarter" idx="12" hasCustomPrompt="1"/>
          </p:nvPr>
        </p:nvSpPr>
        <p:spPr>
          <a:xfrm>
            <a:off x="5328000" y="1368000"/>
            <a:ext cx="5760000" cy="414054"/>
          </a:xfrm>
          <a:prstGeom prst="rect">
            <a:avLst/>
          </a:prstGeom>
        </p:spPr>
        <p:txBody>
          <a:bodyPr lIns="0" tIns="0" rIns="0" bIns="0"/>
          <a:lstStyle>
            <a:lvl1pPr marL="0" indent="0">
              <a:spcBef>
                <a:spcPts val="0"/>
              </a:spcBef>
              <a:buFontTx/>
              <a:buNone/>
              <a:defRPr sz="2200"/>
            </a:lvl1pPr>
          </a:lstStyle>
          <a:p>
            <a:pPr lvl="0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subtitle</a:t>
            </a:r>
            <a:endParaRPr lang="en-US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quarter" idx="13"/>
          </p:nvPr>
        </p:nvSpPr>
        <p:spPr>
          <a:xfrm>
            <a:off x="5328000" y="2123999"/>
            <a:ext cx="5760000" cy="3960000"/>
          </a:xfrm>
          <a:prstGeom prst="rect">
            <a:avLst/>
          </a:prstGeom>
        </p:spPr>
        <p:txBody>
          <a:bodyPr/>
          <a:lstStyle>
            <a:lvl1pPr marL="216000" indent="-216000">
              <a:spcBef>
                <a:spcPts val="0"/>
              </a:spcBef>
              <a:defRPr sz="1800"/>
            </a:lvl1pPr>
            <a:lvl2pPr marL="432000" indent="-216000">
              <a:spcBef>
                <a:spcPts val="0"/>
              </a:spcBef>
              <a:defRPr sz="1800"/>
            </a:lvl2pPr>
            <a:lvl3pPr marL="648000" indent="-216000">
              <a:spcBef>
                <a:spcPts val="0"/>
              </a:spcBef>
              <a:buFont typeface="Wingdings" panose="05000000000000000000" pitchFamily="2" charset="2"/>
              <a:buChar char="§"/>
              <a:defRPr sz="1800"/>
            </a:lvl3pPr>
            <a:lvl4pPr marL="864000" indent="-216000">
              <a:spcBef>
                <a:spcPts val="0"/>
              </a:spcBef>
              <a:buFont typeface="Arial" panose="020B0604020202020204" pitchFamily="34" charset="0"/>
              <a:buChar char="•"/>
              <a:defRPr sz="1800"/>
            </a:lvl4pPr>
            <a:lvl5pPr marL="1080000" indent="-216000">
              <a:spcBef>
                <a:spcPts val="0"/>
              </a:spcBef>
              <a:buFont typeface="Calibri" panose="020F0502020204030204" pitchFamily="34" charset="0"/>
              <a:buChar char="─"/>
              <a:defRPr sz="1800"/>
            </a:lvl5pPr>
            <a:lvl6pPr marL="1296000" indent="-216000">
              <a:spcBef>
                <a:spcPts val="0"/>
              </a:spcBef>
              <a:buFont typeface="Calibri" panose="020F0502020204030204" pitchFamily="34" charset="0"/>
              <a:buChar char="─"/>
              <a:defRPr/>
            </a:lvl6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3038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Horizontal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Inhaltsplatzhalter 6"/>
          <p:cNvSpPr>
            <a:spLocks noGrp="1"/>
          </p:cNvSpPr>
          <p:nvPr>
            <p:ph sz="half" idx="2" hasCustomPrompt="1"/>
            <p:custDataLst>
              <p:tags r:id="rId1"/>
            </p:custDataLst>
          </p:nvPr>
        </p:nvSpPr>
        <p:spPr>
          <a:xfrm>
            <a:off x="1" y="2123999"/>
            <a:ext cx="7541260" cy="3960000"/>
          </a:xfrm>
          <a:prstGeom prst="rect">
            <a:avLst/>
          </a:prstGeom>
          <a:ln w="0">
            <a:noFill/>
          </a:ln>
          <a:effectLst/>
          <a:extLst>
            <a:ext uri="{91240B29-F687-4F45-9708-019B960494DF}">
              <a14:hiddenLine xmlns:a14="http://schemas.microsoft.com/office/drawing/2010/main" w="0">
                <a:solidFill>
                  <a:schemeClr val="tx1"/>
                </a:solidFill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 marL="0" indent="0">
              <a:buFontTx/>
              <a:buNone/>
              <a:defRPr sz="2200">
                <a:solidFill>
                  <a:schemeClr val="tx1"/>
                </a:solidFill>
              </a:defRPr>
            </a:lvl1pPr>
          </a:lstStyle>
          <a:p>
            <a:r>
              <a:rPr lang="de-DE" dirty="0" err="1">
                <a:solidFill>
                  <a:srgbClr val="FFFFFF"/>
                </a:solidFill>
              </a:rPr>
              <a:t>Choose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icon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to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add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image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7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1104000" y="828000"/>
            <a:ext cx="9984000" cy="512768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de-DE" dirty="0"/>
              <a:t>Click to add title</a:t>
            </a:r>
          </a:p>
        </p:txBody>
      </p:sp>
      <p:sp>
        <p:nvSpPr>
          <p:cNvPr id="12" name="Textplatzhalter 3"/>
          <p:cNvSpPr>
            <a:spLocks noGrp="1"/>
          </p:cNvSpPr>
          <p:nvPr>
            <p:ph type="body" sz="quarter" idx="12" hasCustomPrompt="1"/>
          </p:nvPr>
        </p:nvSpPr>
        <p:spPr>
          <a:xfrm>
            <a:off x="1104000" y="1368000"/>
            <a:ext cx="9984000" cy="374400"/>
          </a:xfrm>
          <a:prstGeom prst="rect">
            <a:avLst/>
          </a:prstGeom>
        </p:spPr>
        <p:txBody>
          <a:bodyPr lIns="0" tIns="0" rIns="0" bIns="0"/>
          <a:lstStyle>
            <a:lvl1pPr marL="0" indent="0">
              <a:spcBef>
                <a:spcPts val="0"/>
              </a:spcBef>
              <a:buFontTx/>
              <a:buNone/>
              <a:defRPr sz="2200"/>
            </a:lvl1pPr>
          </a:lstStyle>
          <a:p>
            <a:pPr lvl="0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subtitle</a:t>
            </a:r>
            <a:endParaRPr lang="de-DE" dirty="0"/>
          </a:p>
        </p:txBody>
      </p:sp>
      <p:sp>
        <p:nvSpPr>
          <p:cNvPr id="9" name="Textplatzhalter 2"/>
          <p:cNvSpPr>
            <a:spLocks noGrp="1"/>
          </p:cNvSpPr>
          <p:nvPr>
            <p:ph type="body" sz="quarter" idx="14" hasCustomPrompt="1"/>
          </p:nvPr>
        </p:nvSpPr>
        <p:spPr>
          <a:xfrm>
            <a:off x="7872000" y="2124000"/>
            <a:ext cx="3216000" cy="3960000"/>
          </a:xfrm>
          <a:prstGeom prst="rect">
            <a:avLst/>
          </a:prstGeom>
        </p:spPr>
        <p:txBody>
          <a:bodyPr lIns="0" tIns="0" rIns="0" bIns="0"/>
          <a:lstStyle>
            <a:lvl1pPr marL="180000" indent="-180000">
              <a:spcBef>
                <a:spcPts val="0"/>
              </a:spcBef>
              <a:defRPr sz="1600" baseline="0"/>
            </a:lvl1pPr>
            <a:lvl2pPr marL="360000" indent="-180000">
              <a:spcBef>
                <a:spcPts val="0"/>
              </a:spcBef>
              <a:defRPr sz="1600"/>
            </a:lvl2pPr>
            <a:lvl3pPr marL="540000" indent="-180000">
              <a:spcBef>
                <a:spcPts val="0"/>
              </a:spcBef>
              <a:buFont typeface="Wingdings" panose="05000000000000000000" pitchFamily="2" charset="2"/>
              <a:buChar char="§"/>
              <a:defRPr sz="1600"/>
            </a:lvl3pPr>
            <a:lvl4pPr marL="720000" indent="-180000" algn="l" defTabSz="914400" rtl="0" eaLnBrk="1" latinLnBrk="0" hangingPunct="1">
              <a:spcBef>
                <a:spcPts val="0"/>
              </a:spcBef>
              <a:buFont typeface="Arial" panose="020B0604020202020204" pitchFamily="34" charset="0"/>
              <a:buChar char="•"/>
              <a:defRPr lang="de-DE" sz="16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90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5pPr>
            <a:lvl6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6pPr>
            <a:lvl7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7pPr>
            <a:lvl8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8pPr>
            <a:lvl9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9pPr>
          </a:lstStyle>
          <a:p>
            <a:pPr lvl="0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text</a:t>
            </a:r>
            <a:endParaRPr lang="de-DE" dirty="0"/>
          </a:p>
          <a:p>
            <a:pPr lvl="1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text</a:t>
            </a:r>
            <a:endParaRPr lang="de-DE" dirty="0"/>
          </a:p>
          <a:p>
            <a:pPr lvl="2"/>
            <a:r>
              <a:rPr lang="de-DE" sz="1600" dirty="0"/>
              <a:t>Click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add</a:t>
            </a:r>
            <a:r>
              <a:rPr lang="de-DE" sz="1600" dirty="0"/>
              <a:t> </a:t>
            </a:r>
            <a:r>
              <a:rPr lang="de-DE" sz="1600" dirty="0" err="1"/>
              <a:t>text</a:t>
            </a:r>
            <a:endParaRPr lang="de-DE" sz="1600" dirty="0"/>
          </a:p>
          <a:p>
            <a:pPr lvl="3"/>
            <a:r>
              <a:rPr lang="de-DE" sz="1600" dirty="0"/>
              <a:t>Click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add</a:t>
            </a:r>
            <a:r>
              <a:rPr lang="de-DE" sz="1600" dirty="0"/>
              <a:t> </a:t>
            </a:r>
            <a:r>
              <a:rPr lang="de-DE" sz="1600" dirty="0" err="1"/>
              <a:t>text</a:t>
            </a:r>
            <a:endParaRPr lang="de-DE" sz="1600" dirty="0"/>
          </a:p>
          <a:p>
            <a:pPr lvl="4"/>
            <a:r>
              <a:rPr lang="de-DE" sz="1600" dirty="0"/>
              <a:t>Click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add</a:t>
            </a:r>
            <a:r>
              <a:rPr lang="de-DE" sz="1600" dirty="0"/>
              <a:t> </a:t>
            </a:r>
            <a:r>
              <a:rPr lang="de-DE" sz="1600" dirty="0" err="1"/>
              <a:t>text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2052499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-column imag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Inhaltsplatzhalter 13"/>
          <p:cNvSpPr>
            <a:spLocks noGrp="1"/>
          </p:cNvSpPr>
          <p:nvPr>
            <p:ph sz="quarter" idx="2" hasCustomPrompt="1"/>
            <p:custDataLst>
              <p:tags r:id="rId1"/>
            </p:custDataLst>
          </p:nvPr>
        </p:nvSpPr>
        <p:spPr>
          <a:xfrm>
            <a:off x="6384005" y="2123999"/>
            <a:ext cx="4703996" cy="2627998"/>
          </a:xfrm>
          <a:prstGeom prst="rect">
            <a:avLst/>
          </a:prstGeom>
          <a:ln w="0">
            <a:noFill/>
          </a:ln>
          <a:effectLst/>
          <a:extLst>
            <a:ext uri="{91240B29-F687-4F45-9708-019B960494DF}">
              <a14:hiddenLine xmlns:a14="http://schemas.microsoft.com/office/drawing/2010/main" w="0">
                <a:solidFill>
                  <a:schemeClr val="tx1"/>
                </a:solidFill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 marL="0" indent="0">
              <a:buFontTx/>
              <a:buNone/>
              <a:defRPr sz="2200"/>
            </a:lvl1pPr>
          </a:lstStyle>
          <a:p>
            <a:r>
              <a:rPr lang="de-DE" dirty="0" err="1">
                <a:solidFill>
                  <a:srgbClr val="FFFFFF"/>
                </a:solidFill>
              </a:rPr>
              <a:t>Choose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icon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to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add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image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12" name="Inhaltsplatzhalter 14"/>
          <p:cNvSpPr>
            <a:spLocks noGrp="1"/>
          </p:cNvSpPr>
          <p:nvPr>
            <p:ph sz="quarter" idx="1" hasCustomPrompt="1"/>
            <p:custDataLst>
              <p:tags r:id="rId2"/>
            </p:custDataLst>
          </p:nvPr>
        </p:nvSpPr>
        <p:spPr>
          <a:xfrm>
            <a:off x="1104005" y="2123999"/>
            <a:ext cx="4703996" cy="2627998"/>
          </a:xfrm>
          <a:prstGeom prst="rect">
            <a:avLst/>
          </a:prstGeom>
          <a:ln w="0">
            <a:noFill/>
          </a:ln>
          <a:effectLst/>
          <a:extLst>
            <a:ext uri="{91240B29-F687-4F45-9708-019B960494DF}">
              <a14:hiddenLine xmlns:a14="http://schemas.microsoft.com/office/drawing/2010/main" w="0">
                <a:solidFill>
                  <a:schemeClr val="tx1"/>
                </a:solidFill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 marL="0" indent="0">
              <a:buFontTx/>
              <a:buNone/>
              <a:defRPr sz="2200"/>
            </a:lvl1pPr>
          </a:lstStyle>
          <a:p>
            <a:r>
              <a:rPr lang="de-DE" dirty="0" err="1">
                <a:solidFill>
                  <a:srgbClr val="FFFFFF"/>
                </a:solidFill>
              </a:rPr>
              <a:t>Choose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icon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to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add</a:t>
            </a:r>
            <a:r>
              <a:rPr lang="de-DE" dirty="0">
                <a:solidFill>
                  <a:srgbClr val="FFFFFF"/>
                </a:solidFill>
              </a:rPr>
              <a:t> </a:t>
            </a:r>
            <a:r>
              <a:rPr lang="de-DE" dirty="0" err="1">
                <a:solidFill>
                  <a:srgbClr val="FFFFFF"/>
                </a:solidFill>
              </a:rPr>
              <a:t>image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14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1104000" y="828000"/>
            <a:ext cx="9984000" cy="512768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de-DE" dirty="0"/>
              <a:t>Click to add title</a:t>
            </a:r>
          </a:p>
        </p:txBody>
      </p:sp>
      <p:sp>
        <p:nvSpPr>
          <p:cNvPr id="15" name="Textplatzhalter 3"/>
          <p:cNvSpPr>
            <a:spLocks noGrp="1"/>
          </p:cNvSpPr>
          <p:nvPr>
            <p:ph type="body" sz="quarter" idx="12" hasCustomPrompt="1"/>
          </p:nvPr>
        </p:nvSpPr>
        <p:spPr>
          <a:xfrm>
            <a:off x="1104000" y="1368000"/>
            <a:ext cx="9984000" cy="374400"/>
          </a:xfrm>
          <a:prstGeom prst="rect">
            <a:avLst/>
          </a:prstGeom>
        </p:spPr>
        <p:txBody>
          <a:bodyPr lIns="0" tIns="0" rIns="0" bIns="0"/>
          <a:lstStyle>
            <a:lvl1pPr marL="0" indent="0">
              <a:spcBef>
                <a:spcPts val="0"/>
              </a:spcBef>
              <a:buFontTx/>
              <a:buNone/>
              <a:defRPr sz="2200"/>
            </a:lvl1pPr>
          </a:lstStyle>
          <a:p>
            <a:pPr lvl="0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subtitle</a:t>
            </a:r>
            <a:endParaRPr lang="de-DE" dirty="0"/>
          </a:p>
        </p:txBody>
      </p:sp>
      <p:sp>
        <p:nvSpPr>
          <p:cNvPr id="3" name="Textplatzhalter 2"/>
          <p:cNvSpPr>
            <a:spLocks noGrp="1"/>
          </p:cNvSpPr>
          <p:nvPr>
            <p:ph type="body" sz="quarter" idx="13" hasCustomPrompt="1"/>
          </p:nvPr>
        </p:nvSpPr>
        <p:spPr>
          <a:xfrm>
            <a:off x="1104899" y="5004000"/>
            <a:ext cx="4704000" cy="1116000"/>
          </a:xfrm>
          <a:prstGeom prst="rect">
            <a:avLst/>
          </a:prstGeom>
        </p:spPr>
        <p:txBody>
          <a:bodyPr lIns="0" tIns="0" rIns="0" bIns="0"/>
          <a:lstStyle>
            <a:lvl1pPr marL="180000" indent="-180000">
              <a:spcBef>
                <a:spcPts val="0"/>
              </a:spcBef>
              <a:defRPr sz="1600" baseline="0"/>
            </a:lvl1pPr>
            <a:lvl2pPr marL="360000" indent="-180000">
              <a:spcBef>
                <a:spcPts val="0"/>
              </a:spcBef>
              <a:defRPr sz="1600"/>
            </a:lvl2pPr>
            <a:lvl3pPr marL="540000" indent="-180000">
              <a:spcBef>
                <a:spcPts val="0"/>
              </a:spcBef>
              <a:buFont typeface="Wingdings" panose="05000000000000000000" pitchFamily="2" charset="2"/>
              <a:buChar char="§"/>
              <a:defRPr sz="1600"/>
            </a:lvl3pPr>
            <a:lvl4pPr marL="720000" indent="-180000" algn="l" defTabSz="914400" rtl="0" eaLnBrk="1" latinLnBrk="0" hangingPunct="1">
              <a:spcBef>
                <a:spcPts val="0"/>
              </a:spcBef>
              <a:buFont typeface="Arial" panose="020B0604020202020204" pitchFamily="34" charset="0"/>
              <a:buChar char="•"/>
              <a:defRPr lang="de-DE" sz="16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90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5pPr>
            <a:lvl6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6pPr>
            <a:lvl7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7pPr>
            <a:lvl8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8pPr>
            <a:lvl9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9pPr>
          </a:lstStyle>
          <a:p>
            <a:pPr lvl="0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text</a:t>
            </a:r>
            <a:endParaRPr lang="de-DE" dirty="0"/>
          </a:p>
          <a:p>
            <a:pPr lvl="1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text</a:t>
            </a:r>
            <a:endParaRPr lang="de-DE" dirty="0"/>
          </a:p>
          <a:p>
            <a:pPr lvl="2"/>
            <a:r>
              <a:rPr lang="de-DE" sz="1600" dirty="0"/>
              <a:t>Click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add</a:t>
            </a:r>
            <a:r>
              <a:rPr lang="de-DE" sz="1600" dirty="0"/>
              <a:t> </a:t>
            </a:r>
            <a:r>
              <a:rPr lang="de-DE" sz="1600" dirty="0" err="1"/>
              <a:t>text</a:t>
            </a:r>
            <a:endParaRPr lang="de-DE" sz="1600" dirty="0"/>
          </a:p>
          <a:p>
            <a:pPr lvl="3"/>
            <a:r>
              <a:rPr lang="de-DE" sz="1600" dirty="0"/>
              <a:t>Click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add</a:t>
            </a:r>
            <a:r>
              <a:rPr lang="de-DE" sz="1600" dirty="0"/>
              <a:t> </a:t>
            </a:r>
            <a:r>
              <a:rPr lang="de-DE" sz="1600" dirty="0" err="1"/>
              <a:t>text</a:t>
            </a:r>
            <a:endParaRPr lang="de-DE" sz="1600" dirty="0"/>
          </a:p>
          <a:p>
            <a:pPr lvl="4"/>
            <a:endParaRPr lang="de-DE" sz="1600" dirty="0"/>
          </a:p>
        </p:txBody>
      </p:sp>
      <p:sp>
        <p:nvSpPr>
          <p:cNvPr id="9" name="Textplatzhalter 2"/>
          <p:cNvSpPr>
            <a:spLocks noGrp="1"/>
          </p:cNvSpPr>
          <p:nvPr>
            <p:ph type="body" sz="quarter" idx="14" hasCustomPrompt="1"/>
          </p:nvPr>
        </p:nvSpPr>
        <p:spPr>
          <a:xfrm>
            <a:off x="6384000" y="5004000"/>
            <a:ext cx="4704000" cy="1116000"/>
          </a:xfrm>
          <a:prstGeom prst="rect">
            <a:avLst/>
          </a:prstGeom>
        </p:spPr>
        <p:txBody>
          <a:bodyPr lIns="0" tIns="0" rIns="0" bIns="0"/>
          <a:lstStyle>
            <a:lvl1pPr marL="180000" indent="-180000">
              <a:spcBef>
                <a:spcPts val="0"/>
              </a:spcBef>
              <a:defRPr sz="1600" baseline="0"/>
            </a:lvl1pPr>
            <a:lvl2pPr marL="360000" indent="-180000">
              <a:spcBef>
                <a:spcPts val="0"/>
              </a:spcBef>
              <a:defRPr sz="1600"/>
            </a:lvl2pPr>
            <a:lvl3pPr marL="540000" indent="-180000">
              <a:spcBef>
                <a:spcPts val="0"/>
              </a:spcBef>
              <a:buFont typeface="Wingdings" panose="05000000000000000000" pitchFamily="2" charset="2"/>
              <a:buChar char="§"/>
              <a:defRPr sz="1600"/>
            </a:lvl3pPr>
            <a:lvl4pPr marL="720000" indent="-180000" algn="l" defTabSz="914400" rtl="0" eaLnBrk="1" latinLnBrk="0" hangingPunct="1">
              <a:spcBef>
                <a:spcPts val="0"/>
              </a:spcBef>
              <a:buFont typeface="Arial" panose="020B0604020202020204" pitchFamily="34" charset="0"/>
              <a:buChar char="•"/>
              <a:defRPr lang="de-DE" sz="16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90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5pPr>
            <a:lvl6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6pPr>
            <a:lvl7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7pPr>
            <a:lvl8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8pPr>
            <a:lvl9pPr marL="360000" indent="-180000">
              <a:spcBef>
                <a:spcPts val="0"/>
              </a:spcBef>
              <a:buFont typeface="Calibri" panose="020F0502020204030204" pitchFamily="34" charset="0"/>
              <a:buChar char="─"/>
              <a:defRPr sz="1600"/>
            </a:lvl9pPr>
          </a:lstStyle>
          <a:p>
            <a:pPr lvl="0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text</a:t>
            </a:r>
            <a:endParaRPr lang="de-DE" dirty="0"/>
          </a:p>
          <a:p>
            <a:pPr lvl="1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text</a:t>
            </a:r>
            <a:endParaRPr lang="de-DE" dirty="0"/>
          </a:p>
          <a:p>
            <a:pPr lvl="2"/>
            <a:r>
              <a:rPr lang="de-DE" sz="1600" dirty="0"/>
              <a:t>Click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add</a:t>
            </a:r>
            <a:r>
              <a:rPr lang="de-DE" sz="1600" dirty="0"/>
              <a:t> </a:t>
            </a:r>
            <a:r>
              <a:rPr lang="de-DE" sz="1600" dirty="0" err="1"/>
              <a:t>text</a:t>
            </a:r>
            <a:endParaRPr lang="de-DE" sz="1600" dirty="0"/>
          </a:p>
          <a:p>
            <a:pPr lvl="3"/>
            <a:r>
              <a:rPr lang="de-DE" sz="1600" dirty="0"/>
              <a:t>Click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add</a:t>
            </a:r>
            <a:r>
              <a:rPr lang="de-DE" sz="1600" dirty="0"/>
              <a:t> </a:t>
            </a:r>
            <a:r>
              <a:rPr lang="de-DE" sz="1600" dirty="0" err="1"/>
              <a:t>text</a:t>
            </a:r>
            <a:endParaRPr lang="de-DE" sz="1600" dirty="0"/>
          </a:p>
          <a:p>
            <a:pPr lvl="4"/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3298969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vider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1104899" y="2052000"/>
            <a:ext cx="9984000" cy="1620000"/>
          </a:xfrm>
          <a:prstGeom prst="rect">
            <a:avLst/>
          </a:prstGeom>
        </p:spPr>
        <p:txBody>
          <a:bodyPr lIns="0" tIns="0" rIns="0" bIns="0"/>
          <a:lstStyle>
            <a:lvl1pPr marL="0" indent="0" algn="l">
              <a:spcBef>
                <a:spcPts val="0"/>
              </a:spcBef>
              <a:buFontTx/>
              <a:buNone/>
              <a:defRPr sz="4800">
                <a:solidFill>
                  <a:schemeClr val="tx1"/>
                </a:solidFill>
              </a:defRPr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pPr lvl="0"/>
            <a:r>
              <a:rPr lang="de-DE" dirty="0"/>
              <a:t>Click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add</a:t>
            </a:r>
            <a:r>
              <a:rPr lang="de-DE" dirty="0"/>
              <a:t> title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1" hasCustomPrompt="1"/>
          </p:nvPr>
        </p:nvSpPr>
        <p:spPr>
          <a:xfrm>
            <a:off x="1104900" y="1368000"/>
            <a:ext cx="9984317" cy="404816"/>
          </a:xfrm>
          <a:prstGeom prst="rect">
            <a:avLst/>
          </a:prstGeom>
        </p:spPr>
        <p:txBody>
          <a:bodyPr lIns="0" tIns="0" rIns="0" bIns="0"/>
          <a:lstStyle>
            <a:lvl1pPr marL="0" indent="0">
              <a:spcBef>
                <a:spcPts val="0"/>
              </a:spcBef>
              <a:buFontTx/>
              <a:buNone/>
              <a:defRPr sz="2000">
                <a:solidFill>
                  <a:schemeClr val="tx1"/>
                </a:solidFill>
              </a:defRPr>
            </a:lvl1pPr>
          </a:lstStyle>
          <a:p>
            <a:pPr lvl="0"/>
            <a:r>
              <a:rPr lang="de-DE" dirty="0"/>
              <a:t>Click to </a:t>
            </a:r>
            <a:r>
              <a:rPr lang="de-DE" dirty="0" err="1"/>
              <a:t>add</a:t>
            </a:r>
            <a:r>
              <a:rPr lang="de-DE" dirty="0"/>
              <a:t> </a:t>
            </a:r>
            <a:r>
              <a:rPr lang="de-DE" dirty="0" err="1"/>
              <a:t>section</a:t>
            </a:r>
            <a:r>
              <a:rPr lang="de-DE" dirty="0"/>
              <a:t> </a:t>
            </a:r>
            <a:r>
              <a:rPr lang="de-DE" dirty="0" err="1"/>
              <a:t>number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41160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reeform 9"/>
          <p:cNvSpPr/>
          <p:nvPr userDrawn="1">
            <p:custDataLst>
              <p:tags r:id="rId1"/>
            </p:custDataLst>
          </p:nvPr>
        </p:nvSpPr>
        <p:spPr bwMode="auto">
          <a:xfrm>
            <a:off x="1" y="1"/>
            <a:ext cx="12192001" cy="6858001"/>
          </a:xfrm>
          <a:custGeom>
            <a:avLst/>
            <a:gdLst/>
            <a:ahLst/>
            <a:cxnLst/>
            <a:rect l="0" t="0" r="0" b="0"/>
            <a:pathLst>
              <a:path w="9144001" h="6858001">
                <a:moveTo>
                  <a:pt x="0" y="0"/>
                </a:moveTo>
                <a:lnTo>
                  <a:pt x="9144000" y="0"/>
                </a:lnTo>
                <a:lnTo>
                  <a:pt x="9144000" y="6858000"/>
                </a:lnTo>
                <a:lnTo>
                  <a:pt x="9144000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sz="2000">
              <a:solidFill>
                <a:srgbClr val="000000"/>
              </a:solidFill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3926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04003" y="2052004"/>
            <a:ext cx="9983995" cy="1619999"/>
          </a:xfrm>
          <a:prstGeom prst="rect">
            <a:avLst/>
          </a:prstGeo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 anchor="t"/>
          <a:lstStyle>
            <a:lvl1pPr algn="l" rtl="0" eaLnBrk="1" fontAlgn="base" hangingPunct="1">
              <a:spcBef>
                <a:spcPts val="0"/>
              </a:spcBef>
              <a:spcAft>
                <a:spcPts val="0"/>
              </a:spcAft>
              <a:buNone/>
              <a:defRPr sz="480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 hidden="1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00667" y="6350000"/>
            <a:ext cx="1016000" cy="139700"/>
          </a:xfrm>
          <a:prstGeom prst="rect">
            <a:avLst/>
          </a:prstGeo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 marL="285750" indent="-285750" algn="l" rtl="0" eaLnBrk="1" fontAlgn="base" hangingPunct="1">
              <a:spcBef>
                <a:spcPct val="0"/>
              </a:spcBef>
              <a:spcAft>
                <a:spcPct val="0"/>
              </a:spcAft>
              <a:buClrTx/>
              <a:buSzPct val="100000"/>
              <a:buFont typeface="Calibri" panose="020F0502020204030204" pitchFamily="34" charset="0"/>
              <a:buNone/>
              <a:defRPr sz="1800" b="0" i="0" u="none">
                <a:solidFill>
                  <a:srgbClr val="FFFFFF"/>
                </a:solidFill>
                <a:latin typeface="Calibri" panose="020F050202020403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Footer Placeholder 3" hidden="1"/>
          <p:cNvSpPr>
            <a:spLocks noGrp="1"/>
          </p:cNvSpPr>
          <p:nvPr>
            <p:ph type="ftr" sz="quarter" idx="10"/>
            <p:custDataLst>
              <p:tags r:id="rId3"/>
            </p:custDataLst>
          </p:nvPr>
        </p:nvSpPr>
        <p:spPr>
          <a:xfrm>
            <a:off x="1100667" y="6502400"/>
            <a:ext cx="1016000" cy="139700"/>
          </a:xfrm>
          <a:prstGeom prst="rect">
            <a:avLst/>
          </a:prstGeo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 anchor="b"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 hidden="1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>
          <a:xfrm>
            <a:off x="279400" y="6464300"/>
            <a:ext cx="677333" cy="184150"/>
          </a:xfrm>
          <a:prstGeom prst="rect">
            <a:avLst/>
          </a:prstGeo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9F38A5C-8A05-40D4-A056-C048A3AB7F39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Date Placeholder 6" hidden="1"/>
          <p:cNvSpPr>
            <a:spLocks noGrp="1"/>
          </p:cNvSpPr>
          <p:nvPr>
            <p:ph type="dt" sz="half" idx="13"/>
            <p:custDataLst>
              <p:tags r:id="rId5"/>
            </p:custDataLst>
          </p:nvPr>
        </p:nvSpPr>
        <p:spPr>
          <a:xfrm>
            <a:off x="2116667" y="6502400"/>
            <a:ext cx="5249333" cy="139700"/>
          </a:xfrm>
          <a:prstGeom prst="rect">
            <a:avLst/>
          </a:prstGeo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423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27051" y="565150"/>
            <a:ext cx="11137900" cy="776288"/>
          </a:xfrm>
          <a:prstGeom prst="rect">
            <a:avLst/>
          </a:prstGeom>
        </p:spPr>
        <p:txBody>
          <a:bodyPr/>
          <a:lstStyle/>
          <a:p>
            <a:r>
              <a:rPr lang="en-US" noProof="0" dirty="0"/>
              <a:t>Main title in 28pt – subtitle in 20pt italic blue</a:t>
            </a:r>
            <a:endParaRPr lang="en-US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313267" y="6472500"/>
            <a:ext cx="677333" cy="184150"/>
          </a:xfrm>
          <a:prstGeom prst="rect">
            <a:avLst/>
          </a:prstGeom>
        </p:spPr>
        <p:txBody>
          <a:bodyPr vert="horz" lIns="0" tIns="0" rIns="0" bIns="0" rtlCol="0" anchor="b"/>
          <a:lstStyle>
            <a:defPPr>
              <a:defRPr lang="de-DE"/>
            </a:defPPr>
            <a:lvl1pPr>
              <a:defRPr lang="en-US" sz="1200" smtClean="0"/>
            </a:lvl1pPr>
          </a:lstStyle>
          <a:p>
            <a:fld id="{C3A9D72B-53BE-4D95-9D29-99D7313A36B1}" type="slidenum">
              <a:rPr sz="1200">
                <a:solidFill>
                  <a:srgbClr val="000000"/>
                </a:solidFill>
              </a:rPr>
              <a:pPr/>
              <a:t>‹#›</a:t>
            </a:fld>
            <a:endParaRPr sz="1200" dirty="0">
              <a:solidFill>
                <a:srgbClr val="000000"/>
              </a:solidFill>
            </a:endParaRPr>
          </a:p>
        </p:txBody>
      </p:sp>
      <p:sp>
        <p:nvSpPr>
          <p:cNvPr id="5" name="TextBox 4"/>
          <p:cNvSpPr txBox="1"/>
          <p:nvPr userDrawn="1"/>
        </p:nvSpPr>
        <p:spPr>
          <a:xfrm>
            <a:off x="1104003" y="6508750"/>
            <a:ext cx="6048637" cy="139700"/>
          </a:xfrm>
          <a:prstGeom prst="rect">
            <a:avLst/>
          </a:prstGeom>
          <a:noFill/>
        </p:spPr>
        <p:txBody>
          <a:bodyPr wrap="square" lIns="0" tIns="0" rIns="0" bIns="0" rtlCol="0" anchor="b">
            <a:no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3300641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 userDrawn="1"/>
        </p:nvSpPr>
        <p:spPr>
          <a:xfrm>
            <a:off x="313267" y="6472500"/>
            <a:ext cx="677333" cy="184150"/>
          </a:xfrm>
          <a:prstGeom prst="rect">
            <a:avLst/>
          </a:prstGeom>
        </p:spPr>
        <p:txBody>
          <a:bodyPr vert="horz" lIns="0" tIns="0" rIns="0" bIns="0" rtlCol="0" anchor="b"/>
          <a:lstStyle>
            <a:defPPr>
              <a:defRPr lang="de-DE"/>
            </a:defPPr>
            <a:lvl1pPr>
              <a:defRPr lang="en-US" sz="1200" smtClean="0"/>
            </a:lvl1pPr>
          </a:lstStyle>
          <a:p>
            <a:fld id="{C3A9D72B-53BE-4D95-9D29-99D7313A36B1}" type="slidenum">
              <a:rPr sz="1200">
                <a:solidFill>
                  <a:srgbClr val="000000"/>
                </a:solidFill>
              </a:rPr>
              <a:pPr/>
              <a:t>‹#›</a:t>
            </a:fld>
            <a:endParaRPr sz="12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16909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13" Type="http://schemas.openxmlformats.org/officeDocument/2006/relationships/image" Target="../media/image7.png"/><Relationship Id="rId18" Type="http://schemas.openxmlformats.org/officeDocument/2006/relationships/image" Target="../media/image12.png"/><Relationship Id="rId3" Type="http://schemas.openxmlformats.org/officeDocument/2006/relationships/tags" Target="../tags/tag15.xml"/><Relationship Id="rId21" Type="http://schemas.openxmlformats.org/officeDocument/2006/relationships/image" Target="../media/image15.tiff"/><Relationship Id="rId7" Type="http://schemas.openxmlformats.org/officeDocument/2006/relationships/slideLayout" Target="../slideLayouts/slideLayout18.xml"/><Relationship Id="rId12" Type="http://schemas.openxmlformats.org/officeDocument/2006/relationships/image" Target="../media/image6.jpeg"/><Relationship Id="rId17" Type="http://schemas.openxmlformats.org/officeDocument/2006/relationships/image" Target="../media/image11.jpeg"/><Relationship Id="rId2" Type="http://schemas.openxmlformats.org/officeDocument/2006/relationships/tags" Target="../tags/tag14.xml"/><Relationship Id="rId16" Type="http://schemas.openxmlformats.org/officeDocument/2006/relationships/image" Target="../media/image10.png"/><Relationship Id="rId20" Type="http://schemas.openxmlformats.org/officeDocument/2006/relationships/image" Target="../media/image14.png"/><Relationship Id="rId1" Type="http://schemas.openxmlformats.org/officeDocument/2006/relationships/tags" Target="../tags/tag13.xml"/><Relationship Id="rId6" Type="http://schemas.openxmlformats.org/officeDocument/2006/relationships/tags" Target="../tags/tag18.xml"/><Relationship Id="rId11" Type="http://schemas.openxmlformats.org/officeDocument/2006/relationships/image" Target="../media/image5.gif"/><Relationship Id="rId5" Type="http://schemas.openxmlformats.org/officeDocument/2006/relationships/tags" Target="../tags/tag17.xml"/><Relationship Id="rId15" Type="http://schemas.openxmlformats.org/officeDocument/2006/relationships/image" Target="../media/image9.png"/><Relationship Id="rId10" Type="http://schemas.openxmlformats.org/officeDocument/2006/relationships/image" Target="../media/image4.emf"/><Relationship Id="rId19" Type="http://schemas.openxmlformats.org/officeDocument/2006/relationships/image" Target="../media/image13.png"/><Relationship Id="rId4" Type="http://schemas.openxmlformats.org/officeDocument/2006/relationships/tags" Target="../tags/tag16.xml"/><Relationship Id="rId9" Type="http://schemas.openxmlformats.org/officeDocument/2006/relationships/image" Target="../media/image3.png"/><Relationship Id="rId14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tags" Target="../tags/tag26.xml"/><Relationship Id="rId13" Type="http://schemas.openxmlformats.org/officeDocument/2006/relationships/tags" Target="../tags/tag31.xml"/><Relationship Id="rId18" Type="http://schemas.openxmlformats.org/officeDocument/2006/relationships/image" Target="../media/image10.png"/><Relationship Id="rId3" Type="http://schemas.openxmlformats.org/officeDocument/2006/relationships/tags" Target="../tags/tag21.xml"/><Relationship Id="rId21" Type="http://schemas.openxmlformats.org/officeDocument/2006/relationships/image" Target="../media/image18.png"/><Relationship Id="rId7" Type="http://schemas.openxmlformats.org/officeDocument/2006/relationships/tags" Target="../tags/tag25.xml"/><Relationship Id="rId12" Type="http://schemas.openxmlformats.org/officeDocument/2006/relationships/tags" Target="../tags/tag30.xml"/><Relationship Id="rId17" Type="http://schemas.openxmlformats.org/officeDocument/2006/relationships/slideLayout" Target="../slideLayouts/slideLayout18.xml"/><Relationship Id="rId25" Type="http://schemas.openxmlformats.org/officeDocument/2006/relationships/image" Target="../media/image22.png"/><Relationship Id="rId2" Type="http://schemas.openxmlformats.org/officeDocument/2006/relationships/tags" Target="../tags/tag20.xml"/><Relationship Id="rId16" Type="http://schemas.openxmlformats.org/officeDocument/2006/relationships/tags" Target="../tags/tag34.xml"/><Relationship Id="rId20" Type="http://schemas.openxmlformats.org/officeDocument/2006/relationships/image" Target="../media/image17.png"/><Relationship Id="rId1" Type="http://schemas.openxmlformats.org/officeDocument/2006/relationships/tags" Target="../tags/tag19.xml"/><Relationship Id="rId6" Type="http://schemas.openxmlformats.org/officeDocument/2006/relationships/tags" Target="../tags/tag24.xml"/><Relationship Id="rId11" Type="http://schemas.openxmlformats.org/officeDocument/2006/relationships/tags" Target="../tags/tag29.xml"/><Relationship Id="rId24" Type="http://schemas.openxmlformats.org/officeDocument/2006/relationships/image" Target="../media/image21.png"/><Relationship Id="rId5" Type="http://schemas.openxmlformats.org/officeDocument/2006/relationships/tags" Target="../tags/tag23.xml"/><Relationship Id="rId15" Type="http://schemas.openxmlformats.org/officeDocument/2006/relationships/tags" Target="../tags/tag33.xml"/><Relationship Id="rId23" Type="http://schemas.openxmlformats.org/officeDocument/2006/relationships/image" Target="../media/image20.png"/><Relationship Id="rId10" Type="http://schemas.openxmlformats.org/officeDocument/2006/relationships/tags" Target="../tags/tag28.xml"/><Relationship Id="rId19" Type="http://schemas.openxmlformats.org/officeDocument/2006/relationships/image" Target="../media/image16.png"/><Relationship Id="rId4" Type="http://schemas.openxmlformats.org/officeDocument/2006/relationships/tags" Target="../tags/tag22.xml"/><Relationship Id="rId9" Type="http://schemas.openxmlformats.org/officeDocument/2006/relationships/tags" Target="../tags/tag27.xml"/><Relationship Id="rId14" Type="http://schemas.openxmlformats.org/officeDocument/2006/relationships/tags" Target="../tags/tag32.xml"/><Relationship Id="rId22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emf"/><Relationship Id="rId18" Type="http://schemas.openxmlformats.org/officeDocument/2006/relationships/image" Target="../media/image37.png"/><Relationship Id="rId3" Type="http://schemas.openxmlformats.org/officeDocument/2006/relationships/image" Target="../media/image23.png"/><Relationship Id="rId7" Type="http://schemas.openxmlformats.org/officeDocument/2006/relationships/hyperlink" Target="file:///\\localhost\Users\m232\Desktop\Doctor%20page\8.13%20UI%20Pages\Follow%20up\PSCS_Doctor%20portal_Follow%20up_Follow%20up_med%20history_month%20view.png" TargetMode="External"/><Relationship Id="rId12" Type="http://schemas.openxmlformats.org/officeDocument/2006/relationships/image" Target="../media/image31.emf"/><Relationship Id="rId17" Type="http://schemas.openxmlformats.org/officeDocument/2006/relationships/image" Target="../media/image36.png"/><Relationship Id="rId2" Type="http://schemas.openxmlformats.org/officeDocument/2006/relationships/slideLayout" Target="../slideLayouts/slideLayout18.xml"/><Relationship Id="rId16" Type="http://schemas.openxmlformats.org/officeDocument/2006/relationships/image" Target="../media/image35.png"/><Relationship Id="rId1" Type="http://schemas.openxmlformats.org/officeDocument/2006/relationships/tags" Target="../tags/tag35.xml"/><Relationship Id="rId6" Type="http://schemas.openxmlformats.org/officeDocument/2006/relationships/image" Target="../media/image26.png"/><Relationship Id="rId11" Type="http://schemas.openxmlformats.org/officeDocument/2006/relationships/image" Target="../media/image30.emf"/><Relationship Id="rId5" Type="http://schemas.openxmlformats.org/officeDocument/2006/relationships/image" Target="../media/image25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4" Type="http://schemas.openxmlformats.org/officeDocument/2006/relationships/image" Target="../media/image24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5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86726" y="2891442"/>
            <a:ext cx="2077486" cy="1258021"/>
          </a:xfrm>
          <a:prstGeom prst="rect">
            <a:avLst/>
          </a:prstGeom>
          <a:solidFill>
            <a:srgbClr val="FFFFFF">
              <a:lumMod val="75000"/>
            </a:srgbClr>
          </a:solidFill>
          <a:ln>
            <a:noFill/>
          </a:ln>
        </p:spPr>
      </p:pic>
      <p:grpSp>
        <p:nvGrpSpPr>
          <p:cNvPr id="58" name="Group 57"/>
          <p:cNvGrpSpPr/>
          <p:nvPr/>
        </p:nvGrpSpPr>
        <p:grpSpPr>
          <a:xfrm>
            <a:off x="7821978" y="1641962"/>
            <a:ext cx="772882" cy="586992"/>
            <a:chOff x="2846818" y="1802683"/>
            <a:chExt cx="1020009" cy="709693"/>
          </a:xfrm>
        </p:grpSpPr>
        <p:sp>
          <p:nvSpPr>
            <p:cNvPr id="59" name="AutoShape 11"/>
            <p:cNvSpPr>
              <a:spLocks/>
            </p:cNvSpPr>
            <p:nvPr/>
          </p:nvSpPr>
          <p:spPr bwMode="auto">
            <a:xfrm>
              <a:off x="3164260" y="1802683"/>
              <a:ext cx="702567" cy="703115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7743" y="5306"/>
                  </a:moveTo>
                  <a:lnTo>
                    <a:pt x="15924" y="5306"/>
                  </a:lnTo>
                  <a:lnTo>
                    <a:pt x="15924" y="7135"/>
                  </a:lnTo>
                  <a:lnTo>
                    <a:pt x="14458" y="7135"/>
                  </a:lnTo>
                  <a:lnTo>
                    <a:pt x="14458" y="5306"/>
                  </a:lnTo>
                  <a:lnTo>
                    <a:pt x="12640" y="5306"/>
                  </a:lnTo>
                  <a:lnTo>
                    <a:pt x="12640" y="3832"/>
                  </a:lnTo>
                  <a:lnTo>
                    <a:pt x="14458" y="3832"/>
                  </a:lnTo>
                  <a:lnTo>
                    <a:pt x="14458" y="2003"/>
                  </a:lnTo>
                  <a:lnTo>
                    <a:pt x="15924" y="2003"/>
                  </a:lnTo>
                  <a:lnTo>
                    <a:pt x="15924" y="3832"/>
                  </a:lnTo>
                  <a:lnTo>
                    <a:pt x="17743" y="3832"/>
                  </a:lnTo>
                  <a:cubicBezTo>
                    <a:pt x="17743" y="3832"/>
                    <a:pt x="17743" y="5306"/>
                    <a:pt x="17743" y="5306"/>
                  </a:cubicBezTo>
                  <a:close/>
                  <a:moveTo>
                    <a:pt x="10785" y="14008"/>
                  </a:moveTo>
                  <a:cubicBezTo>
                    <a:pt x="10785" y="14325"/>
                    <a:pt x="10529" y="14583"/>
                    <a:pt x="10213" y="14583"/>
                  </a:cubicBezTo>
                  <a:lnTo>
                    <a:pt x="9070" y="14583"/>
                  </a:lnTo>
                  <a:cubicBezTo>
                    <a:pt x="8754" y="14583"/>
                    <a:pt x="8498" y="14325"/>
                    <a:pt x="8498" y="14008"/>
                  </a:cubicBezTo>
                  <a:lnTo>
                    <a:pt x="8498" y="12858"/>
                  </a:lnTo>
                  <a:cubicBezTo>
                    <a:pt x="8498" y="12540"/>
                    <a:pt x="8754" y="12283"/>
                    <a:pt x="9070" y="12283"/>
                  </a:cubicBezTo>
                  <a:lnTo>
                    <a:pt x="10213" y="12283"/>
                  </a:lnTo>
                  <a:cubicBezTo>
                    <a:pt x="10529" y="12283"/>
                    <a:pt x="10785" y="12540"/>
                    <a:pt x="10785" y="12858"/>
                  </a:cubicBezTo>
                  <a:cubicBezTo>
                    <a:pt x="10785" y="12858"/>
                    <a:pt x="10785" y="14008"/>
                    <a:pt x="10785" y="14008"/>
                  </a:cubicBezTo>
                  <a:close/>
                  <a:moveTo>
                    <a:pt x="10785" y="17602"/>
                  </a:moveTo>
                  <a:cubicBezTo>
                    <a:pt x="10785" y="17920"/>
                    <a:pt x="10529" y="18176"/>
                    <a:pt x="10213" y="18176"/>
                  </a:cubicBezTo>
                  <a:lnTo>
                    <a:pt x="9070" y="18176"/>
                  </a:lnTo>
                  <a:cubicBezTo>
                    <a:pt x="8754" y="18176"/>
                    <a:pt x="8498" y="17920"/>
                    <a:pt x="8498" y="17602"/>
                  </a:cubicBezTo>
                  <a:lnTo>
                    <a:pt x="8498" y="16452"/>
                  </a:lnTo>
                  <a:cubicBezTo>
                    <a:pt x="8498" y="16134"/>
                    <a:pt x="8754" y="15877"/>
                    <a:pt x="9070" y="15877"/>
                  </a:cubicBezTo>
                  <a:lnTo>
                    <a:pt x="10213" y="15877"/>
                  </a:lnTo>
                  <a:cubicBezTo>
                    <a:pt x="10529" y="15877"/>
                    <a:pt x="10785" y="16134"/>
                    <a:pt x="10785" y="16452"/>
                  </a:cubicBezTo>
                  <a:cubicBezTo>
                    <a:pt x="10785" y="16452"/>
                    <a:pt x="10785" y="17602"/>
                    <a:pt x="10785" y="17602"/>
                  </a:cubicBezTo>
                  <a:close/>
                  <a:moveTo>
                    <a:pt x="7426" y="14008"/>
                  </a:moveTo>
                  <a:cubicBezTo>
                    <a:pt x="7426" y="14325"/>
                    <a:pt x="7170" y="14583"/>
                    <a:pt x="6855" y="14583"/>
                  </a:cubicBezTo>
                  <a:lnTo>
                    <a:pt x="5711" y="14583"/>
                  </a:lnTo>
                  <a:cubicBezTo>
                    <a:pt x="5395" y="14583"/>
                    <a:pt x="5140" y="14325"/>
                    <a:pt x="5140" y="14008"/>
                  </a:cubicBezTo>
                  <a:lnTo>
                    <a:pt x="5140" y="12858"/>
                  </a:lnTo>
                  <a:cubicBezTo>
                    <a:pt x="5140" y="12540"/>
                    <a:pt x="5395" y="12283"/>
                    <a:pt x="5711" y="12283"/>
                  </a:cubicBezTo>
                  <a:lnTo>
                    <a:pt x="6855" y="12283"/>
                  </a:lnTo>
                  <a:cubicBezTo>
                    <a:pt x="7170" y="12283"/>
                    <a:pt x="7426" y="12540"/>
                    <a:pt x="7426" y="12858"/>
                  </a:cubicBezTo>
                  <a:cubicBezTo>
                    <a:pt x="7426" y="12858"/>
                    <a:pt x="7426" y="14008"/>
                    <a:pt x="7426" y="14008"/>
                  </a:cubicBezTo>
                  <a:close/>
                  <a:moveTo>
                    <a:pt x="7426" y="17602"/>
                  </a:moveTo>
                  <a:cubicBezTo>
                    <a:pt x="7426" y="17920"/>
                    <a:pt x="7170" y="18176"/>
                    <a:pt x="6855" y="18176"/>
                  </a:cubicBezTo>
                  <a:lnTo>
                    <a:pt x="5711" y="18176"/>
                  </a:lnTo>
                  <a:cubicBezTo>
                    <a:pt x="5395" y="18176"/>
                    <a:pt x="5140" y="17920"/>
                    <a:pt x="5140" y="17602"/>
                  </a:cubicBezTo>
                  <a:lnTo>
                    <a:pt x="5140" y="16452"/>
                  </a:lnTo>
                  <a:cubicBezTo>
                    <a:pt x="5140" y="16134"/>
                    <a:pt x="5395" y="15877"/>
                    <a:pt x="5711" y="15877"/>
                  </a:cubicBezTo>
                  <a:lnTo>
                    <a:pt x="6855" y="15877"/>
                  </a:lnTo>
                  <a:cubicBezTo>
                    <a:pt x="7170" y="15877"/>
                    <a:pt x="7426" y="16134"/>
                    <a:pt x="7426" y="16452"/>
                  </a:cubicBezTo>
                  <a:cubicBezTo>
                    <a:pt x="7426" y="16452"/>
                    <a:pt x="7426" y="17602"/>
                    <a:pt x="7426" y="17602"/>
                  </a:cubicBezTo>
                  <a:close/>
                  <a:moveTo>
                    <a:pt x="4067" y="14008"/>
                  </a:moveTo>
                  <a:cubicBezTo>
                    <a:pt x="4067" y="14325"/>
                    <a:pt x="3812" y="14583"/>
                    <a:pt x="3496" y="14583"/>
                  </a:cubicBezTo>
                  <a:lnTo>
                    <a:pt x="2352" y="14583"/>
                  </a:lnTo>
                  <a:cubicBezTo>
                    <a:pt x="2037" y="14583"/>
                    <a:pt x="1781" y="14325"/>
                    <a:pt x="1781" y="14008"/>
                  </a:cubicBezTo>
                  <a:lnTo>
                    <a:pt x="1781" y="12858"/>
                  </a:lnTo>
                  <a:cubicBezTo>
                    <a:pt x="1781" y="12540"/>
                    <a:pt x="2037" y="12283"/>
                    <a:pt x="2352" y="12283"/>
                  </a:cubicBezTo>
                  <a:lnTo>
                    <a:pt x="3496" y="12283"/>
                  </a:lnTo>
                  <a:cubicBezTo>
                    <a:pt x="3812" y="12283"/>
                    <a:pt x="4067" y="12540"/>
                    <a:pt x="4067" y="12858"/>
                  </a:cubicBezTo>
                  <a:cubicBezTo>
                    <a:pt x="4067" y="12858"/>
                    <a:pt x="4067" y="14008"/>
                    <a:pt x="4067" y="14008"/>
                  </a:cubicBezTo>
                  <a:close/>
                  <a:moveTo>
                    <a:pt x="4067" y="17602"/>
                  </a:moveTo>
                  <a:cubicBezTo>
                    <a:pt x="4067" y="17920"/>
                    <a:pt x="3812" y="18176"/>
                    <a:pt x="3496" y="18176"/>
                  </a:cubicBezTo>
                  <a:lnTo>
                    <a:pt x="2352" y="18176"/>
                  </a:lnTo>
                  <a:cubicBezTo>
                    <a:pt x="2037" y="18176"/>
                    <a:pt x="1781" y="17920"/>
                    <a:pt x="1781" y="17602"/>
                  </a:cubicBezTo>
                  <a:lnTo>
                    <a:pt x="1781" y="16452"/>
                  </a:lnTo>
                  <a:cubicBezTo>
                    <a:pt x="1781" y="16134"/>
                    <a:pt x="2037" y="15877"/>
                    <a:pt x="2352" y="15877"/>
                  </a:cubicBezTo>
                  <a:lnTo>
                    <a:pt x="3496" y="15877"/>
                  </a:lnTo>
                  <a:cubicBezTo>
                    <a:pt x="3812" y="15877"/>
                    <a:pt x="4067" y="16134"/>
                    <a:pt x="4067" y="16452"/>
                  </a:cubicBezTo>
                  <a:cubicBezTo>
                    <a:pt x="4067" y="16452"/>
                    <a:pt x="4067" y="17602"/>
                    <a:pt x="4067" y="17602"/>
                  </a:cubicBezTo>
                  <a:close/>
                  <a:moveTo>
                    <a:pt x="8823" y="0"/>
                  </a:moveTo>
                  <a:lnTo>
                    <a:pt x="8823" y="9411"/>
                  </a:lnTo>
                  <a:lnTo>
                    <a:pt x="13437" y="9411"/>
                  </a:lnTo>
                  <a:cubicBezTo>
                    <a:pt x="14398" y="9411"/>
                    <a:pt x="15179" y="10219"/>
                    <a:pt x="15179" y="11211"/>
                  </a:cubicBezTo>
                  <a:lnTo>
                    <a:pt x="15179" y="14663"/>
                  </a:lnTo>
                  <a:cubicBezTo>
                    <a:pt x="15179" y="14846"/>
                    <a:pt x="15036" y="14994"/>
                    <a:pt x="14859" y="14994"/>
                  </a:cubicBezTo>
                  <a:cubicBezTo>
                    <a:pt x="14682" y="14994"/>
                    <a:pt x="14539" y="14846"/>
                    <a:pt x="14539" y="14663"/>
                  </a:cubicBezTo>
                  <a:lnTo>
                    <a:pt x="14539" y="11211"/>
                  </a:lnTo>
                  <a:cubicBezTo>
                    <a:pt x="14539" y="10583"/>
                    <a:pt x="14045" y="10073"/>
                    <a:pt x="13437" y="10073"/>
                  </a:cubicBezTo>
                  <a:lnTo>
                    <a:pt x="8823" y="10073"/>
                  </a:lnTo>
                  <a:lnTo>
                    <a:pt x="8823" y="10079"/>
                  </a:lnTo>
                  <a:lnTo>
                    <a:pt x="1422" y="10079"/>
                  </a:lnTo>
                  <a:cubicBezTo>
                    <a:pt x="637" y="10079"/>
                    <a:pt x="0" y="10737"/>
                    <a:pt x="0" y="11549"/>
                  </a:cubicBezTo>
                  <a:lnTo>
                    <a:pt x="0" y="21600"/>
                  </a:lnTo>
                  <a:lnTo>
                    <a:pt x="21600" y="21600"/>
                  </a:lnTo>
                  <a:lnTo>
                    <a:pt x="21600" y="0"/>
                  </a:lnTo>
                  <a:cubicBezTo>
                    <a:pt x="21600" y="0"/>
                    <a:pt x="8823" y="0"/>
                    <a:pt x="8823" y="0"/>
                  </a:cubicBezTo>
                  <a:close/>
                  <a:moveTo>
                    <a:pt x="8823" y="0"/>
                  </a:moveTo>
                </a:path>
              </a:pathLst>
            </a:custGeom>
            <a:solidFill>
              <a:srgbClr val="83C9BF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0" name="AutoShape 23"/>
            <p:cNvSpPr>
              <a:spLocks/>
            </p:cNvSpPr>
            <p:nvPr/>
          </p:nvSpPr>
          <p:spPr bwMode="auto">
            <a:xfrm>
              <a:off x="2914382" y="1819127"/>
              <a:ext cx="85662" cy="86200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0799" y="21600"/>
                  </a:moveTo>
                  <a:cubicBezTo>
                    <a:pt x="16761" y="21600"/>
                    <a:pt x="21600" y="16767"/>
                    <a:pt x="21600" y="10804"/>
                  </a:cubicBezTo>
                  <a:cubicBezTo>
                    <a:pt x="21600" y="4838"/>
                    <a:pt x="16761" y="0"/>
                    <a:pt x="10799" y="0"/>
                  </a:cubicBezTo>
                  <a:cubicBezTo>
                    <a:pt x="4834" y="0"/>
                    <a:pt x="0" y="4838"/>
                    <a:pt x="0" y="10804"/>
                  </a:cubicBezTo>
                  <a:cubicBezTo>
                    <a:pt x="0" y="16767"/>
                    <a:pt x="4834" y="21600"/>
                    <a:pt x="10799" y="21600"/>
                  </a:cubicBezTo>
                  <a:close/>
                  <a:moveTo>
                    <a:pt x="10799" y="2160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1" name="AutoShape 24"/>
            <p:cNvSpPr>
              <a:spLocks/>
            </p:cNvSpPr>
            <p:nvPr/>
          </p:nvSpPr>
          <p:spPr bwMode="auto">
            <a:xfrm>
              <a:off x="2895078" y="2236776"/>
              <a:ext cx="59118" cy="275600"/>
            </a:xfrm>
            <a:custGeom>
              <a:avLst/>
              <a:gdLst/>
              <a:ahLst/>
              <a:cxnLst/>
              <a:rect l="0" t="0" r="r" b="b"/>
              <a:pathLst>
                <a:path w="21450" h="21569">
                  <a:moveTo>
                    <a:pt x="5" y="19531"/>
                  </a:moveTo>
                  <a:cubicBezTo>
                    <a:pt x="-150" y="20622"/>
                    <a:pt x="3776" y="21534"/>
                    <a:pt x="8766" y="21568"/>
                  </a:cubicBezTo>
                  <a:cubicBezTo>
                    <a:pt x="13756" y="21600"/>
                    <a:pt x="17923" y="20741"/>
                    <a:pt x="18064" y="19648"/>
                  </a:cubicBezTo>
                  <a:lnTo>
                    <a:pt x="18946" y="16256"/>
                  </a:lnTo>
                  <a:lnTo>
                    <a:pt x="21450" y="0"/>
                  </a:lnTo>
                  <a:lnTo>
                    <a:pt x="236" y="0"/>
                  </a:lnTo>
                  <a:cubicBezTo>
                    <a:pt x="236" y="0"/>
                    <a:pt x="5" y="19531"/>
                    <a:pt x="5" y="19531"/>
                  </a:cubicBezTo>
                  <a:close/>
                  <a:moveTo>
                    <a:pt x="5" y="1953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2" name="AutoShape 26"/>
            <p:cNvSpPr>
              <a:spLocks/>
            </p:cNvSpPr>
            <p:nvPr/>
          </p:nvSpPr>
          <p:spPr bwMode="auto">
            <a:xfrm>
              <a:off x="2846818" y="1899964"/>
              <a:ext cx="236475" cy="604621"/>
            </a:xfrm>
            <a:custGeom>
              <a:avLst/>
              <a:gdLst/>
              <a:ahLst/>
              <a:cxnLst/>
              <a:rect l="0" t="0" r="r" b="b"/>
              <a:pathLst>
                <a:path w="21529" h="21586">
                  <a:moveTo>
                    <a:pt x="17401" y="2359"/>
                  </a:moveTo>
                  <a:lnTo>
                    <a:pt x="15203" y="2359"/>
                  </a:lnTo>
                  <a:cubicBezTo>
                    <a:pt x="15007" y="2359"/>
                    <a:pt x="14849" y="2296"/>
                    <a:pt x="14849" y="2219"/>
                  </a:cubicBezTo>
                  <a:cubicBezTo>
                    <a:pt x="14849" y="2142"/>
                    <a:pt x="15007" y="2079"/>
                    <a:pt x="15203" y="2079"/>
                  </a:cubicBezTo>
                  <a:lnTo>
                    <a:pt x="17401" y="2079"/>
                  </a:lnTo>
                  <a:cubicBezTo>
                    <a:pt x="17597" y="2079"/>
                    <a:pt x="17756" y="2142"/>
                    <a:pt x="17756" y="2219"/>
                  </a:cubicBezTo>
                  <a:cubicBezTo>
                    <a:pt x="17756" y="2296"/>
                    <a:pt x="17597" y="2359"/>
                    <a:pt x="17401" y="2359"/>
                  </a:cubicBezTo>
                  <a:close/>
                  <a:moveTo>
                    <a:pt x="21393" y="6761"/>
                  </a:moveTo>
                  <a:cubicBezTo>
                    <a:pt x="21217" y="5515"/>
                    <a:pt x="20736" y="3164"/>
                    <a:pt x="19844" y="1775"/>
                  </a:cubicBezTo>
                  <a:lnTo>
                    <a:pt x="19737" y="1647"/>
                  </a:lnTo>
                  <a:cubicBezTo>
                    <a:pt x="19016" y="806"/>
                    <a:pt x="17437" y="188"/>
                    <a:pt x="15617" y="45"/>
                  </a:cubicBezTo>
                  <a:cubicBezTo>
                    <a:pt x="15617" y="45"/>
                    <a:pt x="15207" y="20"/>
                    <a:pt x="15000" y="17"/>
                  </a:cubicBezTo>
                  <a:cubicBezTo>
                    <a:pt x="14591" y="3"/>
                    <a:pt x="14246" y="0"/>
                    <a:pt x="14246" y="0"/>
                  </a:cubicBezTo>
                  <a:cubicBezTo>
                    <a:pt x="14233" y="10"/>
                    <a:pt x="14223" y="15"/>
                    <a:pt x="14209" y="22"/>
                  </a:cubicBezTo>
                  <a:lnTo>
                    <a:pt x="13267" y="2684"/>
                  </a:lnTo>
                  <a:cubicBezTo>
                    <a:pt x="13109" y="3083"/>
                    <a:pt x="12440" y="3336"/>
                    <a:pt x="11383" y="3397"/>
                  </a:cubicBezTo>
                  <a:lnTo>
                    <a:pt x="11188" y="3408"/>
                  </a:lnTo>
                  <a:lnTo>
                    <a:pt x="11188" y="4675"/>
                  </a:lnTo>
                  <a:lnTo>
                    <a:pt x="11315" y="4699"/>
                  </a:lnTo>
                  <a:cubicBezTo>
                    <a:pt x="11779" y="4788"/>
                    <a:pt x="12079" y="4981"/>
                    <a:pt x="12079" y="5191"/>
                  </a:cubicBezTo>
                  <a:cubicBezTo>
                    <a:pt x="12079" y="5491"/>
                    <a:pt x="11487" y="5734"/>
                    <a:pt x="10761" y="5734"/>
                  </a:cubicBezTo>
                  <a:cubicBezTo>
                    <a:pt x="10035" y="5734"/>
                    <a:pt x="9445" y="5491"/>
                    <a:pt x="9445" y="5191"/>
                  </a:cubicBezTo>
                  <a:cubicBezTo>
                    <a:pt x="9445" y="4981"/>
                    <a:pt x="9744" y="4788"/>
                    <a:pt x="10208" y="4699"/>
                  </a:cubicBezTo>
                  <a:lnTo>
                    <a:pt x="10336" y="4675"/>
                  </a:lnTo>
                  <a:lnTo>
                    <a:pt x="10336" y="3409"/>
                  </a:lnTo>
                  <a:lnTo>
                    <a:pt x="10144" y="3396"/>
                  </a:lnTo>
                  <a:cubicBezTo>
                    <a:pt x="9128" y="3332"/>
                    <a:pt x="8406" y="3059"/>
                    <a:pt x="8257" y="2683"/>
                  </a:cubicBezTo>
                  <a:lnTo>
                    <a:pt x="7313" y="17"/>
                  </a:lnTo>
                  <a:cubicBezTo>
                    <a:pt x="7304" y="13"/>
                    <a:pt x="7295" y="8"/>
                    <a:pt x="7284" y="0"/>
                  </a:cubicBezTo>
                  <a:cubicBezTo>
                    <a:pt x="7284" y="0"/>
                    <a:pt x="6938" y="3"/>
                    <a:pt x="6529" y="17"/>
                  </a:cubicBezTo>
                  <a:cubicBezTo>
                    <a:pt x="6323" y="20"/>
                    <a:pt x="5912" y="45"/>
                    <a:pt x="5912" y="45"/>
                  </a:cubicBezTo>
                  <a:cubicBezTo>
                    <a:pt x="4092" y="188"/>
                    <a:pt x="2514" y="806"/>
                    <a:pt x="1791" y="1647"/>
                  </a:cubicBezTo>
                  <a:lnTo>
                    <a:pt x="1684" y="1775"/>
                  </a:lnTo>
                  <a:cubicBezTo>
                    <a:pt x="792" y="3164"/>
                    <a:pt x="310" y="5515"/>
                    <a:pt x="136" y="6761"/>
                  </a:cubicBezTo>
                  <a:cubicBezTo>
                    <a:pt x="19" y="7597"/>
                    <a:pt x="-35" y="8005"/>
                    <a:pt x="25" y="8782"/>
                  </a:cubicBezTo>
                  <a:cubicBezTo>
                    <a:pt x="25" y="9328"/>
                    <a:pt x="1110" y="9740"/>
                    <a:pt x="2464" y="9713"/>
                  </a:cubicBezTo>
                  <a:lnTo>
                    <a:pt x="3581" y="3754"/>
                  </a:lnTo>
                  <a:cubicBezTo>
                    <a:pt x="3595" y="3630"/>
                    <a:pt x="3851" y="3531"/>
                    <a:pt x="4167" y="3531"/>
                  </a:cubicBezTo>
                  <a:cubicBezTo>
                    <a:pt x="4172" y="3531"/>
                    <a:pt x="4175" y="3532"/>
                    <a:pt x="4179" y="3532"/>
                  </a:cubicBezTo>
                  <a:lnTo>
                    <a:pt x="4061" y="11438"/>
                  </a:lnTo>
                  <a:lnTo>
                    <a:pt x="13011" y="11438"/>
                  </a:lnTo>
                  <a:cubicBezTo>
                    <a:pt x="13207" y="11438"/>
                    <a:pt x="13365" y="11500"/>
                    <a:pt x="13365" y="11578"/>
                  </a:cubicBezTo>
                  <a:cubicBezTo>
                    <a:pt x="13365" y="11655"/>
                    <a:pt x="13207" y="11717"/>
                    <a:pt x="13011" y="11717"/>
                  </a:cubicBezTo>
                  <a:lnTo>
                    <a:pt x="11393" y="11717"/>
                  </a:lnTo>
                  <a:lnTo>
                    <a:pt x="12051" y="19391"/>
                  </a:lnTo>
                  <a:lnTo>
                    <a:pt x="12239" y="20707"/>
                  </a:lnTo>
                  <a:cubicBezTo>
                    <a:pt x="12276" y="21207"/>
                    <a:pt x="13334" y="21600"/>
                    <a:pt x="14601" y="21586"/>
                  </a:cubicBezTo>
                  <a:cubicBezTo>
                    <a:pt x="15868" y="21570"/>
                    <a:pt x="16867" y="21153"/>
                    <a:pt x="16830" y="20654"/>
                  </a:cubicBezTo>
                  <a:lnTo>
                    <a:pt x="16773" y="11585"/>
                  </a:lnTo>
                  <a:lnTo>
                    <a:pt x="17441" y="11585"/>
                  </a:lnTo>
                  <a:lnTo>
                    <a:pt x="17322" y="3534"/>
                  </a:lnTo>
                  <a:cubicBezTo>
                    <a:pt x="17334" y="3534"/>
                    <a:pt x="17345" y="3531"/>
                    <a:pt x="17359" y="3531"/>
                  </a:cubicBezTo>
                  <a:cubicBezTo>
                    <a:pt x="17677" y="3531"/>
                    <a:pt x="17935" y="3630"/>
                    <a:pt x="17947" y="3754"/>
                  </a:cubicBezTo>
                  <a:lnTo>
                    <a:pt x="19065" y="9713"/>
                  </a:lnTo>
                  <a:cubicBezTo>
                    <a:pt x="20420" y="9740"/>
                    <a:pt x="21504" y="9328"/>
                    <a:pt x="21504" y="8782"/>
                  </a:cubicBezTo>
                  <a:cubicBezTo>
                    <a:pt x="21565" y="8005"/>
                    <a:pt x="21511" y="7597"/>
                    <a:pt x="21393" y="6761"/>
                  </a:cubicBezTo>
                  <a:close/>
                  <a:moveTo>
                    <a:pt x="21393" y="676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63" name="Group 62"/>
          <p:cNvGrpSpPr/>
          <p:nvPr/>
        </p:nvGrpSpPr>
        <p:grpSpPr>
          <a:xfrm>
            <a:off x="10515300" y="3230805"/>
            <a:ext cx="935512" cy="602179"/>
            <a:chOff x="577397" y="1831457"/>
            <a:chExt cx="1202133" cy="715808"/>
          </a:xfrm>
        </p:grpSpPr>
        <p:sp>
          <p:nvSpPr>
            <p:cNvPr id="64" name="AutoShape 13"/>
            <p:cNvSpPr>
              <a:spLocks/>
            </p:cNvSpPr>
            <p:nvPr/>
          </p:nvSpPr>
          <p:spPr bwMode="auto">
            <a:xfrm>
              <a:off x="650122" y="1852023"/>
              <a:ext cx="84089" cy="84618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0797" y="21600"/>
                  </a:moveTo>
                  <a:cubicBezTo>
                    <a:pt x="16764" y="21600"/>
                    <a:pt x="21600" y="16765"/>
                    <a:pt x="21600" y="10801"/>
                  </a:cubicBezTo>
                  <a:cubicBezTo>
                    <a:pt x="21600" y="4839"/>
                    <a:pt x="16764" y="0"/>
                    <a:pt x="10797" y="0"/>
                  </a:cubicBezTo>
                  <a:cubicBezTo>
                    <a:pt x="4834" y="0"/>
                    <a:pt x="0" y="4839"/>
                    <a:pt x="0" y="10801"/>
                  </a:cubicBezTo>
                  <a:cubicBezTo>
                    <a:pt x="0" y="16765"/>
                    <a:pt x="4834" y="21600"/>
                    <a:pt x="10797" y="21600"/>
                  </a:cubicBezTo>
                  <a:close/>
                  <a:moveTo>
                    <a:pt x="10797" y="2160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5" name="AutoShape 14"/>
            <p:cNvSpPr>
              <a:spLocks/>
            </p:cNvSpPr>
            <p:nvPr/>
          </p:nvSpPr>
          <p:spPr bwMode="auto">
            <a:xfrm>
              <a:off x="619820" y="2272827"/>
              <a:ext cx="58332" cy="274438"/>
            </a:xfrm>
            <a:custGeom>
              <a:avLst/>
              <a:gdLst/>
              <a:ahLst/>
              <a:cxnLst/>
              <a:rect l="0" t="0" r="r" b="b"/>
              <a:pathLst>
                <a:path w="21454" h="21570">
                  <a:moveTo>
                    <a:pt x="238" y="0"/>
                  </a:moveTo>
                  <a:lnTo>
                    <a:pt x="4" y="19558"/>
                  </a:lnTo>
                  <a:cubicBezTo>
                    <a:pt x="-146" y="20635"/>
                    <a:pt x="3771" y="21536"/>
                    <a:pt x="8750" y="21569"/>
                  </a:cubicBezTo>
                  <a:cubicBezTo>
                    <a:pt x="13732" y="21600"/>
                    <a:pt x="17890" y="20752"/>
                    <a:pt x="18034" y="19673"/>
                  </a:cubicBezTo>
                  <a:lnTo>
                    <a:pt x="18912" y="16324"/>
                  </a:lnTo>
                  <a:lnTo>
                    <a:pt x="21454" y="0"/>
                  </a:lnTo>
                  <a:cubicBezTo>
                    <a:pt x="21454" y="0"/>
                    <a:pt x="238" y="0"/>
                    <a:pt x="238" y="0"/>
                  </a:cubicBezTo>
                  <a:close/>
                  <a:moveTo>
                    <a:pt x="238" y="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6" name="AutoShape 15"/>
            <p:cNvSpPr>
              <a:spLocks/>
            </p:cNvSpPr>
            <p:nvPr/>
          </p:nvSpPr>
          <p:spPr bwMode="auto">
            <a:xfrm>
              <a:off x="710726" y="2272827"/>
              <a:ext cx="58332" cy="274438"/>
            </a:xfrm>
            <a:custGeom>
              <a:avLst/>
              <a:gdLst/>
              <a:ahLst/>
              <a:cxnLst/>
              <a:rect l="0" t="0" r="r" b="b"/>
              <a:pathLst>
                <a:path w="21456" h="21570">
                  <a:moveTo>
                    <a:pt x="0" y="0"/>
                  </a:moveTo>
                  <a:lnTo>
                    <a:pt x="2631" y="16835"/>
                  </a:lnTo>
                  <a:lnTo>
                    <a:pt x="3370" y="19673"/>
                  </a:lnTo>
                  <a:cubicBezTo>
                    <a:pt x="3516" y="20752"/>
                    <a:pt x="7687" y="21600"/>
                    <a:pt x="12680" y="21569"/>
                  </a:cubicBezTo>
                  <a:cubicBezTo>
                    <a:pt x="17666" y="21536"/>
                    <a:pt x="21600" y="20636"/>
                    <a:pt x="21452" y="19559"/>
                  </a:cubicBezTo>
                  <a:lnTo>
                    <a:pt x="21233" y="0"/>
                  </a:lnTo>
                  <a:cubicBezTo>
                    <a:pt x="21233" y="0"/>
                    <a:pt x="0" y="0"/>
                    <a:pt x="0" y="0"/>
                  </a:cubicBezTo>
                  <a:close/>
                  <a:moveTo>
                    <a:pt x="0" y="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7" name="AutoShape 16"/>
            <p:cNvSpPr>
              <a:spLocks/>
            </p:cNvSpPr>
            <p:nvPr/>
          </p:nvSpPr>
          <p:spPr bwMode="auto">
            <a:xfrm>
              <a:off x="577397" y="1949601"/>
              <a:ext cx="111361" cy="310267"/>
            </a:xfrm>
            <a:custGeom>
              <a:avLst/>
              <a:gdLst/>
              <a:ahLst/>
              <a:cxnLst/>
              <a:rect l="0" t="0" r="r" b="b"/>
              <a:pathLst>
                <a:path w="21527" h="21600">
                  <a:moveTo>
                    <a:pt x="21527" y="21600"/>
                  </a:moveTo>
                  <a:lnTo>
                    <a:pt x="21527" y="9839"/>
                  </a:lnTo>
                  <a:lnTo>
                    <a:pt x="15019" y="0"/>
                  </a:lnTo>
                  <a:cubicBezTo>
                    <a:pt x="14909" y="1"/>
                    <a:pt x="14273" y="8"/>
                    <a:pt x="13503" y="32"/>
                  </a:cubicBezTo>
                  <a:cubicBezTo>
                    <a:pt x="13072" y="39"/>
                    <a:pt x="12226" y="87"/>
                    <a:pt x="12226" y="87"/>
                  </a:cubicBezTo>
                  <a:cubicBezTo>
                    <a:pt x="8461" y="359"/>
                    <a:pt x="5201" y="1539"/>
                    <a:pt x="3705" y="3146"/>
                  </a:cubicBezTo>
                  <a:lnTo>
                    <a:pt x="3484" y="3390"/>
                  </a:lnTo>
                  <a:cubicBezTo>
                    <a:pt x="1640" y="6043"/>
                    <a:pt x="641" y="10533"/>
                    <a:pt x="280" y="12912"/>
                  </a:cubicBezTo>
                  <a:cubicBezTo>
                    <a:pt x="39" y="14508"/>
                    <a:pt x="-73" y="15288"/>
                    <a:pt x="52" y="16771"/>
                  </a:cubicBezTo>
                  <a:cubicBezTo>
                    <a:pt x="52" y="17815"/>
                    <a:pt x="2295" y="18601"/>
                    <a:pt x="5098" y="18550"/>
                  </a:cubicBezTo>
                  <a:lnTo>
                    <a:pt x="7406" y="7169"/>
                  </a:lnTo>
                  <a:cubicBezTo>
                    <a:pt x="7433" y="6933"/>
                    <a:pt x="7963" y="6744"/>
                    <a:pt x="8619" y="6744"/>
                  </a:cubicBezTo>
                  <a:cubicBezTo>
                    <a:pt x="8628" y="6744"/>
                    <a:pt x="8635" y="6746"/>
                    <a:pt x="8642" y="6746"/>
                  </a:cubicBezTo>
                  <a:lnTo>
                    <a:pt x="8402" y="21600"/>
                  </a:lnTo>
                  <a:cubicBezTo>
                    <a:pt x="8402" y="21600"/>
                    <a:pt x="21527" y="21600"/>
                    <a:pt x="21527" y="21600"/>
                  </a:cubicBezTo>
                  <a:close/>
                  <a:moveTo>
                    <a:pt x="21527" y="2160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8" name="AutoShape 17"/>
            <p:cNvSpPr>
              <a:spLocks/>
            </p:cNvSpPr>
            <p:nvPr/>
          </p:nvSpPr>
          <p:spPr bwMode="auto">
            <a:xfrm>
              <a:off x="698606" y="1949601"/>
              <a:ext cx="111361" cy="310267"/>
            </a:xfrm>
            <a:custGeom>
              <a:avLst/>
              <a:gdLst/>
              <a:ahLst/>
              <a:cxnLst/>
              <a:rect l="0" t="0" r="r" b="b"/>
              <a:pathLst>
                <a:path w="21527" h="21600">
                  <a:moveTo>
                    <a:pt x="11532" y="4505"/>
                  </a:moveTo>
                  <a:lnTo>
                    <a:pt x="6989" y="4505"/>
                  </a:lnTo>
                  <a:cubicBezTo>
                    <a:pt x="6584" y="4505"/>
                    <a:pt x="6255" y="4385"/>
                    <a:pt x="6255" y="4238"/>
                  </a:cubicBezTo>
                  <a:cubicBezTo>
                    <a:pt x="6255" y="4090"/>
                    <a:pt x="6584" y="3970"/>
                    <a:pt x="6989" y="3970"/>
                  </a:cubicBezTo>
                  <a:lnTo>
                    <a:pt x="11532" y="3970"/>
                  </a:lnTo>
                  <a:cubicBezTo>
                    <a:pt x="11937" y="3970"/>
                    <a:pt x="12266" y="4090"/>
                    <a:pt x="12266" y="4238"/>
                  </a:cubicBezTo>
                  <a:cubicBezTo>
                    <a:pt x="12266" y="4385"/>
                    <a:pt x="11937" y="4505"/>
                    <a:pt x="11532" y="4505"/>
                  </a:cubicBezTo>
                  <a:close/>
                  <a:moveTo>
                    <a:pt x="21246" y="12912"/>
                  </a:moveTo>
                  <a:cubicBezTo>
                    <a:pt x="20883" y="10533"/>
                    <a:pt x="19888" y="6043"/>
                    <a:pt x="18044" y="3390"/>
                  </a:cubicBezTo>
                  <a:lnTo>
                    <a:pt x="17822" y="3146"/>
                  </a:lnTo>
                  <a:cubicBezTo>
                    <a:pt x="16330" y="1539"/>
                    <a:pt x="13065" y="359"/>
                    <a:pt x="9300" y="88"/>
                  </a:cubicBezTo>
                  <a:cubicBezTo>
                    <a:pt x="9300" y="88"/>
                    <a:pt x="8452" y="39"/>
                    <a:pt x="8024" y="32"/>
                  </a:cubicBezTo>
                  <a:cubicBezTo>
                    <a:pt x="7250" y="8"/>
                    <a:pt x="6614" y="1"/>
                    <a:pt x="6506" y="0"/>
                  </a:cubicBezTo>
                  <a:lnTo>
                    <a:pt x="0" y="9803"/>
                  </a:lnTo>
                  <a:lnTo>
                    <a:pt x="0" y="21600"/>
                  </a:lnTo>
                  <a:lnTo>
                    <a:pt x="13065" y="21600"/>
                  </a:lnTo>
                  <a:lnTo>
                    <a:pt x="12827" y="6750"/>
                  </a:lnTo>
                  <a:cubicBezTo>
                    <a:pt x="12853" y="6750"/>
                    <a:pt x="12877" y="6744"/>
                    <a:pt x="12905" y="6744"/>
                  </a:cubicBezTo>
                  <a:cubicBezTo>
                    <a:pt x="13560" y="6744"/>
                    <a:pt x="14094" y="6933"/>
                    <a:pt x="14119" y="7169"/>
                  </a:cubicBezTo>
                  <a:lnTo>
                    <a:pt x="16431" y="18550"/>
                  </a:lnTo>
                  <a:cubicBezTo>
                    <a:pt x="19233" y="18601"/>
                    <a:pt x="21474" y="17815"/>
                    <a:pt x="21474" y="16772"/>
                  </a:cubicBezTo>
                  <a:cubicBezTo>
                    <a:pt x="21600" y="15288"/>
                    <a:pt x="21491" y="14508"/>
                    <a:pt x="21246" y="12912"/>
                  </a:cubicBezTo>
                  <a:close/>
                  <a:moveTo>
                    <a:pt x="21246" y="12912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9" name="AutoShape 41"/>
            <p:cNvSpPr>
              <a:spLocks/>
            </p:cNvSpPr>
            <p:nvPr/>
          </p:nvSpPr>
          <p:spPr bwMode="auto">
            <a:xfrm>
              <a:off x="905525" y="1851262"/>
              <a:ext cx="85604" cy="86142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0800" y="21600"/>
                  </a:moveTo>
                  <a:cubicBezTo>
                    <a:pt x="16767" y="21600"/>
                    <a:pt x="21600" y="16764"/>
                    <a:pt x="21600" y="10799"/>
                  </a:cubicBezTo>
                  <a:cubicBezTo>
                    <a:pt x="21600" y="4835"/>
                    <a:pt x="16767" y="0"/>
                    <a:pt x="10800" y="0"/>
                  </a:cubicBezTo>
                  <a:cubicBezTo>
                    <a:pt x="4835" y="0"/>
                    <a:pt x="0" y="4835"/>
                    <a:pt x="0" y="10799"/>
                  </a:cubicBezTo>
                  <a:cubicBezTo>
                    <a:pt x="0" y="16764"/>
                    <a:pt x="4835" y="21600"/>
                    <a:pt x="10800" y="21600"/>
                  </a:cubicBezTo>
                  <a:close/>
                  <a:moveTo>
                    <a:pt x="10800" y="2160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0" name="AutoShape 42"/>
            <p:cNvSpPr>
              <a:spLocks/>
            </p:cNvSpPr>
            <p:nvPr/>
          </p:nvSpPr>
          <p:spPr bwMode="auto">
            <a:xfrm>
              <a:off x="887345" y="2333051"/>
              <a:ext cx="53029" cy="214214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6464" y="19691"/>
                  </a:moveTo>
                  <a:cubicBezTo>
                    <a:pt x="6464" y="20745"/>
                    <a:pt x="9852" y="21600"/>
                    <a:pt x="14033" y="21600"/>
                  </a:cubicBezTo>
                  <a:cubicBezTo>
                    <a:pt x="18211" y="21600"/>
                    <a:pt x="21600" y="20745"/>
                    <a:pt x="21600" y="19691"/>
                  </a:cubicBezTo>
                  <a:lnTo>
                    <a:pt x="21600" y="9"/>
                  </a:lnTo>
                  <a:lnTo>
                    <a:pt x="0" y="0"/>
                  </a:lnTo>
                  <a:cubicBezTo>
                    <a:pt x="0" y="0"/>
                    <a:pt x="6464" y="19691"/>
                    <a:pt x="6464" y="19691"/>
                  </a:cubicBezTo>
                  <a:close/>
                  <a:moveTo>
                    <a:pt x="6464" y="1969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1" name="AutoShape 43"/>
            <p:cNvSpPr>
              <a:spLocks/>
            </p:cNvSpPr>
            <p:nvPr/>
          </p:nvSpPr>
          <p:spPr bwMode="auto">
            <a:xfrm>
              <a:off x="832801" y="1942740"/>
              <a:ext cx="224994" cy="603761"/>
            </a:xfrm>
            <a:custGeom>
              <a:avLst/>
              <a:gdLst/>
              <a:ahLst/>
              <a:cxnLst/>
              <a:rect l="0" t="0" r="r" b="b"/>
              <a:pathLst>
                <a:path w="21529" h="21600">
                  <a:moveTo>
                    <a:pt x="21395" y="7031"/>
                  </a:moveTo>
                  <a:cubicBezTo>
                    <a:pt x="21219" y="5733"/>
                    <a:pt x="20737" y="3296"/>
                    <a:pt x="19846" y="1848"/>
                  </a:cubicBezTo>
                  <a:lnTo>
                    <a:pt x="19739" y="1715"/>
                  </a:lnTo>
                  <a:cubicBezTo>
                    <a:pt x="19015" y="839"/>
                    <a:pt x="17437" y="196"/>
                    <a:pt x="15617" y="47"/>
                  </a:cubicBezTo>
                  <a:cubicBezTo>
                    <a:pt x="15617" y="47"/>
                    <a:pt x="15208" y="21"/>
                    <a:pt x="15000" y="17"/>
                  </a:cubicBezTo>
                  <a:cubicBezTo>
                    <a:pt x="14591" y="3"/>
                    <a:pt x="14244" y="0"/>
                    <a:pt x="14244" y="0"/>
                  </a:cubicBezTo>
                  <a:cubicBezTo>
                    <a:pt x="14229" y="13"/>
                    <a:pt x="14224" y="18"/>
                    <a:pt x="14200" y="28"/>
                  </a:cubicBezTo>
                  <a:cubicBezTo>
                    <a:pt x="13383" y="394"/>
                    <a:pt x="12143" y="625"/>
                    <a:pt x="10766" y="634"/>
                  </a:cubicBezTo>
                  <a:lnTo>
                    <a:pt x="10765" y="634"/>
                  </a:lnTo>
                  <a:cubicBezTo>
                    <a:pt x="9388" y="625"/>
                    <a:pt x="8148" y="394"/>
                    <a:pt x="7330" y="28"/>
                  </a:cubicBezTo>
                  <a:cubicBezTo>
                    <a:pt x="7307" y="18"/>
                    <a:pt x="7301" y="13"/>
                    <a:pt x="7286" y="0"/>
                  </a:cubicBezTo>
                  <a:cubicBezTo>
                    <a:pt x="7286" y="0"/>
                    <a:pt x="6940" y="3"/>
                    <a:pt x="6531" y="17"/>
                  </a:cubicBezTo>
                  <a:cubicBezTo>
                    <a:pt x="6323" y="21"/>
                    <a:pt x="5913" y="47"/>
                    <a:pt x="5913" y="47"/>
                  </a:cubicBezTo>
                  <a:cubicBezTo>
                    <a:pt x="4093" y="196"/>
                    <a:pt x="2515" y="839"/>
                    <a:pt x="1792" y="1715"/>
                  </a:cubicBezTo>
                  <a:lnTo>
                    <a:pt x="1684" y="1848"/>
                  </a:lnTo>
                  <a:cubicBezTo>
                    <a:pt x="794" y="3296"/>
                    <a:pt x="311" y="5733"/>
                    <a:pt x="136" y="7031"/>
                  </a:cubicBezTo>
                  <a:cubicBezTo>
                    <a:pt x="18" y="7901"/>
                    <a:pt x="-35" y="8326"/>
                    <a:pt x="26" y="9135"/>
                  </a:cubicBezTo>
                  <a:cubicBezTo>
                    <a:pt x="26" y="9704"/>
                    <a:pt x="1107" y="10132"/>
                    <a:pt x="2460" y="10105"/>
                  </a:cubicBezTo>
                  <a:lnTo>
                    <a:pt x="3675" y="3437"/>
                  </a:lnTo>
                  <a:cubicBezTo>
                    <a:pt x="3694" y="3328"/>
                    <a:pt x="3732" y="3242"/>
                    <a:pt x="3978" y="3228"/>
                  </a:cubicBezTo>
                  <a:cubicBezTo>
                    <a:pt x="4223" y="3214"/>
                    <a:pt x="4354" y="3262"/>
                    <a:pt x="4455" y="3363"/>
                  </a:cubicBezTo>
                  <a:cubicBezTo>
                    <a:pt x="4613" y="3521"/>
                    <a:pt x="5428" y="4669"/>
                    <a:pt x="4486" y="7503"/>
                  </a:cubicBezTo>
                  <a:cubicBezTo>
                    <a:pt x="4160" y="8479"/>
                    <a:pt x="3977" y="9389"/>
                    <a:pt x="3874" y="10155"/>
                  </a:cubicBezTo>
                  <a:cubicBezTo>
                    <a:pt x="3851" y="10404"/>
                    <a:pt x="3830" y="10697"/>
                    <a:pt x="3831" y="10898"/>
                  </a:cubicBezTo>
                  <a:cubicBezTo>
                    <a:pt x="3836" y="11703"/>
                    <a:pt x="3968" y="12959"/>
                    <a:pt x="4213" y="13663"/>
                  </a:cubicBezTo>
                  <a:lnTo>
                    <a:pt x="13402" y="13660"/>
                  </a:lnTo>
                  <a:lnTo>
                    <a:pt x="13426" y="13660"/>
                  </a:lnTo>
                  <a:lnTo>
                    <a:pt x="13426" y="13661"/>
                  </a:lnTo>
                  <a:cubicBezTo>
                    <a:pt x="13616" y="13666"/>
                    <a:pt x="13767" y="13724"/>
                    <a:pt x="13767" y="13797"/>
                  </a:cubicBezTo>
                  <a:cubicBezTo>
                    <a:pt x="13767" y="13870"/>
                    <a:pt x="13616" y="13928"/>
                    <a:pt x="13426" y="13933"/>
                  </a:cubicBezTo>
                  <a:lnTo>
                    <a:pt x="13426" y="13934"/>
                  </a:lnTo>
                  <a:lnTo>
                    <a:pt x="13402" y="13934"/>
                  </a:lnTo>
                  <a:lnTo>
                    <a:pt x="11451" y="13933"/>
                  </a:lnTo>
                  <a:lnTo>
                    <a:pt x="11451" y="20921"/>
                  </a:lnTo>
                  <a:lnTo>
                    <a:pt x="11451" y="20922"/>
                  </a:lnTo>
                  <a:cubicBezTo>
                    <a:pt x="11451" y="21296"/>
                    <a:pt x="12256" y="21600"/>
                    <a:pt x="13250" y="21600"/>
                  </a:cubicBezTo>
                  <a:cubicBezTo>
                    <a:pt x="14244" y="21600"/>
                    <a:pt x="15049" y="21296"/>
                    <a:pt x="15049" y="20922"/>
                  </a:cubicBezTo>
                  <a:lnTo>
                    <a:pt x="16498" y="13922"/>
                  </a:lnTo>
                  <a:lnTo>
                    <a:pt x="17208" y="13922"/>
                  </a:lnTo>
                  <a:cubicBezTo>
                    <a:pt x="17523" y="13318"/>
                    <a:pt x="17694" y="11815"/>
                    <a:pt x="17700" y="10898"/>
                  </a:cubicBezTo>
                  <a:cubicBezTo>
                    <a:pt x="17701" y="10683"/>
                    <a:pt x="17676" y="10364"/>
                    <a:pt x="17652" y="10104"/>
                  </a:cubicBezTo>
                  <a:cubicBezTo>
                    <a:pt x="17548" y="9349"/>
                    <a:pt x="17364" y="8457"/>
                    <a:pt x="17048" y="7503"/>
                  </a:cubicBezTo>
                  <a:cubicBezTo>
                    <a:pt x="16105" y="4669"/>
                    <a:pt x="16919" y="3521"/>
                    <a:pt x="17077" y="3363"/>
                  </a:cubicBezTo>
                  <a:cubicBezTo>
                    <a:pt x="17178" y="3262"/>
                    <a:pt x="17309" y="3214"/>
                    <a:pt x="17555" y="3228"/>
                  </a:cubicBezTo>
                  <a:cubicBezTo>
                    <a:pt x="17801" y="3242"/>
                    <a:pt x="17838" y="3328"/>
                    <a:pt x="17857" y="3437"/>
                  </a:cubicBezTo>
                  <a:lnTo>
                    <a:pt x="19073" y="10105"/>
                  </a:lnTo>
                  <a:cubicBezTo>
                    <a:pt x="20424" y="10131"/>
                    <a:pt x="21505" y="9704"/>
                    <a:pt x="21505" y="9135"/>
                  </a:cubicBezTo>
                  <a:cubicBezTo>
                    <a:pt x="21565" y="8326"/>
                    <a:pt x="21512" y="7901"/>
                    <a:pt x="21395" y="7031"/>
                  </a:cubicBezTo>
                  <a:close/>
                  <a:moveTo>
                    <a:pt x="21395" y="703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212045" y="2201934"/>
              <a:ext cx="368215" cy="292505"/>
            </a:xfrm>
            <a:prstGeom prst="rect">
              <a:avLst/>
            </a:prstGeom>
            <a:solidFill>
              <a:srgbClr val="FFFFFF"/>
            </a:solidFill>
            <a:ln w="25400" cap="flat" cmpd="sng" algn="ctr">
              <a:solidFill>
                <a:srgbClr val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3" name="AutoShape 10"/>
            <p:cNvSpPr>
              <a:spLocks/>
            </p:cNvSpPr>
            <p:nvPr/>
          </p:nvSpPr>
          <p:spPr bwMode="auto">
            <a:xfrm>
              <a:off x="1090609" y="1831457"/>
              <a:ext cx="688921" cy="715808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0698" y="14966"/>
                  </a:moveTo>
                  <a:cubicBezTo>
                    <a:pt x="10698" y="15196"/>
                    <a:pt x="10506" y="15382"/>
                    <a:pt x="10268" y="15382"/>
                  </a:cubicBezTo>
                  <a:lnTo>
                    <a:pt x="8580" y="15382"/>
                  </a:lnTo>
                  <a:cubicBezTo>
                    <a:pt x="8343" y="15382"/>
                    <a:pt x="8151" y="15196"/>
                    <a:pt x="8151" y="14966"/>
                  </a:cubicBezTo>
                  <a:lnTo>
                    <a:pt x="8151" y="13330"/>
                  </a:lnTo>
                  <a:cubicBezTo>
                    <a:pt x="8151" y="13100"/>
                    <a:pt x="8343" y="12914"/>
                    <a:pt x="8580" y="12914"/>
                  </a:cubicBezTo>
                  <a:lnTo>
                    <a:pt x="10268" y="12914"/>
                  </a:lnTo>
                  <a:cubicBezTo>
                    <a:pt x="10506" y="12914"/>
                    <a:pt x="10698" y="13100"/>
                    <a:pt x="10698" y="13330"/>
                  </a:cubicBezTo>
                  <a:cubicBezTo>
                    <a:pt x="10698" y="13330"/>
                    <a:pt x="10698" y="14966"/>
                    <a:pt x="10698" y="14966"/>
                  </a:cubicBezTo>
                  <a:close/>
                  <a:moveTo>
                    <a:pt x="10698" y="18345"/>
                  </a:moveTo>
                  <a:cubicBezTo>
                    <a:pt x="10698" y="18575"/>
                    <a:pt x="10506" y="18761"/>
                    <a:pt x="10268" y="18761"/>
                  </a:cubicBezTo>
                  <a:lnTo>
                    <a:pt x="8580" y="18761"/>
                  </a:lnTo>
                  <a:cubicBezTo>
                    <a:pt x="8343" y="18761"/>
                    <a:pt x="8151" y="18575"/>
                    <a:pt x="8151" y="18345"/>
                  </a:cubicBezTo>
                  <a:lnTo>
                    <a:pt x="8151" y="16709"/>
                  </a:lnTo>
                  <a:cubicBezTo>
                    <a:pt x="8151" y="16479"/>
                    <a:pt x="8343" y="16294"/>
                    <a:pt x="8580" y="16294"/>
                  </a:cubicBezTo>
                  <a:lnTo>
                    <a:pt x="10268" y="16294"/>
                  </a:lnTo>
                  <a:cubicBezTo>
                    <a:pt x="10506" y="16294"/>
                    <a:pt x="10698" y="16479"/>
                    <a:pt x="10698" y="16709"/>
                  </a:cubicBezTo>
                  <a:cubicBezTo>
                    <a:pt x="10698" y="16709"/>
                    <a:pt x="10698" y="18345"/>
                    <a:pt x="10698" y="18345"/>
                  </a:cubicBezTo>
                  <a:close/>
                  <a:moveTo>
                    <a:pt x="7192" y="14966"/>
                  </a:moveTo>
                  <a:cubicBezTo>
                    <a:pt x="7192" y="15196"/>
                    <a:pt x="7000" y="15382"/>
                    <a:pt x="6763" y="15382"/>
                  </a:cubicBezTo>
                  <a:lnTo>
                    <a:pt x="5074" y="15382"/>
                  </a:lnTo>
                  <a:cubicBezTo>
                    <a:pt x="4837" y="15382"/>
                    <a:pt x="4645" y="15196"/>
                    <a:pt x="4645" y="14966"/>
                  </a:cubicBezTo>
                  <a:lnTo>
                    <a:pt x="4645" y="13330"/>
                  </a:lnTo>
                  <a:cubicBezTo>
                    <a:pt x="4645" y="13100"/>
                    <a:pt x="4837" y="12914"/>
                    <a:pt x="5074" y="12914"/>
                  </a:cubicBezTo>
                  <a:lnTo>
                    <a:pt x="6763" y="12914"/>
                  </a:lnTo>
                  <a:cubicBezTo>
                    <a:pt x="7000" y="12914"/>
                    <a:pt x="7192" y="13100"/>
                    <a:pt x="7192" y="13330"/>
                  </a:cubicBezTo>
                  <a:cubicBezTo>
                    <a:pt x="7192" y="13330"/>
                    <a:pt x="7192" y="14966"/>
                    <a:pt x="7192" y="14966"/>
                  </a:cubicBezTo>
                  <a:close/>
                  <a:moveTo>
                    <a:pt x="7192" y="18345"/>
                  </a:moveTo>
                  <a:cubicBezTo>
                    <a:pt x="7192" y="18575"/>
                    <a:pt x="7000" y="18761"/>
                    <a:pt x="6763" y="18761"/>
                  </a:cubicBezTo>
                  <a:lnTo>
                    <a:pt x="5074" y="18761"/>
                  </a:lnTo>
                  <a:cubicBezTo>
                    <a:pt x="4837" y="18761"/>
                    <a:pt x="4645" y="18575"/>
                    <a:pt x="4645" y="18345"/>
                  </a:cubicBezTo>
                  <a:lnTo>
                    <a:pt x="4645" y="16709"/>
                  </a:lnTo>
                  <a:cubicBezTo>
                    <a:pt x="4645" y="16479"/>
                    <a:pt x="4837" y="16294"/>
                    <a:pt x="5074" y="16294"/>
                  </a:cubicBezTo>
                  <a:lnTo>
                    <a:pt x="6763" y="16294"/>
                  </a:lnTo>
                  <a:cubicBezTo>
                    <a:pt x="7000" y="16294"/>
                    <a:pt x="7192" y="16479"/>
                    <a:pt x="7192" y="16709"/>
                  </a:cubicBezTo>
                  <a:cubicBezTo>
                    <a:pt x="7192" y="16709"/>
                    <a:pt x="7192" y="18345"/>
                    <a:pt x="7192" y="18345"/>
                  </a:cubicBezTo>
                  <a:close/>
                  <a:moveTo>
                    <a:pt x="10753" y="0"/>
                  </a:moveTo>
                  <a:lnTo>
                    <a:pt x="4656" y="6577"/>
                  </a:lnTo>
                  <a:lnTo>
                    <a:pt x="4656" y="5401"/>
                  </a:lnTo>
                  <a:lnTo>
                    <a:pt x="2195" y="5401"/>
                  </a:lnTo>
                  <a:lnTo>
                    <a:pt x="2195" y="9232"/>
                  </a:lnTo>
                  <a:lnTo>
                    <a:pt x="0" y="11599"/>
                  </a:lnTo>
                  <a:lnTo>
                    <a:pt x="1991" y="11598"/>
                  </a:lnTo>
                  <a:lnTo>
                    <a:pt x="1991" y="21600"/>
                  </a:lnTo>
                  <a:lnTo>
                    <a:pt x="18945" y="21600"/>
                  </a:lnTo>
                  <a:lnTo>
                    <a:pt x="18945" y="11582"/>
                  </a:lnTo>
                  <a:lnTo>
                    <a:pt x="21600" y="11579"/>
                  </a:lnTo>
                  <a:cubicBezTo>
                    <a:pt x="21600" y="11579"/>
                    <a:pt x="10753" y="0"/>
                    <a:pt x="10753" y="0"/>
                  </a:cubicBezTo>
                  <a:close/>
                  <a:moveTo>
                    <a:pt x="10753" y="0"/>
                  </a:moveTo>
                </a:path>
              </a:pathLst>
            </a:custGeom>
            <a:solidFill>
              <a:srgbClr val="83C9BF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7865389" y="4969231"/>
            <a:ext cx="781392" cy="558048"/>
            <a:chOff x="4894216" y="1839674"/>
            <a:chExt cx="1053002" cy="693249"/>
          </a:xfrm>
        </p:grpSpPr>
        <p:sp>
          <p:nvSpPr>
            <p:cNvPr id="75" name="AutoShape 12"/>
            <p:cNvSpPr>
              <a:spLocks/>
            </p:cNvSpPr>
            <p:nvPr/>
          </p:nvSpPr>
          <p:spPr bwMode="auto">
            <a:xfrm flipH="1">
              <a:off x="5249885" y="1956400"/>
              <a:ext cx="697333" cy="576523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7841" y="16073"/>
                  </a:moveTo>
                  <a:cubicBezTo>
                    <a:pt x="17841" y="16596"/>
                    <a:pt x="17520" y="17019"/>
                    <a:pt x="17125" y="17019"/>
                  </a:cubicBezTo>
                  <a:lnTo>
                    <a:pt x="15692" y="17019"/>
                  </a:lnTo>
                  <a:cubicBezTo>
                    <a:pt x="15297" y="17019"/>
                    <a:pt x="14976" y="16596"/>
                    <a:pt x="14976" y="16073"/>
                  </a:cubicBezTo>
                  <a:lnTo>
                    <a:pt x="14976" y="14179"/>
                  </a:lnTo>
                  <a:cubicBezTo>
                    <a:pt x="14976" y="13656"/>
                    <a:pt x="15297" y="13231"/>
                    <a:pt x="15692" y="13231"/>
                  </a:cubicBezTo>
                  <a:lnTo>
                    <a:pt x="17125" y="13231"/>
                  </a:lnTo>
                  <a:cubicBezTo>
                    <a:pt x="17520" y="13231"/>
                    <a:pt x="17841" y="13656"/>
                    <a:pt x="17841" y="14179"/>
                  </a:cubicBezTo>
                  <a:cubicBezTo>
                    <a:pt x="17841" y="14179"/>
                    <a:pt x="17841" y="16073"/>
                    <a:pt x="17841" y="16073"/>
                  </a:cubicBezTo>
                  <a:close/>
                  <a:moveTo>
                    <a:pt x="13633" y="16073"/>
                  </a:moveTo>
                  <a:cubicBezTo>
                    <a:pt x="13633" y="16596"/>
                    <a:pt x="13312" y="17019"/>
                    <a:pt x="12917" y="17019"/>
                  </a:cubicBezTo>
                  <a:lnTo>
                    <a:pt x="11484" y="17019"/>
                  </a:lnTo>
                  <a:cubicBezTo>
                    <a:pt x="11089" y="17019"/>
                    <a:pt x="10768" y="16596"/>
                    <a:pt x="10768" y="16073"/>
                  </a:cubicBezTo>
                  <a:lnTo>
                    <a:pt x="10768" y="14179"/>
                  </a:lnTo>
                  <a:cubicBezTo>
                    <a:pt x="10768" y="13656"/>
                    <a:pt x="11089" y="13231"/>
                    <a:pt x="11484" y="13231"/>
                  </a:cubicBezTo>
                  <a:lnTo>
                    <a:pt x="12917" y="13231"/>
                  </a:lnTo>
                  <a:cubicBezTo>
                    <a:pt x="13312" y="13231"/>
                    <a:pt x="13633" y="13656"/>
                    <a:pt x="13633" y="14179"/>
                  </a:cubicBezTo>
                  <a:cubicBezTo>
                    <a:pt x="13633" y="14179"/>
                    <a:pt x="13633" y="16073"/>
                    <a:pt x="13633" y="16073"/>
                  </a:cubicBezTo>
                  <a:close/>
                  <a:moveTo>
                    <a:pt x="9425" y="16073"/>
                  </a:moveTo>
                  <a:cubicBezTo>
                    <a:pt x="9425" y="16596"/>
                    <a:pt x="9104" y="17019"/>
                    <a:pt x="8709" y="17019"/>
                  </a:cubicBezTo>
                  <a:lnTo>
                    <a:pt x="7276" y="17019"/>
                  </a:lnTo>
                  <a:cubicBezTo>
                    <a:pt x="6881" y="17019"/>
                    <a:pt x="6561" y="16596"/>
                    <a:pt x="6561" y="16073"/>
                  </a:cubicBezTo>
                  <a:lnTo>
                    <a:pt x="6561" y="14179"/>
                  </a:lnTo>
                  <a:cubicBezTo>
                    <a:pt x="6561" y="13656"/>
                    <a:pt x="6881" y="13231"/>
                    <a:pt x="7276" y="13231"/>
                  </a:cubicBezTo>
                  <a:lnTo>
                    <a:pt x="8709" y="13231"/>
                  </a:lnTo>
                  <a:cubicBezTo>
                    <a:pt x="9104" y="13231"/>
                    <a:pt x="9425" y="13656"/>
                    <a:pt x="9425" y="14179"/>
                  </a:cubicBezTo>
                  <a:cubicBezTo>
                    <a:pt x="9425" y="14179"/>
                    <a:pt x="9425" y="16073"/>
                    <a:pt x="9425" y="16073"/>
                  </a:cubicBezTo>
                  <a:close/>
                  <a:moveTo>
                    <a:pt x="19809" y="7715"/>
                  </a:moveTo>
                  <a:lnTo>
                    <a:pt x="14265" y="7715"/>
                  </a:lnTo>
                  <a:cubicBezTo>
                    <a:pt x="14253" y="7717"/>
                    <a:pt x="14241" y="7720"/>
                    <a:pt x="14229" y="7720"/>
                  </a:cubicBezTo>
                  <a:lnTo>
                    <a:pt x="4957" y="7720"/>
                  </a:lnTo>
                  <a:cubicBezTo>
                    <a:pt x="4134" y="7720"/>
                    <a:pt x="3465" y="8604"/>
                    <a:pt x="3465" y="9692"/>
                  </a:cubicBezTo>
                  <a:lnTo>
                    <a:pt x="3465" y="13981"/>
                  </a:lnTo>
                  <a:cubicBezTo>
                    <a:pt x="3465" y="14199"/>
                    <a:pt x="3331" y="14375"/>
                    <a:pt x="3166" y="14375"/>
                  </a:cubicBezTo>
                  <a:cubicBezTo>
                    <a:pt x="3002" y="14375"/>
                    <a:pt x="2868" y="14199"/>
                    <a:pt x="2868" y="13981"/>
                  </a:cubicBezTo>
                  <a:lnTo>
                    <a:pt x="2868" y="9692"/>
                  </a:lnTo>
                  <a:cubicBezTo>
                    <a:pt x="2868" y="8169"/>
                    <a:pt x="3805" y="6930"/>
                    <a:pt x="4957" y="6930"/>
                  </a:cubicBezTo>
                  <a:lnTo>
                    <a:pt x="14229" y="6930"/>
                  </a:lnTo>
                  <a:cubicBezTo>
                    <a:pt x="14231" y="6930"/>
                    <a:pt x="14232" y="6931"/>
                    <a:pt x="14234" y="6931"/>
                  </a:cubicBezTo>
                  <a:lnTo>
                    <a:pt x="14234" y="2367"/>
                  </a:lnTo>
                  <a:cubicBezTo>
                    <a:pt x="14234" y="1060"/>
                    <a:pt x="13432" y="0"/>
                    <a:pt x="12443" y="0"/>
                  </a:cubicBezTo>
                  <a:lnTo>
                    <a:pt x="1790" y="0"/>
                  </a:lnTo>
                  <a:cubicBezTo>
                    <a:pt x="802" y="0"/>
                    <a:pt x="0" y="1060"/>
                    <a:pt x="0" y="2367"/>
                  </a:cubicBezTo>
                  <a:lnTo>
                    <a:pt x="0" y="19233"/>
                  </a:lnTo>
                  <a:cubicBezTo>
                    <a:pt x="0" y="20292"/>
                    <a:pt x="527" y="21298"/>
                    <a:pt x="1253" y="21600"/>
                  </a:cubicBezTo>
                  <a:lnTo>
                    <a:pt x="19809" y="21600"/>
                  </a:lnTo>
                  <a:cubicBezTo>
                    <a:pt x="20799" y="21600"/>
                    <a:pt x="21600" y="20540"/>
                    <a:pt x="21600" y="19233"/>
                  </a:cubicBezTo>
                  <a:lnTo>
                    <a:pt x="21600" y="10082"/>
                  </a:lnTo>
                  <a:cubicBezTo>
                    <a:pt x="21600" y="8775"/>
                    <a:pt x="20799" y="7715"/>
                    <a:pt x="19809" y="7715"/>
                  </a:cubicBezTo>
                  <a:close/>
                  <a:moveTo>
                    <a:pt x="19809" y="7715"/>
                  </a:moveTo>
                </a:path>
              </a:pathLst>
            </a:custGeom>
            <a:solidFill>
              <a:srgbClr val="1E9D8B">
                <a:alpha val="45098"/>
              </a:srgbClr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algn="l" defTabSz="91430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7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grpSp>
          <p:nvGrpSpPr>
            <p:cNvPr id="76" name="Group 25"/>
            <p:cNvGrpSpPr/>
            <p:nvPr/>
          </p:nvGrpSpPr>
          <p:grpSpPr>
            <a:xfrm>
              <a:off x="4894216" y="1839674"/>
              <a:ext cx="236475" cy="693249"/>
              <a:chOff x="3178434" y="2040176"/>
              <a:chExt cx="157713" cy="462351"/>
            </a:xfrm>
          </p:grpSpPr>
          <p:sp>
            <p:nvSpPr>
              <p:cNvPr id="77" name="AutoShape 23"/>
              <p:cNvSpPr>
                <a:spLocks/>
              </p:cNvSpPr>
              <p:nvPr/>
            </p:nvSpPr>
            <p:spPr bwMode="auto">
              <a:xfrm>
                <a:off x="3223495" y="2040176"/>
                <a:ext cx="57131" cy="57490"/>
              </a:xfrm>
              <a:custGeom>
                <a:avLst/>
                <a:gdLst/>
                <a:ahLst/>
                <a:cxnLst/>
                <a:rect l="0" t="0" r="r" b="b"/>
                <a:pathLst>
                  <a:path w="21600" h="21600">
                    <a:moveTo>
                      <a:pt x="10799" y="21600"/>
                    </a:moveTo>
                    <a:cubicBezTo>
                      <a:pt x="16761" y="21600"/>
                      <a:pt x="21600" y="16767"/>
                      <a:pt x="21600" y="10804"/>
                    </a:cubicBezTo>
                    <a:cubicBezTo>
                      <a:pt x="21600" y="4838"/>
                      <a:pt x="16761" y="0"/>
                      <a:pt x="10799" y="0"/>
                    </a:cubicBezTo>
                    <a:cubicBezTo>
                      <a:pt x="4834" y="0"/>
                      <a:pt x="0" y="4838"/>
                      <a:pt x="0" y="10804"/>
                    </a:cubicBezTo>
                    <a:cubicBezTo>
                      <a:pt x="0" y="16767"/>
                      <a:pt x="4834" y="21600"/>
                      <a:pt x="10799" y="21600"/>
                    </a:cubicBezTo>
                    <a:close/>
                    <a:moveTo>
                      <a:pt x="10799" y="21600"/>
                    </a:moveTo>
                  </a:path>
                </a:pathLst>
              </a:custGeom>
              <a:solidFill>
                <a:srgbClr val="B6BF00"/>
              </a:solidFill>
              <a:ln>
                <a:noFill/>
              </a:ln>
            </p:spPr>
            <p:txBody>
              <a:bodyPr lIns="0" tIns="0" rIns="0" bIns="0"/>
              <a:lstStyle/>
              <a:p>
                <a:pPr marL="0" marR="0" lvl="0" indent="0" algn="l" defTabSz="91430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799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8" name="AutoShape 24"/>
              <p:cNvSpPr>
                <a:spLocks/>
              </p:cNvSpPr>
              <p:nvPr/>
            </p:nvSpPr>
            <p:spPr bwMode="auto">
              <a:xfrm>
                <a:off x="3210620" y="2318720"/>
                <a:ext cx="39428" cy="183807"/>
              </a:xfrm>
              <a:custGeom>
                <a:avLst/>
                <a:gdLst/>
                <a:ahLst/>
                <a:cxnLst/>
                <a:rect l="0" t="0" r="r" b="b"/>
                <a:pathLst>
                  <a:path w="21450" h="21569">
                    <a:moveTo>
                      <a:pt x="5" y="19531"/>
                    </a:moveTo>
                    <a:cubicBezTo>
                      <a:pt x="-150" y="20622"/>
                      <a:pt x="3776" y="21534"/>
                      <a:pt x="8766" y="21568"/>
                    </a:cubicBezTo>
                    <a:cubicBezTo>
                      <a:pt x="13756" y="21600"/>
                      <a:pt x="17923" y="20741"/>
                      <a:pt x="18064" y="19648"/>
                    </a:cubicBezTo>
                    <a:lnTo>
                      <a:pt x="18946" y="16256"/>
                    </a:lnTo>
                    <a:lnTo>
                      <a:pt x="21450" y="0"/>
                    </a:lnTo>
                    <a:lnTo>
                      <a:pt x="236" y="0"/>
                    </a:lnTo>
                    <a:cubicBezTo>
                      <a:pt x="236" y="0"/>
                      <a:pt x="5" y="19531"/>
                      <a:pt x="5" y="19531"/>
                    </a:cubicBezTo>
                    <a:close/>
                    <a:moveTo>
                      <a:pt x="5" y="19531"/>
                    </a:moveTo>
                  </a:path>
                </a:pathLst>
              </a:custGeom>
              <a:solidFill>
                <a:srgbClr val="B6BF00"/>
              </a:solidFill>
              <a:ln>
                <a:noFill/>
              </a:ln>
            </p:spPr>
            <p:txBody>
              <a:bodyPr lIns="0" tIns="0" rIns="0" bIns="0"/>
              <a:lstStyle/>
              <a:p>
                <a:pPr marL="0" marR="0" lvl="0" indent="0" algn="l" defTabSz="91430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799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9" name="AutoShape 25"/>
              <p:cNvSpPr>
                <a:spLocks/>
              </p:cNvSpPr>
              <p:nvPr/>
            </p:nvSpPr>
            <p:spPr bwMode="auto">
              <a:xfrm>
                <a:off x="3236369" y="2104954"/>
                <a:ext cx="36210" cy="50202"/>
              </a:xfrm>
              <a:custGeom>
                <a:avLst/>
                <a:gdLst/>
                <a:ahLst/>
                <a:cxnLst/>
                <a:rect l="0" t="0" r="r" b="b"/>
                <a:pathLst>
                  <a:path w="21600" h="21600">
                    <a:moveTo>
                      <a:pt x="0" y="0"/>
                    </a:moveTo>
                    <a:lnTo>
                      <a:pt x="3576" y="18180"/>
                    </a:lnTo>
                    <a:cubicBezTo>
                      <a:pt x="4011" y="20226"/>
                      <a:pt x="6476" y="21233"/>
                      <a:pt x="8632" y="21491"/>
                    </a:cubicBezTo>
                    <a:cubicBezTo>
                      <a:pt x="9241" y="21565"/>
                      <a:pt x="9943" y="21600"/>
                      <a:pt x="10739" y="21600"/>
                    </a:cubicBezTo>
                    <a:cubicBezTo>
                      <a:pt x="12051" y="21600"/>
                      <a:pt x="13151" y="21496"/>
                      <a:pt x="13214" y="21491"/>
                    </a:cubicBezTo>
                    <a:cubicBezTo>
                      <a:pt x="17489" y="21009"/>
                      <a:pt x="17946" y="18878"/>
                      <a:pt x="18095" y="18140"/>
                    </a:cubicBezTo>
                    <a:lnTo>
                      <a:pt x="21600" y="41"/>
                    </a:lnTo>
                    <a:cubicBezTo>
                      <a:pt x="18515" y="1372"/>
                      <a:pt x="14821" y="2168"/>
                      <a:pt x="10855" y="2216"/>
                    </a:cubicBezTo>
                    <a:lnTo>
                      <a:pt x="10832" y="2216"/>
                    </a:lnTo>
                    <a:cubicBezTo>
                      <a:pt x="6829" y="2168"/>
                      <a:pt x="3103" y="1356"/>
                      <a:pt x="0" y="0"/>
                    </a:cubicBezTo>
                    <a:close/>
                    <a:moveTo>
                      <a:pt x="0" y="0"/>
                    </a:moveTo>
                  </a:path>
                </a:pathLst>
              </a:custGeom>
              <a:solidFill>
                <a:srgbClr val="B6BF00"/>
              </a:solidFill>
              <a:ln>
                <a:noFill/>
              </a:ln>
            </p:spPr>
            <p:txBody>
              <a:bodyPr lIns="0" tIns="0" rIns="0" bIns="0"/>
              <a:lstStyle/>
              <a:p>
                <a:pPr marL="0" marR="0" lvl="0" indent="0" algn="l" defTabSz="91430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799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80" name="AutoShape 26"/>
              <p:cNvSpPr>
                <a:spLocks/>
              </p:cNvSpPr>
              <p:nvPr/>
            </p:nvSpPr>
            <p:spPr bwMode="auto">
              <a:xfrm>
                <a:off x="3178434" y="2098476"/>
                <a:ext cx="157713" cy="403242"/>
              </a:xfrm>
              <a:custGeom>
                <a:avLst/>
                <a:gdLst/>
                <a:ahLst/>
                <a:cxnLst/>
                <a:rect l="0" t="0" r="r" b="b"/>
                <a:pathLst>
                  <a:path w="21529" h="21586">
                    <a:moveTo>
                      <a:pt x="17401" y="2359"/>
                    </a:moveTo>
                    <a:lnTo>
                      <a:pt x="15203" y="2359"/>
                    </a:lnTo>
                    <a:cubicBezTo>
                      <a:pt x="15007" y="2359"/>
                      <a:pt x="14849" y="2296"/>
                      <a:pt x="14849" y="2219"/>
                    </a:cubicBezTo>
                    <a:cubicBezTo>
                      <a:pt x="14849" y="2142"/>
                      <a:pt x="15007" y="2079"/>
                      <a:pt x="15203" y="2079"/>
                    </a:cubicBezTo>
                    <a:lnTo>
                      <a:pt x="17401" y="2079"/>
                    </a:lnTo>
                    <a:cubicBezTo>
                      <a:pt x="17597" y="2079"/>
                      <a:pt x="17756" y="2142"/>
                      <a:pt x="17756" y="2219"/>
                    </a:cubicBezTo>
                    <a:cubicBezTo>
                      <a:pt x="17756" y="2296"/>
                      <a:pt x="17597" y="2359"/>
                      <a:pt x="17401" y="2359"/>
                    </a:cubicBezTo>
                    <a:close/>
                    <a:moveTo>
                      <a:pt x="21393" y="6761"/>
                    </a:moveTo>
                    <a:cubicBezTo>
                      <a:pt x="21217" y="5515"/>
                      <a:pt x="20736" y="3164"/>
                      <a:pt x="19844" y="1775"/>
                    </a:cubicBezTo>
                    <a:lnTo>
                      <a:pt x="19737" y="1647"/>
                    </a:lnTo>
                    <a:cubicBezTo>
                      <a:pt x="19016" y="806"/>
                      <a:pt x="17437" y="188"/>
                      <a:pt x="15617" y="45"/>
                    </a:cubicBezTo>
                    <a:cubicBezTo>
                      <a:pt x="15617" y="45"/>
                      <a:pt x="15207" y="20"/>
                      <a:pt x="15000" y="17"/>
                    </a:cubicBezTo>
                    <a:cubicBezTo>
                      <a:pt x="14591" y="3"/>
                      <a:pt x="14246" y="0"/>
                      <a:pt x="14246" y="0"/>
                    </a:cubicBezTo>
                    <a:cubicBezTo>
                      <a:pt x="14233" y="10"/>
                      <a:pt x="14223" y="15"/>
                      <a:pt x="14209" y="22"/>
                    </a:cubicBezTo>
                    <a:lnTo>
                      <a:pt x="13267" y="2684"/>
                    </a:lnTo>
                    <a:cubicBezTo>
                      <a:pt x="13109" y="3083"/>
                      <a:pt x="12440" y="3336"/>
                      <a:pt x="11383" y="3397"/>
                    </a:cubicBezTo>
                    <a:lnTo>
                      <a:pt x="11188" y="3408"/>
                    </a:lnTo>
                    <a:lnTo>
                      <a:pt x="11188" y="4675"/>
                    </a:lnTo>
                    <a:lnTo>
                      <a:pt x="11315" y="4699"/>
                    </a:lnTo>
                    <a:cubicBezTo>
                      <a:pt x="11779" y="4788"/>
                      <a:pt x="12079" y="4981"/>
                      <a:pt x="12079" y="5191"/>
                    </a:cubicBezTo>
                    <a:cubicBezTo>
                      <a:pt x="12079" y="5491"/>
                      <a:pt x="11487" y="5734"/>
                      <a:pt x="10761" y="5734"/>
                    </a:cubicBezTo>
                    <a:cubicBezTo>
                      <a:pt x="10035" y="5734"/>
                      <a:pt x="9445" y="5491"/>
                      <a:pt x="9445" y="5191"/>
                    </a:cubicBezTo>
                    <a:cubicBezTo>
                      <a:pt x="9445" y="4981"/>
                      <a:pt x="9744" y="4788"/>
                      <a:pt x="10208" y="4699"/>
                    </a:cubicBezTo>
                    <a:lnTo>
                      <a:pt x="10336" y="4675"/>
                    </a:lnTo>
                    <a:lnTo>
                      <a:pt x="10336" y="3409"/>
                    </a:lnTo>
                    <a:lnTo>
                      <a:pt x="10144" y="3396"/>
                    </a:lnTo>
                    <a:cubicBezTo>
                      <a:pt x="9128" y="3332"/>
                      <a:pt x="8406" y="3059"/>
                      <a:pt x="8257" y="2683"/>
                    </a:cubicBezTo>
                    <a:lnTo>
                      <a:pt x="7313" y="17"/>
                    </a:lnTo>
                    <a:cubicBezTo>
                      <a:pt x="7304" y="13"/>
                      <a:pt x="7295" y="8"/>
                      <a:pt x="7284" y="0"/>
                    </a:cubicBezTo>
                    <a:cubicBezTo>
                      <a:pt x="7284" y="0"/>
                      <a:pt x="6938" y="3"/>
                      <a:pt x="6529" y="17"/>
                    </a:cubicBezTo>
                    <a:cubicBezTo>
                      <a:pt x="6323" y="20"/>
                      <a:pt x="5912" y="45"/>
                      <a:pt x="5912" y="45"/>
                    </a:cubicBezTo>
                    <a:cubicBezTo>
                      <a:pt x="4092" y="188"/>
                      <a:pt x="2514" y="806"/>
                      <a:pt x="1791" y="1647"/>
                    </a:cubicBezTo>
                    <a:lnTo>
                      <a:pt x="1684" y="1775"/>
                    </a:lnTo>
                    <a:cubicBezTo>
                      <a:pt x="792" y="3164"/>
                      <a:pt x="310" y="5515"/>
                      <a:pt x="136" y="6761"/>
                    </a:cubicBezTo>
                    <a:cubicBezTo>
                      <a:pt x="19" y="7597"/>
                      <a:pt x="-35" y="8005"/>
                      <a:pt x="25" y="8782"/>
                    </a:cubicBezTo>
                    <a:cubicBezTo>
                      <a:pt x="25" y="9328"/>
                      <a:pt x="1110" y="9740"/>
                      <a:pt x="2464" y="9713"/>
                    </a:cubicBezTo>
                    <a:lnTo>
                      <a:pt x="3581" y="3754"/>
                    </a:lnTo>
                    <a:cubicBezTo>
                      <a:pt x="3595" y="3630"/>
                      <a:pt x="3851" y="3531"/>
                      <a:pt x="4167" y="3531"/>
                    </a:cubicBezTo>
                    <a:cubicBezTo>
                      <a:pt x="4172" y="3531"/>
                      <a:pt x="4175" y="3532"/>
                      <a:pt x="4179" y="3532"/>
                    </a:cubicBezTo>
                    <a:lnTo>
                      <a:pt x="4061" y="11438"/>
                    </a:lnTo>
                    <a:lnTo>
                      <a:pt x="13011" y="11438"/>
                    </a:lnTo>
                    <a:cubicBezTo>
                      <a:pt x="13207" y="11438"/>
                      <a:pt x="13365" y="11500"/>
                      <a:pt x="13365" y="11578"/>
                    </a:cubicBezTo>
                    <a:cubicBezTo>
                      <a:pt x="13365" y="11655"/>
                      <a:pt x="13207" y="11717"/>
                      <a:pt x="13011" y="11717"/>
                    </a:cubicBezTo>
                    <a:lnTo>
                      <a:pt x="11393" y="11717"/>
                    </a:lnTo>
                    <a:lnTo>
                      <a:pt x="12051" y="19391"/>
                    </a:lnTo>
                    <a:lnTo>
                      <a:pt x="12239" y="20707"/>
                    </a:lnTo>
                    <a:cubicBezTo>
                      <a:pt x="12276" y="21207"/>
                      <a:pt x="13334" y="21600"/>
                      <a:pt x="14601" y="21586"/>
                    </a:cubicBezTo>
                    <a:cubicBezTo>
                      <a:pt x="15868" y="21570"/>
                      <a:pt x="16867" y="21153"/>
                      <a:pt x="16830" y="20654"/>
                    </a:cubicBezTo>
                    <a:lnTo>
                      <a:pt x="16773" y="11585"/>
                    </a:lnTo>
                    <a:lnTo>
                      <a:pt x="17441" y="11585"/>
                    </a:lnTo>
                    <a:lnTo>
                      <a:pt x="17322" y="3534"/>
                    </a:lnTo>
                    <a:cubicBezTo>
                      <a:pt x="17334" y="3534"/>
                      <a:pt x="17345" y="3531"/>
                      <a:pt x="17359" y="3531"/>
                    </a:cubicBezTo>
                    <a:cubicBezTo>
                      <a:pt x="17677" y="3531"/>
                      <a:pt x="17935" y="3630"/>
                      <a:pt x="17947" y="3754"/>
                    </a:cubicBezTo>
                    <a:lnTo>
                      <a:pt x="19065" y="9713"/>
                    </a:lnTo>
                    <a:cubicBezTo>
                      <a:pt x="20420" y="9740"/>
                      <a:pt x="21504" y="9328"/>
                      <a:pt x="21504" y="8782"/>
                    </a:cubicBezTo>
                    <a:cubicBezTo>
                      <a:pt x="21565" y="8005"/>
                      <a:pt x="21511" y="7597"/>
                      <a:pt x="21393" y="6761"/>
                    </a:cubicBezTo>
                    <a:close/>
                    <a:moveTo>
                      <a:pt x="21393" y="6761"/>
                    </a:moveTo>
                  </a:path>
                </a:pathLst>
              </a:custGeom>
              <a:solidFill>
                <a:srgbClr val="B6BF00"/>
              </a:solidFill>
              <a:ln>
                <a:noFill/>
              </a:ln>
            </p:spPr>
            <p:txBody>
              <a:bodyPr lIns="0" tIns="0" rIns="0" bIns="0"/>
              <a:lstStyle/>
              <a:p>
                <a:pPr marL="0" marR="0" lvl="0" indent="0" algn="l" defTabSz="91430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799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</p:grpSp>
      <p:sp>
        <p:nvSpPr>
          <p:cNvPr id="81" name="TextBox 80"/>
          <p:cNvSpPr txBox="1"/>
          <p:nvPr/>
        </p:nvSpPr>
        <p:spPr>
          <a:xfrm flipH="1">
            <a:off x="7834758" y="2268279"/>
            <a:ext cx="935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Physicians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2" name="TextBox 81"/>
          <p:cNvSpPr txBox="1"/>
          <p:nvPr/>
        </p:nvSpPr>
        <p:spPr>
          <a:xfrm flipH="1">
            <a:off x="10321405" y="3906477"/>
            <a:ext cx="1417782" cy="2730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Discharged patients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698421" y="3222532"/>
            <a:ext cx="1651737" cy="8190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rgbClr val="1E9D8B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AMA Applications System</a:t>
            </a:r>
          </a:p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rgbClr val="1E9D8B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+</a:t>
            </a:r>
          </a:p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rgbClr val="1E9D8B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loud Platform</a:t>
            </a:r>
          </a:p>
        </p:txBody>
      </p:sp>
      <p:sp>
        <p:nvSpPr>
          <p:cNvPr id="84" name="Rounded Rectangle 83"/>
          <p:cNvSpPr/>
          <p:nvPr/>
        </p:nvSpPr>
        <p:spPr>
          <a:xfrm>
            <a:off x="4245997" y="2683932"/>
            <a:ext cx="2626486" cy="1629601"/>
          </a:xfrm>
          <a:prstGeom prst="roundRect">
            <a:avLst/>
          </a:prstGeom>
          <a:noFill/>
          <a:ln w="25400" cap="flat" cmpd="sng" algn="ctr">
            <a:solidFill>
              <a:srgbClr val="FFFFFF">
                <a:lumMod val="50000"/>
              </a:srgbClr>
            </a:solidFill>
            <a:prstDash val="dash"/>
          </a:ln>
          <a:effectLst/>
        </p:spPr>
        <p:txBody>
          <a:bodyPr rtlCol="0" anchor="ctr"/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799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5" name="Rounded Rectangular Callout 84"/>
          <p:cNvSpPr/>
          <p:nvPr/>
        </p:nvSpPr>
        <p:spPr>
          <a:xfrm>
            <a:off x="6831276" y="1278587"/>
            <a:ext cx="771458" cy="385483"/>
          </a:xfrm>
          <a:prstGeom prst="wedgeRoundRectCallout">
            <a:avLst>
              <a:gd name="adj1" fmla="val 39856"/>
              <a:gd name="adj2" fmla="val 101936"/>
              <a:gd name="adj3" fmla="val 16667"/>
            </a:avLst>
          </a:prstGeom>
          <a:solidFill>
            <a:srgbClr val="FFFFFF">
              <a:lumMod val="65000"/>
            </a:srgbClr>
          </a:solidFill>
          <a:ln w="127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hysician Portal</a:t>
            </a:r>
          </a:p>
        </p:txBody>
      </p:sp>
      <p:sp>
        <p:nvSpPr>
          <p:cNvPr id="86" name="Rounded Rectangular Callout 85"/>
          <p:cNvSpPr/>
          <p:nvPr/>
        </p:nvSpPr>
        <p:spPr>
          <a:xfrm>
            <a:off x="8953433" y="3046258"/>
            <a:ext cx="562274" cy="292868"/>
          </a:xfrm>
          <a:prstGeom prst="wedgeRoundRectCallout">
            <a:avLst>
              <a:gd name="adj1" fmla="val 81339"/>
              <a:gd name="adj2" fmla="val 52921"/>
              <a:gd name="adj3" fmla="val 16667"/>
            </a:avLst>
          </a:prstGeom>
          <a:solidFill>
            <a:srgbClr val="FFFFFF">
              <a:lumMod val="65000"/>
            </a:srgbClr>
          </a:solidFill>
          <a:ln w="127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pp</a:t>
            </a:r>
          </a:p>
        </p:txBody>
      </p:sp>
      <p:cxnSp>
        <p:nvCxnSpPr>
          <p:cNvPr id="87" name="Straight Connector 86"/>
          <p:cNvCxnSpPr/>
          <p:nvPr/>
        </p:nvCxnSpPr>
        <p:spPr>
          <a:xfrm flipV="1">
            <a:off x="6323821" y="2325797"/>
            <a:ext cx="1083260" cy="1096899"/>
          </a:xfrm>
          <a:prstGeom prst="line">
            <a:avLst/>
          </a:prstGeom>
          <a:noFill/>
          <a:ln w="28575" cap="flat" cmpd="sng" algn="ctr">
            <a:solidFill>
              <a:srgbClr val="1E9D8B"/>
            </a:solidFill>
            <a:prstDash val="solid"/>
          </a:ln>
          <a:effectLst/>
        </p:spPr>
      </p:cxnSp>
      <p:cxnSp>
        <p:nvCxnSpPr>
          <p:cNvPr id="88" name="Straight Connector 87"/>
          <p:cNvCxnSpPr/>
          <p:nvPr/>
        </p:nvCxnSpPr>
        <p:spPr>
          <a:xfrm>
            <a:off x="6433103" y="4032437"/>
            <a:ext cx="888609" cy="1016615"/>
          </a:xfrm>
          <a:prstGeom prst="line">
            <a:avLst/>
          </a:prstGeom>
          <a:noFill/>
          <a:ln w="28575" cap="flat" cmpd="sng" algn="ctr">
            <a:solidFill>
              <a:srgbClr val="1E9D8B"/>
            </a:solidFill>
            <a:prstDash val="solid"/>
          </a:ln>
          <a:effectLst/>
        </p:spPr>
      </p:cxnSp>
      <p:cxnSp>
        <p:nvCxnSpPr>
          <p:cNvPr id="89" name="Straight Connector 88"/>
          <p:cNvCxnSpPr/>
          <p:nvPr/>
        </p:nvCxnSpPr>
        <p:spPr>
          <a:xfrm flipV="1">
            <a:off x="6571998" y="3649528"/>
            <a:ext cx="3019177" cy="31960"/>
          </a:xfrm>
          <a:prstGeom prst="line">
            <a:avLst/>
          </a:prstGeom>
          <a:noFill/>
          <a:ln w="28575" cap="flat" cmpd="sng" algn="ctr">
            <a:solidFill>
              <a:srgbClr val="1E9D8B"/>
            </a:solidFill>
            <a:prstDash val="solid"/>
          </a:ln>
          <a:effectLst/>
        </p:spPr>
      </p:cxnSp>
      <p:cxnSp>
        <p:nvCxnSpPr>
          <p:cNvPr id="90" name="Straight Arrow Connector 89"/>
          <p:cNvCxnSpPr/>
          <p:nvPr/>
        </p:nvCxnSpPr>
        <p:spPr>
          <a:xfrm flipV="1">
            <a:off x="9051374" y="4149463"/>
            <a:ext cx="1161877" cy="718800"/>
          </a:xfrm>
          <a:prstGeom prst="straightConnector1">
            <a:avLst/>
          </a:prstGeom>
          <a:noFill/>
          <a:ln w="28575" cap="flat" cmpd="sng" algn="ctr">
            <a:solidFill>
              <a:srgbClr val="0089C4">
                <a:shade val="95000"/>
                <a:satMod val="105000"/>
              </a:srgbClr>
            </a:solidFill>
            <a:prstDash val="solid"/>
            <a:tailEnd type="triangle"/>
          </a:ln>
          <a:effectLst/>
        </p:spPr>
      </p:cxnSp>
      <p:sp>
        <p:nvSpPr>
          <p:cNvPr id="91" name="TextBox 90"/>
          <p:cNvSpPr txBox="1"/>
          <p:nvPr/>
        </p:nvSpPr>
        <p:spPr>
          <a:xfrm>
            <a:off x="8861505" y="4705435"/>
            <a:ext cx="20682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ele-monitoring, </a:t>
            </a:r>
          </a:p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all services, </a:t>
            </a:r>
          </a:p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eferral</a:t>
            </a:r>
          </a:p>
        </p:txBody>
      </p:sp>
      <p:cxnSp>
        <p:nvCxnSpPr>
          <p:cNvPr id="92" name="Straight Arrow Connector 91"/>
          <p:cNvCxnSpPr/>
          <p:nvPr/>
        </p:nvCxnSpPr>
        <p:spPr>
          <a:xfrm>
            <a:off x="8964132" y="2339101"/>
            <a:ext cx="1300067" cy="763918"/>
          </a:xfrm>
          <a:prstGeom prst="straightConnector1">
            <a:avLst/>
          </a:prstGeom>
          <a:noFill/>
          <a:ln w="28575" cap="flat" cmpd="sng" algn="ctr">
            <a:solidFill>
              <a:srgbClr val="0089C4">
                <a:shade val="95000"/>
                <a:satMod val="105000"/>
              </a:srgbClr>
            </a:solidFill>
            <a:prstDash val="solid"/>
            <a:tailEnd type="triangle"/>
          </a:ln>
          <a:effectLst/>
        </p:spPr>
      </p:cxnSp>
      <p:sp>
        <p:nvSpPr>
          <p:cNvPr id="93" name="Rounded Rectangle 92"/>
          <p:cNvSpPr/>
          <p:nvPr/>
        </p:nvSpPr>
        <p:spPr>
          <a:xfrm>
            <a:off x="5732532" y="4787218"/>
            <a:ext cx="3231599" cy="1598756"/>
          </a:xfrm>
          <a:prstGeom prst="roundRect">
            <a:avLst/>
          </a:prstGeom>
          <a:noFill/>
          <a:ln w="25400" cap="flat" cmpd="sng" algn="ctr">
            <a:solidFill>
              <a:srgbClr val="FFFFFF">
                <a:lumMod val="50000"/>
              </a:srgbClr>
            </a:solidFill>
            <a:prstDash val="dash"/>
          </a:ln>
          <a:effectLst/>
        </p:spPr>
        <p:txBody>
          <a:bodyPr rtlCol="0" anchor="ctr"/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799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9071926" y="1816783"/>
            <a:ext cx="15076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reatment plan, </a:t>
            </a:r>
          </a:p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ele-consultation,  ‘Green Path’</a:t>
            </a:r>
          </a:p>
        </p:txBody>
      </p:sp>
      <p:sp>
        <p:nvSpPr>
          <p:cNvPr id="96" name="Rounded Rectangular Callout 95"/>
          <p:cNvSpPr/>
          <p:nvPr/>
        </p:nvSpPr>
        <p:spPr>
          <a:xfrm>
            <a:off x="10422351" y="2525201"/>
            <a:ext cx="933166" cy="522528"/>
          </a:xfrm>
          <a:prstGeom prst="wedgeRoundRectCallout">
            <a:avLst>
              <a:gd name="adj1" fmla="val -52758"/>
              <a:gd name="adj2" fmla="val 80256"/>
              <a:gd name="adj3" fmla="val 16667"/>
            </a:avLst>
          </a:prstGeom>
          <a:solidFill>
            <a:srgbClr val="FFFFFF">
              <a:lumMod val="65000"/>
            </a:srgbClr>
          </a:solidFill>
          <a:ln w="12700" cap="flat" cmpd="sng" algn="ctr">
            <a:noFill/>
            <a:prstDash val="solid"/>
          </a:ln>
          <a:effectLst/>
        </p:spPr>
        <p:txBody>
          <a:bodyPr lIns="0" rIns="0" rtlCol="0" anchor="ctr"/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onnected Devices</a:t>
            </a:r>
          </a:p>
        </p:txBody>
      </p:sp>
      <p:pic>
        <p:nvPicPr>
          <p:cNvPr id="97" name="Picture 96"/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865360" y="3105234"/>
            <a:ext cx="145290" cy="214058"/>
          </a:xfrm>
          <a:prstGeom prst="rect">
            <a:avLst/>
          </a:prstGeom>
        </p:spPr>
      </p:pic>
      <p:sp>
        <p:nvSpPr>
          <p:cNvPr id="98" name="Rounded Rectangular Callout 97"/>
          <p:cNvSpPr/>
          <p:nvPr/>
        </p:nvSpPr>
        <p:spPr>
          <a:xfrm>
            <a:off x="7336431" y="4224898"/>
            <a:ext cx="870719" cy="477164"/>
          </a:xfrm>
          <a:prstGeom prst="wedgeRoundRectCallout">
            <a:avLst>
              <a:gd name="adj1" fmla="val -33443"/>
              <a:gd name="adj2" fmla="val 109212"/>
              <a:gd name="adj3" fmla="val 16667"/>
            </a:avLst>
          </a:prstGeom>
          <a:solidFill>
            <a:srgbClr val="FFFFFF">
              <a:lumMod val="65000"/>
            </a:srgbClr>
          </a:solidFill>
          <a:ln w="127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ealth Worker Portal</a:t>
            </a:r>
          </a:p>
        </p:txBody>
      </p:sp>
      <p:sp>
        <p:nvSpPr>
          <p:cNvPr id="99" name="TextBox 98"/>
          <p:cNvSpPr txBox="1"/>
          <p:nvPr/>
        </p:nvSpPr>
        <p:spPr>
          <a:xfrm flipH="1">
            <a:off x="7726965" y="5593401"/>
            <a:ext cx="1043270" cy="4550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Call center w/ health workers  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00" name="Rounded Rectangle 99"/>
          <p:cNvSpPr/>
          <p:nvPr/>
        </p:nvSpPr>
        <p:spPr>
          <a:xfrm>
            <a:off x="5086211" y="1121134"/>
            <a:ext cx="3779088" cy="1404067"/>
          </a:xfrm>
          <a:prstGeom prst="roundRect">
            <a:avLst/>
          </a:prstGeom>
          <a:noFill/>
          <a:ln w="25400" cap="flat" cmpd="sng" algn="ctr">
            <a:solidFill>
              <a:srgbClr val="FFFFFF">
                <a:lumMod val="50000"/>
              </a:srgbClr>
            </a:solidFill>
            <a:prstDash val="dash"/>
          </a:ln>
          <a:effectLst/>
        </p:spPr>
        <p:txBody>
          <a:bodyPr rtlCol="0" anchor="ctr"/>
          <a:lstStyle/>
          <a:p>
            <a:pPr marL="0" marR="0" lvl="0" indent="0" algn="ctr" defTabSz="91430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799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pic>
        <p:nvPicPr>
          <p:cNvPr id="101" name="Picture 100"/>
          <p:cNvPicPr>
            <a:picLocks/>
          </p:cNvPicPr>
          <p:nvPr>
            <p:custDataLst>
              <p:tags r:id="rId1"/>
            </p:custDataLst>
          </p:nvPr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26067" y="2842461"/>
            <a:ext cx="969380" cy="195775"/>
          </a:xfrm>
          <a:prstGeom prst="rect">
            <a:avLst/>
          </a:prstGeom>
          <a:ln w="0">
            <a:noFill/>
          </a:ln>
          <a:effectLst/>
          <a:extLst>
            <a:ext uri="{91240B29-F687-4F45-9708-019B960494DF}">
              <a14:hiddenLine xmlns:a14="http://schemas.microsoft.com/office/drawing/2010/main" w="0">
                <a:solidFill>
                  <a:schemeClr val="tx1"/>
                </a:solidFill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2" name="Picture 101" descr="http://www.bddyyy.com.cn/images/logo.gif"/>
          <p:cNvPicPr>
            <a:picLocks noChangeAspect="1" noChangeArrowheads="1"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238758" y="1821312"/>
            <a:ext cx="1530359" cy="5099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3" name="TextBox 102"/>
          <p:cNvSpPr txBox="1"/>
          <p:nvPr/>
        </p:nvSpPr>
        <p:spPr>
          <a:xfrm>
            <a:off x="5238758" y="1177058"/>
            <a:ext cx="1289971" cy="3639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07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99" b="1" i="0" u="none" strike="noStrike" kern="0" cap="none" spc="0" normalizeH="0" baseline="0" noProof="0" dirty="0">
                <a:ln>
                  <a:noFill/>
                </a:ln>
                <a:solidFill>
                  <a:srgbClr val="00396C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spitals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5890605" y="5135545"/>
            <a:ext cx="1116149" cy="6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07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99" b="1" i="0" u="none" strike="noStrike" kern="0" cap="none" spc="0" normalizeH="0" baseline="0" noProof="0" dirty="0">
                <a:ln>
                  <a:noFill/>
                </a:ln>
                <a:solidFill>
                  <a:srgbClr val="00396C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ervice provider*</a:t>
            </a:r>
          </a:p>
        </p:txBody>
      </p:sp>
      <p:pic>
        <p:nvPicPr>
          <p:cNvPr id="106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38948" y="3230806"/>
            <a:ext cx="325456" cy="383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8" name="Picture 2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9491638" y="3220082"/>
            <a:ext cx="539916" cy="5928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9" name="Picture 7"/>
          <p:cNvPicPr>
            <a:picLocks noChangeAspect="1" noChangeArrowheads="1"/>
          </p:cNvPicPr>
          <p:nvPr>
            <p:custDataLst>
              <p:tags r:id="rId2"/>
            </p:custDataLst>
          </p:nvPr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40998" y="5110564"/>
            <a:ext cx="532267" cy="4760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" name="Picture 7"/>
          <p:cNvPicPr>
            <a:picLocks noChangeAspect="1" noChangeArrowheads="1"/>
          </p:cNvPicPr>
          <p:nvPr>
            <p:custDataLst>
              <p:tags r:id="rId3"/>
            </p:custDataLst>
          </p:nvPr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088653" y="1866545"/>
            <a:ext cx="532267" cy="4713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41" name="Group 140"/>
          <p:cNvGrpSpPr/>
          <p:nvPr/>
        </p:nvGrpSpPr>
        <p:grpSpPr>
          <a:xfrm>
            <a:off x="434349" y="3422696"/>
            <a:ext cx="1643439" cy="1158557"/>
            <a:chOff x="539552" y="2006484"/>
            <a:chExt cx="4054220" cy="2695625"/>
          </a:xfrm>
        </p:grpSpPr>
        <p:pic>
          <p:nvPicPr>
            <p:cNvPr id="142" name="Picture 141"/>
            <p:cNvPicPr>
              <a:picLocks noChangeAspect="1"/>
            </p:cNvPicPr>
            <p:nvPr>
              <p:custDataLst>
                <p:tags r:id="rId6"/>
              </p:custDataLst>
            </p:nvPr>
          </p:nvPicPr>
          <p:blipFill>
            <a:blip r:embed="rId16"/>
            <a:stretch>
              <a:fillRect/>
            </a:stretch>
          </p:blipFill>
          <p:spPr>
            <a:xfrm rot="16200000">
              <a:off x="1218849" y="1327187"/>
              <a:ext cx="2695625" cy="4054220"/>
            </a:xfrm>
            <a:prstGeom prst="rect">
              <a:avLst/>
            </a:prstGeom>
          </p:spPr>
        </p:pic>
        <p:pic>
          <p:nvPicPr>
            <p:cNvPr id="143" name="Picture 142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3080" y="2129776"/>
              <a:ext cx="3265387" cy="2449041"/>
            </a:xfrm>
            <a:prstGeom prst="rect">
              <a:avLst/>
            </a:prstGeom>
          </p:spPr>
        </p:pic>
      </p:grpSp>
      <p:pic>
        <p:nvPicPr>
          <p:cNvPr id="147" name="Picture 146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071" y="5317955"/>
            <a:ext cx="1351839" cy="1005927"/>
          </a:xfrm>
          <a:prstGeom prst="rect">
            <a:avLst/>
          </a:prstGeom>
        </p:spPr>
      </p:pic>
      <p:grpSp>
        <p:nvGrpSpPr>
          <p:cNvPr id="154" name="Group 153"/>
          <p:cNvGrpSpPr/>
          <p:nvPr/>
        </p:nvGrpSpPr>
        <p:grpSpPr>
          <a:xfrm>
            <a:off x="494796" y="1535109"/>
            <a:ext cx="3375804" cy="1159584"/>
            <a:chOff x="592840" y="2170611"/>
            <a:chExt cx="4935032" cy="1598919"/>
          </a:xfrm>
        </p:grpSpPr>
        <p:grpSp>
          <p:nvGrpSpPr>
            <p:cNvPr id="144" name="Group 143"/>
            <p:cNvGrpSpPr/>
            <p:nvPr/>
          </p:nvGrpSpPr>
          <p:grpSpPr>
            <a:xfrm>
              <a:off x="592840" y="2170611"/>
              <a:ext cx="2404775" cy="1598919"/>
              <a:chOff x="3430316" y="1704491"/>
              <a:chExt cx="2404775" cy="1598919"/>
            </a:xfrm>
          </p:grpSpPr>
          <p:pic>
            <p:nvPicPr>
              <p:cNvPr id="145" name="Picture 144"/>
              <p:cNvPicPr>
                <a:picLocks noChangeAspect="1"/>
              </p:cNvPicPr>
              <p:nvPr>
                <p:custDataLst>
                  <p:tags r:id="rId5"/>
                </p:custDataLst>
              </p:nvPr>
            </p:nvPicPr>
            <p:blipFill>
              <a:blip r:embed="rId16"/>
              <a:stretch>
                <a:fillRect/>
              </a:stretch>
            </p:blipFill>
            <p:spPr>
              <a:xfrm rot="16200000">
                <a:off x="3833244" y="1301563"/>
                <a:ext cx="1598919" cy="2404775"/>
              </a:xfrm>
              <a:prstGeom prst="rect">
                <a:avLst/>
              </a:prstGeom>
            </p:spPr>
          </p:pic>
          <p:pic>
            <p:nvPicPr>
              <p:cNvPr id="146" name="Picture 145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77144" y="1757855"/>
                <a:ext cx="1935499" cy="1451624"/>
              </a:xfrm>
              <a:prstGeom prst="rect">
                <a:avLst/>
              </a:prstGeom>
            </p:spPr>
          </p:pic>
        </p:grpSp>
        <p:grpSp>
          <p:nvGrpSpPr>
            <p:cNvPr id="148" name="Group 147"/>
            <p:cNvGrpSpPr/>
            <p:nvPr/>
          </p:nvGrpSpPr>
          <p:grpSpPr>
            <a:xfrm>
              <a:off x="3123097" y="2170611"/>
              <a:ext cx="2404775" cy="1598919"/>
              <a:chOff x="3430316" y="1704491"/>
              <a:chExt cx="2404775" cy="1598919"/>
            </a:xfrm>
          </p:grpSpPr>
          <p:pic>
            <p:nvPicPr>
              <p:cNvPr id="149" name="Picture 148"/>
              <p:cNvPicPr>
                <a:picLocks noChangeAspect="1"/>
              </p:cNvPicPr>
              <p:nvPr>
                <p:custDataLst>
                  <p:tags r:id="rId4"/>
                </p:custDataLst>
              </p:nvPr>
            </p:nvPicPr>
            <p:blipFill>
              <a:blip r:embed="rId16"/>
              <a:stretch>
                <a:fillRect/>
              </a:stretch>
            </p:blipFill>
            <p:spPr>
              <a:xfrm rot="16200000">
                <a:off x="3833244" y="1301563"/>
                <a:ext cx="1598919" cy="2404775"/>
              </a:xfrm>
              <a:prstGeom prst="rect">
                <a:avLst/>
              </a:prstGeom>
            </p:spPr>
          </p:pic>
          <p:pic>
            <p:nvPicPr>
              <p:cNvPr id="150" name="Picture 149"/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77144" y="1757855"/>
                <a:ext cx="1935499" cy="1500862"/>
              </a:xfrm>
              <a:prstGeom prst="rect">
                <a:avLst/>
              </a:prstGeom>
            </p:spPr>
          </p:pic>
        </p:grpSp>
      </p:grpSp>
      <p:sp>
        <p:nvSpPr>
          <p:cNvPr id="152" name="Text Placeholder 2"/>
          <p:cNvSpPr txBox="1">
            <a:spLocks/>
          </p:cNvSpPr>
          <p:nvPr/>
        </p:nvSpPr>
        <p:spPr>
          <a:xfrm>
            <a:off x="496978" y="1091272"/>
            <a:ext cx="1728638" cy="330707"/>
          </a:xfrm>
          <a:prstGeom prst="rect">
            <a:avLst/>
          </a:prstGeom>
          <a:noFill/>
        </p:spPr>
        <p:txBody>
          <a:bodyPr/>
          <a:lstStyle>
            <a:lvl1pPr marL="216032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•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1pPr>
            <a:lvl2pPr marL="432064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–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2pPr>
            <a:lvl3pPr marL="648097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Wingdings"/>
              <a:buChar char="§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3pPr>
            <a:lvl4pPr marL="864129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•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4pPr>
            <a:lvl5pPr marL="1080161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–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5pPr>
            <a:lvl6pPr marL="2515103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2394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686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977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hysician portal</a:t>
            </a:r>
          </a:p>
        </p:txBody>
      </p:sp>
      <p:sp>
        <p:nvSpPr>
          <p:cNvPr id="155" name="Text Placeholder 2"/>
          <p:cNvSpPr txBox="1">
            <a:spLocks/>
          </p:cNvSpPr>
          <p:nvPr/>
        </p:nvSpPr>
        <p:spPr>
          <a:xfrm>
            <a:off x="494796" y="3060360"/>
            <a:ext cx="1728638" cy="330707"/>
          </a:xfrm>
          <a:prstGeom prst="rect">
            <a:avLst/>
          </a:prstGeom>
          <a:noFill/>
        </p:spPr>
        <p:txBody>
          <a:bodyPr/>
          <a:lstStyle>
            <a:lvl1pPr marL="216032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•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1pPr>
            <a:lvl2pPr marL="432064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–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2pPr>
            <a:lvl3pPr marL="648097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Wingdings"/>
              <a:buChar char="§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3pPr>
            <a:lvl4pPr marL="864129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•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4pPr>
            <a:lvl5pPr marL="1080161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–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5pPr>
            <a:lvl6pPr marL="2515103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2394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686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977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atient portal</a:t>
            </a:r>
          </a:p>
        </p:txBody>
      </p:sp>
      <p:pic>
        <p:nvPicPr>
          <p:cNvPr id="156" name="Picture 155"/>
          <p:cNvPicPr>
            <a:picLocks noChangeAspect="1"/>
          </p:cNvPicPr>
          <p:nvPr/>
        </p:nvPicPr>
        <p:blipFill rotWithShape="1">
          <a:blip r:embed="rId2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0984" t="26907" r="30013" b="26948"/>
          <a:stretch/>
        </p:blipFill>
        <p:spPr>
          <a:xfrm>
            <a:off x="2391252" y="3444749"/>
            <a:ext cx="748007" cy="884966"/>
          </a:xfrm>
          <a:prstGeom prst="rect">
            <a:avLst/>
          </a:prstGeom>
        </p:spPr>
      </p:pic>
      <p:sp>
        <p:nvSpPr>
          <p:cNvPr id="157" name="Text Placeholder 2"/>
          <p:cNvSpPr txBox="1">
            <a:spLocks/>
          </p:cNvSpPr>
          <p:nvPr/>
        </p:nvSpPr>
        <p:spPr>
          <a:xfrm>
            <a:off x="2323643" y="3076795"/>
            <a:ext cx="1728638" cy="330707"/>
          </a:xfrm>
          <a:prstGeom prst="rect">
            <a:avLst/>
          </a:prstGeom>
          <a:noFill/>
        </p:spPr>
        <p:txBody>
          <a:bodyPr/>
          <a:lstStyle>
            <a:lvl1pPr marL="216032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•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1pPr>
            <a:lvl2pPr marL="432064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–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2pPr>
            <a:lvl3pPr marL="648097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Wingdings"/>
              <a:buChar char="§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3pPr>
            <a:lvl4pPr marL="864129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•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4pPr>
            <a:lvl5pPr marL="1080161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–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5pPr>
            <a:lvl6pPr marL="2515103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2394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686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977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P meter</a:t>
            </a:r>
          </a:p>
        </p:txBody>
      </p:sp>
      <p:sp>
        <p:nvSpPr>
          <p:cNvPr id="158" name="Text Placeholder 2"/>
          <p:cNvSpPr txBox="1">
            <a:spLocks/>
          </p:cNvSpPr>
          <p:nvPr/>
        </p:nvSpPr>
        <p:spPr>
          <a:xfrm>
            <a:off x="431116" y="4897838"/>
            <a:ext cx="2041740" cy="330707"/>
          </a:xfrm>
          <a:prstGeom prst="rect">
            <a:avLst/>
          </a:prstGeom>
          <a:noFill/>
        </p:spPr>
        <p:txBody>
          <a:bodyPr/>
          <a:lstStyle>
            <a:lvl1pPr marL="216032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•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1pPr>
            <a:lvl2pPr marL="432064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–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2pPr>
            <a:lvl3pPr marL="648097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Wingdings"/>
              <a:buChar char="§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3pPr>
            <a:lvl4pPr marL="864129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•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4pPr>
            <a:lvl5pPr marL="1080161" indent="-216032" algn="l" rtl="0" eaLnBrk="1" fontAlgn="base" hangingPunct="1"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Char char="–"/>
              <a:defRPr sz="1800" b="0" i="0" u="none" kern="1200">
                <a:solidFill>
                  <a:schemeClr val="tx1"/>
                </a:solidFill>
                <a:latin typeface="Calibri"/>
                <a:ea typeface="+mn-ea"/>
                <a:cs typeface="+mn-cs"/>
              </a:defRPr>
            </a:lvl5pPr>
            <a:lvl6pPr marL="2515103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2394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686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977" indent="-228646" algn="l" defTabSz="914583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00000"/>
              <a:buFont typeface="Calibri"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Brochure &amp; Diary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11" name="Shape 372" descr="TextBox 1"/>
          <p:cNvSpPr/>
          <p:nvPr/>
        </p:nvSpPr>
        <p:spPr>
          <a:xfrm>
            <a:off x="480237" y="185755"/>
            <a:ext cx="10244469" cy="584775"/>
          </a:xfrm>
          <a:prstGeom prst="rect">
            <a:avLst/>
          </a:prstGeom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altLang="zh-CN" sz="3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Setting of BAMA clinical study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9523523" y="5934838"/>
            <a:ext cx="2215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* Executed by PKU1 nurses</a:t>
            </a:r>
          </a:p>
        </p:txBody>
      </p:sp>
    </p:spTree>
    <p:extLst>
      <p:ext uri="{BB962C8B-B14F-4D97-AF65-F5344CB8AC3E}">
        <p14:creationId xmlns:p14="http://schemas.microsoft.com/office/powerpoint/2010/main" val="348914943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0"/>
    </mc:Choice>
    <mc:Fallback>
      <p:transition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Cloud 72">
            <a:extLst>
              <a:ext uri="{FF2B5EF4-FFF2-40B4-BE49-F238E27FC236}">
                <a16:creationId xmlns:a16="http://schemas.microsoft.com/office/drawing/2014/main" id="{7C0F0228-B362-4545-B421-DCF771ED629F}"/>
              </a:ext>
            </a:extLst>
          </p:cNvPr>
          <p:cNvSpPr/>
          <p:nvPr>
            <p:custDataLst>
              <p:tags r:id="rId1"/>
            </p:custDataLst>
          </p:nvPr>
        </p:nvSpPr>
        <p:spPr>
          <a:xfrm>
            <a:off x="4313181" y="898926"/>
            <a:ext cx="1994397" cy="836986"/>
          </a:xfrm>
          <a:prstGeom prst="cloud">
            <a:avLst/>
          </a:prstGeom>
          <a:solidFill>
            <a:sysClr val="window" lastClr="FFFFFF">
              <a:lumMod val="75000"/>
            </a:sys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AMA Server in Cloud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9B0FCED7-5F94-48CE-B7D0-17810A1C253A}"/>
              </a:ext>
            </a:extLst>
          </p:cNvPr>
          <p:cNvCxnSpPr>
            <a:cxnSpLocks/>
          </p:cNvCxnSpPr>
          <p:nvPr>
            <p:custDataLst>
              <p:tags r:id="rId2"/>
            </p:custDataLst>
          </p:nvPr>
        </p:nvCxnSpPr>
        <p:spPr>
          <a:xfrm flipH="1" flipV="1">
            <a:off x="5378211" y="1661038"/>
            <a:ext cx="1776351" cy="1594967"/>
          </a:xfrm>
          <a:prstGeom prst="line">
            <a:avLst/>
          </a:prstGeom>
          <a:noFill/>
          <a:ln w="12700" cap="flat" cmpd="sng" algn="ctr">
            <a:solidFill>
              <a:sysClr val="window" lastClr="FFFFFF">
                <a:lumMod val="50000"/>
              </a:sysClr>
            </a:solidFill>
            <a:prstDash val="dash"/>
          </a:ln>
          <a:effectLst/>
        </p:spPr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BDC0CB17-652F-4F22-BB6A-6FE99A4F5FF4}"/>
              </a:ext>
            </a:extLst>
          </p:cNvPr>
          <p:cNvCxnSpPr>
            <a:cxnSpLocks/>
          </p:cNvCxnSpPr>
          <p:nvPr>
            <p:custDataLst>
              <p:tags r:id="rId3"/>
            </p:custDataLst>
          </p:nvPr>
        </p:nvCxnSpPr>
        <p:spPr>
          <a:xfrm flipH="1" flipV="1">
            <a:off x="5854597" y="1552658"/>
            <a:ext cx="3153479" cy="557646"/>
          </a:xfrm>
          <a:prstGeom prst="line">
            <a:avLst/>
          </a:prstGeom>
          <a:noFill/>
          <a:ln w="12700" cap="flat" cmpd="sng" algn="ctr">
            <a:solidFill>
              <a:sysClr val="window" lastClr="FFFFFF">
                <a:lumMod val="50000"/>
              </a:sysClr>
            </a:solidFill>
            <a:prstDash val="dash"/>
          </a:ln>
          <a:effectLst/>
        </p:spPr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1B76EA11-7A1C-4E5D-BCCC-BD3053C880D6}"/>
              </a:ext>
            </a:extLst>
          </p:cNvPr>
          <p:cNvCxnSpPr/>
          <p:nvPr>
            <p:custDataLst>
              <p:tags r:id="rId4"/>
            </p:custDataLst>
          </p:nvPr>
        </p:nvCxnSpPr>
        <p:spPr>
          <a:xfrm flipV="1">
            <a:off x="4148219" y="1663835"/>
            <a:ext cx="728682" cy="781908"/>
          </a:xfrm>
          <a:prstGeom prst="line">
            <a:avLst/>
          </a:prstGeom>
          <a:noFill/>
          <a:ln w="12700" cap="flat" cmpd="sng" algn="ctr">
            <a:solidFill>
              <a:sysClr val="window" lastClr="FFFFFF">
                <a:lumMod val="50000"/>
              </a:sysClr>
            </a:solidFill>
            <a:prstDash val="dash"/>
          </a:ln>
          <a:effectLst/>
        </p:spPr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FFB44F1E-CDA3-4D04-ACDF-A3631BA8DEE2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>
            <a:off x="8464136" y="3074342"/>
            <a:ext cx="1169690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rPr>
              <a:t>BP, HR</a:t>
            </a:r>
            <a:endParaRPr kumimoji="0" lang="en-US" altLang="en-US" sz="1000" b="1" i="0" u="none" strike="noStrike" kern="0" cap="none" spc="0" normalizeH="0" baseline="0" noProof="0" dirty="0">
              <a:ln>
                <a:noFill/>
              </a:ln>
              <a:solidFill>
                <a:prstClr val="white">
                  <a:lumMod val="85000"/>
                </a:prstClr>
              </a:solidFill>
              <a:effectLst/>
              <a:uLnTx/>
              <a:uFillTx/>
            </a:endParaRPr>
          </a:p>
        </p:txBody>
      </p:sp>
      <p:sp>
        <p:nvSpPr>
          <p:cNvPr id="78" name="Rounded Rectangle 31">
            <a:extLst>
              <a:ext uri="{FF2B5EF4-FFF2-40B4-BE49-F238E27FC236}">
                <a16:creationId xmlns:a16="http://schemas.microsoft.com/office/drawing/2014/main" id="{26CE8C7F-E588-4D56-A4AB-D23B668FEFCE}"/>
              </a:ext>
            </a:extLst>
          </p:cNvPr>
          <p:cNvSpPr/>
          <p:nvPr/>
        </p:nvSpPr>
        <p:spPr>
          <a:xfrm>
            <a:off x="1415047" y="2110304"/>
            <a:ext cx="3890607" cy="2467649"/>
          </a:xfrm>
          <a:prstGeom prst="roundRect">
            <a:avLst>
              <a:gd name="adj" fmla="val 9113"/>
            </a:avLst>
          </a:prstGeom>
          <a:solidFill>
            <a:sysClr val="window" lastClr="FFFFFF">
              <a:alpha val="35000"/>
            </a:sysClr>
          </a:solidFill>
          <a:ln w="25400" cap="flat" cmpd="sng" algn="ctr">
            <a:solidFill>
              <a:srgbClr val="0066A1">
                <a:shade val="50000"/>
              </a:srgbClr>
            </a:solidFill>
            <a:prstDash val="dash"/>
          </a:ln>
          <a:effectLst/>
        </p:spPr>
        <p:txBody>
          <a:bodyPr rtlCol="0" anchor="ctr"/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en-US" sz="10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9" name="Can 32">
            <a:extLst>
              <a:ext uri="{FF2B5EF4-FFF2-40B4-BE49-F238E27FC236}">
                <a16:creationId xmlns:a16="http://schemas.microsoft.com/office/drawing/2014/main" id="{BAC084F3-4E47-49C2-807D-3EB3922CF8B7}"/>
              </a:ext>
            </a:extLst>
          </p:cNvPr>
          <p:cNvSpPr/>
          <p:nvPr/>
        </p:nvSpPr>
        <p:spPr>
          <a:xfrm>
            <a:off x="3894493" y="2468975"/>
            <a:ext cx="1110651" cy="706507"/>
          </a:xfrm>
          <a:prstGeom prst="can">
            <a:avLst/>
          </a:prstGeom>
          <a:solidFill>
            <a:sysClr val="window" lastClr="FFFFFF">
              <a:lumMod val="85000"/>
            </a:sysClr>
          </a:solidFill>
          <a:ln w="25400" cap="flat" cmpd="sng" algn="ctr">
            <a:solidFill>
              <a:srgbClr val="0066A1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entury Gothic" panose="020B0502020202020204" pitchFamily="34" charset="0"/>
                <a:ea typeface="+mn-ea"/>
                <a:cs typeface="+mn-cs"/>
              </a:rPr>
              <a:t>BAMA</a:t>
            </a:r>
          </a:p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entury Gothic" panose="020B0502020202020204" pitchFamily="34" charset="0"/>
                <a:ea typeface="+mn-ea"/>
                <a:cs typeface="+mn-cs"/>
              </a:rPr>
              <a:t>Hospital</a:t>
            </a:r>
          </a:p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entury Gothic" panose="020B0502020202020204" pitchFamily="34" charset="0"/>
                <a:ea typeface="+mn-ea"/>
                <a:cs typeface="+mn-cs"/>
              </a:rPr>
              <a:t>Server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0EDC4BC-F05C-48E4-847B-16E5ED2AC4A9}"/>
              </a:ext>
            </a:extLst>
          </p:cNvPr>
          <p:cNvSpPr txBox="1"/>
          <p:nvPr/>
        </p:nvSpPr>
        <p:spPr>
          <a:xfrm>
            <a:off x="1233800" y="2160082"/>
            <a:ext cx="2170922" cy="246222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rPr>
              <a:t>Hospital information system </a:t>
            </a:r>
          </a:p>
        </p:txBody>
      </p:sp>
      <p:grpSp>
        <p:nvGrpSpPr>
          <p:cNvPr id="81" name="Group 80">
            <a:extLst>
              <a:ext uri="{FF2B5EF4-FFF2-40B4-BE49-F238E27FC236}">
                <a16:creationId xmlns:a16="http://schemas.microsoft.com/office/drawing/2014/main" id="{C7F7AB30-94A3-4889-BFF0-9FDDC50081ED}"/>
              </a:ext>
            </a:extLst>
          </p:cNvPr>
          <p:cNvGrpSpPr/>
          <p:nvPr/>
        </p:nvGrpSpPr>
        <p:grpSpPr>
          <a:xfrm>
            <a:off x="1671635" y="2452272"/>
            <a:ext cx="1243094" cy="750763"/>
            <a:chOff x="1772078" y="5450744"/>
            <a:chExt cx="1572512" cy="1045787"/>
          </a:xfrm>
        </p:grpSpPr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1EEFE2D6-3B34-4758-8800-60652A69757D}"/>
                </a:ext>
              </a:extLst>
            </p:cNvPr>
            <p:cNvGrpSpPr/>
            <p:nvPr/>
          </p:nvGrpSpPr>
          <p:grpSpPr>
            <a:xfrm>
              <a:off x="1772078" y="5450744"/>
              <a:ext cx="1550277" cy="1045787"/>
              <a:chOff x="3124198" y="2527635"/>
              <a:chExt cx="1295402" cy="825165"/>
            </a:xfrm>
            <a:solidFill>
              <a:sysClr val="window" lastClr="FFFFFF">
                <a:lumMod val="85000"/>
              </a:sysClr>
            </a:solidFill>
          </p:grpSpPr>
          <p:sp>
            <p:nvSpPr>
              <p:cNvPr id="138" name="Can 38">
                <a:extLst>
                  <a:ext uri="{FF2B5EF4-FFF2-40B4-BE49-F238E27FC236}">
                    <a16:creationId xmlns:a16="http://schemas.microsoft.com/office/drawing/2014/main" id="{BC20F26E-ED7E-4697-9AB9-3E0E819FC768}"/>
                  </a:ext>
                </a:extLst>
              </p:cNvPr>
              <p:cNvSpPr/>
              <p:nvPr/>
            </p:nvSpPr>
            <p:spPr>
              <a:xfrm>
                <a:off x="3800447" y="2603194"/>
                <a:ext cx="619153" cy="703535"/>
              </a:xfrm>
              <a:prstGeom prst="can">
                <a:avLst/>
              </a:prstGeom>
              <a:grpFill/>
              <a:ln w="25400" cap="flat" cmpd="sng" algn="ctr">
                <a:solidFill>
                  <a:srgbClr val="0066A1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278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en-US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entury Gothic" panose="020B0502020202020204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139" name="Can 39">
                <a:extLst>
                  <a:ext uri="{FF2B5EF4-FFF2-40B4-BE49-F238E27FC236}">
                    <a16:creationId xmlns:a16="http://schemas.microsoft.com/office/drawing/2014/main" id="{2ECBE5BF-961D-4BA2-9B57-6527F1EC49B4}"/>
                  </a:ext>
                </a:extLst>
              </p:cNvPr>
              <p:cNvSpPr/>
              <p:nvPr/>
            </p:nvSpPr>
            <p:spPr>
              <a:xfrm>
                <a:off x="3124198" y="2603194"/>
                <a:ext cx="619153" cy="703535"/>
              </a:xfrm>
              <a:prstGeom prst="can">
                <a:avLst/>
              </a:prstGeom>
              <a:grpFill/>
              <a:ln w="25400" cap="flat" cmpd="sng" algn="ctr">
                <a:solidFill>
                  <a:srgbClr val="0066A1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278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en-US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entury Gothic" panose="020B0502020202020204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140" name="Can 40">
                <a:extLst>
                  <a:ext uri="{FF2B5EF4-FFF2-40B4-BE49-F238E27FC236}">
                    <a16:creationId xmlns:a16="http://schemas.microsoft.com/office/drawing/2014/main" id="{C122E2F6-9761-4568-B2AE-B45CE36CF78D}"/>
                  </a:ext>
                </a:extLst>
              </p:cNvPr>
              <p:cNvSpPr/>
              <p:nvPr/>
            </p:nvSpPr>
            <p:spPr>
              <a:xfrm>
                <a:off x="3451593" y="2527635"/>
                <a:ext cx="640612" cy="825165"/>
              </a:xfrm>
              <a:prstGeom prst="can">
                <a:avLst/>
              </a:prstGeom>
              <a:grpFill/>
              <a:ln w="25400" cap="flat" cmpd="sng" algn="ctr">
                <a:solidFill>
                  <a:srgbClr val="0066A1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278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en-US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entury Gothic" panose="020B0502020202020204" pitchFamily="34" charset="0"/>
                  <a:ea typeface="+mn-ea"/>
                  <a:cs typeface="+mn-cs"/>
                </a:endParaRPr>
              </a:p>
            </p:txBody>
          </p:sp>
        </p:grp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6E4319ED-E8D3-48DD-8018-7AFA1FD5BAA9}"/>
                </a:ext>
              </a:extLst>
            </p:cNvPr>
            <p:cNvSpPr/>
            <p:nvPr/>
          </p:nvSpPr>
          <p:spPr>
            <a:xfrm>
              <a:off x="1780755" y="5838087"/>
              <a:ext cx="1563835" cy="55733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entury Gothic" panose="020B0502020202020204" pitchFamily="34" charset="0"/>
                </a:rPr>
                <a:t>Cardiology CDR/</a:t>
              </a:r>
            </a:p>
            <a:p>
              <a:pPr marL="0" marR="0" lvl="0" indent="0" algn="ctr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entury Gothic" panose="020B0502020202020204" pitchFamily="34" charset="0"/>
                </a:rPr>
                <a:t>EMR/HIS/CPOE</a:t>
              </a:r>
            </a:p>
          </p:txBody>
        </p:sp>
      </p:grp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689A4534-BF73-4F46-BD4B-7185D80E01BE}"/>
              </a:ext>
            </a:extLst>
          </p:cNvPr>
          <p:cNvCxnSpPr>
            <a:cxnSpLocks/>
            <a:endCxn id="79" idx="2"/>
          </p:cNvCxnSpPr>
          <p:nvPr/>
        </p:nvCxnSpPr>
        <p:spPr>
          <a:xfrm flipV="1">
            <a:off x="2879631" y="2822230"/>
            <a:ext cx="1014861" cy="5419"/>
          </a:xfrm>
          <a:prstGeom prst="straightConnector1">
            <a:avLst/>
          </a:prstGeom>
          <a:noFill/>
          <a:ln w="9525" cap="flat" cmpd="sng" algn="ctr">
            <a:solidFill>
              <a:srgbClr val="0066A1">
                <a:shade val="95000"/>
                <a:satMod val="105000"/>
              </a:srgbClr>
            </a:solidFill>
            <a:prstDash val="solid"/>
            <a:headEnd type="none" w="med" len="med"/>
            <a:tailEnd type="none" w="med" len="med"/>
          </a:ln>
          <a:effectLst/>
        </p:spPr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9E4672B1-9F64-4852-94B2-3ECD7D31D471}"/>
              </a:ext>
            </a:extLst>
          </p:cNvPr>
          <p:cNvSpPr txBox="1"/>
          <p:nvPr/>
        </p:nvSpPr>
        <p:spPr>
          <a:xfrm>
            <a:off x="2893449" y="2579889"/>
            <a:ext cx="1100348" cy="246222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rPr>
              <a:t>Intranet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9A092079-F8D6-4956-B44B-7E8334A2FEA4}"/>
              </a:ext>
            </a:extLst>
          </p:cNvPr>
          <p:cNvSpPr txBox="1"/>
          <p:nvPr/>
        </p:nvSpPr>
        <p:spPr>
          <a:xfrm rot="18878046">
            <a:off x="3966646" y="1882324"/>
            <a:ext cx="1021845" cy="246221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entury Gothic" panose="020B0502020202020204" pitchFamily="34" charset="0"/>
              </a:rPr>
              <a:t>Internet</a:t>
            </a:r>
          </a:p>
        </p:txBody>
      </p:sp>
      <p:grpSp>
        <p:nvGrpSpPr>
          <p:cNvPr id="85" name="Group 84">
            <a:extLst>
              <a:ext uri="{FF2B5EF4-FFF2-40B4-BE49-F238E27FC236}">
                <a16:creationId xmlns:a16="http://schemas.microsoft.com/office/drawing/2014/main" id="{56F1EE91-5D50-4AD9-8975-3985D3833C14}"/>
              </a:ext>
            </a:extLst>
          </p:cNvPr>
          <p:cNvGrpSpPr/>
          <p:nvPr/>
        </p:nvGrpSpPr>
        <p:grpSpPr>
          <a:xfrm>
            <a:off x="1486085" y="3518283"/>
            <a:ext cx="1746032" cy="934982"/>
            <a:chOff x="224716" y="4149897"/>
            <a:chExt cx="1664801" cy="959973"/>
          </a:xfrm>
        </p:grpSpPr>
        <p:sp>
          <p:nvSpPr>
            <p:cNvPr id="131" name="Rounded Rectangle 48">
              <a:extLst>
                <a:ext uri="{FF2B5EF4-FFF2-40B4-BE49-F238E27FC236}">
                  <a16:creationId xmlns:a16="http://schemas.microsoft.com/office/drawing/2014/main" id="{907436A3-0884-45D5-A31C-A5FB0FC5C0D3}"/>
                </a:ext>
              </a:extLst>
            </p:cNvPr>
            <p:cNvSpPr/>
            <p:nvPr/>
          </p:nvSpPr>
          <p:spPr>
            <a:xfrm>
              <a:off x="391876" y="4149897"/>
              <a:ext cx="1382060" cy="959973"/>
            </a:xfrm>
            <a:prstGeom prst="roundRect">
              <a:avLst/>
            </a:prstGeom>
            <a:solidFill>
              <a:srgbClr val="FFFFFF">
                <a:alpha val="35000"/>
              </a:srgbClr>
            </a:solidFill>
            <a:ln w="25400" cap="flat" cmpd="sng" algn="ctr">
              <a:solidFill>
                <a:srgbClr val="0066A1">
                  <a:shade val="50000"/>
                </a:srgbClr>
              </a:solidFill>
              <a:prstDash val="lgDashDot"/>
            </a:ln>
            <a:effectLst/>
          </p:spPr>
          <p:txBody>
            <a:bodyPr rtlCol="0" anchor="ctr"/>
            <a:lstStyle/>
            <a:p>
              <a:pPr marL="0" marR="0" lvl="0" indent="0" algn="ctr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en-US" sz="10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B71602BA-5E32-4C99-A292-3B9036201978}"/>
                </a:ext>
              </a:extLst>
            </p:cNvPr>
            <p:cNvSpPr txBox="1"/>
            <p:nvPr/>
          </p:nvSpPr>
          <p:spPr>
            <a:xfrm>
              <a:off x="224716" y="4211225"/>
              <a:ext cx="1664801" cy="252802"/>
            </a:xfrm>
            <a:prstGeom prst="rect">
              <a:avLst/>
            </a:prstGeom>
            <a:noFill/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wrap="square" rtlCol="0">
              <a:spAutoFit/>
            </a:bodyPr>
            <a:lstStyle/>
            <a:p>
              <a:pPr marL="0" marR="0" lvl="0" indent="0" algn="ctr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</a:rPr>
                <a:t>Cardiology Ward</a:t>
              </a:r>
            </a:p>
          </p:txBody>
        </p:sp>
        <p:grpSp>
          <p:nvGrpSpPr>
            <p:cNvPr id="133" name="Group 132">
              <a:extLst>
                <a:ext uri="{FF2B5EF4-FFF2-40B4-BE49-F238E27FC236}">
                  <a16:creationId xmlns:a16="http://schemas.microsoft.com/office/drawing/2014/main" id="{7C4A3B62-4EAD-4E90-A060-7E805F85F86F}"/>
                </a:ext>
              </a:extLst>
            </p:cNvPr>
            <p:cNvGrpSpPr/>
            <p:nvPr/>
          </p:nvGrpSpPr>
          <p:grpSpPr>
            <a:xfrm>
              <a:off x="692694" y="4509124"/>
              <a:ext cx="800232" cy="545166"/>
              <a:chOff x="361634" y="3349382"/>
              <a:chExt cx="4229467" cy="2812024"/>
            </a:xfrm>
          </p:grpSpPr>
          <p:pic>
            <p:nvPicPr>
              <p:cNvPr id="134" name="Picture 133">
                <a:extLst>
                  <a:ext uri="{FF2B5EF4-FFF2-40B4-BE49-F238E27FC236}">
                    <a16:creationId xmlns:a16="http://schemas.microsoft.com/office/drawing/2014/main" id="{43D15BB1-8590-45EF-9D3A-E22726C06BA9}"/>
                  </a:ext>
                </a:extLst>
              </p:cNvPr>
              <p:cNvPicPr>
                <a:picLocks noChangeAspect="1"/>
              </p:cNvPicPr>
              <p:nvPr>
                <p:custDataLst>
                  <p:tags r:id="rId15"/>
                </p:custDataLst>
              </p:nvPr>
            </p:nvPicPr>
            <p:blipFill>
              <a:blip r:embed="rId18"/>
              <a:stretch>
                <a:fillRect/>
              </a:stretch>
            </p:blipFill>
            <p:spPr>
              <a:xfrm rot="16200000">
                <a:off x="1070356" y="2640660"/>
                <a:ext cx="2812024" cy="4229467"/>
              </a:xfrm>
              <a:prstGeom prst="rect">
                <a:avLst/>
              </a:prstGeom>
            </p:spPr>
          </p:pic>
          <p:pic>
            <p:nvPicPr>
              <p:cNvPr id="135" name="Picture 134">
                <a:extLst>
                  <a:ext uri="{FF2B5EF4-FFF2-40B4-BE49-F238E27FC236}">
                    <a16:creationId xmlns:a16="http://schemas.microsoft.com/office/drawing/2014/main" id="{D9A2B3A8-A70A-46AF-8F01-28C69A162A52}"/>
                  </a:ext>
                </a:extLst>
              </p:cNvPr>
              <p:cNvPicPr>
                <a:picLocks noChangeAspect="1"/>
              </p:cNvPicPr>
              <p:nvPr>
                <p:custDataLst>
                  <p:tags r:id="rId16"/>
                </p:custDataLst>
              </p:nvPr>
            </p:nvPicPr>
            <p:blipFill>
              <a:blip r:embed="rId19"/>
              <a:stretch>
                <a:fillRect/>
              </a:stretch>
            </p:blipFill>
            <p:spPr>
              <a:xfrm>
                <a:off x="783135" y="3505986"/>
                <a:ext cx="3337920" cy="2519909"/>
              </a:xfrm>
              <a:prstGeom prst="rect">
                <a:avLst/>
              </a:prstGeom>
            </p:spPr>
          </p:pic>
        </p:grpSp>
      </p:grpSp>
      <p:grpSp>
        <p:nvGrpSpPr>
          <p:cNvPr id="86" name="Group 85">
            <a:extLst>
              <a:ext uri="{FF2B5EF4-FFF2-40B4-BE49-F238E27FC236}">
                <a16:creationId xmlns:a16="http://schemas.microsoft.com/office/drawing/2014/main" id="{0D173436-454C-462A-BCE2-A09BDE417115}"/>
              </a:ext>
            </a:extLst>
          </p:cNvPr>
          <p:cNvGrpSpPr/>
          <p:nvPr/>
        </p:nvGrpSpPr>
        <p:grpSpPr>
          <a:xfrm>
            <a:off x="3501590" y="3516833"/>
            <a:ext cx="1649821" cy="936430"/>
            <a:chOff x="2155590" y="4148408"/>
            <a:chExt cx="1573068" cy="961461"/>
          </a:xfrm>
        </p:grpSpPr>
        <p:sp>
          <p:nvSpPr>
            <p:cNvPr id="125" name="Rounded Rectangle 54">
              <a:extLst>
                <a:ext uri="{FF2B5EF4-FFF2-40B4-BE49-F238E27FC236}">
                  <a16:creationId xmlns:a16="http://schemas.microsoft.com/office/drawing/2014/main" id="{DE5AC437-F778-45DB-8569-A6E95979E662}"/>
                </a:ext>
              </a:extLst>
            </p:cNvPr>
            <p:cNvSpPr/>
            <p:nvPr/>
          </p:nvSpPr>
          <p:spPr>
            <a:xfrm>
              <a:off x="2200819" y="4148408"/>
              <a:ext cx="1382059" cy="279697"/>
            </a:xfrm>
            <a:prstGeom prst="roundRect">
              <a:avLst/>
            </a:prstGeom>
            <a:noFill/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wrap="square" rtlCol="0">
              <a:spAutoFit/>
            </a:bodyPr>
            <a:lstStyle/>
            <a:p>
              <a:pPr marL="0" marR="0" lvl="0" indent="0" algn="ctr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en-US" sz="1000" b="1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entury Gothic" panose="020B0502020202020204" pitchFamily="34" charset="0"/>
              </a:endParaRPr>
            </a:p>
          </p:txBody>
        </p:sp>
        <p:sp>
          <p:nvSpPr>
            <p:cNvPr id="126" name="Rounded Rectangle 55">
              <a:extLst>
                <a:ext uri="{FF2B5EF4-FFF2-40B4-BE49-F238E27FC236}">
                  <a16:creationId xmlns:a16="http://schemas.microsoft.com/office/drawing/2014/main" id="{D9734637-DBDF-4930-9B86-92145D7F832C}"/>
                </a:ext>
              </a:extLst>
            </p:cNvPr>
            <p:cNvSpPr/>
            <p:nvPr/>
          </p:nvSpPr>
          <p:spPr>
            <a:xfrm>
              <a:off x="2237184" y="4161696"/>
              <a:ext cx="1382060" cy="948173"/>
            </a:xfrm>
            <a:prstGeom prst="roundRect">
              <a:avLst/>
            </a:prstGeom>
            <a:solidFill>
              <a:srgbClr val="FFFFFF">
                <a:alpha val="35000"/>
              </a:srgbClr>
            </a:solidFill>
            <a:ln w="25400" cap="flat" cmpd="sng" algn="ctr">
              <a:solidFill>
                <a:srgbClr val="0066A1">
                  <a:shade val="50000"/>
                </a:srgbClr>
              </a:solidFill>
              <a:prstDash val="lgDashDot"/>
            </a:ln>
            <a:effectLst/>
          </p:spPr>
          <p:txBody>
            <a:bodyPr rtlCol="0" anchor="ctr"/>
            <a:lstStyle/>
            <a:p>
              <a:pPr marL="0" marR="0" lvl="0" indent="0" algn="ctr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en-US" sz="10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289028B8-1AD2-4E4B-BB3F-B69902C06205}"/>
                </a:ext>
              </a:extLst>
            </p:cNvPr>
            <p:cNvSpPr txBox="1"/>
            <p:nvPr/>
          </p:nvSpPr>
          <p:spPr>
            <a:xfrm>
              <a:off x="2155590" y="4190143"/>
              <a:ext cx="1573068" cy="252803"/>
            </a:xfrm>
            <a:prstGeom prst="rect">
              <a:avLst/>
            </a:prstGeom>
            <a:noFill/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wrap="square" rtlCol="0">
              <a:spAutoFit/>
            </a:bodyPr>
            <a:lstStyle/>
            <a:p>
              <a:pPr marL="0" marR="0" lvl="0" indent="0" algn="ctr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</a:rPr>
                <a:t>Follow-up Clinic</a:t>
              </a:r>
            </a:p>
          </p:txBody>
        </p:sp>
        <p:grpSp>
          <p:nvGrpSpPr>
            <p:cNvPr id="128" name="Group 127">
              <a:extLst>
                <a:ext uri="{FF2B5EF4-FFF2-40B4-BE49-F238E27FC236}">
                  <a16:creationId xmlns:a16="http://schemas.microsoft.com/office/drawing/2014/main" id="{458FA2E6-800B-49B9-A01D-3181AB73FE0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532775" y="4487187"/>
              <a:ext cx="812195" cy="540000"/>
              <a:chOff x="389066" y="323870"/>
              <a:chExt cx="4229467" cy="2812024"/>
            </a:xfrm>
          </p:grpSpPr>
          <p:pic>
            <p:nvPicPr>
              <p:cNvPr id="129" name="Picture 128">
                <a:extLst>
                  <a:ext uri="{FF2B5EF4-FFF2-40B4-BE49-F238E27FC236}">
                    <a16:creationId xmlns:a16="http://schemas.microsoft.com/office/drawing/2014/main" id="{1B4C4EC2-BFF2-4A2D-AFAF-385EDADF9B8B}"/>
                  </a:ext>
                </a:extLst>
              </p:cNvPr>
              <p:cNvPicPr>
                <a:picLocks noChangeAspect="1"/>
              </p:cNvPicPr>
              <p:nvPr>
                <p:custDataLst>
                  <p:tags r:id="rId13"/>
                </p:custDataLst>
              </p:nvPr>
            </p:nvPicPr>
            <p:blipFill>
              <a:blip r:embed="rId18"/>
              <a:stretch>
                <a:fillRect/>
              </a:stretch>
            </p:blipFill>
            <p:spPr>
              <a:xfrm rot="16200000">
                <a:off x="1097788" y="-384852"/>
                <a:ext cx="2812024" cy="4229467"/>
              </a:xfrm>
              <a:prstGeom prst="rect">
                <a:avLst/>
              </a:prstGeom>
            </p:spPr>
          </p:pic>
          <p:pic>
            <p:nvPicPr>
              <p:cNvPr id="130" name="Picture 129">
                <a:extLst>
                  <a:ext uri="{FF2B5EF4-FFF2-40B4-BE49-F238E27FC236}">
                    <a16:creationId xmlns:a16="http://schemas.microsoft.com/office/drawing/2014/main" id="{09701E2E-451A-4553-BBC1-6FB913170C7B}"/>
                  </a:ext>
                </a:extLst>
              </p:cNvPr>
              <p:cNvPicPr>
                <a:picLocks noChangeAspect="1"/>
              </p:cNvPicPr>
              <p:nvPr>
                <p:custDataLst>
                  <p:tags r:id="rId14"/>
                </p:custDataLst>
              </p:nvPr>
            </p:nvPicPr>
            <p:blipFill>
              <a:blip r:embed="rId20"/>
              <a:stretch>
                <a:fillRect/>
              </a:stretch>
            </p:blipFill>
            <p:spPr>
              <a:xfrm>
                <a:off x="799567" y="462796"/>
                <a:ext cx="3351807" cy="2527592"/>
              </a:xfrm>
              <a:prstGeom prst="rect">
                <a:avLst/>
              </a:prstGeom>
            </p:spPr>
          </p:pic>
        </p:grpSp>
      </p:grp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9E6281EA-DAA2-442E-BC04-D223F1542884}"/>
              </a:ext>
            </a:extLst>
          </p:cNvPr>
          <p:cNvCxnSpPr>
            <a:endCxn id="131" idx="0"/>
          </p:cNvCxnSpPr>
          <p:nvPr/>
        </p:nvCxnSpPr>
        <p:spPr>
          <a:xfrm flipH="1">
            <a:off x="2386151" y="3211280"/>
            <a:ext cx="2049546" cy="307010"/>
          </a:xfrm>
          <a:prstGeom prst="line">
            <a:avLst/>
          </a:prstGeom>
          <a:noFill/>
          <a:ln w="9525" cap="flat" cmpd="sng" algn="ctr">
            <a:solidFill>
              <a:srgbClr val="0066A1">
                <a:shade val="95000"/>
                <a:satMod val="105000"/>
              </a:srgbClr>
            </a:solidFill>
            <a:prstDash val="solid"/>
          </a:ln>
          <a:effectLst/>
        </p:spPr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832A5C7E-E63B-404F-BD56-CA1258938B9B}"/>
              </a:ext>
            </a:extLst>
          </p:cNvPr>
          <p:cNvCxnSpPr>
            <a:endCxn id="126" idx="0"/>
          </p:cNvCxnSpPr>
          <p:nvPr/>
        </p:nvCxnSpPr>
        <p:spPr>
          <a:xfrm flipH="1">
            <a:off x="4311907" y="3199582"/>
            <a:ext cx="123791" cy="330195"/>
          </a:xfrm>
          <a:prstGeom prst="line">
            <a:avLst/>
          </a:prstGeom>
          <a:noFill/>
          <a:ln w="9525" cap="flat" cmpd="sng" algn="ctr">
            <a:solidFill>
              <a:srgbClr val="0066A1">
                <a:shade val="95000"/>
                <a:satMod val="105000"/>
              </a:srgbClr>
            </a:solidFill>
            <a:prstDash val="solid"/>
          </a:ln>
          <a:effectLst/>
        </p:spPr>
      </p:cxnSp>
      <p:sp>
        <p:nvSpPr>
          <p:cNvPr id="89" name="Rectangle 88">
            <a:extLst>
              <a:ext uri="{FF2B5EF4-FFF2-40B4-BE49-F238E27FC236}">
                <a16:creationId xmlns:a16="http://schemas.microsoft.com/office/drawing/2014/main" id="{EBA04C61-A221-418F-B95C-F5240FB99F3B}"/>
              </a:ext>
            </a:extLst>
          </p:cNvPr>
          <p:cNvSpPr/>
          <p:nvPr>
            <p:custDataLst>
              <p:tags r:id="rId6"/>
            </p:custDataLst>
          </p:nvPr>
        </p:nvSpPr>
        <p:spPr>
          <a:xfrm>
            <a:off x="2220737" y="5516965"/>
            <a:ext cx="1260630" cy="442109"/>
          </a:xfrm>
          <a:prstGeom prst="rect">
            <a:avLst/>
          </a:prstGeom>
          <a:solidFill>
            <a:sysClr val="window" lastClr="FFFFFF">
              <a:lumMod val="50000"/>
            </a:sys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HYSICIAN PORTAL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5E1BA774-FFA9-407B-B3DF-A8C5F2121C12}"/>
              </a:ext>
            </a:extLst>
          </p:cNvPr>
          <p:cNvSpPr/>
          <p:nvPr>
            <p:custDataLst>
              <p:tags r:id="rId7"/>
            </p:custDataLst>
          </p:nvPr>
        </p:nvSpPr>
        <p:spPr>
          <a:xfrm>
            <a:off x="9252717" y="5516965"/>
            <a:ext cx="1487655" cy="438604"/>
          </a:xfrm>
          <a:prstGeom prst="rect">
            <a:avLst/>
          </a:prstGeom>
          <a:solidFill>
            <a:sysClr val="window" lastClr="FFFFFF">
              <a:lumMod val="50000"/>
            </a:sys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ATIENT PORTAL</a:t>
            </a:r>
          </a:p>
        </p:txBody>
      </p:sp>
      <p:sp>
        <p:nvSpPr>
          <p:cNvPr id="91" name="AutoShape 11">
            <a:extLst>
              <a:ext uri="{FF2B5EF4-FFF2-40B4-BE49-F238E27FC236}">
                <a16:creationId xmlns:a16="http://schemas.microsoft.com/office/drawing/2014/main" id="{BF9A0CAF-6C34-4957-BE0D-51542B0B97DD}"/>
              </a:ext>
            </a:extLst>
          </p:cNvPr>
          <p:cNvSpPr>
            <a:spLocks/>
          </p:cNvSpPr>
          <p:nvPr/>
        </p:nvSpPr>
        <p:spPr bwMode="auto">
          <a:xfrm>
            <a:off x="2620248" y="4793227"/>
            <a:ext cx="736848" cy="684810"/>
          </a:xfrm>
          <a:custGeom>
            <a:avLst/>
            <a:gdLst/>
            <a:ahLst/>
            <a:cxnLst/>
            <a:rect l="0" t="0" r="r" b="b"/>
            <a:pathLst>
              <a:path w="21600" h="21600">
                <a:moveTo>
                  <a:pt x="17743" y="5306"/>
                </a:moveTo>
                <a:lnTo>
                  <a:pt x="15924" y="5306"/>
                </a:lnTo>
                <a:lnTo>
                  <a:pt x="15924" y="7135"/>
                </a:lnTo>
                <a:lnTo>
                  <a:pt x="14458" y="7135"/>
                </a:lnTo>
                <a:lnTo>
                  <a:pt x="14458" y="5306"/>
                </a:lnTo>
                <a:lnTo>
                  <a:pt x="12640" y="5306"/>
                </a:lnTo>
                <a:lnTo>
                  <a:pt x="12640" y="3832"/>
                </a:lnTo>
                <a:lnTo>
                  <a:pt x="14458" y="3832"/>
                </a:lnTo>
                <a:lnTo>
                  <a:pt x="14458" y="2003"/>
                </a:lnTo>
                <a:lnTo>
                  <a:pt x="15924" y="2003"/>
                </a:lnTo>
                <a:lnTo>
                  <a:pt x="15924" y="3832"/>
                </a:lnTo>
                <a:lnTo>
                  <a:pt x="17743" y="3832"/>
                </a:lnTo>
                <a:cubicBezTo>
                  <a:pt x="17743" y="3832"/>
                  <a:pt x="17743" y="5306"/>
                  <a:pt x="17743" y="5306"/>
                </a:cubicBezTo>
                <a:close/>
                <a:moveTo>
                  <a:pt x="10785" y="14008"/>
                </a:moveTo>
                <a:cubicBezTo>
                  <a:pt x="10785" y="14325"/>
                  <a:pt x="10529" y="14583"/>
                  <a:pt x="10213" y="14583"/>
                </a:cubicBezTo>
                <a:lnTo>
                  <a:pt x="9070" y="14583"/>
                </a:lnTo>
                <a:cubicBezTo>
                  <a:pt x="8754" y="14583"/>
                  <a:pt x="8498" y="14325"/>
                  <a:pt x="8498" y="14008"/>
                </a:cubicBezTo>
                <a:lnTo>
                  <a:pt x="8498" y="12858"/>
                </a:lnTo>
                <a:cubicBezTo>
                  <a:pt x="8498" y="12540"/>
                  <a:pt x="8754" y="12283"/>
                  <a:pt x="9070" y="12283"/>
                </a:cubicBezTo>
                <a:lnTo>
                  <a:pt x="10213" y="12283"/>
                </a:lnTo>
                <a:cubicBezTo>
                  <a:pt x="10529" y="12283"/>
                  <a:pt x="10785" y="12540"/>
                  <a:pt x="10785" y="12858"/>
                </a:cubicBezTo>
                <a:cubicBezTo>
                  <a:pt x="10785" y="12858"/>
                  <a:pt x="10785" y="14008"/>
                  <a:pt x="10785" y="14008"/>
                </a:cubicBezTo>
                <a:close/>
                <a:moveTo>
                  <a:pt x="10785" y="17602"/>
                </a:moveTo>
                <a:cubicBezTo>
                  <a:pt x="10785" y="17920"/>
                  <a:pt x="10529" y="18176"/>
                  <a:pt x="10213" y="18176"/>
                </a:cubicBezTo>
                <a:lnTo>
                  <a:pt x="9070" y="18176"/>
                </a:lnTo>
                <a:cubicBezTo>
                  <a:pt x="8754" y="18176"/>
                  <a:pt x="8498" y="17920"/>
                  <a:pt x="8498" y="17602"/>
                </a:cubicBezTo>
                <a:lnTo>
                  <a:pt x="8498" y="16452"/>
                </a:lnTo>
                <a:cubicBezTo>
                  <a:pt x="8498" y="16134"/>
                  <a:pt x="8754" y="15877"/>
                  <a:pt x="9070" y="15877"/>
                </a:cubicBezTo>
                <a:lnTo>
                  <a:pt x="10213" y="15877"/>
                </a:lnTo>
                <a:cubicBezTo>
                  <a:pt x="10529" y="15877"/>
                  <a:pt x="10785" y="16134"/>
                  <a:pt x="10785" y="16452"/>
                </a:cubicBezTo>
                <a:cubicBezTo>
                  <a:pt x="10785" y="16452"/>
                  <a:pt x="10785" y="17602"/>
                  <a:pt x="10785" y="17602"/>
                </a:cubicBezTo>
                <a:close/>
                <a:moveTo>
                  <a:pt x="7426" y="14008"/>
                </a:moveTo>
                <a:cubicBezTo>
                  <a:pt x="7426" y="14325"/>
                  <a:pt x="7170" y="14583"/>
                  <a:pt x="6855" y="14583"/>
                </a:cubicBezTo>
                <a:lnTo>
                  <a:pt x="5711" y="14583"/>
                </a:lnTo>
                <a:cubicBezTo>
                  <a:pt x="5395" y="14583"/>
                  <a:pt x="5140" y="14325"/>
                  <a:pt x="5140" y="14008"/>
                </a:cubicBezTo>
                <a:lnTo>
                  <a:pt x="5140" y="12858"/>
                </a:lnTo>
                <a:cubicBezTo>
                  <a:pt x="5140" y="12540"/>
                  <a:pt x="5395" y="12283"/>
                  <a:pt x="5711" y="12283"/>
                </a:cubicBezTo>
                <a:lnTo>
                  <a:pt x="6855" y="12283"/>
                </a:lnTo>
                <a:cubicBezTo>
                  <a:pt x="7170" y="12283"/>
                  <a:pt x="7426" y="12540"/>
                  <a:pt x="7426" y="12858"/>
                </a:cubicBezTo>
                <a:cubicBezTo>
                  <a:pt x="7426" y="12858"/>
                  <a:pt x="7426" y="14008"/>
                  <a:pt x="7426" y="14008"/>
                </a:cubicBezTo>
                <a:close/>
                <a:moveTo>
                  <a:pt x="7426" y="17602"/>
                </a:moveTo>
                <a:cubicBezTo>
                  <a:pt x="7426" y="17920"/>
                  <a:pt x="7170" y="18176"/>
                  <a:pt x="6855" y="18176"/>
                </a:cubicBezTo>
                <a:lnTo>
                  <a:pt x="5711" y="18176"/>
                </a:lnTo>
                <a:cubicBezTo>
                  <a:pt x="5395" y="18176"/>
                  <a:pt x="5140" y="17920"/>
                  <a:pt x="5140" y="17602"/>
                </a:cubicBezTo>
                <a:lnTo>
                  <a:pt x="5140" y="16452"/>
                </a:lnTo>
                <a:cubicBezTo>
                  <a:pt x="5140" y="16134"/>
                  <a:pt x="5395" y="15877"/>
                  <a:pt x="5711" y="15877"/>
                </a:cubicBezTo>
                <a:lnTo>
                  <a:pt x="6855" y="15877"/>
                </a:lnTo>
                <a:cubicBezTo>
                  <a:pt x="7170" y="15877"/>
                  <a:pt x="7426" y="16134"/>
                  <a:pt x="7426" y="16452"/>
                </a:cubicBezTo>
                <a:cubicBezTo>
                  <a:pt x="7426" y="16452"/>
                  <a:pt x="7426" y="17602"/>
                  <a:pt x="7426" y="17602"/>
                </a:cubicBezTo>
                <a:close/>
                <a:moveTo>
                  <a:pt x="4067" y="14008"/>
                </a:moveTo>
                <a:cubicBezTo>
                  <a:pt x="4067" y="14325"/>
                  <a:pt x="3812" y="14583"/>
                  <a:pt x="3496" y="14583"/>
                </a:cubicBezTo>
                <a:lnTo>
                  <a:pt x="2352" y="14583"/>
                </a:lnTo>
                <a:cubicBezTo>
                  <a:pt x="2037" y="14583"/>
                  <a:pt x="1781" y="14325"/>
                  <a:pt x="1781" y="14008"/>
                </a:cubicBezTo>
                <a:lnTo>
                  <a:pt x="1781" y="12858"/>
                </a:lnTo>
                <a:cubicBezTo>
                  <a:pt x="1781" y="12540"/>
                  <a:pt x="2037" y="12283"/>
                  <a:pt x="2352" y="12283"/>
                </a:cubicBezTo>
                <a:lnTo>
                  <a:pt x="3496" y="12283"/>
                </a:lnTo>
                <a:cubicBezTo>
                  <a:pt x="3812" y="12283"/>
                  <a:pt x="4067" y="12540"/>
                  <a:pt x="4067" y="12858"/>
                </a:cubicBezTo>
                <a:cubicBezTo>
                  <a:pt x="4067" y="12858"/>
                  <a:pt x="4067" y="14008"/>
                  <a:pt x="4067" y="14008"/>
                </a:cubicBezTo>
                <a:close/>
                <a:moveTo>
                  <a:pt x="4067" y="17602"/>
                </a:moveTo>
                <a:cubicBezTo>
                  <a:pt x="4067" y="17920"/>
                  <a:pt x="3812" y="18176"/>
                  <a:pt x="3496" y="18176"/>
                </a:cubicBezTo>
                <a:lnTo>
                  <a:pt x="2352" y="18176"/>
                </a:lnTo>
                <a:cubicBezTo>
                  <a:pt x="2037" y="18176"/>
                  <a:pt x="1781" y="17920"/>
                  <a:pt x="1781" y="17602"/>
                </a:cubicBezTo>
                <a:lnTo>
                  <a:pt x="1781" y="16452"/>
                </a:lnTo>
                <a:cubicBezTo>
                  <a:pt x="1781" y="16134"/>
                  <a:pt x="2037" y="15877"/>
                  <a:pt x="2352" y="15877"/>
                </a:cubicBezTo>
                <a:lnTo>
                  <a:pt x="3496" y="15877"/>
                </a:lnTo>
                <a:cubicBezTo>
                  <a:pt x="3812" y="15877"/>
                  <a:pt x="4067" y="16134"/>
                  <a:pt x="4067" y="16452"/>
                </a:cubicBezTo>
                <a:cubicBezTo>
                  <a:pt x="4067" y="16452"/>
                  <a:pt x="4067" y="17602"/>
                  <a:pt x="4067" y="17602"/>
                </a:cubicBezTo>
                <a:close/>
                <a:moveTo>
                  <a:pt x="8823" y="0"/>
                </a:moveTo>
                <a:lnTo>
                  <a:pt x="8823" y="9411"/>
                </a:lnTo>
                <a:lnTo>
                  <a:pt x="13437" y="9411"/>
                </a:lnTo>
                <a:cubicBezTo>
                  <a:pt x="14398" y="9411"/>
                  <a:pt x="15179" y="10219"/>
                  <a:pt x="15179" y="11211"/>
                </a:cubicBezTo>
                <a:lnTo>
                  <a:pt x="15179" y="14663"/>
                </a:lnTo>
                <a:cubicBezTo>
                  <a:pt x="15179" y="14846"/>
                  <a:pt x="15036" y="14994"/>
                  <a:pt x="14859" y="14994"/>
                </a:cubicBezTo>
                <a:cubicBezTo>
                  <a:pt x="14682" y="14994"/>
                  <a:pt x="14539" y="14846"/>
                  <a:pt x="14539" y="14663"/>
                </a:cubicBezTo>
                <a:lnTo>
                  <a:pt x="14539" y="11211"/>
                </a:lnTo>
                <a:cubicBezTo>
                  <a:pt x="14539" y="10583"/>
                  <a:pt x="14045" y="10073"/>
                  <a:pt x="13437" y="10073"/>
                </a:cubicBezTo>
                <a:lnTo>
                  <a:pt x="8823" y="10073"/>
                </a:lnTo>
                <a:lnTo>
                  <a:pt x="8823" y="10079"/>
                </a:lnTo>
                <a:lnTo>
                  <a:pt x="1422" y="10079"/>
                </a:lnTo>
                <a:cubicBezTo>
                  <a:pt x="637" y="10079"/>
                  <a:pt x="0" y="10737"/>
                  <a:pt x="0" y="11549"/>
                </a:cubicBezTo>
                <a:lnTo>
                  <a:pt x="0" y="21600"/>
                </a:lnTo>
                <a:lnTo>
                  <a:pt x="21600" y="21600"/>
                </a:lnTo>
                <a:lnTo>
                  <a:pt x="21600" y="0"/>
                </a:lnTo>
                <a:cubicBezTo>
                  <a:pt x="21600" y="0"/>
                  <a:pt x="8823" y="0"/>
                  <a:pt x="8823" y="0"/>
                </a:cubicBezTo>
                <a:close/>
                <a:moveTo>
                  <a:pt x="8823" y="0"/>
                </a:moveTo>
              </a:path>
            </a:pathLst>
          </a:custGeom>
          <a:solidFill>
            <a:srgbClr val="83C9BF"/>
          </a:solidFill>
          <a:ln>
            <a:noFill/>
          </a:ln>
        </p:spPr>
        <p:txBody>
          <a:bodyPr lIns="0" tIns="0" rIns="0" bIns="0"/>
          <a:lstStyle/>
          <a:p>
            <a:pPr marL="0" marR="0" lvl="0" indent="0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000" b="0" i="0" u="none" strike="noStrike" kern="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</a:endParaRPr>
          </a:p>
        </p:txBody>
      </p:sp>
      <p:grpSp>
        <p:nvGrpSpPr>
          <p:cNvPr id="92" name="Group 91">
            <a:extLst>
              <a:ext uri="{FF2B5EF4-FFF2-40B4-BE49-F238E27FC236}">
                <a16:creationId xmlns:a16="http://schemas.microsoft.com/office/drawing/2014/main" id="{F76CA714-D3ED-4F3F-8F53-AEA22FD40E35}"/>
              </a:ext>
            </a:extLst>
          </p:cNvPr>
          <p:cNvGrpSpPr/>
          <p:nvPr/>
        </p:nvGrpSpPr>
        <p:grpSpPr>
          <a:xfrm>
            <a:off x="2287319" y="4802846"/>
            <a:ext cx="248013" cy="675201"/>
            <a:chOff x="539552" y="1819127"/>
            <a:chExt cx="236475" cy="693249"/>
          </a:xfrm>
        </p:grpSpPr>
        <p:sp>
          <p:nvSpPr>
            <p:cNvPr id="122" name="AutoShape 23">
              <a:extLst>
                <a:ext uri="{FF2B5EF4-FFF2-40B4-BE49-F238E27FC236}">
                  <a16:creationId xmlns:a16="http://schemas.microsoft.com/office/drawing/2014/main" id="{4B5552A9-FBDB-4E01-AD33-39C0B5847F19}"/>
                </a:ext>
              </a:extLst>
            </p:cNvPr>
            <p:cNvSpPr>
              <a:spLocks/>
            </p:cNvSpPr>
            <p:nvPr/>
          </p:nvSpPr>
          <p:spPr bwMode="auto">
            <a:xfrm>
              <a:off x="607116" y="1819127"/>
              <a:ext cx="85662" cy="86200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0799" y="21600"/>
                  </a:moveTo>
                  <a:cubicBezTo>
                    <a:pt x="16761" y="21600"/>
                    <a:pt x="21600" y="16767"/>
                    <a:pt x="21600" y="10804"/>
                  </a:cubicBezTo>
                  <a:cubicBezTo>
                    <a:pt x="21600" y="4838"/>
                    <a:pt x="16761" y="0"/>
                    <a:pt x="10799" y="0"/>
                  </a:cubicBezTo>
                  <a:cubicBezTo>
                    <a:pt x="4834" y="0"/>
                    <a:pt x="0" y="4838"/>
                    <a:pt x="0" y="10804"/>
                  </a:cubicBezTo>
                  <a:cubicBezTo>
                    <a:pt x="0" y="16767"/>
                    <a:pt x="4834" y="21600"/>
                    <a:pt x="10799" y="21600"/>
                  </a:cubicBezTo>
                  <a:close/>
                  <a:moveTo>
                    <a:pt x="10799" y="2160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23" name="AutoShape 24">
              <a:extLst>
                <a:ext uri="{FF2B5EF4-FFF2-40B4-BE49-F238E27FC236}">
                  <a16:creationId xmlns:a16="http://schemas.microsoft.com/office/drawing/2014/main" id="{7593A423-9E49-48AD-BC97-1D8820245CC3}"/>
                </a:ext>
              </a:extLst>
            </p:cNvPr>
            <p:cNvSpPr>
              <a:spLocks/>
            </p:cNvSpPr>
            <p:nvPr/>
          </p:nvSpPr>
          <p:spPr bwMode="auto">
            <a:xfrm>
              <a:off x="587812" y="2236776"/>
              <a:ext cx="59118" cy="275600"/>
            </a:xfrm>
            <a:custGeom>
              <a:avLst/>
              <a:gdLst/>
              <a:ahLst/>
              <a:cxnLst/>
              <a:rect l="0" t="0" r="r" b="b"/>
              <a:pathLst>
                <a:path w="21450" h="21569">
                  <a:moveTo>
                    <a:pt x="5" y="19531"/>
                  </a:moveTo>
                  <a:cubicBezTo>
                    <a:pt x="-150" y="20622"/>
                    <a:pt x="3776" y="21534"/>
                    <a:pt x="8766" y="21568"/>
                  </a:cubicBezTo>
                  <a:cubicBezTo>
                    <a:pt x="13756" y="21600"/>
                    <a:pt x="17923" y="20741"/>
                    <a:pt x="18064" y="19648"/>
                  </a:cubicBezTo>
                  <a:lnTo>
                    <a:pt x="18946" y="16256"/>
                  </a:lnTo>
                  <a:lnTo>
                    <a:pt x="21450" y="0"/>
                  </a:lnTo>
                  <a:lnTo>
                    <a:pt x="236" y="0"/>
                  </a:lnTo>
                  <a:cubicBezTo>
                    <a:pt x="236" y="0"/>
                    <a:pt x="5" y="19531"/>
                    <a:pt x="5" y="19531"/>
                  </a:cubicBezTo>
                  <a:close/>
                  <a:moveTo>
                    <a:pt x="5" y="1953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24" name="AutoShape 26">
              <a:extLst>
                <a:ext uri="{FF2B5EF4-FFF2-40B4-BE49-F238E27FC236}">
                  <a16:creationId xmlns:a16="http://schemas.microsoft.com/office/drawing/2014/main" id="{EA568991-76B8-4B82-87B2-82DAB9D7105A}"/>
                </a:ext>
              </a:extLst>
            </p:cNvPr>
            <p:cNvSpPr>
              <a:spLocks/>
            </p:cNvSpPr>
            <p:nvPr/>
          </p:nvSpPr>
          <p:spPr bwMode="auto">
            <a:xfrm>
              <a:off x="539552" y="1906542"/>
              <a:ext cx="236475" cy="604621"/>
            </a:xfrm>
            <a:custGeom>
              <a:avLst/>
              <a:gdLst/>
              <a:ahLst/>
              <a:cxnLst/>
              <a:rect l="0" t="0" r="r" b="b"/>
              <a:pathLst>
                <a:path w="21529" h="21586">
                  <a:moveTo>
                    <a:pt x="17401" y="2359"/>
                  </a:moveTo>
                  <a:lnTo>
                    <a:pt x="15203" y="2359"/>
                  </a:lnTo>
                  <a:cubicBezTo>
                    <a:pt x="15007" y="2359"/>
                    <a:pt x="14849" y="2296"/>
                    <a:pt x="14849" y="2219"/>
                  </a:cubicBezTo>
                  <a:cubicBezTo>
                    <a:pt x="14849" y="2142"/>
                    <a:pt x="15007" y="2079"/>
                    <a:pt x="15203" y="2079"/>
                  </a:cubicBezTo>
                  <a:lnTo>
                    <a:pt x="17401" y="2079"/>
                  </a:lnTo>
                  <a:cubicBezTo>
                    <a:pt x="17597" y="2079"/>
                    <a:pt x="17756" y="2142"/>
                    <a:pt x="17756" y="2219"/>
                  </a:cubicBezTo>
                  <a:cubicBezTo>
                    <a:pt x="17756" y="2296"/>
                    <a:pt x="17597" y="2359"/>
                    <a:pt x="17401" y="2359"/>
                  </a:cubicBezTo>
                  <a:close/>
                  <a:moveTo>
                    <a:pt x="21393" y="6761"/>
                  </a:moveTo>
                  <a:cubicBezTo>
                    <a:pt x="21217" y="5515"/>
                    <a:pt x="20736" y="3164"/>
                    <a:pt x="19844" y="1775"/>
                  </a:cubicBezTo>
                  <a:lnTo>
                    <a:pt x="19737" y="1647"/>
                  </a:lnTo>
                  <a:cubicBezTo>
                    <a:pt x="19016" y="806"/>
                    <a:pt x="17437" y="188"/>
                    <a:pt x="15617" y="45"/>
                  </a:cubicBezTo>
                  <a:cubicBezTo>
                    <a:pt x="15617" y="45"/>
                    <a:pt x="15207" y="20"/>
                    <a:pt x="15000" y="17"/>
                  </a:cubicBezTo>
                  <a:cubicBezTo>
                    <a:pt x="14591" y="3"/>
                    <a:pt x="14246" y="0"/>
                    <a:pt x="14246" y="0"/>
                  </a:cubicBezTo>
                  <a:cubicBezTo>
                    <a:pt x="14233" y="10"/>
                    <a:pt x="14223" y="15"/>
                    <a:pt x="14209" y="22"/>
                  </a:cubicBezTo>
                  <a:lnTo>
                    <a:pt x="13267" y="2684"/>
                  </a:lnTo>
                  <a:cubicBezTo>
                    <a:pt x="13109" y="3083"/>
                    <a:pt x="12440" y="3336"/>
                    <a:pt x="11383" y="3397"/>
                  </a:cubicBezTo>
                  <a:lnTo>
                    <a:pt x="11188" y="3408"/>
                  </a:lnTo>
                  <a:lnTo>
                    <a:pt x="11188" y="4675"/>
                  </a:lnTo>
                  <a:lnTo>
                    <a:pt x="11315" y="4699"/>
                  </a:lnTo>
                  <a:cubicBezTo>
                    <a:pt x="11779" y="4788"/>
                    <a:pt x="12079" y="4981"/>
                    <a:pt x="12079" y="5191"/>
                  </a:cubicBezTo>
                  <a:cubicBezTo>
                    <a:pt x="12079" y="5491"/>
                    <a:pt x="11487" y="5734"/>
                    <a:pt x="10761" y="5734"/>
                  </a:cubicBezTo>
                  <a:cubicBezTo>
                    <a:pt x="10035" y="5734"/>
                    <a:pt x="9445" y="5491"/>
                    <a:pt x="9445" y="5191"/>
                  </a:cubicBezTo>
                  <a:cubicBezTo>
                    <a:pt x="9445" y="4981"/>
                    <a:pt x="9744" y="4788"/>
                    <a:pt x="10208" y="4699"/>
                  </a:cubicBezTo>
                  <a:lnTo>
                    <a:pt x="10336" y="4675"/>
                  </a:lnTo>
                  <a:lnTo>
                    <a:pt x="10336" y="3409"/>
                  </a:lnTo>
                  <a:lnTo>
                    <a:pt x="10144" y="3396"/>
                  </a:lnTo>
                  <a:cubicBezTo>
                    <a:pt x="9128" y="3332"/>
                    <a:pt x="8406" y="3059"/>
                    <a:pt x="8257" y="2683"/>
                  </a:cubicBezTo>
                  <a:lnTo>
                    <a:pt x="7313" y="17"/>
                  </a:lnTo>
                  <a:cubicBezTo>
                    <a:pt x="7304" y="13"/>
                    <a:pt x="7295" y="8"/>
                    <a:pt x="7284" y="0"/>
                  </a:cubicBezTo>
                  <a:cubicBezTo>
                    <a:pt x="7284" y="0"/>
                    <a:pt x="6938" y="3"/>
                    <a:pt x="6529" y="17"/>
                  </a:cubicBezTo>
                  <a:cubicBezTo>
                    <a:pt x="6323" y="20"/>
                    <a:pt x="5912" y="45"/>
                    <a:pt x="5912" y="45"/>
                  </a:cubicBezTo>
                  <a:cubicBezTo>
                    <a:pt x="4092" y="188"/>
                    <a:pt x="2514" y="806"/>
                    <a:pt x="1791" y="1647"/>
                  </a:cubicBezTo>
                  <a:lnTo>
                    <a:pt x="1684" y="1775"/>
                  </a:lnTo>
                  <a:cubicBezTo>
                    <a:pt x="792" y="3164"/>
                    <a:pt x="310" y="5515"/>
                    <a:pt x="136" y="6761"/>
                  </a:cubicBezTo>
                  <a:cubicBezTo>
                    <a:pt x="19" y="7597"/>
                    <a:pt x="-35" y="8005"/>
                    <a:pt x="25" y="8782"/>
                  </a:cubicBezTo>
                  <a:cubicBezTo>
                    <a:pt x="25" y="9328"/>
                    <a:pt x="1110" y="9740"/>
                    <a:pt x="2464" y="9713"/>
                  </a:cubicBezTo>
                  <a:lnTo>
                    <a:pt x="3581" y="3754"/>
                  </a:lnTo>
                  <a:cubicBezTo>
                    <a:pt x="3595" y="3630"/>
                    <a:pt x="3851" y="3531"/>
                    <a:pt x="4167" y="3531"/>
                  </a:cubicBezTo>
                  <a:cubicBezTo>
                    <a:pt x="4172" y="3531"/>
                    <a:pt x="4175" y="3532"/>
                    <a:pt x="4179" y="3532"/>
                  </a:cubicBezTo>
                  <a:lnTo>
                    <a:pt x="4061" y="11438"/>
                  </a:lnTo>
                  <a:lnTo>
                    <a:pt x="13011" y="11438"/>
                  </a:lnTo>
                  <a:cubicBezTo>
                    <a:pt x="13207" y="11438"/>
                    <a:pt x="13365" y="11500"/>
                    <a:pt x="13365" y="11578"/>
                  </a:cubicBezTo>
                  <a:cubicBezTo>
                    <a:pt x="13365" y="11655"/>
                    <a:pt x="13207" y="11717"/>
                    <a:pt x="13011" y="11717"/>
                  </a:cubicBezTo>
                  <a:lnTo>
                    <a:pt x="11393" y="11717"/>
                  </a:lnTo>
                  <a:lnTo>
                    <a:pt x="12051" y="19391"/>
                  </a:lnTo>
                  <a:lnTo>
                    <a:pt x="12239" y="20707"/>
                  </a:lnTo>
                  <a:cubicBezTo>
                    <a:pt x="12276" y="21207"/>
                    <a:pt x="13334" y="21600"/>
                    <a:pt x="14601" y="21586"/>
                  </a:cubicBezTo>
                  <a:cubicBezTo>
                    <a:pt x="15868" y="21570"/>
                    <a:pt x="16867" y="21153"/>
                    <a:pt x="16830" y="20654"/>
                  </a:cubicBezTo>
                  <a:lnTo>
                    <a:pt x="16773" y="11585"/>
                  </a:lnTo>
                  <a:lnTo>
                    <a:pt x="17441" y="11585"/>
                  </a:lnTo>
                  <a:lnTo>
                    <a:pt x="17322" y="3534"/>
                  </a:lnTo>
                  <a:cubicBezTo>
                    <a:pt x="17334" y="3534"/>
                    <a:pt x="17345" y="3531"/>
                    <a:pt x="17359" y="3531"/>
                  </a:cubicBezTo>
                  <a:cubicBezTo>
                    <a:pt x="17677" y="3531"/>
                    <a:pt x="17935" y="3630"/>
                    <a:pt x="17947" y="3754"/>
                  </a:cubicBezTo>
                  <a:lnTo>
                    <a:pt x="19065" y="9713"/>
                  </a:lnTo>
                  <a:cubicBezTo>
                    <a:pt x="20420" y="9740"/>
                    <a:pt x="21504" y="9328"/>
                    <a:pt x="21504" y="8782"/>
                  </a:cubicBezTo>
                  <a:cubicBezTo>
                    <a:pt x="21565" y="8005"/>
                    <a:pt x="21511" y="7597"/>
                    <a:pt x="21393" y="6761"/>
                  </a:cubicBezTo>
                  <a:close/>
                  <a:moveTo>
                    <a:pt x="21393" y="676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38F203B1-4C71-493E-93B0-7AE1CF22DC66}"/>
              </a:ext>
            </a:extLst>
          </p:cNvPr>
          <p:cNvGrpSpPr/>
          <p:nvPr/>
        </p:nvGrpSpPr>
        <p:grpSpPr>
          <a:xfrm>
            <a:off x="9457338" y="4796789"/>
            <a:ext cx="503838" cy="677884"/>
            <a:chOff x="2430235" y="1836056"/>
            <a:chExt cx="480398" cy="696003"/>
          </a:xfrm>
        </p:grpSpPr>
        <p:sp>
          <p:nvSpPr>
            <p:cNvPr id="114" name="AutoShape 13">
              <a:extLst>
                <a:ext uri="{FF2B5EF4-FFF2-40B4-BE49-F238E27FC236}">
                  <a16:creationId xmlns:a16="http://schemas.microsoft.com/office/drawing/2014/main" id="{0EE57FBE-F23C-4694-A691-BAEFBCD57CEA}"/>
                </a:ext>
              </a:extLst>
            </p:cNvPr>
            <p:cNvSpPr>
              <a:spLocks/>
            </p:cNvSpPr>
            <p:nvPr/>
          </p:nvSpPr>
          <p:spPr bwMode="auto">
            <a:xfrm>
              <a:off x="2502960" y="1836817"/>
              <a:ext cx="84089" cy="84618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0797" y="21600"/>
                  </a:moveTo>
                  <a:cubicBezTo>
                    <a:pt x="16764" y="21600"/>
                    <a:pt x="21600" y="16765"/>
                    <a:pt x="21600" y="10801"/>
                  </a:cubicBezTo>
                  <a:cubicBezTo>
                    <a:pt x="21600" y="4839"/>
                    <a:pt x="16764" y="0"/>
                    <a:pt x="10797" y="0"/>
                  </a:cubicBezTo>
                  <a:cubicBezTo>
                    <a:pt x="4834" y="0"/>
                    <a:pt x="0" y="4839"/>
                    <a:pt x="0" y="10801"/>
                  </a:cubicBezTo>
                  <a:cubicBezTo>
                    <a:pt x="0" y="16765"/>
                    <a:pt x="4834" y="21600"/>
                    <a:pt x="10797" y="21600"/>
                  </a:cubicBezTo>
                  <a:close/>
                  <a:moveTo>
                    <a:pt x="10797" y="2160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AutoShape 14">
              <a:extLst>
                <a:ext uri="{FF2B5EF4-FFF2-40B4-BE49-F238E27FC236}">
                  <a16:creationId xmlns:a16="http://schemas.microsoft.com/office/drawing/2014/main" id="{3B452B11-30FA-461E-8E3E-11A715F3FBDF}"/>
                </a:ext>
              </a:extLst>
            </p:cNvPr>
            <p:cNvSpPr>
              <a:spLocks/>
            </p:cNvSpPr>
            <p:nvPr/>
          </p:nvSpPr>
          <p:spPr bwMode="auto">
            <a:xfrm>
              <a:off x="2472658" y="2257621"/>
              <a:ext cx="58332" cy="274438"/>
            </a:xfrm>
            <a:custGeom>
              <a:avLst/>
              <a:gdLst/>
              <a:ahLst/>
              <a:cxnLst/>
              <a:rect l="0" t="0" r="r" b="b"/>
              <a:pathLst>
                <a:path w="21454" h="21570">
                  <a:moveTo>
                    <a:pt x="238" y="0"/>
                  </a:moveTo>
                  <a:lnTo>
                    <a:pt x="4" y="19558"/>
                  </a:lnTo>
                  <a:cubicBezTo>
                    <a:pt x="-146" y="20635"/>
                    <a:pt x="3771" y="21536"/>
                    <a:pt x="8750" y="21569"/>
                  </a:cubicBezTo>
                  <a:cubicBezTo>
                    <a:pt x="13732" y="21600"/>
                    <a:pt x="17890" y="20752"/>
                    <a:pt x="18034" y="19673"/>
                  </a:cubicBezTo>
                  <a:lnTo>
                    <a:pt x="18912" y="16324"/>
                  </a:lnTo>
                  <a:lnTo>
                    <a:pt x="21454" y="0"/>
                  </a:lnTo>
                  <a:cubicBezTo>
                    <a:pt x="21454" y="0"/>
                    <a:pt x="238" y="0"/>
                    <a:pt x="238" y="0"/>
                  </a:cubicBezTo>
                  <a:close/>
                  <a:moveTo>
                    <a:pt x="238" y="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AutoShape 15">
              <a:extLst>
                <a:ext uri="{FF2B5EF4-FFF2-40B4-BE49-F238E27FC236}">
                  <a16:creationId xmlns:a16="http://schemas.microsoft.com/office/drawing/2014/main" id="{0EEC2A79-9AD2-4ABA-A164-8EC7FD236C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3564" y="2257621"/>
              <a:ext cx="58332" cy="274438"/>
            </a:xfrm>
            <a:custGeom>
              <a:avLst/>
              <a:gdLst/>
              <a:ahLst/>
              <a:cxnLst/>
              <a:rect l="0" t="0" r="r" b="b"/>
              <a:pathLst>
                <a:path w="21456" h="21570">
                  <a:moveTo>
                    <a:pt x="0" y="0"/>
                  </a:moveTo>
                  <a:lnTo>
                    <a:pt x="2631" y="16835"/>
                  </a:lnTo>
                  <a:lnTo>
                    <a:pt x="3370" y="19673"/>
                  </a:lnTo>
                  <a:cubicBezTo>
                    <a:pt x="3516" y="20752"/>
                    <a:pt x="7687" y="21600"/>
                    <a:pt x="12680" y="21569"/>
                  </a:cubicBezTo>
                  <a:cubicBezTo>
                    <a:pt x="17666" y="21536"/>
                    <a:pt x="21600" y="20636"/>
                    <a:pt x="21452" y="19559"/>
                  </a:cubicBezTo>
                  <a:lnTo>
                    <a:pt x="21233" y="0"/>
                  </a:lnTo>
                  <a:cubicBezTo>
                    <a:pt x="21233" y="0"/>
                    <a:pt x="0" y="0"/>
                    <a:pt x="0" y="0"/>
                  </a:cubicBezTo>
                  <a:close/>
                  <a:moveTo>
                    <a:pt x="0" y="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7" name="AutoShape 16">
              <a:extLst>
                <a:ext uri="{FF2B5EF4-FFF2-40B4-BE49-F238E27FC236}">
                  <a16:creationId xmlns:a16="http://schemas.microsoft.com/office/drawing/2014/main" id="{2C8867FB-C324-48B7-8379-E509AC0EA3D6}"/>
                </a:ext>
              </a:extLst>
            </p:cNvPr>
            <p:cNvSpPr>
              <a:spLocks/>
            </p:cNvSpPr>
            <p:nvPr/>
          </p:nvSpPr>
          <p:spPr bwMode="auto">
            <a:xfrm>
              <a:off x="2430235" y="1934395"/>
              <a:ext cx="111361" cy="310267"/>
            </a:xfrm>
            <a:custGeom>
              <a:avLst/>
              <a:gdLst/>
              <a:ahLst/>
              <a:cxnLst/>
              <a:rect l="0" t="0" r="r" b="b"/>
              <a:pathLst>
                <a:path w="21527" h="21600">
                  <a:moveTo>
                    <a:pt x="21527" y="21600"/>
                  </a:moveTo>
                  <a:lnTo>
                    <a:pt x="21527" y="9839"/>
                  </a:lnTo>
                  <a:lnTo>
                    <a:pt x="15019" y="0"/>
                  </a:lnTo>
                  <a:cubicBezTo>
                    <a:pt x="14909" y="1"/>
                    <a:pt x="14273" y="8"/>
                    <a:pt x="13503" y="32"/>
                  </a:cubicBezTo>
                  <a:cubicBezTo>
                    <a:pt x="13072" y="39"/>
                    <a:pt x="12226" y="87"/>
                    <a:pt x="12226" y="87"/>
                  </a:cubicBezTo>
                  <a:cubicBezTo>
                    <a:pt x="8461" y="359"/>
                    <a:pt x="5201" y="1539"/>
                    <a:pt x="3705" y="3146"/>
                  </a:cubicBezTo>
                  <a:lnTo>
                    <a:pt x="3484" y="3390"/>
                  </a:lnTo>
                  <a:cubicBezTo>
                    <a:pt x="1640" y="6043"/>
                    <a:pt x="641" y="10533"/>
                    <a:pt x="280" y="12912"/>
                  </a:cubicBezTo>
                  <a:cubicBezTo>
                    <a:pt x="39" y="14508"/>
                    <a:pt x="-73" y="15288"/>
                    <a:pt x="52" y="16771"/>
                  </a:cubicBezTo>
                  <a:cubicBezTo>
                    <a:pt x="52" y="17815"/>
                    <a:pt x="2295" y="18601"/>
                    <a:pt x="5098" y="18550"/>
                  </a:cubicBezTo>
                  <a:lnTo>
                    <a:pt x="7406" y="7169"/>
                  </a:lnTo>
                  <a:cubicBezTo>
                    <a:pt x="7433" y="6933"/>
                    <a:pt x="7963" y="6744"/>
                    <a:pt x="8619" y="6744"/>
                  </a:cubicBezTo>
                  <a:cubicBezTo>
                    <a:pt x="8628" y="6744"/>
                    <a:pt x="8635" y="6746"/>
                    <a:pt x="8642" y="6746"/>
                  </a:cubicBezTo>
                  <a:lnTo>
                    <a:pt x="8402" y="21600"/>
                  </a:lnTo>
                  <a:cubicBezTo>
                    <a:pt x="8402" y="21600"/>
                    <a:pt x="21527" y="21600"/>
                    <a:pt x="21527" y="21600"/>
                  </a:cubicBezTo>
                  <a:close/>
                  <a:moveTo>
                    <a:pt x="21527" y="2160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8" name="AutoShape 17">
              <a:extLst>
                <a:ext uri="{FF2B5EF4-FFF2-40B4-BE49-F238E27FC236}">
                  <a16:creationId xmlns:a16="http://schemas.microsoft.com/office/drawing/2014/main" id="{C7561366-2691-46BE-972F-A5876A8BE238}"/>
                </a:ext>
              </a:extLst>
            </p:cNvPr>
            <p:cNvSpPr>
              <a:spLocks/>
            </p:cNvSpPr>
            <p:nvPr/>
          </p:nvSpPr>
          <p:spPr bwMode="auto">
            <a:xfrm>
              <a:off x="2551444" y="1934395"/>
              <a:ext cx="111361" cy="310267"/>
            </a:xfrm>
            <a:custGeom>
              <a:avLst/>
              <a:gdLst/>
              <a:ahLst/>
              <a:cxnLst/>
              <a:rect l="0" t="0" r="r" b="b"/>
              <a:pathLst>
                <a:path w="21527" h="21600">
                  <a:moveTo>
                    <a:pt x="11532" y="4505"/>
                  </a:moveTo>
                  <a:lnTo>
                    <a:pt x="6989" y="4505"/>
                  </a:lnTo>
                  <a:cubicBezTo>
                    <a:pt x="6584" y="4505"/>
                    <a:pt x="6255" y="4385"/>
                    <a:pt x="6255" y="4238"/>
                  </a:cubicBezTo>
                  <a:cubicBezTo>
                    <a:pt x="6255" y="4090"/>
                    <a:pt x="6584" y="3970"/>
                    <a:pt x="6989" y="3970"/>
                  </a:cubicBezTo>
                  <a:lnTo>
                    <a:pt x="11532" y="3970"/>
                  </a:lnTo>
                  <a:cubicBezTo>
                    <a:pt x="11937" y="3970"/>
                    <a:pt x="12266" y="4090"/>
                    <a:pt x="12266" y="4238"/>
                  </a:cubicBezTo>
                  <a:cubicBezTo>
                    <a:pt x="12266" y="4385"/>
                    <a:pt x="11937" y="4505"/>
                    <a:pt x="11532" y="4505"/>
                  </a:cubicBezTo>
                  <a:close/>
                  <a:moveTo>
                    <a:pt x="21246" y="12912"/>
                  </a:moveTo>
                  <a:cubicBezTo>
                    <a:pt x="20883" y="10533"/>
                    <a:pt x="19888" y="6043"/>
                    <a:pt x="18044" y="3390"/>
                  </a:cubicBezTo>
                  <a:lnTo>
                    <a:pt x="17822" y="3146"/>
                  </a:lnTo>
                  <a:cubicBezTo>
                    <a:pt x="16330" y="1539"/>
                    <a:pt x="13065" y="359"/>
                    <a:pt x="9300" y="88"/>
                  </a:cubicBezTo>
                  <a:cubicBezTo>
                    <a:pt x="9300" y="88"/>
                    <a:pt x="8452" y="39"/>
                    <a:pt x="8024" y="32"/>
                  </a:cubicBezTo>
                  <a:cubicBezTo>
                    <a:pt x="7250" y="8"/>
                    <a:pt x="6614" y="1"/>
                    <a:pt x="6506" y="0"/>
                  </a:cubicBezTo>
                  <a:lnTo>
                    <a:pt x="0" y="9803"/>
                  </a:lnTo>
                  <a:lnTo>
                    <a:pt x="0" y="21600"/>
                  </a:lnTo>
                  <a:lnTo>
                    <a:pt x="13065" y="21600"/>
                  </a:lnTo>
                  <a:lnTo>
                    <a:pt x="12827" y="6750"/>
                  </a:lnTo>
                  <a:cubicBezTo>
                    <a:pt x="12853" y="6750"/>
                    <a:pt x="12877" y="6744"/>
                    <a:pt x="12905" y="6744"/>
                  </a:cubicBezTo>
                  <a:cubicBezTo>
                    <a:pt x="13560" y="6744"/>
                    <a:pt x="14094" y="6933"/>
                    <a:pt x="14119" y="7169"/>
                  </a:cubicBezTo>
                  <a:lnTo>
                    <a:pt x="16431" y="18550"/>
                  </a:lnTo>
                  <a:cubicBezTo>
                    <a:pt x="19233" y="18601"/>
                    <a:pt x="21474" y="17815"/>
                    <a:pt x="21474" y="16772"/>
                  </a:cubicBezTo>
                  <a:cubicBezTo>
                    <a:pt x="21600" y="15288"/>
                    <a:pt x="21491" y="14508"/>
                    <a:pt x="21246" y="12912"/>
                  </a:cubicBezTo>
                  <a:close/>
                  <a:moveTo>
                    <a:pt x="21246" y="12912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9" name="AutoShape 41">
              <a:extLst>
                <a:ext uri="{FF2B5EF4-FFF2-40B4-BE49-F238E27FC236}">
                  <a16:creationId xmlns:a16="http://schemas.microsoft.com/office/drawing/2014/main" id="{DC7E27A9-E31D-4E96-941C-A67A0C3CCC5E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8363" y="1836056"/>
              <a:ext cx="85604" cy="86142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0800" y="21600"/>
                  </a:moveTo>
                  <a:cubicBezTo>
                    <a:pt x="16767" y="21600"/>
                    <a:pt x="21600" y="16764"/>
                    <a:pt x="21600" y="10799"/>
                  </a:cubicBezTo>
                  <a:cubicBezTo>
                    <a:pt x="21600" y="4835"/>
                    <a:pt x="16767" y="0"/>
                    <a:pt x="10800" y="0"/>
                  </a:cubicBezTo>
                  <a:cubicBezTo>
                    <a:pt x="4835" y="0"/>
                    <a:pt x="0" y="4835"/>
                    <a:pt x="0" y="10799"/>
                  </a:cubicBezTo>
                  <a:cubicBezTo>
                    <a:pt x="0" y="16764"/>
                    <a:pt x="4835" y="21600"/>
                    <a:pt x="10800" y="21600"/>
                  </a:cubicBezTo>
                  <a:close/>
                  <a:moveTo>
                    <a:pt x="10800" y="2160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20" name="AutoShape 42">
              <a:extLst>
                <a:ext uri="{FF2B5EF4-FFF2-40B4-BE49-F238E27FC236}">
                  <a16:creationId xmlns:a16="http://schemas.microsoft.com/office/drawing/2014/main" id="{7B2F7F15-99F7-447F-ABA1-E218E0878E12}"/>
                </a:ext>
              </a:extLst>
            </p:cNvPr>
            <p:cNvSpPr>
              <a:spLocks/>
            </p:cNvSpPr>
            <p:nvPr/>
          </p:nvSpPr>
          <p:spPr bwMode="auto">
            <a:xfrm>
              <a:off x="2740183" y="2317845"/>
              <a:ext cx="53029" cy="214214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6464" y="19691"/>
                  </a:moveTo>
                  <a:cubicBezTo>
                    <a:pt x="6464" y="20745"/>
                    <a:pt x="9852" y="21600"/>
                    <a:pt x="14033" y="21600"/>
                  </a:cubicBezTo>
                  <a:cubicBezTo>
                    <a:pt x="18211" y="21600"/>
                    <a:pt x="21600" y="20745"/>
                    <a:pt x="21600" y="19691"/>
                  </a:cubicBezTo>
                  <a:lnTo>
                    <a:pt x="21600" y="9"/>
                  </a:lnTo>
                  <a:lnTo>
                    <a:pt x="0" y="0"/>
                  </a:lnTo>
                  <a:cubicBezTo>
                    <a:pt x="0" y="0"/>
                    <a:pt x="6464" y="19691"/>
                    <a:pt x="6464" y="19691"/>
                  </a:cubicBezTo>
                  <a:close/>
                  <a:moveTo>
                    <a:pt x="6464" y="1969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21" name="AutoShape 43">
              <a:extLst>
                <a:ext uri="{FF2B5EF4-FFF2-40B4-BE49-F238E27FC236}">
                  <a16:creationId xmlns:a16="http://schemas.microsoft.com/office/drawing/2014/main" id="{DE2CBBB0-446C-4D0D-B71F-4C9C55FA9E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85639" y="1927534"/>
              <a:ext cx="224994" cy="603761"/>
            </a:xfrm>
            <a:custGeom>
              <a:avLst/>
              <a:gdLst/>
              <a:ahLst/>
              <a:cxnLst/>
              <a:rect l="0" t="0" r="r" b="b"/>
              <a:pathLst>
                <a:path w="21529" h="21600">
                  <a:moveTo>
                    <a:pt x="21395" y="7031"/>
                  </a:moveTo>
                  <a:cubicBezTo>
                    <a:pt x="21219" y="5733"/>
                    <a:pt x="20737" y="3296"/>
                    <a:pt x="19846" y="1848"/>
                  </a:cubicBezTo>
                  <a:lnTo>
                    <a:pt x="19739" y="1715"/>
                  </a:lnTo>
                  <a:cubicBezTo>
                    <a:pt x="19015" y="839"/>
                    <a:pt x="17437" y="196"/>
                    <a:pt x="15617" y="47"/>
                  </a:cubicBezTo>
                  <a:cubicBezTo>
                    <a:pt x="15617" y="47"/>
                    <a:pt x="15208" y="21"/>
                    <a:pt x="15000" y="17"/>
                  </a:cubicBezTo>
                  <a:cubicBezTo>
                    <a:pt x="14591" y="3"/>
                    <a:pt x="14244" y="0"/>
                    <a:pt x="14244" y="0"/>
                  </a:cubicBezTo>
                  <a:cubicBezTo>
                    <a:pt x="14229" y="13"/>
                    <a:pt x="14224" y="18"/>
                    <a:pt x="14200" y="28"/>
                  </a:cubicBezTo>
                  <a:cubicBezTo>
                    <a:pt x="13383" y="394"/>
                    <a:pt x="12143" y="625"/>
                    <a:pt x="10766" y="634"/>
                  </a:cubicBezTo>
                  <a:lnTo>
                    <a:pt x="10765" y="634"/>
                  </a:lnTo>
                  <a:cubicBezTo>
                    <a:pt x="9388" y="625"/>
                    <a:pt x="8148" y="394"/>
                    <a:pt x="7330" y="28"/>
                  </a:cubicBezTo>
                  <a:cubicBezTo>
                    <a:pt x="7307" y="18"/>
                    <a:pt x="7301" y="13"/>
                    <a:pt x="7286" y="0"/>
                  </a:cubicBezTo>
                  <a:cubicBezTo>
                    <a:pt x="7286" y="0"/>
                    <a:pt x="6940" y="3"/>
                    <a:pt x="6531" y="17"/>
                  </a:cubicBezTo>
                  <a:cubicBezTo>
                    <a:pt x="6323" y="21"/>
                    <a:pt x="5913" y="47"/>
                    <a:pt x="5913" y="47"/>
                  </a:cubicBezTo>
                  <a:cubicBezTo>
                    <a:pt x="4093" y="196"/>
                    <a:pt x="2515" y="839"/>
                    <a:pt x="1792" y="1715"/>
                  </a:cubicBezTo>
                  <a:lnTo>
                    <a:pt x="1684" y="1848"/>
                  </a:lnTo>
                  <a:cubicBezTo>
                    <a:pt x="794" y="3296"/>
                    <a:pt x="311" y="5733"/>
                    <a:pt x="136" y="7031"/>
                  </a:cubicBezTo>
                  <a:cubicBezTo>
                    <a:pt x="18" y="7901"/>
                    <a:pt x="-35" y="8326"/>
                    <a:pt x="26" y="9135"/>
                  </a:cubicBezTo>
                  <a:cubicBezTo>
                    <a:pt x="26" y="9704"/>
                    <a:pt x="1107" y="10132"/>
                    <a:pt x="2460" y="10105"/>
                  </a:cubicBezTo>
                  <a:lnTo>
                    <a:pt x="3675" y="3437"/>
                  </a:lnTo>
                  <a:cubicBezTo>
                    <a:pt x="3694" y="3328"/>
                    <a:pt x="3732" y="3242"/>
                    <a:pt x="3978" y="3228"/>
                  </a:cubicBezTo>
                  <a:cubicBezTo>
                    <a:pt x="4223" y="3214"/>
                    <a:pt x="4354" y="3262"/>
                    <a:pt x="4455" y="3363"/>
                  </a:cubicBezTo>
                  <a:cubicBezTo>
                    <a:pt x="4613" y="3521"/>
                    <a:pt x="5428" y="4669"/>
                    <a:pt x="4486" y="7503"/>
                  </a:cubicBezTo>
                  <a:cubicBezTo>
                    <a:pt x="4160" y="8479"/>
                    <a:pt x="3977" y="9389"/>
                    <a:pt x="3874" y="10155"/>
                  </a:cubicBezTo>
                  <a:cubicBezTo>
                    <a:pt x="3851" y="10404"/>
                    <a:pt x="3830" y="10697"/>
                    <a:pt x="3831" y="10898"/>
                  </a:cubicBezTo>
                  <a:cubicBezTo>
                    <a:pt x="3836" y="11703"/>
                    <a:pt x="3968" y="12959"/>
                    <a:pt x="4213" y="13663"/>
                  </a:cubicBezTo>
                  <a:lnTo>
                    <a:pt x="13402" y="13660"/>
                  </a:lnTo>
                  <a:lnTo>
                    <a:pt x="13426" y="13660"/>
                  </a:lnTo>
                  <a:lnTo>
                    <a:pt x="13426" y="13661"/>
                  </a:lnTo>
                  <a:cubicBezTo>
                    <a:pt x="13616" y="13666"/>
                    <a:pt x="13767" y="13724"/>
                    <a:pt x="13767" y="13797"/>
                  </a:cubicBezTo>
                  <a:cubicBezTo>
                    <a:pt x="13767" y="13870"/>
                    <a:pt x="13616" y="13928"/>
                    <a:pt x="13426" y="13933"/>
                  </a:cubicBezTo>
                  <a:lnTo>
                    <a:pt x="13426" y="13934"/>
                  </a:lnTo>
                  <a:lnTo>
                    <a:pt x="13402" y="13934"/>
                  </a:lnTo>
                  <a:lnTo>
                    <a:pt x="11451" y="13933"/>
                  </a:lnTo>
                  <a:lnTo>
                    <a:pt x="11451" y="20921"/>
                  </a:lnTo>
                  <a:lnTo>
                    <a:pt x="11451" y="20922"/>
                  </a:lnTo>
                  <a:cubicBezTo>
                    <a:pt x="11451" y="21296"/>
                    <a:pt x="12256" y="21600"/>
                    <a:pt x="13250" y="21600"/>
                  </a:cubicBezTo>
                  <a:cubicBezTo>
                    <a:pt x="14244" y="21600"/>
                    <a:pt x="15049" y="21296"/>
                    <a:pt x="15049" y="20922"/>
                  </a:cubicBezTo>
                  <a:lnTo>
                    <a:pt x="16498" y="13922"/>
                  </a:lnTo>
                  <a:lnTo>
                    <a:pt x="17208" y="13922"/>
                  </a:lnTo>
                  <a:cubicBezTo>
                    <a:pt x="17523" y="13318"/>
                    <a:pt x="17694" y="11815"/>
                    <a:pt x="17700" y="10898"/>
                  </a:cubicBezTo>
                  <a:cubicBezTo>
                    <a:pt x="17701" y="10683"/>
                    <a:pt x="17676" y="10364"/>
                    <a:pt x="17652" y="10104"/>
                  </a:cubicBezTo>
                  <a:cubicBezTo>
                    <a:pt x="17548" y="9349"/>
                    <a:pt x="17364" y="8457"/>
                    <a:pt x="17048" y="7503"/>
                  </a:cubicBezTo>
                  <a:cubicBezTo>
                    <a:pt x="16105" y="4669"/>
                    <a:pt x="16919" y="3521"/>
                    <a:pt x="17077" y="3363"/>
                  </a:cubicBezTo>
                  <a:cubicBezTo>
                    <a:pt x="17178" y="3262"/>
                    <a:pt x="17309" y="3214"/>
                    <a:pt x="17555" y="3228"/>
                  </a:cubicBezTo>
                  <a:cubicBezTo>
                    <a:pt x="17801" y="3242"/>
                    <a:pt x="17838" y="3328"/>
                    <a:pt x="17857" y="3437"/>
                  </a:cubicBezTo>
                  <a:lnTo>
                    <a:pt x="19073" y="10105"/>
                  </a:lnTo>
                  <a:cubicBezTo>
                    <a:pt x="20424" y="10131"/>
                    <a:pt x="21505" y="9704"/>
                    <a:pt x="21505" y="9135"/>
                  </a:cubicBezTo>
                  <a:cubicBezTo>
                    <a:pt x="21565" y="8326"/>
                    <a:pt x="21512" y="7901"/>
                    <a:pt x="21395" y="7031"/>
                  </a:cubicBezTo>
                  <a:close/>
                  <a:moveTo>
                    <a:pt x="21395" y="703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94" name="AutoShape 10">
            <a:extLst>
              <a:ext uri="{FF2B5EF4-FFF2-40B4-BE49-F238E27FC236}">
                <a16:creationId xmlns:a16="http://schemas.microsoft.com/office/drawing/2014/main" id="{1A11CE93-3CE8-4292-87C3-674C17A317CE}"/>
              </a:ext>
            </a:extLst>
          </p:cNvPr>
          <p:cNvSpPr>
            <a:spLocks/>
          </p:cNvSpPr>
          <p:nvPr/>
        </p:nvSpPr>
        <p:spPr bwMode="auto">
          <a:xfrm>
            <a:off x="9995604" y="4777500"/>
            <a:ext cx="722534" cy="697173"/>
          </a:xfrm>
          <a:custGeom>
            <a:avLst/>
            <a:gdLst/>
            <a:ahLst/>
            <a:cxnLst/>
            <a:rect l="0" t="0" r="r" b="b"/>
            <a:pathLst>
              <a:path w="21600" h="21600">
                <a:moveTo>
                  <a:pt x="10698" y="14966"/>
                </a:moveTo>
                <a:cubicBezTo>
                  <a:pt x="10698" y="15196"/>
                  <a:pt x="10506" y="15382"/>
                  <a:pt x="10268" y="15382"/>
                </a:cubicBezTo>
                <a:lnTo>
                  <a:pt x="8580" y="15382"/>
                </a:lnTo>
                <a:cubicBezTo>
                  <a:pt x="8343" y="15382"/>
                  <a:pt x="8151" y="15196"/>
                  <a:pt x="8151" y="14966"/>
                </a:cubicBezTo>
                <a:lnTo>
                  <a:pt x="8151" y="13330"/>
                </a:lnTo>
                <a:cubicBezTo>
                  <a:pt x="8151" y="13100"/>
                  <a:pt x="8343" y="12914"/>
                  <a:pt x="8580" y="12914"/>
                </a:cubicBezTo>
                <a:lnTo>
                  <a:pt x="10268" y="12914"/>
                </a:lnTo>
                <a:cubicBezTo>
                  <a:pt x="10506" y="12914"/>
                  <a:pt x="10698" y="13100"/>
                  <a:pt x="10698" y="13330"/>
                </a:cubicBezTo>
                <a:cubicBezTo>
                  <a:pt x="10698" y="13330"/>
                  <a:pt x="10698" y="14966"/>
                  <a:pt x="10698" y="14966"/>
                </a:cubicBezTo>
                <a:close/>
                <a:moveTo>
                  <a:pt x="10698" y="18345"/>
                </a:moveTo>
                <a:cubicBezTo>
                  <a:pt x="10698" y="18575"/>
                  <a:pt x="10506" y="18761"/>
                  <a:pt x="10268" y="18761"/>
                </a:cubicBezTo>
                <a:lnTo>
                  <a:pt x="8580" y="18761"/>
                </a:lnTo>
                <a:cubicBezTo>
                  <a:pt x="8343" y="18761"/>
                  <a:pt x="8151" y="18575"/>
                  <a:pt x="8151" y="18345"/>
                </a:cubicBezTo>
                <a:lnTo>
                  <a:pt x="8151" y="16709"/>
                </a:lnTo>
                <a:cubicBezTo>
                  <a:pt x="8151" y="16479"/>
                  <a:pt x="8343" y="16294"/>
                  <a:pt x="8580" y="16294"/>
                </a:cubicBezTo>
                <a:lnTo>
                  <a:pt x="10268" y="16294"/>
                </a:lnTo>
                <a:cubicBezTo>
                  <a:pt x="10506" y="16294"/>
                  <a:pt x="10698" y="16479"/>
                  <a:pt x="10698" y="16709"/>
                </a:cubicBezTo>
                <a:cubicBezTo>
                  <a:pt x="10698" y="16709"/>
                  <a:pt x="10698" y="18345"/>
                  <a:pt x="10698" y="18345"/>
                </a:cubicBezTo>
                <a:close/>
                <a:moveTo>
                  <a:pt x="7192" y="14966"/>
                </a:moveTo>
                <a:cubicBezTo>
                  <a:pt x="7192" y="15196"/>
                  <a:pt x="7000" y="15382"/>
                  <a:pt x="6763" y="15382"/>
                </a:cubicBezTo>
                <a:lnTo>
                  <a:pt x="5074" y="15382"/>
                </a:lnTo>
                <a:cubicBezTo>
                  <a:pt x="4837" y="15382"/>
                  <a:pt x="4645" y="15196"/>
                  <a:pt x="4645" y="14966"/>
                </a:cubicBezTo>
                <a:lnTo>
                  <a:pt x="4645" y="13330"/>
                </a:lnTo>
                <a:cubicBezTo>
                  <a:pt x="4645" y="13100"/>
                  <a:pt x="4837" y="12914"/>
                  <a:pt x="5074" y="12914"/>
                </a:cubicBezTo>
                <a:lnTo>
                  <a:pt x="6763" y="12914"/>
                </a:lnTo>
                <a:cubicBezTo>
                  <a:pt x="7000" y="12914"/>
                  <a:pt x="7192" y="13100"/>
                  <a:pt x="7192" y="13330"/>
                </a:cubicBezTo>
                <a:cubicBezTo>
                  <a:pt x="7192" y="13330"/>
                  <a:pt x="7192" y="14966"/>
                  <a:pt x="7192" y="14966"/>
                </a:cubicBezTo>
                <a:close/>
                <a:moveTo>
                  <a:pt x="7192" y="18345"/>
                </a:moveTo>
                <a:cubicBezTo>
                  <a:pt x="7192" y="18575"/>
                  <a:pt x="7000" y="18761"/>
                  <a:pt x="6763" y="18761"/>
                </a:cubicBezTo>
                <a:lnTo>
                  <a:pt x="5074" y="18761"/>
                </a:lnTo>
                <a:cubicBezTo>
                  <a:pt x="4837" y="18761"/>
                  <a:pt x="4645" y="18575"/>
                  <a:pt x="4645" y="18345"/>
                </a:cubicBezTo>
                <a:lnTo>
                  <a:pt x="4645" y="16709"/>
                </a:lnTo>
                <a:cubicBezTo>
                  <a:pt x="4645" y="16479"/>
                  <a:pt x="4837" y="16294"/>
                  <a:pt x="5074" y="16294"/>
                </a:cubicBezTo>
                <a:lnTo>
                  <a:pt x="6763" y="16294"/>
                </a:lnTo>
                <a:cubicBezTo>
                  <a:pt x="7000" y="16294"/>
                  <a:pt x="7192" y="16479"/>
                  <a:pt x="7192" y="16709"/>
                </a:cubicBezTo>
                <a:cubicBezTo>
                  <a:pt x="7192" y="16709"/>
                  <a:pt x="7192" y="18345"/>
                  <a:pt x="7192" y="18345"/>
                </a:cubicBezTo>
                <a:close/>
                <a:moveTo>
                  <a:pt x="10753" y="0"/>
                </a:moveTo>
                <a:lnTo>
                  <a:pt x="4656" y="6577"/>
                </a:lnTo>
                <a:lnTo>
                  <a:pt x="4656" y="5401"/>
                </a:lnTo>
                <a:lnTo>
                  <a:pt x="2195" y="5401"/>
                </a:lnTo>
                <a:lnTo>
                  <a:pt x="2195" y="9232"/>
                </a:lnTo>
                <a:lnTo>
                  <a:pt x="0" y="11599"/>
                </a:lnTo>
                <a:lnTo>
                  <a:pt x="1991" y="11598"/>
                </a:lnTo>
                <a:lnTo>
                  <a:pt x="1991" y="21600"/>
                </a:lnTo>
                <a:lnTo>
                  <a:pt x="18945" y="21600"/>
                </a:lnTo>
                <a:lnTo>
                  <a:pt x="18945" y="11582"/>
                </a:lnTo>
                <a:lnTo>
                  <a:pt x="21600" y="11579"/>
                </a:lnTo>
                <a:cubicBezTo>
                  <a:pt x="21600" y="11579"/>
                  <a:pt x="10753" y="0"/>
                  <a:pt x="10753" y="0"/>
                </a:cubicBezTo>
                <a:close/>
                <a:moveTo>
                  <a:pt x="10753" y="0"/>
                </a:moveTo>
              </a:path>
            </a:pathLst>
          </a:custGeom>
          <a:solidFill>
            <a:srgbClr val="83C9BF"/>
          </a:solidFill>
          <a:ln>
            <a:noFill/>
          </a:ln>
        </p:spPr>
        <p:txBody>
          <a:bodyPr lIns="0" tIns="0" rIns="0" bIns="0"/>
          <a:lstStyle/>
          <a:p>
            <a:pPr marL="0" marR="0" lvl="0" indent="0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000" b="0" i="0" u="none" strike="noStrike" kern="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</a:endParaRPr>
          </a:p>
        </p:txBody>
      </p:sp>
      <p:pic>
        <p:nvPicPr>
          <p:cNvPr id="95" name="Picture 4" descr="image004">
            <a:extLst>
              <a:ext uri="{FF2B5EF4-FFF2-40B4-BE49-F238E27FC236}">
                <a16:creationId xmlns:a16="http://schemas.microsoft.com/office/drawing/2014/main" id="{087B192C-FAA1-42A5-9ACD-946418349A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62965" y="2334835"/>
            <a:ext cx="804108" cy="7852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96" name="Group 95">
            <a:extLst>
              <a:ext uri="{FF2B5EF4-FFF2-40B4-BE49-F238E27FC236}">
                <a16:creationId xmlns:a16="http://schemas.microsoft.com/office/drawing/2014/main" id="{356904AF-2742-4DF1-9B1C-6E7D0F40D72F}"/>
              </a:ext>
            </a:extLst>
          </p:cNvPr>
          <p:cNvGrpSpPr/>
          <p:nvPr/>
        </p:nvGrpSpPr>
        <p:grpSpPr>
          <a:xfrm>
            <a:off x="9220628" y="3540961"/>
            <a:ext cx="1419646" cy="876569"/>
            <a:chOff x="6367613" y="3888609"/>
            <a:chExt cx="1353600" cy="900000"/>
          </a:xfrm>
        </p:grpSpPr>
        <p:pic>
          <p:nvPicPr>
            <p:cNvPr id="112" name="Picture 111">
              <a:extLst>
                <a:ext uri="{FF2B5EF4-FFF2-40B4-BE49-F238E27FC236}">
                  <a16:creationId xmlns:a16="http://schemas.microsoft.com/office/drawing/2014/main" id="{CD416D3B-9569-44F5-AEFF-D5EFCBC324A9}"/>
                </a:ext>
              </a:extLst>
            </p:cNvPr>
            <p:cNvPicPr>
              <a:picLocks noChangeAspect="1"/>
            </p:cNvPicPr>
            <p:nvPr>
              <p:custDataLst>
                <p:tags r:id="rId12"/>
              </p:custDataLst>
            </p:nvPr>
          </p:nvPicPr>
          <p:blipFill>
            <a:blip r:embed="rId18"/>
            <a:stretch>
              <a:fillRect/>
            </a:stretch>
          </p:blipFill>
          <p:spPr>
            <a:xfrm rot="16200000">
              <a:off x="6594413" y="3661809"/>
              <a:ext cx="900000" cy="1353600"/>
            </a:xfrm>
            <a:prstGeom prst="rect">
              <a:avLst/>
            </a:prstGeom>
          </p:spPr>
        </p:pic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C682536A-520C-47FB-AA09-2AB8DB2E6A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73911" y="3918206"/>
              <a:ext cx="1126349" cy="844763"/>
            </a:xfrm>
            <a:prstGeom prst="rect">
              <a:avLst/>
            </a:prstGeom>
          </p:spPr>
        </p:pic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86CF2517-AD18-4063-87FF-A2579C871600}"/>
              </a:ext>
            </a:extLst>
          </p:cNvPr>
          <p:cNvGrpSpPr>
            <a:grpSpLocks noChangeAspect="1"/>
          </p:cNvGrpSpPr>
          <p:nvPr/>
        </p:nvGrpSpPr>
        <p:grpSpPr>
          <a:xfrm>
            <a:off x="6370922" y="3525580"/>
            <a:ext cx="1419707" cy="876569"/>
            <a:chOff x="389066" y="323870"/>
            <a:chExt cx="4229467" cy="2812024"/>
          </a:xfrm>
        </p:grpSpPr>
        <p:pic>
          <p:nvPicPr>
            <p:cNvPr id="110" name="Picture 109">
              <a:extLst>
                <a:ext uri="{FF2B5EF4-FFF2-40B4-BE49-F238E27FC236}">
                  <a16:creationId xmlns:a16="http://schemas.microsoft.com/office/drawing/2014/main" id="{4A09E496-C048-43B8-B3CC-B531B6C04C39}"/>
                </a:ext>
              </a:extLst>
            </p:cNvPr>
            <p:cNvPicPr>
              <a:picLocks noChangeAspect="1"/>
            </p:cNvPicPr>
            <p:nvPr>
              <p:custDataLst>
                <p:tags r:id="rId10"/>
              </p:custDataLst>
            </p:nvPr>
          </p:nvPicPr>
          <p:blipFill>
            <a:blip r:embed="rId18"/>
            <a:stretch>
              <a:fillRect/>
            </a:stretch>
          </p:blipFill>
          <p:spPr>
            <a:xfrm rot="16200000">
              <a:off x="1097788" y="-384852"/>
              <a:ext cx="2812024" cy="4229467"/>
            </a:xfrm>
            <a:prstGeom prst="rect">
              <a:avLst/>
            </a:prstGeom>
          </p:spPr>
        </p:pic>
        <p:pic>
          <p:nvPicPr>
            <p:cNvPr id="111" name="Picture 110">
              <a:extLst>
                <a:ext uri="{FF2B5EF4-FFF2-40B4-BE49-F238E27FC236}">
                  <a16:creationId xmlns:a16="http://schemas.microsoft.com/office/drawing/2014/main" id="{AC8C2990-9FBD-4FCA-9FDF-47DEB776E7A2}"/>
                </a:ext>
              </a:extLst>
            </p:cNvPr>
            <p:cNvPicPr>
              <a:picLocks noChangeAspect="1"/>
            </p:cNvPicPr>
            <p:nvPr>
              <p:custDataLst>
                <p:tags r:id="rId11"/>
              </p:custDataLst>
            </p:nvPr>
          </p:nvPicPr>
          <p:blipFill>
            <a:blip r:embed="rId20"/>
            <a:stretch>
              <a:fillRect/>
            </a:stretch>
          </p:blipFill>
          <p:spPr>
            <a:xfrm>
              <a:off x="799568" y="462796"/>
              <a:ext cx="3351807" cy="2527592"/>
            </a:xfrm>
            <a:prstGeom prst="rect">
              <a:avLst/>
            </a:prstGeom>
          </p:spPr>
        </p:pic>
      </p:grpSp>
      <p:grpSp>
        <p:nvGrpSpPr>
          <p:cNvPr id="98" name="Group 97">
            <a:extLst>
              <a:ext uri="{FF2B5EF4-FFF2-40B4-BE49-F238E27FC236}">
                <a16:creationId xmlns:a16="http://schemas.microsoft.com/office/drawing/2014/main" id="{5FA4CC85-56A3-4FBA-89EE-811905C52C48}"/>
              </a:ext>
            </a:extLst>
          </p:cNvPr>
          <p:cNvGrpSpPr/>
          <p:nvPr/>
        </p:nvGrpSpPr>
        <p:grpSpPr>
          <a:xfrm>
            <a:off x="9650157" y="2388314"/>
            <a:ext cx="789556" cy="522972"/>
            <a:chOff x="4575510" y="2743132"/>
            <a:chExt cx="1032358" cy="823886"/>
          </a:xfrm>
        </p:grpSpPr>
        <p:pic>
          <p:nvPicPr>
            <p:cNvPr id="107" name="Picture 3_">
              <a:extLst>
                <a:ext uri="{FF2B5EF4-FFF2-40B4-BE49-F238E27FC236}">
                  <a16:creationId xmlns:a16="http://schemas.microsoft.com/office/drawing/2014/main" id="{72A7242F-8160-4D02-BE73-4B33BA9733B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881949">
              <a:off x="5126493" y="2743132"/>
              <a:ext cx="481375" cy="661683"/>
            </a:xfrm>
            <a:prstGeom prst="rect">
              <a:avLst/>
            </a:prstGeom>
            <a:noFill/>
            <a:ln w="9525">
              <a:solidFill>
                <a:srgbClr val="0066A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8" name="Picture 3__">
              <a:extLst>
                <a:ext uri="{FF2B5EF4-FFF2-40B4-BE49-F238E27FC236}">
                  <a16:creationId xmlns:a16="http://schemas.microsoft.com/office/drawing/2014/main" id="{C750EB10-013D-40C3-9C86-18B03B3B5F6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1189719">
              <a:off x="4842449" y="2840336"/>
              <a:ext cx="491236" cy="675238"/>
            </a:xfrm>
            <a:prstGeom prst="rect">
              <a:avLst/>
            </a:prstGeom>
            <a:noFill/>
            <a:ln w="9525">
              <a:solidFill>
                <a:srgbClr val="0066A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9" name="Picture 3___">
              <a:extLst>
                <a:ext uri="{FF2B5EF4-FFF2-40B4-BE49-F238E27FC236}">
                  <a16:creationId xmlns:a16="http://schemas.microsoft.com/office/drawing/2014/main" id="{C84395D2-5BDF-42AE-9A35-93787B27965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5510" y="2931170"/>
              <a:ext cx="462580" cy="635848"/>
            </a:xfrm>
            <a:prstGeom prst="rect">
              <a:avLst/>
            </a:prstGeom>
            <a:noFill/>
            <a:ln w="9525">
              <a:solidFill>
                <a:srgbClr val="0066A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99" name="TextBox 98">
            <a:extLst>
              <a:ext uri="{FF2B5EF4-FFF2-40B4-BE49-F238E27FC236}">
                <a16:creationId xmlns:a16="http://schemas.microsoft.com/office/drawing/2014/main" id="{E2D44E27-024D-496E-BC52-C194298DED3A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>
            <a:off x="9565150" y="2957599"/>
            <a:ext cx="12840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rPr>
              <a:t>Drug refill</a:t>
            </a:r>
          </a:p>
          <a:p>
            <a:pPr marL="0" marR="0" lvl="0" indent="0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rPr>
              <a:t>Test reports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80A1B1F9-05D1-4BD9-BF2F-C049E126D49A}"/>
              </a:ext>
            </a:extLst>
          </p:cNvPr>
          <p:cNvSpPr/>
          <p:nvPr>
            <p:custDataLst>
              <p:tags r:id="rId9"/>
            </p:custDataLst>
          </p:nvPr>
        </p:nvSpPr>
        <p:spPr>
          <a:xfrm>
            <a:off x="6285526" y="5516965"/>
            <a:ext cx="1741243" cy="438604"/>
          </a:xfrm>
          <a:prstGeom prst="rect">
            <a:avLst/>
          </a:prstGeom>
          <a:solidFill>
            <a:sysClr val="window" lastClr="FFFFFF">
              <a:lumMod val="50000"/>
            </a:sys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EALTH MANAGER PORTAL*</a:t>
            </a:r>
          </a:p>
        </p:txBody>
      </p:sp>
      <p:grpSp>
        <p:nvGrpSpPr>
          <p:cNvPr id="101" name="Group 25">
            <a:extLst>
              <a:ext uri="{FF2B5EF4-FFF2-40B4-BE49-F238E27FC236}">
                <a16:creationId xmlns:a16="http://schemas.microsoft.com/office/drawing/2014/main" id="{9599DA33-D4F2-47E5-AC15-C48D250D24A9}"/>
              </a:ext>
            </a:extLst>
          </p:cNvPr>
          <p:cNvGrpSpPr/>
          <p:nvPr/>
        </p:nvGrpSpPr>
        <p:grpSpPr>
          <a:xfrm>
            <a:off x="6495609" y="4795189"/>
            <a:ext cx="248013" cy="675201"/>
            <a:chOff x="3178434" y="2040176"/>
            <a:chExt cx="157713" cy="462351"/>
          </a:xfrm>
        </p:grpSpPr>
        <p:sp>
          <p:nvSpPr>
            <p:cNvPr id="103" name="AutoShape 23">
              <a:extLst>
                <a:ext uri="{FF2B5EF4-FFF2-40B4-BE49-F238E27FC236}">
                  <a16:creationId xmlns:a16="http://schemas.microsoft.com/office/drawing/2014/main" id="{03A0D1BC-C580-4C27-BA30-F48B2CE5E76A}"/>
                </a:ext>
              </a:extLst>
            </p:cNvPr>
            <p:cNvSpPr>
              <a:spLocks/>
            </p:cNvSpPr>
            <p:nvPr/>
          </p:nvSpPr>
          <p:spPr bwMode="auto">
            <a:xfrm>
              <a:off x="3223495" y="2040176"/>
              <a:ext cx="57131" cy="57490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10799" y="21600"/>
                  </a:moveTo>
                  <a:cubicBezTo>
                    <a:pt x="16761" y="21600"/>
                    <a:pt x="21600" y="16767"/>
                    <a:pt x="21600" y="10804"/>
                  </a:cubicBezTo>
                  <a:cubicBezTo>
                    <a:pt x="21600" y="4838"/>
                    <a:pt x="16761" y="0"/>
                    <a:pt x="10799" y="0"/>
                  </a:cubicBezTo>
                  <a:cubicBezTo>
                    <a:pt x="4834" y="0"/>
                    <a:pt x="0" y="4838"/>
                    <a:pt x="0" y="10804"/>
                  </a:cubicBezTo>
                  <a:cubicBezTo>
                    <a:pt x="0" y="16767"/>
                    <a:pt x="4834" y="21600"/>
                    <a:pt x="10799" y="21600"/>
                  </a:cubicBezTo>
                  <a:close/>
                  <a:moveTo>
                    <a:pt x="10799" y="2160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04" name="AutoShape 24">
              <a:extLst>
                <a:ext uri="{FF2B5EF4-FFF2-40B4-BE49-F238E27FC236}">
                  <a16:creationId xmlns:a16="http://schemas.microsoft.com/office/drawing/2014/main" id="{D86603C8-C3E2-46E8-BF20-52F6AFC7F815}"/>
                </a:ext>
              </a:extLst>
            </p:cNvPr>
            <p:cNvSpPr>
              <a:spLocks/>
            </p:cNvSpPr>
            <p:nvPr/>
          </p:nvSpPr>
          <p:spPr bwMode="auto">
            <a:xfrm>
              <a:off x="3210620" y="2318720"/>
              <a:ext cx="39428" cy="183807"/>
            </a:xfrm>
            <a:custGeom>
              <a:avLst/>
              <a:gdLst/>
              <a:ahLst/>
              <a:cxnLst/>
              <a:rect l="0" t="0" r="r" b="b"/>
              <a:pathLst>
                <a:path w="21450" h="21569">
                  <a:moveTo>
                    <a:pt x="5" y="19531"/>
                  </a:moveTo>
                  <a:cubicBezTo>
                    <a:pt x="-150" y="20622"/>
                    <a:pt x="3776" y="21534"/>
                    <a:pt x="8766" y="21568"/>
                  </a:cubicBezTo>
                  <a:cubicBezTo>
                    <a:pt x="13756" y="21600"/>
                    <a:pt x="17923" y="20741"/>
                    <a:pt x="18064" y="19648"/>
                  </a:cubicBezTo>
                  <a:lnTo>
                    <a:pt x="18946" y="16256"/>
                  </a:lnTo>
                  <a:lnTo>
                    <a:pt x="21450" y="0"/>
                  </a:lnTo>
                  <a:lnTo>
                    <a:pt x="236" y="0"/>
                  </a:lnTo>
                  <a:cubicBezTo>
                    <a:pt x="236" y="0"/>
                    <a:pt x="5" y="19531"/>
                    <a:pt x="5" y="19531"/>
                  </a:cubicBezTo>
                  <a:close/>
                  <a:moveTo>
                    <a:pt x="5" y="1953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05" name="AutoShape 25">
              <a:extLst>
                <a:ext uri="{FF2B5EF4-FFF2-40B4-BE49-F238E27FC236}">
                  <a16:creationId xmlns:a16="http://schemas.microsoft.com/office/drawing/2014/main" id="{F995A130-901F-4693-B3A1-2188EA9BE6ED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6369" y="2104954"/>
              <a:ext cx="36210" cy="50202"/>
            </a:xfrm>
            <a:custGeom>
              <a:avLst/>
              <a:gdLst/>
              <a:ahLst/>
              <a:cxnLst/>
              <a:rect l="0" t="0" r="r" b="b"/>
              <a:pathLst>
                <a:path w="21600" h="21600">
                  <a:moveTo>
                    <a:pt x="0" y="0"/>
                  </a:moveTo>
                  <a:lnTo>
                    <a:pt x="3576" y="18180"/>
                  </a:lnTo>
                  <a:cubicBezTo>
                    <a:pt x="4011" y="20226"/>
                    <a:pt x="6476" y="21233"/>
                    <a:pt x="8632" y="21491"/>
                  </a:cubicBezTo>
                  <a:cubicBezTo>
                    <a:pt x="9241" y="21565"/>
                    <a:pt x="9943" y="21600"/>
                    <a:pt x="10739" y="21600"/>
                  </a:cubicBezTo>
                  <a:cubicBezTo>
                    <a:pt x="12051" y="21600"/>
                    <a:pt x="13151" y="21496"/>
                    <a:pt x="13214" y="21491"/>
                  </a:cubicBezTo>
                  <a:cubicBezTo>
                    <a:pt x="17489" y="21009"/>
                    <a:pt x="17946" y="18878"/>
                    <a:pt x="18095" y="18140"/>
                  </a:cubicBezTo>
                  <a:lnTo>
                    <a:pt x="21600" y="41"/>
                  </a:lnTo>
                  <a:cubicBezTo>
                    <a:pt x="18515" y="1372"/>
                    <a:pt x="14821" y="2168"/>
                    <a:pt x="10855" y="2216"/>
                  </a:cubicBezTo>
                  <a:lnTo>
                    <a:pt x="10832" y="2216"/>
                  </a:lnTo>
                  <a:cubicBezTo>
                    <a:pt x="6829" y="2168"/>
                    <a:pt x="3103" y="1356"/>
                    <a:pt x="0" y="0"/>
                  </a:cubicBezTo>
                  <a:close/>
                  <a:moveTo>
                    <a:pt x="0" y="0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  <p:sp>
          <p:nvSpPr>
            <p:cNvPr id="106" name="AutoShape 26">
              <a:extLst>
                <a:ext uri="{FF2B5EF4-FFF2-40B4-BE49-F238E27FC236}">
                  <a16:creationId xmlns:a16="http://schemas.microsoft.com/office/drawing/2014/main" id="{1CE73A73-A845-4BEB-AFA6-206508C4B04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8434" y="2098476"/>
              <a:ext cx="157713" cy="403242"/>
            </a:xfrm>
            <a:custGeom>
              <a:avLst/>
              <a:gdLst/>
              <a:ahLst/>
              <a:cxnLst/>
              <a:rect l="0" t="0" r="r" b="b"/>
              <a:pathLst>
                <a:path w="21529" h="21586">
                  <a:moveTo>
                    <a:pt x="17401" y="2359"/>
                  </a:moveTo>
                  <a:lnTo>
                    <a:pt x="15203" y="2359"/>
                  </a:lnTo>
                  <a:cubicBezTo>
                    <a:pt x="15007" y="2359"/>
                    <a:pt x="14849" y="2296"/>
                    <a:pt x="14849" y="2219"/>
                  </a:cubicBezTo>
                  <a:cubicBezTo>
                    <a:pt x="14849" y="2142"/>
                    <a:pt x="15007" y="2079"/>
                    <a:pt x="15203" y="2079"/>
                  </a:cubicBezTo>
                  <a:lnTo>
                    <a:pt x="17401" y="2079"/>
                  </a:lnTo>
                  <a:cubicBezTo>
                    <a:pt x="17597" y="2079"/>
                    <a:pt x="17756" y="2142"/>
                    <a:pt x="17756" y="2219"/>
                  </a:cubicBezTo>
                  <a:cubicBezTo>
                    <a:pt x="17756" y="2296"/>
                    <a:pt x="17597" y="2359"/>
                    <a:pt x="17401" y="2359"/>
                  </a:cubicBezTo>
                  <a:close/>
                  <a:moveTo>
                    <a:pt x="21393" y="6761"/>
                  </a:moveTo>
                  <a:cubicBezTo>
                    <a:pt x="21217" y="5515"/>
                    <a:pt x="20736" y="3164"/>
                    <a:pt x="19844" y="1775"/>
                  </a:cubicBezTo>
                  <a:lnTo>
                    <a:pt x="19737" y="1647"/>
                  </a:lnTo>
                  <a:cubicBezTo>
                    <a:pt x="19016" y="806"/>
                    <a:pt x="17437" y="188"/>
                    <a:pt x="15617" y="45"/>
                  </a:cubicBezTo>
                  <a:cubicBezTo>
                    <a:pt x="15617" y="45"/>
                    <a:pt x="15207" y="20"/>
                    <a:pt x="15000" y="17"/>
                  </a:cubicBezTo>
                  <a:cubicBezTo>
                    <a:pt x="14591" y="3"/>
                    <a:pt x="14246" y="0"/>
                    <a:pt x="14246" y="0"/>
                  </a:cubicBezTo>
                  <a:cubicBezTo>
                    <a:pt x="14233" y="10"/>
                    <a:pt x="14223" y="15"/>
                    <a:pt x="14209" y="22"/>
                  </a:cubicBezTo>
                  <a:lnTo>
                    <a:pt x="13267" y="2684"/>
                  </a:lnTo>
                  <a:cubicBezTo>
                    <a:pt x="13109" y="3083"/>
                    <a:pt x="12440" y="3336"/>
                    <a:pt x="11383" y="3397"/>
                  </a:cubicBezTo>
                  <a:lnTo>
                    <a:pt x="11188" y="3408"/>
                  </a:lnTo>
                  <a:lnTo>
                    <a:pt x="11188" y="4675"/>
                  </a:lnTo>
                  <a:lnTo>
                    <a:pt x="11315" y="4699"/>
                  </a:lnTo>
                  <a:cubicBezTo>
                    <a:pt x="11779" y="4788"/>
                    <a:pt x="12079" y="4981"/>
                    <a:pt x="12079" y="5191"/>
                  </a:cubicBezTo>
                  <a:cubicBezTo>
                    <a:pt x="12079" y="5491"/>
                    <a:pt x="11487" y="5734"/>
                    <a:pt x="10761" y="5734"/>
                  </a:cubicBezTo>
                  <a:cubicBezTo>
                    <a:pt x="10035" y="5734"/>
                    <a:pt x="9445" y="5491"/>
                    <a:pt x="9445" y="5191"/>
                  </a:cubicBezTo>
                  <a:cubicBezTo>
                    <a:pt x="9445" y="4981"/>
                    <a:pt x="9744" y="4788"/>
                    <a:pt x="10208" y="4699"/>
                  </a:cubicBezTo>
                  <a:lnTo>
                    <a:pt x="10336" y="4675"/>
                  </a:lnTo>
                  <a:lnTo>
                    <a:pt x="10336" y="3409"/>
                  </a:lnTo>
                  <a:lnTo>
                    <a:pt x="10144" y="3396"/>
                  </a:lnTo>
                  <a:cubicBezTo>
                    <a:pt x="9128" y="3332"/>
                    <a:pt x="8406" y="3059"/>
                    <a:pt x="8257" y="2683"/>
                  </a:cubicBezTo>
                  <a:lnTo>
                    <a:pt x="7313" y="17"/>
                  </a:lnTo>
                  <a:cubicBezTo>
                    <a:pt x="7304" y="13"/>
                    <a:pt x="7295" y="8"/>
                    <a:pt x="7284" y="0"/>
                  </a:cubicBezTo>
                  <a:cubicBezTo>
                    <a:pt x="7284" y="0"/>
                    <a:pt x="6938" y="3"/>
                    <a:pt x="6529" y="17"/>
                  </a:cubicBezTo>
                  <a:cubicBezTo>
                    <a:pt x="6323" y="20"/>
                    <a:pt x="5912" y="45"/>
                    <a:pt x="5912" y="45"/>
                  </a:cubicBezTo>
                  <a:cubicBezTo>
                    <a:pt x="4092" y="188"/>
                    <a:pt x="2514" y="806"/>
                    <a:pt x="1791" y="1647"/>
                  </a:cubicBezTo>
                  <a:lnTo>
                    <a:pt x="1684" y="1775"/>
                  </a:lnTo>
                  <a:cubicBezTo>
                    <a:pt x="792" y="3164"/>
                    <a:pt x="310" y="5515"/>
                    <a:pt x="136" y="6761"/>
                  </a:cubicBezTo>
                  <a:cubicBezTo>
                    <a:pt x="19" y="7597"/>
                    <a:pt x="-35" y="8005"/>
                    <a:pt x="25" y="8782"/>
                  </a:cubicBezTo>
                  <a:cubicBezTo>
                    <a:pt x="25" y="9328"/>
                    <a:pt x="1110" y="9740"/>
                    <a:pt x="2464" y="9713"/>
                  </a:cubicBezTo>
                  <a:lnTo>
                    <a:pt x="3581" y="3754"/>
                  </a:lnTo>
                  <a:cubicBezTo>
                    <a:pt x="3595" y="3630"/>
                    <a:pt x="3851" y="3531"/>
                    <a:pt x="4167" y="3531"/>
                  </a:cubicBezTo>
                  <a:cubicBezTo>
                    <a:pt x="4172" y="3531"/>
                    <a:pt x="4175" y="3532"/>
                    <a:pt x="4179" y="3532"/>
                  </a:cubicBezTo>
                  <a:lnTo>
                    <a:pt x="4061" y="11438"/>
                  </a:lnTo>
                  <a:lnTo>
                    <a:pt x="13011" y="11438"/>
                  </a:lnTo>
                  <a:cubicBezTo>
                    <a:pt x="13207" y="11438"/>
                    <a:pt x="13365" y="11500"/>
                    <a:pt x="13365" y="11578"/>
                  </a:cubicBezTo>
                  <a:cubicBezTo>
                    <a:pt x="13365" y="11655"/>
                    <a:pt x="13207" y="11717"/>
                    <a:pt x="13011" y="11717"/>
                  </a:cubicBezTo>
                  <a:lnTo>
                    <a:pt x="11393" y="11717"/>
                  </a:lnTo>
                  <a:lnTo>
                    <a:pt x="12051" y="19391"/>
                  </a:lnTo>
                  <a:lnTo>
                    <a:pt x="12239" y="20707"/>
                  </a:lnTo>
                  <a:cubicBezTo>
                    <a:pt x="12276" y="21207"/>
                    <a:pt x="13334" y="21600"/>
                    <a:pt x="14601" y="21586"/>
                  </a:cubicBezTo>
                  <a:cubicBezTo>
                    <a:pt x="15868" y="21570"/>
                    <a:pt x="16867" y="21153"/>
                    <a:pt x="16830" y="20654"/>
                  </a:cubicBezTo>
                  <a:lnTo>
                    <a:pt x="16773" y="11585"/>
                  </a:lnTo>
                  <a:lnTo>
                    <a:pt x="17441" y="11585"/>
                  </a:lnTo>
                  <a:lnTo>
                    <a:pt x="17322" y="3534"/>
                  </a:lnTo>
                  <a:cubicBezTo>
                    <a:pt x="17334" y="3534"/>
                    <a:pt x="17345" y="3531"/>
                    <a:pt x="17359" y="3531"/>
                  </a:cubicBezTo>
                  <a:cubicBezTo>
                    <a:pt x="17677" y="3531"/>
                    <a:pt x="17935" y="3630"/>
                    <a:pt x="17947" y="3754"/>
                  </a:cubicBezTo>
                  <a:lnTo>
                    <a:pt x="19065" y="9713"/>
                  </a:lnTo>
                  <a:cubicBezTo>
                    <a:pt x="20420" y="9740"/>
                    <a:pt x="21504" y="9328"/>
                    <a:pt x="21504" y="8782"/>
                  </a:cubicBezTo>
                  <a:cubicBezTo>
                    <a:pt x="21565" y="8005"/>
                    <a:pt x="21511" y="7597"/>
                    <a:pt x="21393" y="6761"/>
                  </a:cubicBezTo>
                  <a:close/>
                  <a:moveTo>
                    <a:pt x="21393" y="6761"/>
                  </a:moveTo>
                </a:path>
              </a:pathLst>
            </a:custGeom>
            <a:solidFill>
              <a:srgbClr val="B6BF00"/>
            </a:solidFill>
            <a:ln>
              <a:noFill/>
            </a:ln>
          </p:spPr>
          <p:txBody>
            <a:bodyPr lIns="0" tIns="0" rIns="0" bIns="0"/>
            <a:lstStyle/>
            <a:p>
              <a:pPr marL="0" marR="0" lvl="0" indent="0" defTabSz="914278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02" name="AutoShape 12">
            <a:extLst>
              <a:ext uri="{FF2B5EF4-FFF2-40B4-BE49-F238E27FC236}">
                <a16:creationId xmlns:a16="http://schemas.microsoft.com/office/drawing/2014/main" id="{D92FD665-5ED9-4ED0-B52E-DEC5BA33A238}"/>
              </a:ext>
            </a:extLst>
          </p:cNvPr>
          <p:cNvSpPr>
            <a:spLocks/>
          </p:cNvSpPr>
          <p:nvPr/>
        </p:nvSpPr>
        <p:spPr bwMode="auto">
          <a:xfrm>
            <a:off x="6840131" y="4908868"/>
            <a:ext cx="731358" cy="561514"/>
          </a:xfrm>
          <a:custGeom>
            <a:avLst/>
            <a:gdLst/>
            <a:ahLst/>
            <a:cxnLst/>
            <a:rect l="0" t="0" r="r" b="b"/>
            <a:pathLst>
              <a:path w="21600" h="21600">
                <a:moveTo>
                  <a:pt x="17841" y="16073"/>
                </a:moveTo>
                <a:cubicBezTo>
                  <a:pt x="17841" y="16596"/>
                  <a:pt x="17520" y="17019"/>
                  <a:pt x="17125" y="17019"/>
                </a:cubicBezTo>
                <a:lnTo>
                  <a:pt x="15692" y="17019"/>
                </a:lnTo>
                <a:cubicBezTo>
                  <a:pt x="15297" y="17019"/>
                  <a:pt x="14976" y="16596"/>
                  <a:pt x="14976" y="16073"/>
                </a:cubicBezTo>
                <a:lnTo>
                  <a:pt x="14976" y="14179"/>
                </a:lnTo>
                <a:cubicBezTo>
                  <a:pt x="14976" y="13656"/>
                  <a:pt x="15297" y="13231"/>
                  <a:pt x="15692" y="13231"/>
                </a:cubicBezTo>
                <a:lnTo>
                  <a:pt x="17125" y="13231"/>
                </a:lnTo>
                <a:cubicBezTo>
                  <a:pt x="17520" y="13231"/>
                  <a:pt x="17841" y="13656"/>
                  <a:pt x="17841" y="14179"/>
                </a:cubicBezTo>
                <a:cubicBezTo>
                  <a:pt x="17841" y="14179"/>
                  <a:pt x="17841" y="16073"/>
                  <a:pt x="17841" y="16073"/>
                </a:cubicBezTo>
                <a:close/>
                <a:moveTo>
                  <a:pt x="13633" y="16073"/>
                </a:moveTo>
                <a:cubicBezTo>
                  <a:pt x="13633" y="16596"/>
                  <a:pt x="13312" y="17019"/>
                  <a:pt x="12917" y="17019"/>
                </a:cubicBezTo>
                <a:lnTo>
                  <a:pt x="11484" y="17019"/>
                </a:lnTo>
                <a:cubicBezTo>
                  <a:pt x="11089" y="17019"/>
                  <a:pt x="10768" y="16596"/>
                  <a:pt x="10768" y="16073"/>
                </a:cubicBezTo>
                <a:lnTo>
                  <a:pt x="10768" y="14179"/>
                </a:lnTo>
                <a:cubicBezTo>
                  <a:pt x="10768" y="13656"/>
                  <a:pt x="11089" y="13231"/>
                  <a:pt x="11484" y="13231"/>
                </a:cubicBezTo>
                <a:lnTo>
                  <a:pt x="12917" y="13231"/>
                </a:lnTo>
                <a:cubicBezTo>
                  <a:pt x="13312" y="13231"/>
                  <a:pt x="13633" y="13656"/>
                  <a:pt x="13633" y="14179"/>
                </a:cubicBezTo>
                <a:cubicBezTo>
                  <a:pt x="13633" y="14179"/>
                  <a:pt x="13633" y="16073"/>
                  <a:pt x="13633" y="16073"/>
                </a:cubicBezTo>
                <a:close/>
                <a:moveTo>
                  <a:pt x="9425" y="16073"/>
                </a:moveTo>
                <a:cubicBezTo>
                  <a:pt x="9425" y="16596"/>
                  <a:pt x="9104" y="17019"/>
                  <a:pt x="8709" y="17019"/>
                </a:cubicBezTo>
                <a:lnTo>
                  <a:pt x="7276" y="17019"/>
                </a:lnTo>
                <a:cubicBezTo>
                  <a:pt x="6881" y="17019"/>
                  <a:pt x="6561" y="16596"/>
                  <a:pt x="6561" y="16073"/>
                </a:cubicBezTo>
                <a:lnTo>
                  <a:pt x="6561" y="14179"/>
                </a:lnTo>
                <a:cubicBezTo>
                  <a:pt x="6561" y="13656"/>
                  <a:pt x="6881" y="13231"/>
                  <a:pt x="7276" y="13231"/>
                </a:cubicBezTo>
                <a:lnTo>
                  <a:pt x="8709" y="13231"/>
                </a:lnTo>
                <a:cubicBezTo>
                  <a:pt x="9104" y="13231"/>
                  <a:pt x="9425" y="13656"/>
                  <a:pt x="9425" y="14179"/>
                </a:cubicBezTo>
                <a:cubicBezTo>
                  <a:pt x="9425" y="14179"/>
                  <a:pt x="9425" y="16073"/>
                  <a:pt x="9425" y="16073"/>
                </a:cubicBezTo>
                <a:close/>
                <a:moveTo>
                  <a:pt x="19809" y="7715"/>
                </a:moveTo>
                <a:lnTo>
                  <a:pt x="14265" y="7715"/>
                </a:lnTo>
                <a:cubicBezTo>
                  <a:pt x="14253" y="7717"/>
                  <a:pt x="14241" y="7720"/>
                  <a:pt x="14229" y="7720"/>
                </a:cubicBezTo>
                <a:lnTo>
                  <a:pt x="4957" y="7720"/>
                </a:lnTo>
                <a:cubicBezTo>
                  <a:pt x="4134" y="7720"/>
                  <a:pt x="3465" y="8604"/>
                  <a:pt x="3465" y="9692"/>
                </a:cubicBezTo>
                <a:lnTo>
                  <a:pt x="3465" y="13981"/>
                </a:lnTo>
                <a:cubicBezTo>
                  <a:pt x="3465" y="14199"/>
                  <a:pt x="3331" y="14375"/>
                  <a:pt x="3166" y="14375"/>
                </a:cubicBezTo>
                <a:cubicBezTo>
                  <a:pt x="3002" y="14375"/>
                  <a:pt x="2868" y="14199"/>
                  <a:pt x="2868" y="13981"/>
                </a:cubicBezTo>
                <a:lnTo>
                  <a:pt x="2868" y="9692"/>
                </a:lnTo>
                <a:cubicBezTo>
                  <a:pt x="2868" y="8169"/>
                  <a:pt x="3805" y="6930"/>
                  <a:pt x="4957" y="6930"/>
                </a:cubicBezTo>
                <a:lnTo>
                  <a:pt x="14229" y="6930"/>
                </a:lnTo>
                <a:cubicBezTo>
                  <a:pt x="14231" y="6930"/>
                  <a:pt x="14232" y="6931"/>
                  <a:pt x="14234" y="6931"/>
                </a:cubicBezTo>
                <a:lnTo>
                  <a:pt x="14234" y="2367"/>
                </a:lnTo>
                <a:cubicBezTo>
                  <a:pt x="14234" y="1060"/>
                  <a:pt x="13432" y="0"/>
                  <a:pt x="12443" y="0"/>
                </a:cubicBezTo>
                <a:lnTo>
                  <a:pt x="1790" y="0"/>
                </a:lnTo>
                <a:cubicBezTo>
                  <a:pt x="802" y="0"/>
                  <a:pt x="0" y="1060"/>
                  <a:pt x="0" y="2367"/>
                </a:cubicBezTo>
                <a:lnTo>
                  <a:pt x="0" y="19233"/>
                </a:lnTo>
                <a:cubicBezTo>
                  <a:pt x="0" y="20292"/>
                  <a:pt x="527" y="21298"/>
                  <a:pt x="1253" y="21600"/>
                </a:cubicBezTo>
                <a:lnTo>
                  <a:pt x="19809" y="21600"/>
                </a:lnTo>
                <a:cubicBezTo>
                  <a:pt x="20799" y="21600"/>
                  <a:pt x="21600" y="20540"/>
                  <a:pt x="21600" y="19233"/>
                </a:cubicBezTo>
                <a:lnTo>
                  <a:pt x="21600" y="10082"/>
                </a:lnTo>
                <a:cubicBezTo>
                  <a:pt x="21600" y="8775"/>
                  <a:pt x="20799" y="7715"/>
                  <a:pt x="19809" y="7715"/>
                </a:cubicBezTo>
                <a:close/>
                <a:moveTo>
                  <a:pt x="19809" y="7715"/>
                </a:moveTo>
              </a:path>
            </a:pathLst>
          </a:custGeom>
          <a:solidFill>
            <a:srgbClr val="1E9D8B">
              <a:alpha val="45098"/>
            </a:srgbClr>
          </a:solidFill>
          <a:ln>
            <a:noFill/>
          </a:ln>
        </p:spPr>
        <p:txBody>
          <a:bodyPr lIns="0" tIns="0" rIns="0" bIns="0"/>
          <a:lstStyle/>
          <a:p>
            <a:pPr marL="0" marR="0" lvl="0" indent="0" defTabSz="914278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000" b="0" i="0" u="none" strike="noStrike" kern="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9A660FD6-BE7A-4A28-B6A8-9AB8B3D5E883}"/>
              </a:ext>
            </a:extLst>
          </p:cNvPr>
          <p:cNvSpPr txBox="1"/>
          <p:nvPr/>
        </p:nvSpPr>
        <p:spPr>
          <a:xfrm>
            <a:off x="6809137" y="6377547"/>
            <a:ext cx="4306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* Health manager role acted by PKU1 nurses</a:t>
            </a:r>
          </a:p>
        </p:txBody>
      </p:sp>
      <p:sp>
        <p:nvSpPr>
          <p:cNvPr id="142" name="Shape 372" descr="TextBox 1">
            <a:extLst>
              <a:ext uri="{FF2B5EF4-FFF2-40B4-BE49-F238E27FC236}">
                <a16:creationId xmlns:a16="http://schemas.microsoft.com/office/drawing/2014/main" id="{DB6A0AC6-4514-4B9C-ACF2-825D5020B87A}"/>
              </a:ext>
            </a:extLst>
          </p:cNvPr>
          <p:cNvSpPr/>
          <p:nvPr/>
        </p:nvSpPr>
        <p:spPr>
          <a:xfrm>
            <a:off x="480237" y="185755"/>
            <a:ext cx="10244469" cy="584775"/>
          </a:xfrm>
          <a:prstGeom prst="rect">
            <a:avLst/>
          </a:prstGeom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altLang="zh-CN" sz="3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High level solution architecture</a:t>
            </a:r>
          </a:p>
        </p:txBody>
      </p:sp>
    </p:spTree>
    <p:extLst>
      <p:ext uri="{BB962C8B-B14F-4D97-AF65-F5344CB8AC3E}">
        <p14:creationId xmlns:p14="http://schemas.microsoft.com/office/powerpoint/2010/main" val="426670594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0"/>
    </mc:Choice>
    <mc:Fallback>
      <p:transition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E8716A5E-E955-498A-8E2F-6B4E4EE546B7}"/>
              </a:ext>
            </a:extLst>
          </p:cNvPr>
          <p:cNvSpPr txBox="1">
            <a:spLocks/>
          </p:cNvSpPr>
          <p:nvPr>
            <p:custDataLst>
              <p:tags r:id="rId1"/>
            </p:custDataLst>
          </p:nvPr>
        </p:nvSpPr>
        <p:spPr>
          <a:xfrm>
            <a:off x="389239" y="177800"/>
            <a:ext cx="9951738" cy="914400"/>
          </a:xfrm>
          <a:prstGeom prst="rect">
            <a:avLst/>
          </a:prstGeom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/>
          <a:lstStyle>
            <a:defPPr>
              <a:defRPr lang="en-US"/>
            </a:defPPr>
            <a:lvl1pPr marR="0" lvl="0" indent="0" fontAlgn="auto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 kumimoji="0" sz="3200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</a:defRPr>
            </a:lvl1pPr>
          </a:lstStyle>
          <a:p>
            <a:r>
              <a:rPr lang="en-US" dirty="0"/>
              <a:t>Software module screen shots</a:t>
            </a:r>
          </a:p>
        </p:txBody>
      </p:sp>
      <p:pic>
        <p:nvPicPr>
          <p:cNvPr id="4" name="Picture 86">
            <a:extLst>
              <a:ext uri="{FF2B5EF4-FFF2-40B4-BE49-F238E27FC236}">
                <a16:creationId xmlns:a16="http://schemas.microsoft.com/office/drawing/2014/main" id="{7C33D52A-6992-4E9B-AA89-7C922F68538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9433"/>
          <a:stretch/>
        </p:blipFill>
        <p:spPr>
          <a:xfrm>
            <a:off x="4810462" y="5014610"/>
            <a:ext cx="1502621" cy="1215024"/>
          </a:xfrm>
          <a:prstGeom prst="rect">
            <a:avLst/>
          </a:prstGeom>
          <a:ln w="19050">
            <a:solidFill>
              <a:schemeClr val="bg1">
                <a:lumMod val="75000"/>
              </a:schemeClr>
            </a:solidFill>
          </a:ln>
        </p:spPr>
      </p:pic>
      <p:sp>
        <p:nvSpPr>
          <p:cNvPr id="5" name="TextBox 87">
            <a:extLst>
              <a:ext uri="{FF2B5EF4-FFF2-40B4-BE49-F238E27FC236}">
                <a16:creationId xmlns:a16="http://schemas.microsoft.com/office/drawing/2014/main" id="{92F2D5C0-32BB-483A-B545-4DC881AAF05C}"/>
              </a:ext>
            </a:extLst>
          </p:cNvPr>
          <p:cNvSpPr txBox="1"/>
          <p:nvPr/>
        </p:nvSpPr>
        <p:spPr>
          <a:xfrm>
            <a:off x="1597307" y="957407"/>
            <a:ext cx="19985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</a:rPr>
              <a:t>Discharge module</a:t>
            </a:r>
          </a:p>
        </p:txBody>
      </p:sp>
      <p:grpSp>
        <p:nvGrpSpPr>
          <p:cNvPr id="6" name="Group 88">
            <a:extLst>
              <a:ext uri="{FF2B5EF4-FFF2-40B4-BE49-F238E27FC236}">
                <a16:creationId xmlns:a16="http://schemas.microsoft.com/office/drawing/2014/main" id="{56E2FF21-5D6E-4E81-8ACD-2C1209503898}"/>
              </a:ext>
            </a:extLst>
          </p:cNvPr>
          <p:cNvGrpSpPr/>
          <p:nvPr/>
        </p:nvGrpSpPr>
        <p:grpSpPr>
          <a:xfrm>
            <a:off x="1581406" y="1423818"/>
            <a:ext cx="1605393" cy="1507199"/>
            <a:chOff x="4569498" y="1339271"/>
            <a:chExt cx="1944194" cy="1609029"/>
          </a:xfrm>
        </p:grpSpPr>
        <p:pic>
          <p:nvPicPr>
            <p:cNvPr id="7" name="Picture 89">
              <a:extLst>
                <a:ext uri="{FF2B5EF4-FFF2-40B4-BE49-F238E27FC236}">
                  <a16:creationId xmlns:a16="http://schemas.microsoft.com/office/drawing/2014/main" id="{E8CC6577-F622-4F8E-8F74-0E98FD19E47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4892" y="1576700"/>
              <a:ext cx="1828800" cy="1371600"/>
            </a:xfrm>
            <a:prstGeom prst="rect">
              <a:avLst/>
            </a:prstGeom>
          </p:spPr>
        </p:pic>
        <p:sp>
          <p:nvSpPr>
            <p:cNvPr id="8" name="TextBox 90">
              <a:extLst>
                <a:ext uri="{FF2B5EF4-FFF2-40B4-BE49-F238E27FC236}">
                  <a16:creationId xmlns:a16="http://schemas.microsoft.com/office/drawing/2014/main" id="{78C28BD1-9DF9-4C17-8B6B-14EC091406A6}"/>
                </a:ext>
              </a:extLst>
            </p:cNvPr>
            <p:cNvSpPr txBox="1"/>
            <p:nvPr/>
          </p:nvSpPr>
          <p:spPr>
            <a:xfrm>
              <a:off x="4569498" y="1339271"/>
              <a:ext cx="1752600" cy="2464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solidFill>
                    <a:srgbClr val="000000"/>
                  </a:solidFill>
                </a:rPr>
                <a:t>Medication plan</a:t>
              </a:r>
            </a:p>
          </p:txBody>
        </p:sp>
      </p:grpSp>
      <p:grpSp>
        <p:nvGrpSpPr>
          <p:cNvPr id="9" name="Group 91">
            <a:extLst>
              <a:ext uri="{FF2B5EF4-FFF2-40B4-BE49-F238E27FC236}">
                <a16:creationId xmlns:a16="http://schemas.microsoft.com/office/drawing/2014/main" id="{9F221E7E-D7E5-4E45-ACE0-2B9667E2D18F}"/>
              </a:ext>
            </a:extLst>
          </p:cNvPr>
          <p:cNvGrpSpPr/>
          <p:nvPr/>
        </p:nvGrpSpPr>
        <p:grpSpPr>
          <a:xfrm>
            <a:off x="1598725" y="2964255"/>
            <a:ext cx="1588073" cy="1572593"/>
            <a:chOff x="4590321" y="3002142"/>
            <a:chExt cx="1923222" cy="1779648"/>
          </a:xfrm>
        </p:grpSpPr>
        <p:pic>
          <p:nvPicPr>
            <p:cNvPr id="10" name="Picture 92">
              <a:extLst>
                <a:ext uri="{FF2B5EF4-FFF2-40B4-BE49-F238E27FC236}">
                  <a16:creationId xmlns:a16="http://schemas.microsoft.com/office/drawing/2014/main" id="{471710B6-A2E5-4032-A699-BF1D530F7A5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5041" y="3266165"/>
              <a:ext cx="1828502" cy="1515625"/>
            </a:xfrm>
            <a:prstGeom prst="rect">
              <a:avLst/>
            </a:prstGeom>
          </p:spPr>
        </p:pic>
        <p:sp>
          <p:nvSpPr>
            <p:cNvPr id="11" name="TextBox 93">
              <a:extLst>
                <a:ext uri="{FF2B5EF4-FFF2-40B4-BE49-F238E27FC236}">
                  <a16:creationId xmlns:a16="http://schemas.microsoft.com/office/drawing/2014/main" id="{AC679797-0DD2-4694-8DAB-9A85F6455489}"/>
                </a:ext>
              </a:extLst>
            </p:cNvPr>
            <p:cNvSpPr txBox="1"/>
            <p:nvPr/>
          </p:nvSpPr>
          <p:spPr>
            <a:xfrm>
              <a:off x="4590321" y="3002142"/>
              <a:ext cx="1752601" cy="2612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solidFill>
                    <a:srgbClr val="000000"/>
                  </a:solidFill>
                </a:rPr>
                <a:t>Lifestyle intervention plan</a:t>
              </a:r>
            </a:p>
          </p:txBody>
        </p:sp>
      </p:grpSp>
      <p:pic>
        <p:nvPicPr>
          <p:cNvPr id="12" name="Picture 94">
            <a:extLst>
              <a:ext uri="{FF2B5EF4-FFF2-40B4-BE49-F238E27FC236}">
                <a16:creationId xmlns:a16="http://schemas.microsoft.com/office/drawing/2014/main" id="{7C74DE79-1292-435B-8710-6483BE7FF28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4416" y="4822137"/>
            <a:ext cx="1500962" cy="1291712"/>
          </a:xfrm>
          <a:prstGeom prst="rect">
            <a:avLst/>
          </a:prstGeom>
        </p:spPr>
      </p:pic>
      <p:sp>
        <p:nvSpPr>
          <p:cNvPr id="13" name="TextBox 95">
            <a:extLst>
              <a:ext uri="{FF2B5EF4-FFF2-40B4-BE49-F238E27FC236}">
                <a16:creationId xmlns:a16="http://schemas.microsoft.com/office/drawing/2014/main" id="{FB58C0DB-E031-4D62-A962-35D910B4F423}"/>
              </a:ext>
            </a:extLst>
          </p:cNvPr>
          <p:cNvSpPr txBox="1"/>
          <p:nvPr/>
        </p:nvSpPr>
        <p:spPr>
          <a:xfrm>
            <a:off x="1597305" y="4589850"/>
            <a:ext cx="15880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Follow-up plan</a:t>
            </a:r>
          </a:p>
        </p:txBody>
      </p:sp>
      <p:sp>
        <p:nvSpPr>
          <p:cNvPr id="14" name="TextBox 96">
            <a:extLst>
              <a:ext uri="{FF2B5EF4-FFF2-40B4-BE49-F238E27FC236}">
                <a16:creationId xmlns:a16="http://schemas.microsoft.com/office/drawing/2014/main" id="{1D855563-9D5B-4854-AFFE-BA1EDDFC476B}"/>
              </a:ext>
            </a:extLst>
          </p:cNvPr>
          <p:cNvSpPr txBox="1"/>
          <p:nvPr/>
        </p:nvSpPr>
        <p:spPr>
          <a:xfrm>
            <a:off x="4706614" y="957407"/>
            <a:ext cx="20023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</a:rPr>
              <a:t>Follow-up module</a:t>
            </a:r>
          </a:p>
        </p:txBody>
      </p:sp>
      <p:pic>
        <p:nvPicPr>
          <p:cNvPr id="15" name="Picture 97">
            <a:hlinkClick r:id="rId7" action="ppaction://hlinkfile"/>
            <a:extLst>
              <a:ext uri="{FF2B5EF4-FFF2-40B4-BE49-F238E27FC236}">
                <a16:creationId xmlns:a16="http://schemas.microsoft.com/office/drawing/2014/main" id="{664AFB20-F729-42C3-B2F8-D69A0E83ACDA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2506" y="3092973"/>
            <a:ext cx="1502621" cy="1600355"/>
          </a:xfrm>
          <a:prstGeom prst="rect">
            <a:avLst/>
          </a:prstGeom>
        </p:spPr>
      </p:pic>
      <p:pic>
        <p:nvPicPr>
          <p:cNvPr id="16" name="Picture 98">
            <a:extLst>
              <a:ext uri="{FF2B5EF4-FFF2-40B4-BE49-F238E27FC236}">
                <a16:creationId xmlns:a16="http://schemas.microsoft.com/office/drawing/2014/main" id="{C15A71BC-6D8D-40D1-87D9-F3042E971D67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2499" y="1592800"/>
            <a:ext cx="1502620" cy="1252949"/>
          </a:xfrm>
          <a:prstGeom prst="rect">
            <a:avLst/>
          </a:prstGeom>
        </p:spPr>
      </p:pic>
      <p:sp>
        <p:nvSpPr>
          <p:cNvPr id="17" name="TextBox 99">
            <a:extLst>
              <a:ext uri="{FF2B5EF4-FFF2-40B4-BE49-F238E27FC236}">
                <a16:creationId xmlns:a16="http://schemas.microsoft.com/office/drawing/2014/main" id="{64253E88-8B99-4DDB-90C1-825D1E6D8F49}"/>
              </a:ext>
            </a:extLst>
          </p:cNvPr>
          <p:cNvSpPr txBox="1"/>
          <p:nvPr/>
        </p:nvSpPr>
        <p:spPr>
          <a:xfrm>
            <a:off x="4720723" y="1368208"/>
            <a:ext cx="14926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Status overview</a:t>
            </a:r>
          </a:p>
        </p:txBody>
      </p:sp>
      <p:sp>
        <p:nvSpPr>
          <p:cNvPr id="18" name="TextBox 100">
            <a:extLst>
              <a:ext uri="{FF2B5EF4-FFF2-40B4-BE49-F238E27FC236}">
                <a16:creationId xmlns:a16="http://schemas.microsoft.com/office/drawing/2014/main" id="{C320AFC9-FE9C-4735-A856-4A02BE79BB2A}"/>
              </a:ext>
            </a:extLst>
          </p:cNvPr>
          <p:cNvSpPr txBox="1"/>
          <p:nvPr/>
        </p:nvSpPr>
        <p:spPr>
          <a:xfrm>
            <a:off x="4712731" y="2875410"/>
            <a:ext cx="1753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Medication update</a:t>
            </a:r>
          </a:p>
        </p:txBody>
      </p:sp>
      <p:sp>
        <p:nvSpPr>
          <p:cNvPr id="19" name="TextBox 101">
            <a:extLst>
              <a:ext uri="{FF2B5EF4-FFF2-40B4-BE49-F238E27FC236}">
                <a16:creationId xmlns:a16="http://schemas.microsoft.com/office/drawing/2014/main" id="{148217BF-4AF8-4840-A35E-909B1223809E}"/>
              </a:ext>
            </a:extLst>
          </p:cNvPr>
          <p:cNvSpPr txBox="1"/>
          <p:nvPr/>
        </p:nvSpPr>
        <p:spPr>
          <a:xfrm>
            <a:off x="4721217" y="4737443"/>
            <a:ext cx="1657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Measurement + events advices</a:t>
            </a:r>
          </a:p>
        </p:txBody>
      </p:sp>
      <p:pic>
        <p:nvPicPr>
          <p:cNvPr id="20" name="Picture 104">
            <a:extLst>
              <a:ext uri="{FF2B5EF4-FFF2-40B4-BE49-F238E27FC236}">
                <a16:creationId xmlns:a16="http://schemas.microsoft.com/office/drawing/2014/main" id="{6EB5371E-6937-4926-919F-C7EC0D0E9E4C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0008" y="4834451"/>
            <a:ext cx="1544023" cy="1307276"/>
          </a:xfrm>
          <a:prstGeom prst="rect">
            <a:avLst/>
          </a:prstGeom>
          <a:ln w="19050">
            <a:solidFill>
              <a:schemeClr val="bg1">
                <a:lumMod val="75000"/>
              </a:schemeClr>
            </a:solidFill>
          </a:ln>
        </p:spPr>
      </p:pic>
      <p:sp>
        <p:nvSpPr>
          <p:cNvPr id="21" name="TextBox 105">
            <a:extLst>
              <a:ext uri="{FF2B5EF4-FFF2-40B4-BE49-F238E27FC236}">
                <a16:creationId xmlns:a16="http://schemas.microsoft.com/office/drawing/2014/main" id="{218876A6-6D73-4993-82BE-AC0833BA3EBA}"/>
              </a:ext>
            </a:extLst>
          </p:cNvPr>
          <p:cNvSpPr txBox="1"/>
          <p:nvPr/>
        </p:nvSpPr>
        <p:spPr>
          <a:xfrm>
            <a:off x="9462754" y="2966091"/>
            <a:ext cx="2410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Lifestyle coaching/reminder</a:t>
            </a:r>
          </a:p>
        </p:txBody>
      </p:sp>
      <p:sp>
        <p:nvSpPr>
          <p:cNvPr id="22" name="TextBox 106">
            <a:extLst>
              <a:ext uri="{FF2B5EF4-FFF2-40B4-BE49-F238E27FC236}">
                <a16:creationId xmlns:a16="http://schemas.microsoft.com/office/drawing/2014/main" id="{7C45A4B0-0D8D-42A8-9EDF-F334C2C64113}"/>
              </a:ext>
            </a:extLst>
          </p:cNvPr>
          <p:cNvSpPr txBox="1"/>
          <p:nvPr/>
        </p:nvSpPr>
        <p:spPr>
          <a:xfrm>
            <a:off x="7738188" y="2947864"/>
            <a:ext cx="15880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Medication intake</a:t>
            </a:r>
          </a:p>
        </p:txBody>
      </p:sp>
      <p:sp>
        <p:nvSpPr>
          <p:cNvPr id="23" name="TextBox 107">
            <a:extLst>
              <a:ext uri="{FF2B5EF4-FFF2-40B4-BE49-F238E27FC236}">
                <a16:creationId xmlns:a16="http://schemas.microsoft.com/office/drawing/2014/main" id="{79AB4BCC-A76E-4490-9571-F0B40F71F273}"/>
              </a:ext>
            </a:extLst>
          </p:cNvPr>
          <p:cNvSpPr txBox="1"/>
          <p:nvPr/>
        </p:nvSpPr>
        <p:spPr>
          <a:xfrm>
            <a:off x="7773281" y="4573464"/>
            <a:ext cx="19863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Measurement &amp; implication </a:t>
            </a:r>
          </a:p>
        </p:txBody>
      </p:sp>
      <p:sp>
        <p:nvSpPr>
          <p:cNvPr id="24" name="TextBox 108">
            <a:extLst>
              <a:ext uri="{FF2B5EF4-FFF2-40B4-BE49-F238E27FC236}">
                <a16:creationId xmlns:a16="http://schemas.microsoft.com/office/drawing/2014/main" id="{6C93C584-DAF5-4304-9F88-5D8F2EE5DCC8}"/>
              </a:ext>
            </a:extLst>
          </p:cNvPr>
          <p:cNvSpPr txBox="1"/>
          <p:nvPr/>
        </p:nvSpPr>
        <p:spPr>
          <a:xfrm>
            <a:off x="7705023" y="957407"/>
            <a:ext cx="2511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</a:rPr>
              <a:t>Home management</a:t>
            </a:r>
          </a:p>
        </p:txBody>
      </p:sp>
      <p:grpSp>
        <p:nvGrpSpPr>
          <p:cNvPr id="25" name="Group 109">
            <a:extLst>
              <a:ext uri="{FF2B5EF4-FFF2-40B4-BE49-F238E27FC236}">
                <a16:creationId xmlns:a16="http://schemas.microsoft.com/office/drawing/2014/main" id="{971A3ACB-012E-48D7-AAD3-271A015A46DD}"/>
              </a:ext>
            </a:extLst>
          </p:cNvPr>
          <p:cNvGrpSpPr/>
          <p:nvPr/>
        </p:nvGrpSpPr>
        <p:grpSpPr>
          <a:xfrm>
            <a:off x="987704" y="1103267"/>
            <a:ext cx="609600" cy="631651"/>
            <a:chOff x="1207634" y="623995"/>
            <a:chExt cx="970164" cy="1115009"/>
          </a:xfrm>
        </p:grpSpPr>
        <p:grpSp>
          <p:nvGrpSpPr>
            <p:cNvPr id="26" name="Group 110">
              <a:extLst>
                <a:ext uri="{FF2B5EF4-FFF2-40B4-BE49-F238E27FC236}">
                  <a16:creationId xmlns:a16="http://schemas.microsoft.com/office/drawing/2014/main" id="{ED709AD3-2031-4B4C-8DF9-0DEFFE634383}"/>
                </a:ext>
              </a:extLst>
            </p:cNvPr>
            <p:cNvGrpSpPr/>
            <p:nvPr/>
          </p:nvGrpSpPr>
          <p:grpSpPr>
            <a:xfrm>
              <a:off x="1257991" y="779713"/>
              <a:ext cx="898601" cy="918673"/>
              <a:chOff x="3762767" y="1772648"/>
              <a:chExt cx="898601" cy="918673"/>
            </a:xfrm>
          </p:grpSpPr>
          <p:pic>
            <p:nvPicPr>
              <p:cNvPr id="28" name="Picture 112">
                <a:extLst>
                  <a:ext uri="{FF2B5EF4-FFF2-40B4-BE49-F238E27FC236}">
                    <a16:creationId xmlns:a16="http://schemas.microsoft.com/office/drawing/2014/main" id="{C9D0AB0F-85B1-4381-9BA5-0120AF63D2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985880" y="1772648"/>
                <a:ext cx="423221" cy="562633"/>
              </a:xfrm>
              <a:prstGeom prst="rect">
                <a:avLst/>
              </a:prstGeom>
            </p:spPr>
          </p:pic>
          <p:sp>
            <p:nvSpPr>
              <p:cNvPr id="29" name="TextBox 113">
                <a:extLst>
                  <a:ext uri="{FF2B5EF4-FFF2-40B4-BE49-F238E27FC236}">
                    <a16:creationId xmlns:a16="http://schemas.microsoft.com/office/drawing/2014/main" id="{FD536A3E-A39E-401B-97AF-7BF38A2FDAEB}"/>
                  </a:ext>
                </a:extLst>
              </p:cNvPr>
              <p:cNvSpPr txBox="1"/>
              <p:nvPr/>
            </p:nvSpPr>
            <p:spPr>
              <a:xfrm>
                <a:off x="3762767" y="2311013"/>
                <a:ext cx="898601" cy="3803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en-US" sz="800" dirty="0">
                    <a:solidFill>
                      <a:srgbClr val="FFFFFF">
                        <a:lumMod val="50000"/>
                      </a:srgbClr>
                    </a:solidFill>
                  </a:rPr>
                  <a:t>Hospital</a:t>
                </a:r>
              </a:p>
            </p:txBody>
          </p:sp>
        </p:grpSp>
        <p:sp>
          <p:nvSpPr>
            <p:cNvPr id="27" name="Oval 111">
              <a:extLst>
                <a:ext uri="{FF2B5EF4-FFF2-40B4-BE49-F238E27FC236}">
                  <a16:creationId xmlns:a16="http://schemas.microsoft.com/office/drawing/2014/main" id="{C2F3D4A7-1F39-4A0D-8A2C-84BB235500A0}"/>
                </a:ext>
              </a:extLst>
            </p:cNvPr>
            <p:cNvSpPr/>
            <p:nvPr/>
          </p:nvSpPr>
          <p:spPr>
            <a:xfrm>
              <a:off x="1207634" y="623995"/>
              <a:ext cx="970164" cy="1115009"/>
            </a:xfrm>
            <a:prstGeom prst="ellipse">
              <a:avLst/>
            </a:prstGeom>
            <a:noFill/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en-US" sz="2800">
                <a:solidFill>
                  <a:srgbClr val="FFFFFF"/>
                </a:solidFill>
              </a:endParaRPr>
            </a:p>
          </p:txBody>
        </p:sp>
      </p:grpSp>
      <p:grpSp>
        <p:nvGrpSpPr>
          <p:cNvPr id="30" name="Group 114">
            <a:extLst>
              <a:ext uri="{FF2B5EF4-FFF2-40B4-BE49-F238E27FC236}">
                <a16:creationId xmlns:a16="http://schemas.microsoft.com/office/drawing/2014/main" id="{6D8D3F04-3701-4317-8F96-E6FB9EEABA81}"/>
              </a:ext>
            </a:extLst>
          </p:cNvPr>
          <p:cNvGrpSpPr/>
          <p:nvPr/>
        </p:nvGrpSpPr>
        <p:grpSpPr>
          <a:xfrm>
            <a:off x="4077490" y="1815565"/>
            <a:ext cx="609600" cy="671069"/>
            <a:chOff x="2146462" y="2179352"/>
            <a:chExt cx="792561" cy="743179"/>
          </a:xfrm>
        </p:grpSpPr>
        <p:grpSp>
          <p:nvGrpSpPr>
            <p:cNvPr id="31" name="Group 115">
              <a:extLst>
                <a:ext uri="{FF2B5EF4-FFF2-40B4-BE49-F238E27FC236}">
                  <a16:creationId xmlns:a16="http://schemas.microsoft.com/office/drawing/2014/main" id="{06580F8A-03F2-4E3B-9D4F-710A74E26FFB}"/>
                </a:ext>
              </a:extLst>
            </p:cNvPr>
            <p:cNvGrpSpPr/>
            <p:nvPr/>
          </p:nvGrpSpPr>
          <p:grpSpPr>
            <a:xfrm>
              <a:off x="2264358" y="2291096"/>
              <a:ext cx="531974" cy="582833"/>
              <a:chOff x="2180255" y="4076132"/>
              <a:chExt cx="664581" cy="929813"/>
            </a:xfrm>
          </p:grpSpPr>
          <p:pic>
            <p:nvPicPr>
              <p:cNvPr id="33" name="Picture 117">
                <a:extLst>
                  <a:ext uri="{FF2B5EF4-FFF2-40B4-BE49-F238E27FC236}">
                    <a16:creationId xmlns:a16="http://schemas.microsoft.com/office/drawing/2014/main" id="{FDBFD551-EE82-49D5-966C-505C6B08B2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288972" y="4076132"/>
                <a:ext cx="478124" cy="612797"/>
              </a:xfrm>
              <a:prstGeom prst="rect">
                <a:avLst/>
              </a:prstGeom>
              <a:noFill/>
              <a:ln w="12700">
                <a:noFill/>
              </a:ln>
            </p:spPr>
          </p:pic>
          <p:sp>
            <p:nvSpPr>
              <p:cNvPr id="34" name="TextBox 118">
                <a:extLst>
                  <a:ext uri="{FF2B5EF4-FFF2-40B4-BE49-F238E27FC236}">
                    <a16:creationId xmlns:a16="http://schemas.microsoft.com/office/drawing/2014/main" id="{AAF3C82A-FBAB-4ABE-A6B3-C25D1BB38957}"/>
                  </a:ext>
                </a:extLst>
              </p:cNvPr>
              <p:cNvSpPr txBox="1"/>
              <p:nvPr/>
            </p:nvSpPr>
            <p:spPr>
              <a:xfrm>
                <a:off x="2180255" y="4625307"/>
                <a:ext cx="664581" cy="3806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en-US" sz="800" dirty="0">
                    <a:solidFill>
                      <a:srgbClr val="FFFFFF">
                        <a:lumMod val="50000"/>
                      </a:srgbClr>
                    </a:solidFill>
                  </a:rPr>
                  <a:t>CHC</a:t>
                </a:r>
              </a:p>
            </p:txBody>
          </p:sp>
        </p:grpSp>
        <p:sp>
          <p:nvSpPr>
            <p:cNvPr id="32" name="Oval 116">
              <a:extLst>
                <a:ext uri="{FF2B5EF4-FFF2-40B4-BE49-F238E27FC236}">
                  <a16:creationId xmlns:a16="http://schemas.microsoft.com/office/drawing/2014/main" id="{121C02E5-C178-4BF1-BE5C-C24774DCD504}"/>
                </a:ext>
              </a:extLst>
            </p:cNvPr>
            <p:cNvSpPr/>
            <p:nvPr/>
          </p:nvSpPr>
          <p:spPr>
            <a:xfrm>
              <a:off x="2146462" y="2179352"/>
              <a:ext cx="792561" cy="743179"/>
            </a:xfrm>
            <a:prstGeom prst="ellipse">
              <a:avLst/>
            </a:prstGeom>
            <a:noFill/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en-US" sz="800">
                <a:solidFill>
                  <a:srgbClr val="FFFFFF"/>
                </a:solidFill>
              </a:endParaRPr>
            </a:p>
          </p:txBody>
        </p:sp>
      </p:grpSp>
      <p:grpSp>
        <p:nvGrpSpPr>
          <p:cNvPr id="35" name="Group 124">
            <a:extLst>
              <a:ext uri="{FF2B5EF4-FFF2-40B4-BE49-F238E27FC236}">
                <a16:creationId xmlns:a16="http://schemas.microsoft.com/office/drawing/2014/main" id="{1B159F58-1F50-4903-85DE-FD6598E0D89A}"/>
              </a:ext>
            </a:extLst>
          </p:cNvPr>
          <p:cNvGrpSpPr/>
          <p:nvPr/>
        </p:nvGrpSpPr>
        <p:grpSpPr>
          <a:xfrm>
            <a:off x="7016411" y="1080024"/>
            <a:ext cx="635229" cy="613083"/>
            <a:chOff x="2103037" y="3149499"/>
            <a:chExt cx="792561" cy="743180"/>
          </a:xfrm>
        </p:grpSpPr>
        <p:grpSp>
          <p:nvGrpSpPr>
            <p:cNvPr id="36" name="Group 125">
              <a:extLst>
                <a:ext uri="{FF2B5EF4-FFF2-40B4-BE49-F238E27FC236}">
                  <a16:creationId xmlns:a16="http://schemas.microsoft.com/office/drawing/2014/main" id="{35F80084-C5EA-41B6-A32E-9A5175BA2C87}"/>
                </a:ext>
              </a:extLst>
            </p:cNvPr>
            <p:cNvGrpSpPr/>
            <p:nvPr/>
          </p:nvGrpSpPr>
          <p:grpSpPr>
            <a:xfrm>
              <a:off x="2242953" y="3225694"/>
              <a:ext cx="567983" cy="642162"/>
              <a:chOff x="1448980" y="4477751"/>
              <a:chExt cx="699531" cy="1008138"/>
            </a:xfrm>
          </p:grpSpPr>
          <p:pic>
            <p:nvPicPr>
              <p:cNvPr id="38" name="Picture 127">
                <a:extLst>
                  <a:ext uri="{FF2B5EF4-FFF2-40B4-BE49-F238E27FC236}">
                    <a16:creationId xmlns:a16="http://schemas.microsoft.com/office/drawing/2014/main" id="{11581661-AB79-4551-94FF-69D2259FCF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82526" y="4477751"/>
                <a:ext cx="376875" cy="675000"/>
              </a:xfrm>
              <a:prstGeom prst="rect">
                <a:avLst/>
              </a:prstGeom>
            </p:spPr>
          </p:pic>
          <p:sp>
            <p:nvSpPr>
              <p:cNvPr id="39" name="TextBox 128">
                <a:extLst>
                  <a:ext uri="{FF2B5EF4-FFF2-40B4-BE49-F238E27FC236}">
                    <a16:creationId xmlns:a16="http://schemas.microsoft.com/office/drawing/2014/main" id="{DE5F5E61-E7EF-4E5D-ABA8-D16667D9D84F}"/>
                  </a:ext>
                </a:extLst>
              </p:cNvPr>
              <p:cNvSpPr txBox="1"/>
              <p:nvPr/>
            </p:nvSpPr>
            <p:spPr>
              <a:xfrm>
                <a:off x="1448980" y="5075888"/>
                <a:ext cx="699531" cy="4100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en-US" sz="800" dirty="0">
                    <a:solidFill>
                      <a:srgbClr val="FFFFFF">
                        <a:lumMod val="50000"/>
                      </a:srgbClr>
                    </a:solidFill>
                  </a:rPr>
                  <a:t>Home</a:t>
                </a:r>
              </a:p>
            </p:txBody>
          </p:sp>
        </p:grpSp>
        <p:sp>
          <p:nvSpPr>
            <p:cNvPr id="37" name="Oval 126">
              <a:extLst>
                <a:ext uri="{FF2B5EF4-FFF2-40B4-BE49-F238E27FC236}">
                  <a16:creationId xmlns:a16="http://schemas.microsoft.com/office/drawing/2014/main" id="{34D8A533-00C2-4855-AAD4-B7A8AD56F873}"/>
                </a:ext>
              </a:extLst>
            </p:cNvPr>
            <p:cNvSpPr/>
            <p:nvPr/>
          </p:nvSpPr>
          <p:spPr>
            <a:xfrm>
              <a:off x="2103037" y="3149499"/>
              <a:ext cx="792561" cy="743180"/>
            </a:xfrm>
            <a:prstGeom prst="ellipse">
              <a:avLst/>
            </a:prstGeom>
            <a:noFill/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en-US" sz="800">
                <a:solidFill>
                  <a:srgbClr val="FFFFFF"/>
                </a:solidFill>
              </a:endParaRPr>
            </a:p>
          </p:txBody>
        </p:sp>
      </p:grpSp>
      <p:sp>
        <p:nvSpPr>
          <p:cNvPr id="41" name="TextBox 107">
            <a:extLst>
              <a:ext uri="{FF2B5EF4-FFF2-40B4-BE49-F238E27FC236}">
                <a16:creationId xmlns:a16="http://schemas.microsoft.com/office/drawing/2014/main" id="{0B83F256-F33D-44A9-8ACE-960EEEB4C78E}"/>
              </a:ext>
            </a:extLst>
          </p:cNvPr>
          <p:cNvSpPr txBox="1"/>
          <p:nvPr/>
        </p:nvSpPr>
        <p:spPr>
          <a:xfrm>
            <a:off x="9430950" y="1290460"/>
            <a:ext cx="167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Symptoms &amp; events </a:t>
            </a:r>
          </a:p>
        </p:txBody>
      </p:sp>
      <p:grpSp>
        <p:nvGrpSpPr>
          <p:cNvPr id="42" name="Group 109">
            <a:extLst>
              <a:ext uri="{FF2B5EF4-FFF2-40B4-BE49-F238E27FC236}">
                <a16:creationId xmlns:a16="http://schemas.microsoft.com/office/drawing/2014/main" id="{9D7AACBD-B7E9-4DB8-B747-AA3B2D9581BF}"/>
              </a:ext>
            </a:extLst>
          </p:cNvPr>
          <p:cNvGrpSpPr/>
          <p:nvPr/>
        </p:nvGrpSpPr>
        <p:grpSpPr>
          <a:xfrm>
            <a:off x="4077490" y="1079845"/>
            <a:ext cx="609600" cy="631651"/>
            <a:chOff x="1207634" y="623995"/>
            <a:chExt cx="970164" cy="1115009"/>
          </a:xfrm>
        </p:grpSpPr>
        <p:grpSp>
          <p:nvGrpSpPr>
            <p:cNvPr id="43" name="Group 110">
              <a:extLst>
                <a:ext uri="{FF2B5EF4-FFF2-40B4-BE49-F238E27FC236}">
                  <a16:creationId xmlns:a16="http://schemas.microsoft.com/office/drawing/2014/main" id="{B1FC937D-351A-40EA-908F-A1D28F4020B2}"/>
                </a:ext>
              </a:extLst>
            </p:cNvPr>
            <p:cNvGrpSpPr/>
            <p:nvPr/>
          </p:nvGrpSpPr>
          <p:grpSpPr>
            <a:xfrm>
              <a:off x="1257991" y="779713"/>
              <a:ext cx="898601" cy="918673"/>
              <a:chOff x="3762767" y="1772648"/>
              <a:chExt cx="898601" cy="918673"/>
            </a:xfrm>
          </p:grpSpPr>
          <p:pic>
            <p:nvPicPr>
              <p:cNvPr id="45" name="Picture 112">
                <a:extLst>
                  <a:ext uri="{FF2B5EF4-FFF2-40B4-BE49-F238E27FC236}">
                    <a16:creationId xmlns:a16="http://schemas.microsoft.com/office/drawing/2014/main" id="{C939C106-D8DA-48F3-93CA-C7C598C8CE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985880" y="1772648"/>
                <a:ext cx="423221" cy="562633"/>
              </a:xfrm>
              <a:prstGeom prst="rect">
                <a:avLst/>
              </a:prstGeom>
            </p:spPr>
          </p:pic>
          <p:sp>
            <p:nvSpPr>
              <p:cNvPr id="46" name="TextBox 113">
                <a:extLst>
                  <a:ext uri="{FF2B5EF4-FFF2-40B4-BE49-F238E27FC236}">
                    <a16:creationId xmlns:a16="http://schemas.microsoft.com/office/drawing/2014/main" id="{4D3A22F1-3FEE-4C2D-925E-F816836D3945}"/>
                  </a:ext>
                </a:extLst>
              </p:cNvPr>
              <p:cNvSpPr txBox="1"/>
              <p:nvPr/>
            </p:nvSpPr>
            <p:spPr>
              <a:xfrm>
                <a:off x="3762767" y="2311013"/>
                <a:ext cx="898601" cy="3803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en-US" sz="800" dirty="0">
                    <a:solidFill>
                      <a:srgbClr val="FFFFFF">
                        <a:lumMod val="50000"/>
                      </a:srgbClr>
                    </a:solidFill>
                  </a:rPr>
                  <a:t>Hospital</a:t>
                </a:r>
              </a:p>
            </p:txBody>
          </p:sp>
        </p:grpSp>
        <p:sp>
          <p:nvSpPr>
            <p:cNvPr id="44" name="Oval 111">
              <a:extLst>
                <a:ext uri="{FF2B5EF4-FFF2-40B4-BE49-F238E27FC236}">
                  <a16:creationId xmlns:a16="http://schemas.microsoft.com/office/drawing/2014/main" id="{BC408843-8210-4D77-9609-EF04D385E83B}"/>
                </a:ext>
              </a:extLst>
            </p:cNvPr>
            <p:cNvSpPr/>
            <p:nvPr/>
          </p:nvSpPr>
          <p:spPr>
            <a:xfrm>
              <a:off x="1207634" y="623995"/>
              <a:ext cx="970164" cy="1115009"/>
            </a:xfrm>
            <a:prstGeom prst="ellipse">
              <a:avLst/>
            </a:prstGeom>
            <a:noFill/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en-US" sz="2800">
                <a:solidFill>
                  <a:srgbClr val="FFFFFF"/>
                </a:solidFill>
              </a:endParaRPr>
            </a:p>
          </p:txBody>
        </p:sp>
      </p:grpSp>
      <p:pic>
        <p:nvPicPr>
          <p:cNvPr id="47" name="Picture 46">
            <a:extLst>
              <a:ext uri="{FF2B5EF4-FFF2-40B4-BE49-F238E27FC236}">
                <a16:creationId xmlns:a16="http://schemas.microsoft.com/office/drawing/2014/main" id="{03578481-151F-4CC2-AA06-F77C250C4703}"/>
              </a:ext>
            </a:extLst>
          </p:cNvPr>
          <p:cNvPicPr/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21550" y="1570604"/>
            <a:ext cx="1495211" cy="1289591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BD00FFB6-3A65-4908-8C19-4BF055AAF96F}"/>
              </a:ext>
            </a:extLst>
          </p:cNvPr>
          <p:cNvPicPr/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2807" y="3237653"/>
            <a:ext cx="1453948" cy="1282809"/>
          </a:xfrm>
          <a:prstGeom prst="rect">
            <a:avLst/>
          </a:prstGeom>
          <a:ln w="19050">
            <a:solidFill>
              <a:schemeClr val="bg1">
                <a:lumMod val="75000"/>
              </a:schemeClr>
            </a:solidFill>
          </a:ln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19AD2ED8-ACCC-4A1C-A455-893A2D23A8F1}"/>
              </a:ext>
            </a:extLst>
          </p:cNvPr>
          <p:cNvPicPr/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1045" y="1570737"/>
            <a:ext cx="1494720" cy="1292317"/>
          </a:xfrm>
          <a:prstGeom prst="rect">
            <a:avLst/>
          </a:prstGeom>
          <a:ln w="19050">
            <a:solidFill>
              <a:schemeClr val="bg1">
                <a:lumMod val="75000"/>
              </a:schemeClr>
            </a:solidFill>
          </a:ln>
        </p:spPr>
      </p:pic>
      <p:sp>
        <p:nvSpPr>
          <p:cNvPr id="50" name="TextBox 107">
            <a:extLst>
              <a:ext uri="{FF2B5EF4-FFF2-40B4-BE49-F238E27FC236}">
                <a16:creationId xmlns:a16="http://schemas.microsoft.com/office/drawing/2014/main" id="{BA188B36-3646-4E59-8985-1E7CC15FF1C2}"/>
              </a:ext>
            </a:extLst>
          </p:cNvPr>
          <p:cNvSpPr txBox="1"/>
          <p:nvPr/>
        </p:nvSpPr>
        <p:spPr>
          <a:xfrm>
            <a:off x="7702203" y="1322264"/>
            <a:ext cx="19863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Overall compliance score 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0EB1386D-3F42-48FA-9B35-C1A5E4D665F4}"/>
              </a:ext>
            </a:extLst>
          </p:cNvPr>
          <p:cNvPicPr/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831045" y="3181407"/>
            <a:ext cx="1507326" cy="129774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9B54E188-0E50-4818-A2CD-42C0B96E8066}"/>
              </a:ext>
            </a:extLst>
          </p:cNvPr>
          <p:cNvPicPr/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9562807" y="4858124"/>
            <a:ext cx="1453948" cy="1259928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</p:pic>
      <p:sp>
        <p:nvSpPr>
          <p:cNvPr id="53" name="TextBox 105">
            <a:extLst>
              <a:ext uri="{FF2B5EF4-FFF2-40B4-BE49-F238E27FC236}">
                <a16:creationId xmlns:a16="http://schemas.microsoft.com/office/drawing/2014/main" id="{5A178377-89BA-41EF-B65F-48E6139C3C3C}"/>
              </a:ext>
            </a:extLst>
          </p:cNvPr>
          <p:cNvSpPr txBox="1"/>
          <p:nvPr/>
        </p:nvSpPr>
        <p:spPr>
          <a:xfrm>
            <a:off x="9462754" y="4619081"/>
            <a:ext cx="2410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Follow-up reminder</a:t>
            </a:r>
          </a:p>
        </p:txBody>
      </p:sp>
    </p:spTree>
    <p:extLst>
      <p:ext uri="{BB962C8B-B14F-4D97-AF65-F5344CB8AC3E}">
        <p14:creationId xmlns:p14="http://schemas.microsoft.com/office/powerpoint/2010/main" val="66627476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0"/>
    </mc:Choice>
    <mc:Fallback>
      <p:transition/>
    </mc:Fallback>
  </mc:AlternateContent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SHAPECLASSNAME" val="CustFormCol001RoundSingleCornerRectangle"/>
  <p:tag name="COLORSETCLASSNAME" val="ColorSet1"/>
  <p:tag name="COLORS" val="-1;Scheme9;-2;-2;-1;-2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HiddenPageNumber"/>
  <p:tag name="SHAPECLASSPROTECTIONTYPE" val="3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HiddenDate"/>
  <p:tag name="SHAPECLASSPROTECTIONTYPE" val="31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SHAPECLASSNAME" val="CustFormCol001Rectangle"/>
  <p:tag name="COLORSETCLASSNAME" val="ColorSet1"/>
  <p:tag name="COLORS" val="-1;-1;-2;-2;-1;-2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-2;-2"/>
  <p:tag name="COLORSETCLASSNAME" val="ColorSet1"/>
  <p:tag name="MLI" val="1"/>
  <p:tag name="SHAPESETGROUPCLASSNAME" val="ShapeSetGroup2"/>
  <p:tag name="SHAPESETCLASSNAME" val="FORMCOLORTEXT01"/>
  <p:tag name="COLORSETGROUPCLASSNAME" val="ColorSetGroupLight"/>
  <p:tag name="FONTSETGROUPCLASSNAME" val="FontSetGroup1"/>
  <p:tag name="SHAPECLASSNAME" val="PhilipsLogoSlide"/>
  <p:tag name="SHAPECLASSFILE" val="PHGMCWORDMARK2008$C.emf"/>
  <p:tag name="SHAPECLASSPROTECTIONTYPE" val="31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PhilColorsBackgroundA4;Scheme1;-2;-2;-1;-2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TextFontColorLight;-2"/>
  <p:tag name="COLORSETCLASSNAME" val="ColorSet1"/>
  <p:tag name="MLI" val="1"/>
  <p:tag name="SHAPESETGROUPCLASSNAME" val="ShapeSetGroup2"/>
  <p:tag name="SHAPESETCLASSNAME" val="CONTENTTITLETEXT01"/>
  <p:tag name="COLORSETGROUPCLASSNAME" val="ColorSetGroupLight"/>
  <p:tag name="FONTSETGROUPCLASSNAME" val="FontSetGroup1"/>
  <p:tag name="SHAPECLASSNAME" val="ContentSmalLeftG3S1"/>
  <p:tag name="SHAPECLASSPROTECTIONTYPE" val="3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PhilColorsBackgroundA2;Scheme1;-1;-2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PhilColorsBackgroundA2;Scheme1;-1;-2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PhilColorsBackgroundA2;Scheme1;-1;-2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Scheme5;Scheme1;-2;-2;Scheme1;-2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PhilColorsGreen5;Scheme1;-2;-2;Scheme1;-2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Scheme5;Scheme1;-2;-2;Scheme1;-2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TextFontColorLight;-2"/>
  <p:tag name="COLORSETCLASSNAME" val="ColorSet1"/>
  <p:tag name="MLI" val="1"/>
  <p:tag name="SHAPESETGROUPCLASSNAME" val="ShapeSetGroup2"/>
  <p:tag name="SHAPESETCLASSNAME" val="TITLEBIGCONTENTTEXT01"/>
  <p:tag name="COLORSETGROUPCLASSNAME" val="ColorSetGroupLight"/>
  <p:tag name="FONTSETGROUPCLASSNAME" val="FontSetGroup1"/>
  <p:tag name="SHAPECLASSNAME" val="ContentBigRightG3S4"/>
  <p:tag name="SHAPECLASSPROTECTIONTYPE" val="3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FONT" val="SlideTitleFontC"/>
  <p:tag name="FONTSETCLASSNAME" val="FontSet1"/>
  <p:tag name="COLORSETCLASSNAME" val="ColorSet1"/>
  <p:tag name="MLI" val="1"/>
  <p:tag name="SHAPESETGROUPCLASSNAME" val="ShapeSetGroup2"/>
  <p:tag name="SHAPESETCLASSNAME" val="TITLETEXT"/>
  <p:tag name="COLORSETGROUPCLASSNAME" val="ColorSetGroupLight"/>
  <p:tag name="FONTSETGROUPCLASSNAME" val="FontSetGroup1"/>
  <p:tag name="SHAPECLASSNAME" val="TitleOnSlide02"/>
  <p:tag name="SHAPECLASSPROTECTIONTYPE" val="3"/>
  <p:tag name="COLORS" val="-2;-2;-2;-2;-1;-2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TextFontColorLight;-2"/>
  <p:tag name="COLORSETCLASSNAME" val="ColorSet1"/>
  <p:tag name="MLI" val="1"/>
  <p:tag name="SHAPESETGROUPCLASSNAME" val="ShapeSetGroup2"/>
  <p:tag name="SHAPESETCLASSNAME" val="TITLETWOCONTENTTWOTEXT01"/>
  <p:tag name="COLORSETGROUPCLASSNAME" val="ColorSetGroupLight"/>
  <p:tag name="FONTSETGROUPCLASSNAME" val="FontSetGroup1"/>
  <p:tag name="SHAPECLASSNAME" val="ContentRightTopG3S3"/>
  <p:tag name="SHAPECLASSPROTECTIONTYPE" val="3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TextFontColorLight;-2"/>
  <p:tag name="COLORSETCLASSNAME" val="ColorSet1"/>
  <p:tag name="MLI" val="1"/>
  <p:tag name="SHAPESETGROUPCLASSNAME" val="ShapeSetGroup2"/>
  <p:tag name="SHAPESETCLASSNAME" val="TITLETWOCONTENTTWOTEXT01"/>
  <p:tag name="COLORSETGROUPCLASSNAME" val="ColorSetGroupLight"/>
  <p:tag name="FONTSETGROUPCLASSNAME" val="FontSetGroup1"/>
  <p:tag name="SHAPECLASSNAME" val="ContentLeftTopG3S3"/>
  <p:tag name="SHAPECLASSPROTECTIONTYPE" val="3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SHAPECLASSNAME" val="CustFormEnd001Rectangle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FONT" val="TitleSlideTitleFontC"/>
  <p:tag name="FONTSETCLASSNAME" val="FontSet1"/>
  <p:tag name="COLORS" val="-2;-2;-2;-2;TitleSlideTitleFontColorLight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TitleOnTitleSlide"/>
  <p:tag name="SHAPECLASSPROTECTIONTYPE" val="3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HiddenSubtitle"/>
  <p:tag name="SHAPECLASSPROTECTIONTYPE" val="31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HiddenFooter"/>
  <p:tag name="SHAPECLASSPROTECTIONTYPE" val="31"/>
</p:tagLst>
</file>

<file path=ppt/theme/theme1.xml><?xml version="1.0" encoding="utf-8"?>
<a:theme xmlns:a="http://schemas.openxmlformats.org/drawingml/2006/main" name="1_philips_internal_documentation_template_nov13">
  <a:themeElements>
    <a:clrScheme name="PhCST">
      <a:dk1>
        <a:srgbClr val="000000"/>
      </a:dk1>
      <a:lt1>
        <a:srgbClr val="FFFFFF"/>
      </a:lt1>
      <a:dk2>
        <a:srgbClr val="000000"/>
      </a:dk2>
      <a:lt2>
        <a:srgbClr val="CCCEDB"/>
      </a:lt2>
      <a:accent1>
        <a:srgbClr val="0089C4"/>
      </a:accent1>
      <a:accent2>
        <a:srgbClr val="1E9D8B"/>
      </a:accent2>
      <a:accent3>
        <a:srgbClr val="5B8F22"/>
      </a:accent3>
      <a:accent4>
        <a:srgbClr val="E98300"/>
      </a:accent4>
      <a:accent5>
        <a:srgbClr val="CD202C"/>
      </a:accent5>
      <a:accent6>
        <a:srgbClr val="7D0063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hilips_internal_documentation_template_nov13.pptx" id="{DE36B277-C83F-4A85-9819-A77CE0CA1F6F}" vid="{FCDF7755-76C1-4ABB-A274-22B823C3C88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58</Words>
  <Application>Microsoft Office PowerPoint</Application>
  <PresentationFormat>宽屏</PresentationFormat>
  <Paragraphs>6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Century Gothic</vt:lpstr>
      <vt:lpstr>Wingdings</vt:lpstr>
      <vt:lpstr>1_philips_internal_documentation_template_nov13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, Bin</dc:creator>
  <cp:lastModifiedBy>李 昱熙</cp:lastModifiedBy>
  <cp:revision>2</cp:revision>
  <dcterms:created xsi:type="dcterms:W3CDTF">2021-10-09T03:11:28Z</dcterms:created>
  <dcterms:modified xsi:type="dcterms:W3CDTF">2021-10-11T04:14:31Z</dcterms:modified>
</cp:coreProperties>
</file>